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omments/modernComment_101_B587871D.xml" ContentType="application/vnd.ms-powerpoint.comments+xml"/>
  <Override PartName="/ppt/comments/modernComment_10B_7350BF2.xml" ContentType="application/vnd.ms-powerpoint.comment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2"/>
  </p:notesMasterIdLst>
  <p:handoutMasterIdLst>
    <p:handoutMasterId r:id="rId13"/>
  </p:handoutMasterIdLst>
  <p:sldIdLst>
    <p:sldId id="256" r:id="rId2"/>
    <p:sldId id="257" r:id="rId3"/>
    <p:sldId id="262" r:id="rId4"/>
    <p:sldId id="259" r:id="rId5"/>
    <p:sldId id="268" r:id="rId6"/>
    <p:sldId id="267" r:id="rId7"/>
    <p:sldId id="258" r:id="rId8"/>
    <p:sldId id="261" r:id="rId9"/>
    <p:sldId id="271" r:id="rId10"/>
    <p:sldId id="299" r:id="rId11"/>
  </p:sldIdLst>
  <p:sldSz cx="6858000" cy="9906000" type="A4"/>
  <p:notesSz cx="9926638" cy="67976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346" userDrawn="1">
          <p15:clr>
            <a:srgbClr val="A4A3A4"/>
          </p15:clr>
        </p15:guide>
        <p15:guide id="2" orient="horz" pos="4345" userDrawn="1">
          <p15:clr>
            <a:srgbClr val="A4A3A4"/>
          </p15:clr>
        </p15:guide>
        <p15:guide id="3" orient="horz" pos="1442" userDrawn="1">
          <p15:clr>
            <a:srgbClr val="A4A3A4"/>
          </p15:clr>
        </p15:guide>
        <p15:guide id="4" pos="1094" userDrawn="1">
          <p15:clr>
            <a:srgbClr val="A4A3A4"/>
          </p15:clr>
        </p15:guide>
        <p15:guide id="5" pos="3997" userDrawn="1">
          <p15:clr>
            <a:srgbClr val="A4A3A4"/>
          </p15:clr>
        </p15:guide>
        <p15:guide id="6" orient="horz" pos="2145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724F09F-13BB-75C9-5B38-8E5856302EFF}" name="In Hee Kim" initials="h" userId="In Hee Kim" providerId="Non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lga Anczukow" initials="OA" lastIdx="5" clrIdx="0">
    <p:extLst>
      <p:ext uri="{19B8F6BF-5375-455C-9EA6-DF929625EA0E}">
        <p15:presenceInfo xmlns:p15="http://schemas.microsoft.com/office/powerpoint/2012/main" userId="S::olga.anczukow@jax.org::5cbc4b43-c211-4e22-855f-d3f870357a2d" providerId="AD"/>
      </p:ext>
    </p:extLst>
  </p:cmAuthor>
  <p:cmAuthor id="2" name="Jun Yukyung" initials="JY" lastIdx="1" clrIdx="1">
    <p:extLst>
      <p:ext uri="{19B8F6BF-5375-455C-9EA6-DF929625EA0E}">
        <p15:presenceInfo xmlns:p15="http://schemas.microsoft.com/office/powerpoint/2012/main" userId="1b4405d72578e431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1FF"/>
    <a:srgbClr val="4472C4"/>
    <a:srgbClr val="C00000"/>
    <a:srgbClr val="9370DC"/>
    <a:srgbClr val="38B3AB"/>
    <a:srgbClr val="7EFF2D"/>
    <a:srgbClr val="FEAEFF"/>
    <a:srgbClr val="C5EEC5"/>
    <a:srgbClr val="36CC32"/>
    <a:srgbClr val="F57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867" autoAdjust="0"/>
    <p:restoredTop sz="93955" autoAdjust="0"/>
  </p:normalViewPr>
  <p:slideViewPr>
    <p:cSldViewPr snapToGrid="0" snapToObjects="1">
      <p:cViewPr varScale="1">
        <p:scale>
          <a:sx n="78" d="100"/>
          <a:sy n="78" d="100"/>
        </p:scale>
        <p:origin x="3402" y="84"/>
      </p:cViewPr>
      <p:guideLst>
        <p:guide pos="346"/>
        <p:guide orient="horz" pos="4345"/>
        <p:guide orient="horz" pos="1442"/>
        <p:guide pos="1094"/>
        <p:guide pos="3997"/>
        <p:guide orient="horz" pos="214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handoutMaster" Target="handoutMasters/handoutMaster1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microsoft.com/office/2018/10/relationships/authors" Target="authors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commentAuthors" Target="commentAuthors.xml"/></Relationships>
</file>

<file path=ppt/comments/modernComment_101_B587871D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1DCA1ED6-3052-4B1F-84E8-525F9E028C26}" authorId="{C724F09F-13BB-75C9-5B38-8E5856302EFF}" created="2024-02-16T08:30:32.388">
    <pc:sldMkLst xmlns:pc="http://schemas.microsoft.com/office/powerpoint/2013/main/command">
      <pc:docMk/>
      <pc:sldMk cId="3045558045" sldId="257"/>
    </pc:sldMkLst>
    <p188:txBody>
      <a:bodyPr/>
      <a:lstStyle/>
      <a:p>
        <a:r>
          <a:rPr lang="ko-KR" altLang="en-US"/>
          <a:t>- 장비이미지교체
- 약물반응이미지 진하게 요청</a:t>
        </a:r>
      </a:p>
    </p188:txBody>
  </p188:cm>
</p188:cmLst>
</file>

<file path=ppt/comments/modernComment_10B_7350BF2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CCFE3AF7-027A-4E22-8DF9-227CDC4F9BAD}" authorId="{C724F09F-13BB-75C9-5B38-8E5856302EFF}" created="2024-02-06T09:22:04.675">
    <pc:sldMkLst xmlns:pc="http://schemas.microsoft.com/office/powerpoint/2013/main/command">
      <pc:docMk/>
      <pc:sldMk cId="120916978" sldId="267"/>
    </pc:sldMkLst>
    <p188:txBody>
      <a:bodyPr/>
      <a:lstStyle/>
      <a:p>
        <a:r>
          <a:rPr lang="ko-KR" altLang="en-US"/>
          <a:t>organoids를 tumoroids 로 변경</a:t>
        </a:r>
      </a:p>
    </p188:txBody>
  </p188:cm>
</p188:cmLst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4A65C714-7A6C-4747-957A-8D57A759824B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1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CD9A806-BB10-964C-B5B5-9C0D807A3F3F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5622798" y="1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E95BFD-7F99-6A4A-9214-C375D81BF8A5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A13325A-BF0B-2F44-9FD9-75FA7978B18E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6456612"/>
            <a:ext cx="4301543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741C647-0D1A-BF47-BA74-D926FE935EB7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5622798" y="6456612"/>
            <a:ext cx="4301543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B52305-FD59-8440-BA54-644C9ECB3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23463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2798" y="1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CC8C429-817E-B643-9FC5-34A002C33180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168775" y="849313"/>
            <a:ext cx="1589088" cy="22939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2664" y="3271381"/>
            <a:ext cx="7941310" cy="267658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456612"/>
            <a:ext cx="4301543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2798" y="6456612"/>
            <a:ext cx="4301543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4DAEB8-CE64-5843-915F-D41B3F754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9558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66" indent="0" algn="ctr">
              <a:buNone/>
              <a:defRPr sz="1500"/>
            </a:lvl2pPr>
            <a:lvl3pPr marL="685732" indent="0" algn="ctr">
              <a:buNone/>
              <a:defRPr sz="1350"/>
            </a:lvl3pPr>
            <a:lvl4pPr marL="1028599" indent="0" algn="ctr">
              <a:buNone/>
              <a:defRPr sz="1200"/>
            </a:lvl4pPr>
            <a:lvl5pPr marL="1371464" indent="0" algn="ctr">
              <a:buNone/>
              <a:defRPr sz="1200"/>
            </a:lvl5pPr>
            <a:lvl6pPr marL="1714331" indent="0" algn="ctr">
              <a:buNone/>
              <a:defRPr sz="1200"/>
            </a:lvl6pPr>
            <a:lvl7pPr marL="2057197" indent="0" algn="ctr">
              <a:buNone/>
              <a:defRPr sz="1200"/>
            </a:lvl7pPr>
            <a:lvl8pPr marL="2400063" indent="0" algn="ctr">
              <a:buNone/>
              <a:defRPr sz="1200"/>
            </a:lvl8pPr>
            <a:lvl9pPr marL="2742929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329-C026-0E49-896F-5899BD239D7B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6B1C-38E0-004B-96AF-3A8D497C6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0143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329-C026-0E49-896F-5899BD239D7B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6B1C-38E0-004B-96AF-3A8D497C6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7276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5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5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329-C026-0E49-896F-5899BD239D7B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6B1C-38E0-004B-96AF-3A8D497C6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3853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329-C026-0E49-896F-5899BD239D7B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6B1C-38E0-004B-96AF-3A8D497C6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32290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6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3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5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6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19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06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92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329-C026-0E49-896F-5899BD239D7B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6B1C-38E0-004B-96AF-3A8D497C6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582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329-C026-0E49-896F-5899BD239D7B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6B1C-38E0-004B-96AF-3A8D497C6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708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9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66" indent="0">
              <a:buNone/>
              <a:defRPr sz="1500" b="1"/>
            </a:lvl2pPr>
            <a:lvl3pPr marL="685732" indent="0">
              <a:buNone/>
              <a:defRPr sz="1350" b="1"/>
            </a:lvl3pPr>
            <a:lvl4pPr marL="1028599" indent="0">
              <a:buNone/>
              <a:defRPr sz="1200" b="1"/>
            </a:lvl4pPr>
            <a:lvl5pPr marL="1371464" indent="0">
              <a:buNone/>
              <a:defRPr sz="1200" b="1"/>
            </a:lvl5pPr>
            <a:lvl6pPr marL="1714331" indent="0">
              <a:buNone/>
              <a:defRPr sz="1200" b="1"/>
            </a:lvl6pPr>
            <a:lvl7pPr marL="2057197" indent="0">
              <a:buNone/>
              <a:defRPr sz="1200" b="1"/>
            </a:lvl7pPr>
            <a:lvl8pPr marL="2400063" indent="0">
              <a:buNone/>
              <a:defRPr sz="1200" b="1"/>
            </a:lvl8pPr>
            <a:lvl9pPr marL="2742929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4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9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66" indent="0">
              <a:buNone/>
              <a:defRPr sz="1500" b="1"/>
            </a:lvl2pPr>
            <a:lvl3pPr marL="685732" indent="0">
              <a:buNone/>
              <a:defRPr sz="1350" b="1"/>
            </a:lvl3pPr>
            <a:lvl4pPr marL="1028599" indent="0">
              <a:buNone/>
              <a:defRPr sz="1200" b="1"/>
            </a:lvl4pPr>
            <a:lvl5pPr marL="1371464" indent="0">
              <a:buNone/>
              <a:defRPr sz="1200" b="1"/>
            </a:lvl5pPr>
            <a:lvl6pPr marL="1714331" indent="0">
              <a:buNone/>
              <a:defRPr sz="1200" b="1"/>
            </a:lvl6pPr>
            <a:lvl7pPr marL="2057197" indent="0">
              <a:buNone/>
              <a:defRPr sz="1200" b="1"/>
            </a:lvl7pPr>
            <a:lvl8pPr marL="2400063" indent="0">
              <a:buNone/>
              <a:defRPr sz="1200" b="1"/>
            </a:lvl8pPr>
            <a:lvl9pPr marL="2742929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329-C026-0E49-896F-5899BD239D7B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6B1C-38E0-004B-96AF-3A8D497C6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54633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329-C026-0E49-896F-5899BD239D7B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6B1C-38E0-004B-96AF-3A8D497C6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5794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329-C026-0E49-896F-5899BD239D7B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6B1C-38E0-004B-96AF-3A8D497C6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2975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66" indent="0">
              <a:buNone/>
              <a:defRPr sz="1050"/>
            </a:lvl2pPr>
            <a:lvl3pPr marL="685732" indent="0">
              <a:buNone/>
              <a:defRPr sz="900"/>
            </a:lvl3pPr>
            <a:lvl4pPr marL="1028599" indent="0">
              <a:buNone/>
              <a:defRPr sz="750"/>
            </a:lvl4pPr>
            <a:lvl5pPr marL="1371464" indent="0">
              <a:buNone/>
              <a:defRPr sz="750"/>
            </a:lvl5pPr>
            <a:lvl6pPr marL="1714331" indent="0">
              <a:buNone/>
              <a:defRPr sz="750"/>
            </a:lvl6pPr>
            <a:lvl7pPr marL="2057197" indent="0">
              <a:buNone/>
              <a:defRPr sz="750"/>
            </a:lvl7pPr>
            <a:lvl8pPr marL="2400063" indent="0">
              <a:buNone/>
              <a:defRPr sz="750"/>
            </a:lvl8pPr>
            <a:lvl9pPr marL="2742929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329-C026-0E49-896F-5899BD239D7B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6B1C-38E0-004B-96AF-3A8D497C6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131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66" indent="0">
              <a:buNone/>
              <a:defRPr sz="2100"/>
            </a:lvl2pPr>
            <a:lvl3pPr marL="685732" indent="0">
              <a:buNone/>
              <a:defRPr sz="1800"/>
            </a:lvl3pPr>
            <a:lvl4pPr marL="1028599" indent="0">
              <a:buNone/>
              <a:defRPr sz="1500"/>
            </a:lvl4pPr>
            <a:lvl5pPr marL="1371464" indent="0">
              <a:buNone/>
              <a:defRPr sz="1500"/>
            </a:lvl5pPr>
            <a:lvl6pPr marL="1714331" indent="0">
              <a:buNone/>
              <a:defRPr sz="1500"/>
            </a:lvl6pPr>
            <a:lvl7pPr marL="2057197" indent="0">
              <a:buNone/>
              <a:defRPr sz="1500"/>
            </a:lvl7pPr>
            <a:lvl8pPr marL="2400063" indent="0">
              <a:buNone/>
              <a:defRPr sz="1500"/>
            </a:lvl8pPr>
            <a:lvl9pPr marL="2742929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66" indent="0">
              <a:buNone/>
              <a:defRPr sz="1050"/>
            </a:lvl2pPr>
            <a:lvl3pPr marL="685732" indent="0">
              <a:buNone/>
              <a:defRPr sz="900"/>
            </a:lvl3pPr>
            <a:lvl4pPr marL="1028599" indent="0">
              <a:buNone/>
              <a:defRPr sz="750"/>
            </a:lvl4pPr>
            <a:lvl5pPr marL="1371464" indent="0">
              <a:buNone/>
              <a:defRPr sz="750"/>
            </a:lvl5pPr>
            <a:lvl6pPr marL="1714331" indent="0">
              <a:buNone/>
              <a:defRPr sz="750"/>
            </a:lvl6pPr>
            <a:lvl7pPr marL="2057197" indent="0">
              <a:buNone/>
              <a:defRPr sz="750"/>
            </a:lvl7pPr>
            <a:lvl8pPr marL="2400063" indent="0">
              <a:buNone/>
              <a:defRPr sz="750"/>
            </a:lvl8pPr>
            <a:lvl9pPr marL="2742929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329-C026-0E49-896F-5899BD239D7B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6B1C-38E0-004B-96AF-3A8D497C6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12198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292329-C026-0E49-896F-5899BD239D7B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B06B1C-38E0-004B-96AF-3A8D497C6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3653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3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3" indent="-171433" algn="l" defTabSz="68573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299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66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32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898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764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30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496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362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66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32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599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464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31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197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063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929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9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8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8.svg"/><Relationship Id="rId5" Type="http://schemas.openxmlformats.org/officeDocument/2006/relationships/image" Target="../media/image4.jpeg"/><Relationship Id="rId4" Type="http://schemas.openxmlformats.org/officeDocument/2006/relationships/image" Target="../media/image3.png"/><Relationship Id="rId9" Type="http://schemas.openxmlformats.org/officeDocument/2006/relationships/image" Target="../media/image7.png"/><Relationship Id="rId14" Type="http://schemas.microsoft.com/office/2018/10/relationships/comments" Target="../comments/modernComment_101_B587871D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18/10/relationships/comments" Target="../comments/modernComment_10B_7350BF2.xml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ko-KR" dirty="0"/>
              <a:t>Supplementary Figure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03486888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A7417203-7FEA-101A-9AF2-76020EFC7F9D}"/>
              </a:ext>
            </a:extLst>
          </p:cNvPr>
          <p:cNvSpPr txBox="1"/>
          <p:nvPr/>
        </p:nvSpPr>
        <p:spPr>
          <a:xfrm>
            <a:off x="1" y="28528"/>
            <a:ext cx="685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Supple Fig. S9</a:t>
            </a:r>
            <a:r>
              <a:rPr lang="en-US" altLang="ko-KR" sz="1400" dirty="0"/>
              <a:t>. </a:t>
            </a:r>
            <a:r>
              <a:rPr lang="en-US" altLang="ko-KR" sz="1400" dirty="0">
                <a:effectLst/>
                <a:cs typeface="Times New Roman" panose="02020603050405020304" pitchFamily="18" charset="0"/>
              </a:rPr>
              <a:t>Violin plot of Z score according to </a:t>
            </a:r>
            <a:r>
              <a:rPr lang="en-US" altLang="ko-KR" sz="1400" dirty="0">
                <a:cs typeface="Times New Roman" panose="02020603050405020304" pitchFamily="18" charset="0"/>
              </a:rPr>
              <a:t>individual</a:t>
            </a:r>
            <a:r>
              <a:rPr lang="en-US" altLang="ko-KR" sz="1400" dirty="0">
                <a:effectLst/>
                <a:cs typeface="Times New Roman" panose="02020603050405020304" pitchFamily="18" charset="0"/>
              </a:rPr>
              <a:t> parameter </a:t>
            </a:r>
            <a:r>
              <a:rPr lang="en-US" altLang="ko-KR" sz="1400" dirty="0" smtClean="0">
                <a:effectLst/>
                <a:cs typeface="Times New Roman" panose="02020603050405020304" pitchFamily="18" charset="0"/>
              </a:rPr>
              <a:t>analyses. </a:t>
            </a:r>
            <a:endParaRPr lang="ko-KR" altLang="en-US" sz="1400" dirty="0"/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id="{13AA1791-5F5D-77C9-17BF-0F2EC50F20AD}"/>
              </a:ext>
            </a:extLst>
          </p:cNvPr>
          <p:cNvGrpSpPr/>
          <p:nvPr/>
        </p:nvGrpSpPr>
        <p:grpSpPr>
          <a:xfrm>
            <a:off x="147237" y="1008248"/>
            <a:ext cx="6878668" cy="4050885"/>
            <a:chOff x="-1977495" y="1442772"/>
            <a:chExt cx="6529143" cy="4050885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9FD8D7F7-0823-0BD5-4A14-252B209520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6850" b="5124"/>
            <a:stretch/>
          </p:blipFill>
          <p:spPr>
            <a:xfrm>
              <a:off x="-1977495" y="1442772"/>
              <a:ext cx="6529143" cy="3780000"/>
            </a:xfrm>
            <a:prstGeom prst="rect">
              <a:avLst/>
            </a:prstGeom>
          </p:spPr>
        </p:pic>
        <p:grpSp>
          <p:nvGrpSpPr>
            <p:cNvPr id="5" name="그룹 4">
              <a:extLst>
                <a:ext uri="{FF2B5EF4-FFF2-40B4-BE49-F238E27FC236}">
                  <a16:creationId xmlns:a16="http://schemas.microsoft.com/office/drawing/2014/main" id="{8EF257C2-41E8-9DBD-CC9A-C4917CD58078}"/>
                </a:ext>
              </a:extLst>
            </p:cNvPr>
            <p:cNvGrpSpPr/>
            <p:nvPr/>
          </p:nvGrpSpPr>
          <p:grpSpPr>
            <a:xfrm>
              <a:off x="-1093742" y="5183269"/>
              <a:ext cx="3600666" cy="310388"/>
              <a:chOff x="-1745893" y="769219"/>
              <a:chExt cx="4197011" cy="310388"/>
            </a:xfrm>
          </p:grpSpPr>
          <p:sp>
            <p:nvSpPr>
              <p:cNvPr id="13" name="직사각형 12">
                <a:extLst>
                  <a:ext uri="{FF2B5EF4-FFF2-40B4-BE49-F238E27FC236}">
                    <a16:creationId xmlns:a16="http://schemas.microsoft.com/office/drawing/2014/main" id="{035F2D38-0CEB-68DA-C5FE-8F5809D8484C}"/>
                  </a:ext>
                </a:extLst>
              </p:cNvPr>
              <p:cNvSpPr/>
              <p:nvPr/>
            </p:nvSpPr>
            <p:spPr>
              <a:xfrm>
                <a:off x="-1745893" y="771830"/>
                <a:ext cx="908471" cy="30777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100" b="1" dirty="0">
                    <a:solidFill>
                      <a:schemeClr val="tx1"/>
                    </a:solidFill>
                    <a:latin typeface="+mn-ea"/>
                  </a:rPr>
                  <a:t>AUC</a:t>
                </a:r>
              </a:p>
            </p:txBody>
          </p:sp>
          <p:sp>
            <p:nvSpPr>
              <p:cNvPr id="14" name="직사각형 13">
                <a:extLst>
                  <a:ext uri="{FF2B5EF4-FFF2-40B4-BE49-F238E27FC236}">
                    <a16:creationId xmlns:a16="http://schemas.microsoft.com/office/drawing/2014/main" id="{C0746B32-A649-BC62-1184-F20EFEE01A8A}"/>
                  </a:ext>
                </a:extLst>
              </p:cNvPr>
              <p:cNvSpPr/>
              <p:nvPr/>
            </p:nvSpPr>
            <p:spPr>
              <a:xfrm>
                <a:off x="-179375" y="769219"/>
                <a:ext cx="908471" cy="30777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100" b="1" dirty="0">
                    <a:solidFill>
                      <a:schemeClr val="tx1"/>
                    </a:solidFill>
                    <a:latin typeface="+mn-ea"/>
                  </a:rPr>
                  <a:t>TNM</a:t>
                </a:r>
              </a:p>
            </p:txBody>
          </p:sp>
          <p:sp>
            <p:nvSpPr>
              <p:cNvPr id="15" name="직사각형 14">
                <a:extLst>
                  <a:ext uri="{FF2B5EF4-FFF2-40B4-BE49-F238E27FC236}">
                    <a16:creationId xmlns:a16="http://schemas.microsoft.com/office/drawing/2014/main" id="{A106CEDF-5A08-A831-8D46-BC8B435759E5}"/>
                  </a:ext>
                </a:extLst>
              </p:cNvPr>
              <p:cNvSpPr/>
              <p:nvPr/>
            </p:nvSpPr>
            <p:spPr>
              <a:xfrm>
                <a:off x="1227398" y="770343"/>
                <a:ext cx="1223720" cy="30665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100" b="1" dirty="0">
                    <a:solidFill>
                      <a:schemeClr val="tx1"/>
                    </a:solidFill>
                    <a:latin typeface="+mn-ea"/>
                  </a:rPr>
                  <a:t>Growth Rate</a:t>
                </a:r>
              </a:p>
            </p:txBody>
          </p:sp>
        </p:grpSp>
      </p:grpSp>
      <p:sp>
        <p:nvSpPr>
          <p:cNvPr id="17" name="직사각형 16">
            <a:extLst>
              <a:ext uri="{FF2B5EF4-FFF2-40B4-BE49-F238E27FC236}">
                <a16:creationId xmlns:a16="http://schemas.microsoft.com/office/drawing/2014/main" id="{7A202477-21A2-16E0-136B-B50431C0CBE3}"/>
              </a:ext>
            </a:extLst>
          </p:cNvPr>
          <p:cNvSpPr/>
          <p:nvPr/>
        </p:nvSpPr>
        <p:spPr>
          <a:xfrm>
            <a:off x="712876" y="598144"/>
            <a:ext cx="3960000" cy="310261"/>
          </a:xfrm>
          <a:prstGeom prst="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200" b="1" dirty="0">
                <a:solidFill>
                  <a:schemeClr val="bg1"/>
                </a:solidFill>
                <a:latin typeface="+mn-ea"/>
              </a:rPr>
              <a:t>Single Parameter </a:t>
            </a: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7DEDD181-CE98-F516-F1E3-C8C78B350CC7}"/>
              </a:ext>
            </a:extLst>
          </p:cNvPr>
          <p:cNvSpPr/>
          <p:nvPr/>
        </p:nvSpPr>
        <p:spPr>
          <a:xfrm>
            <a:off x="4919999" y="600628"/>
            <a:ext cx="1470490" cy="307777"/>
          </a:xfrm>
          <a:prstGeom prst="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200" b="1" dirty="0">
                <a:latin typeface="+mn-ea"/>
              </a:rPr>
              <a:t>Multi Parameter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383FE34-403A-EF48-A89C-269EDBD8EC15}"/>
              </a:ext>
            </a:extLst>
          </p:cNvPr>
          <p:cNvSpPr txBox="1"/>
          <p:nvPr/>
        </p:nvSpPr>
        <p:spPr>
          <a:xfrm>
            <a:off x="4672876" y="4407267"/>
            <a:ext cx="2129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/>
              <a:t>Red dot : </a:t>
            </a:r>
            <a:r>
              <a:rPr lang="en-US" altLang="ko-KR" sz="1000" b="1" dirty="0" smtClean="0"/>
              <a:t>Clinical Recurrence</a:t>
            </a:r>
            <a:endParaRPr lang="ko-KR" altLang="en-US" sz="1000" b="1" dirty="0"/>
          </a:p>
        </p:txBody>
      </p:sp>
      <p:sp>
        <p:nvSpPr>
          <p:cNvPr id="19" name="직사각형 18">
            <a:extLst>
              <a:ext uri="{FF2B5EF4-FFF2-40B4-BE49-F238E27FC236}">
                <a16:creationId xmlns:a16="http://schemas.microsoft.com/office/drawing/2014/main" id="{C0746B32-A649-BC62-1184-F20EFEE01A8A}"/>
              </a:ext>
            </a:extLst>
          </p:cNvPr>
          <p:cNvSpPr/>
          <p:nvPr/>
        </p:nvSpPr>
        <p:spPr>
          <a:xfrm>
            <a:off x="5262305" y="4751356"/>
            <a:ext cx="821111" cy="30777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b="1" dirty="0" smtClean="0">
                <a:solidFill>
                  <a:schemeClr val="tx1"/>
                </a:solidFill>
                <a:latin typeface="+mn-ea"/>
              </a:rPr>
              <a:t>MPI</a:t>
            </a:r>
            <a:endParaRPr lang="en-US" altLang="ko-KR" sz="1100" b="1" dirty="0">
              <a:solidFill>
                <a:schemeClr val="tx1"/>
              </a:solidFill>
              <a:latin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20395444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TextBox 125"/>
          <p:cNvSpPr txBox="1"/>
          <p:nvPr/>
        </p:nvSpPr>
        <p:spPr>
          <a:xfrm>
            <a:off x="0" y="28528"/>
            <a:ext cx="6858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Supple Fig. S1</a:t>
            </a:r>
            <a:r>
              <a:rPr lang="en-US" altLang="ko-KR" sz="1400" dirty="0"/>
              <a:t>. Live action images of cure-GA system.  Cure-GA platform comprises tissue sampling, tissue dissociation, cell-</a:t>
            </a:r>
            <a:r>
              <a:rPr lang="en-US" altLang="ko-KR" sz="1400" dirty="0" err="1"/>
              <a:t>Materigel</a:t>
            </a:r>
            <a:r>
              <a:rPr lang="en-US" altLang="ko-KR" sz="1400" dirty="0"/>
              <a:t> mixture printing in </a:t>
            </a:r>
            <a:r>
              <a:rPr lang="en-US" altLang="ko-KR" sz="1400" dirty="0" err="1"/>
              <a:t>micropillar</a:t>
            </a:r>
            <a:r>
              <a:rPr lang="en-US" altLang="ko-KR" sz="1400" dirty="0"/>
              <a:t>, cell stabilization, drug treatment and cell viability measurement.</a:t>
            </a:r>
            <a:endParaRPr lang="ko-KR" altLang="en-US" sz="1400" dirty="0"/>
          </a:p>
        </p:txBody>
      </p:sp>
      <p:grpSp>
        <p:nvGrpSpPr>
          <p:cNvPr id="257" name="그룹 256"/>
          <p:cNvGrpSpPr/>
          <p:nvPr/>
        </p:nvGrpSpPr>
        <p:grpSpPr>
          <a:xfrm>
            <a:off x="438402" y="1180517"/>
            <a:ext cx="5886198" cy="5638280"/>
            <a:chOff x="438402" y="1180517"/>
            <a:chExt cx="5886198" cy="5638280"/>
          </a:xfrm>
        </p:grpSpPr>
        <p:pic>
          <p:nvPicPr>
            <p:cNvPr id="24" name="그림 2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8402" y="1588969"/>
              <a:ext cx="5886198" cy="1908214"/>
            </a:xfrm>
            <a:prstGeom prst="rect">
              <a:avLst/>
            </a:prstGeom>
          </p:spPr>
        </p:pic>
        <p:pic>
          <p:nvPicPr>
            <p:cNvPr id="118" name="그림 117"/>
            <p:cNvPicPr>
              <a:picLocks noChangeAspect="1"/>
            </p:cNvPicPr>
            <p:nvPr/>
          </p:nvPicPr>
          <p:blipFill rotWithShape="1">
            <a:blip r:embed="rId3"/>
            <a:srcRect r="21856"/>
            <a:stretch/>
          </p:blipFill>
          <p:spPr>
            <a:xfrm>
              <a:off x="438402" y="3846739"/>
              <a:ext cx="5807403" cy="2972058"/>
            </a:xfrm>
            <a:prstGeom prst="rect">
              <a:avLst/>
            </a:prstGeom>
          </p:spPr>
        </p:pic>
        <p:pic>
          <p:nvPicPr>
            <p:cNvPr id="125" name="그림 12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38402" y="1180517"/>
              <a:ext cx="5886198" cy="440718"/>
            </a:xfrm>
            <a:prstGeom prst="rect">
              <a:avLst/>
            </a:prstGeom>
          </p:spPr>
        </p:pic>
        <p:grpSp>
          <p:nvGrpSpPr>
            <p:cNvPr id="256" name="그룹 255">
              <a:extLst>
                <a:ext uri="{FF2B5EF4-FFF2-40B4-BE49-F238E27FC236}">
                  <a16:creationId xmlns:a16="http://schemas.microsoft.com/office/drawing/2014/main" id="{373DA886-0AF3-29A0-8D9F-0C06EB4B9B8B}"/>
                </a:ext>
              </a:extLst>
            </p:cNvPr>
            <p:cNvGrpSpPr/>
            <p:nvPr/>
          </p:nvGrpSpPr>
          <p:grpSpPr>
            <a:xfrm>
              <a:off x="477002" y="4398421"/>
              <a:ext cx="1838869" cy="2241727"/>
              <a:chOff x="522161" y="7352367"/>
              <a:chExt cx="1907654" cy="2387467"/>
            </a:xfrm>
          </p:grpSpPr>
          <p:grpSp>
            <p:nvGrpSpPr>
              <p:cNvPr id="2" name="그룹 1">
                <a:extLst>
                  <a:ext uri="{FF2B5EF4-FFF2-40B4-BE49-F238E27FC236}">
                    <a16:creationId xmlns:a16="http://schemas.microsoft.com/office/drawing/2014/main" id="{5D43396C-1503-DA7E-0C52-5DD0BAB6987F}"/>
                  </a:ext>
                </a:extLst>
              </p:cNvPr>
              <p:cNvGrpSpPr/>
              <p:nvPr/>
            </p:nvGrpSpPr>
            <p:grpSpPr>
              <a:xfrm>
                <a:off x="522161" y="7352367"/>
                <a:ext cx="1907654" cy="2387467"/>
                <a:chOff x="2366608" y="764556"/>
                <a:chExt cx="4492051" cy="4926294"/>
              </a:xfrm>
            </p:grpSpPr>
            <p:grpSp>
              <p:nvGrpSpPr>
                <p:cNvPr id="3" name="그룹 2">
                  <a:extLst>
                    <a:ext uri="{FF2B5EF4-FFF2-40B4-BE49-F238E27FC236}">
                      <a16:creationId xmlns:a16="http://schemas.microsoft.com/office/drawing/2014/main" id="{AC97328B-5B02-C2C0-6954-242AF3A5DFE3}"/>
                    </a:ext>
                  </a:extLst>
                </p:cNvPr>
                <p:cNvGrpSpPr/>
                <p:nvPr/>
              </p:nvGrpSpPr>
              <p:grpSpPr>
                <a:xfrm>
                  <a:off x="2366608" y="764556"/>
                  <a:ext cx="4492051" cy="4926294"/>
                  <a:chOff x="35003" y="438714"/>
                  <a:chExt cx="6383154" cy="6973845"/>
                </a:xfrm>
              </p:grpSpPr>
              <p:sp>
                <p:nvSpPr>
                  <p:cNvPr id="5" name="직사각형 4">
                    <a:extLst>
                      <a:ext uri="{FF2B5EF4-FFF2-40B4-BE49-F238E27FC236}">
                        <a16:creationId xmlns:a16="http://schemas.microsoft.com/office/drawing/2014/main" id="{DC8B1C24-7091-63C4-5199-E0291D46D65A}"/>
                      </a:ext>
                    </a:extLst>
                  </p:cNvPr>
                  <p:cNvSpPr/>
                  <p:nvPr/>
                </p:nvSpPr>
                <p:spPr>
                  <a:xfrm>
                    <a:off x="440171" y="443836"/>
                    <a:ext cx="5977984" cy="6968723"/>
                  </a:xfrm>
                  <a:prstGeom prst="rect">
                    <a:avLst/>
                  </a:prstGeom>
                  <a:gradFill>
                    <a:gsLst>
                      <a:gs pos="23000">
                        <a:schemeClr val="bg1"/>
                      </a:gs>
                      <a:gs pos="74000">
                        <a:schemeClr val="bg1">
                          <a:lumMod val="85000"/>
                        </a:schemeClr>
                      </a:gs>
                    </a:gsLst>
                    <a:lin ang="5400000" scaled="1"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/>
                  </a:p>
                </p:txBody>
              </p:sp>
              <p:sp>
                <p:nvSpPr>
                  <p:cNvPr id="6" name="직사각형 5">
                    <a:extLst>
                      <a:ext uri="{FF2B5EF4-FFF2-40B4-BE49-F238E27FC236}">
                        <a16:creationId xmlns:a16="http://schemas.microsoft.com/office/drawing/2014/main" id="{5B8380D8-86B6-C354-D5F7-82257F76E6AA}"/>
                      </a:ext>
                    </a:extLst>
                  </p:cNvPr>
                  <p:cNvSpPr/>
                  <p:nvPr/>
                </p:nvSpPr>
                <p:spPr>
                  <a:xfrm>
                    <a:off x="359026" y="5279912"/>
                    <a:ext cx="6059131" cy="2037925"/>
                  </a:xfrm>
                  <a:prstGeom prst="rect">
                    <a:avLst/>
                  </a:prstGeom>
                  <a:gradFill>
                    <a:gsLst>
                      <a:gs pos="50000">
                        <a:schemeClr val="bg1"/>
                      </a:gs>
                      <a:gs pos="100000">
                        <a:schemeClr val="bg1">
                          <a:lumMod val="95000"/>
                          <a:alpha val="70000"/>
                        </a:schemeClr>
                      </a:gs>
                    </a:gsLst>
                    <a:lin ang="5400000" scaled="1"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/>
                  </a:p>
                </p:txBody>
              </p:sp>
              <p:grpSp>
                <p:nvGrpSpPr>
                  <p:cNvPr id="7" name="그룹 6">
                    <a:extLst>
                      <a:ext uri="{FF2B5EF4-FFF2-40B4-BE49-F238E27FC236}">
                        <a16:creationId xmlns:a16="http://schemas.microsoft.com/office/drawing/2014/main" id="{2764D507-DD53-158A-6437-1A321C319B60}"/>
                      </a:ext>
                    </a:extLst>
                  </p:cNvPr>
                  <p:cNvGrpSpPr/>
                  <p:nvPr/>
                </p:nvGrpSpPr>
                <p:grpSpPr>
                  <a:xfrm>
                    <a:off x="3733630" y="6107771"/>
                    <a:ext cx="934037" cy="1140476"/>
                    <a:chOff x="5284141" y="7108983"/>
                    <a:chExt cx="349659" cy="484965"/>
                  </a:xfrm>
                  <a:gradFill>
                    <a:gsLst>
                      <a:gs pos="100000">
                        <a:schemeClr val="bg1">
                          <a:lumMod val="95000"/>
                        </a:schemeClr>
                      </a:gs>
                      <a:gs pos="0">
                        <a:schemeClr val="accent1">
                          <a:lumMod val="5000"/>
                          <a:lumOff val="95000"/>
                        </a:schemeClr>
                      </a:gs>
                      <a:gs pos="95000">
                        <a:schemeClr val="bg1">
                          <a:lumMod val="75000"/>
                        </a:schemeClr>
                      </a:gs>
                    </a:gsLst>
                    <a:lin ang="5400000" scaled="1"/>
                  </a:gradFill>
                </p:grpSpPr>
                <p:sp>
                  <p:nvSpPr>
                    <p:cNvPr id="253" name="사각형: 둥근 모서리 252">
                      <a:extLst>
                        <a:ext uri="{FF2B5EF4-FFF2-40B4-BE49-F238E27FC236}">
                          <a16:creationId xmlns:a16="http://schemas.microsoft.com/office/drawing/2014/main" id="{E0D10CC5-09C1-7A65-7987-4E7B0D8EA75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284141" y="7108983"/>
                      <a:ext cx="349659" cy="484965"/>
                    </a:xfrm>
                    <a:prstGeom prst="roundRect">
                      <a:avLst/>
                    </a:prstGeom>
                    <a:grpFill/>
                    <a:ln>
                      <a:solidFill>
                        <a:schemeClr val="bg1">
                          <a:lumMod val="75000"/>
                        </a:schemeClr>
                      </a:solidFill>
                    </a:ln>
                    <a:scene3d>
                      <a:camera prst="orthographicFront"/>
                      <a:lightRig rig="threePt" dir="t"/>
                    </a:scene3d>
                    <a:sp3d>
                      <a:bevelT/>
                    </a:sp3d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400" b="1">
                        <a:latin typeface="+mn-ea"/>
                      </a:endParaRPr>
                    </a:p>
                  </p:txBody>
                </p:sp>
                <p:sp>
                  <p:nvSpPr>
                    <p:cNvPr id="254" name="자유형: 도형 253">
                      <a:extLst>
                        <a:ext uri="{FF2B5EF4-FFF2-40B4-BE49-F238E27FC236}">
                          <a16:creationId xmlns:a16="http://schemas.microsoft.com/office/drawing/2014/main" id="{45848213-D435-640A-E318-CEA0351D69E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294152" y="7130255"/>
                      <a:ext cx="327861" cy="31875"/>
                    </a:xfrm>
                    <a:custGeom>
                      <a:avLst/>
                      <a:gdLst>
                        <a:gd name="connsiteX0" fmla="*/ 0 w 339725"/>
                        <a:gd name="connsiteY0" fmla="*/ 6367 h 6367"/>
                        <a:gd name="connsiteX1" fmla="*/ 76200 w 339725"/>
                        <a:gd name="connsiteY1" fmla="*/ 17 h 6367"/>
                        <a:gd name="connsiteX2" fmla="*/ 339725 w 339725"/>
                        <a:gd name="connsiteY2" fmla="*/ 3192 h 6367"/>
                        <a:gd name="connsiteX0" fmla="*/ 0 w 10000"/>
                        <a:gd name="connsiteY0" fmla="*/ 5057 h 25075"/>
                        <a:gd name="connsiteX1" fmla="*/ 5421 w 10000"/>
                        <a:gd name="connsiteY1" fmla="*/ 25004 h 25075"/>
                        <a:gd name="connsiteX2" fmla="*/ 10000 w 10000"/>
                        <a:gd name="connsiteY2" fmla="*/ 70 h 25075"/>
                        <a:gd name="connsiteX0" fmla="*/ 0 w 10000"/>
                        <a:gd name="connsiteY0" fmla="*/ 5057 h 25428"/>
                        <a:gd name="connsiteX1" fmla="*/ 2804 w 10000"/>
                        <a:gd name="connsiteY1" fmla="*/ 15029 h 25428"/>
                        <a:gd name="connsiteX2" fmla="*/ 5421 w 10000"/>
                        <a:gd name="connsiteY2" fmla="*/ 25004 h 25428"/>
                        <a:gd name="connsiteX3" fmla="*/ 10000 w 10000"/>
                        <a:gd name="connsiteY3" fmla="*/ 70 h 25428"/>
                        <a:gd name="connsiteX0" fmla="*/ 0 w 10000"/>
                        <a:gd name="connsiteY0" fmla="*/ 5057 h 25430"/>
                        <a:gd name="connsiteX1" fmla="*/ 2804 w 10000"/>
                        <a:gd name="connsiteY1" fmla="*/ 15029 h 25430"/>
                        <a:gd name="connsiteX2" fmla="*/ 5421 w 10000"/>
                        <a:gd name="connsiteY2" fmla="*/ 25004 h 25430"/>
                        <a:gd name="connsiteX3" fmla="*/ 10000 w 10000"/>
                        <a:gd name="connsiteY3" fmla="*/ 70 h 25430"/>
                        <a:gd name="connsiteX0" fmla="*/ 0 w 10000"/>
                        <a:gd name="connsiteY0" fmla="*/ 5057 h 35605"/>
                        <a:gd name="connsiteX1" fmla="*/ 2711 w 10000"/>
                        <a:gd name="connsiteY1" fmla="*/ 34976 h 35605"/>
                        <a:gd name="connsiteX2" fmla="*/ 5421 w 10000"/>
                        <a:gd name="connsiteY2" fmla="*/ 25004 h 35605"/>
                        <a:gd name="connsiteX3" fmla="*/ 10000 w 10000"/>
                        <a:gd name="connsiteY3" fmla="*/ 70 h 35605"/>
                        <a:gd name="connsiteX0" fmla="*/ 0 w 9860"/>
                        <a:gd name="connsiteY0" fmla="*/ 0 h 66218"/>
                        <a:gd name="connsiteX1" fmla="*/ 2571 w 9860"/>
                        <a:gd name="connsiteY1" fmla="*/ 63579 h 66218"/>
                        <a:gd name="connsiteX2" fmla="*/ 5281 w 9860"/>
                        <a:gd name="connsiteY2" fmla="*/ 53607 h 66218"/>
                        <a:gd name="connsiteX3" fmla="*/ 9860 w 9860"/>
                        <a:gd name="connsiteY3" fmla="*/ 28673 h 66218"/>
                        <a:gd name="connsiteX0" fmla="*/ 0 w 10000"/>
                        <a:gd name="connsiteY0" fmla="*/ 0 h 9766"/>
                        <a:gd name="connsiteX1" fmla="*/ 1067 w 10000"/>
                        <a:gd name="connsiteY1" fmla="*/ 3765 h 9766"/>
                        <a:gd name="connsiteX2" fmla="*/ 2608 w 10000"/>
                        <a:gd name="connsiteY2" fmla="*/ 9601 h 9766"/>
                        <a:gd name="connsiteX3" fmla="*/ 5356 w 10000"/>
                        <a:gd name="connsiteY3" fmla="*/ 8096 h 9766"/>
                        <a:gd name="connsiteX4" fmla="*/ 10000 w 10000"/>
                        <a:gd name="connsiteY4" fmla="*/ 4330 h 9766"/>
                        <a:gd name="connsiteX0" fmla="*/ 0 w 10000"/>
                        <a:gd name="connsiteY0" fmla="*/ 0 h 8349"/>
                        <a:gd name="connsiteX1" fmla="*/ 1067 w 10000"/>
                        <a:gd name="connsiteY1" fmla="*/ 3855 h 8349"/>
                        <a:gd name="connsiteX2" fmla="*/ 2821 w 10000"/>
                        <a:gd name="connsiteY2" fmla="*/ 6361 h 8349"/>
                        <a:gd name="connsiteX3" fmla="*/ 5356 w 10000"/>
                        <a:gd name="connsiteY3" fmla="*/ 8290 h 8349"/>
                        <a:gd name="connsiteX4" fmla="*/ 10000 w 10000"/>
                        <a:gd name="connsiteY4" fmla="*/ 4434 h 8349"/>
                        <a:gd name="connsiteX0" fmla="*/ 0 w 10000"/>
                        <a:gd name="connsiteY0" fmla="*/ 0 h 8123"/>
                        <a:gd name="connsiteX1" fmla="*/ 1067 w 10000"/>
                        <a:gd name="connsiteY1" fmla="*/ 4617 h 8123"/>
                        <a:gd name="connsiteX2" fmla="*/ 2821 w 10000"/>
                        <a:gd name="connsiteY2" fmla="*/ 7619 h 8123"/>
                        <a:gd name="connsiteX3" fmla="*/ 5427 w 10000"/>
                        <a:gd name="connsiteY3" fmla="*/ 7851 h 8123"/>
                        <a:gd name="connsiteX4" fmla="*/ 10000 w 10000"/>
                        <a:gd name="connsiteY4" fmla="*/ 5311 h 8123"/>
                        <a:gd name="connsiteX0" fmla="*/ 0 w 10000"/>
                        <a:gd name="connsiteY0" fmla="*/ 0 h 9691"/>
                        <a:gd name="connsiteX1" fmla="*/ 1067 w 10000"/>
                        <a:gd name="connsiteY1" fmla="*/ 5684 h 9691"/>
                        <a:gd name="connsiteX2" fmla="*/ 2821 w 10000"/>
                        <a:gd name="connsiteY2" fmla="*/ 9380 h 9691"/>
                        <a:gd name="connsiteX3" fmla="*/ 5427 w 10000"/>
                        <a:gd name="connsiteY3" fmla="*/ 9665 h 9691"/>
                        <a:gd name="connsiteX4" fmla="*/ 10000 w 10000"/>
                        <a:gd name="connsiteY4" fmla="*/ 6538 h 9691"/>
                        <a:gd name="connsiteX0" fmla="*/ 0 w 10000"/>
                        <a:gd name="connsiteY0" fmla="*/ 0 h 10726"/>
                        <a:gd name="connsiteX1" fmla="*/ 1067 w 10000"/>
                        <a:gd name="connsiteY1" fmla="*/ 5865 h 10726"/>
                        <a:gd name="connsiteX2" fmla="*/ 2821 w 10000"/>
                        <a:gd name="connsiteY2" fmla="*/ 9679 h 10726"/>
                        <a:gd name="connsiteX3" fmla="*/ 5427 w 10000"/>
                        <a:gd name="connsiteY3" fmla="*/ 9973 h 10726"/>
                        <a:gd name="connsiteX4" fmla="*/ 10000 w 10000"/>
                        <a:gd name="connsiteY4" fmla="*/ 586 h 10726"/>
                        <a:gd name="connsiteX0" fmla="*/ 0 w 10000"/>
                        <a:gd name="connsiteY0" fmla="*/ 0 h 10597"/>
                        <a:gd name="connsiteX1" fmla="*/ 1067 w 10000"/>
                        <a:gd name="connsiteY1" fmla="*/ 5865 h 10597"/>
                        <a:gd name="connsiteX2" fmla="*/ 2821 w 10000"/>
                        <a:gd name="connsiteY2" fmla="*/ 9679 h 10597"/>
                        <a:gd name="connsiteX3" fmla="*/ 5427 w 10000"/>
                        <a:gd name="connsiteY3" fmla="*/ 9973 h 10597"/>
                        <a:gd name="connsiteX4" fmla="*/ 7962 w 10000"/>
                        <a:gd name="connsiteY4" fmla="*/ 2346 h 10597"/>
                        <a:gd name="connsiteX5" fmla="*/ 10000 w 10000"/>
                        <a:gd name="connsiteY5" fmla="*/ 586 h 10597"/>
                        <a:gd name="connsiteX0" fmla="*/ 0 w 10000"/>
                        <a:gd name="connsiteY0" fmla="*/ 0 h 10216"/>
                        <a:gd name="connsiteX1" fmla="*/ 1067 w 10000"/>
                        <a:gd name="connsiteY1" fmla="*/ 5865 h 10216"/>
                        <a:gd name="connsiteX2" fmla="*/ 2821 w 10000"/>
                        <a:gd name="connsiteY2" fmla="*/ 9679 h 10216"/>
                        <a:gd name="connsiteX3" fmla="*/ 5427 w 10000"/>
                        <a:gd name="connsiteY3" fmla="*/ 9973 h 10216"/>
                        <a:gd name="connsiteX4" fmla="*/ 8033 w 10000"/>
                        <a:gd name="connsiteY4" fmla="*/ 7626 h 10216"/>
                        <a:gd name="connsiteX5" fmla="*/ 10000 w 10000"/>
                        <a:gd name="connsiteY5" fmla="*/ 586 h 10216"/>
                        <a:gd name="connsiteX0" fmla="*/ 0 w 10000"/>
                        <a:gd name="connsiteY0" fmla="*/ 0 h 10156"/>
                        <a:gd name="connsiteX1" fmla="*/ 1067 w 10000"/>
                        <a:gd name="connsiteY1" fmla="*/ 5865 h 10156"/>
                        <a:gd name="connsiteX2" fmla="*/ 2821 w 10000"/>
                        <a:gd name="connsiteY2" fmla="*/ 9679 h 10156"/>
                        <a:gd name="connsiteX3" fmla="*/ 5427 w 10000"/>
                        <a:gd name="connsiteY3" fmla="*/ 9973 h 10156"/>
                        <a:gd name="connsiteX4" fmla="*/ 8317 w 10000"/>
                        <a:gd name="connsiteY4" fmla="*/ 8506 h 10156"/>
                        <a:gd name="connsiteX5" fmla="*/ 10000 w 10000"/>
                        <a:gd name="connsiteY5" fmla="*/ 586 h 10156"/>
                        <a:gd name="connsiteX0" fmla="*/ 0 w 10000"/>
                        <a:gd name="connsiteY0" fmla="*/ 0 h 10340"/>
                        <a:gd name="connsiteX1" fmla="*/ 1067 w 10000"/>
                        <a:gd name="connsiteY1" fmla="*/ 5865 h 10340"/>
                        <a:gd name="connsiteX2" fmla="*/ 2821 w 10000"/>
                        <a:gd name="connsiteY2" fmla="*/ 9679 h 10340"/>
                        <a:gd name="connsiteX3" fmla="*/ 5427 w 10000"/>
                        <a:gd name="connsiteY3" fmla="*/ 9973 h 10340"/>
                        <a:gd name="connsiteX4" fmla="*/ 8246 w 10000"/>
                        <a:gd name="connsiteY4" fmla="*/ 5866 h 10340"/>
                        <a:gd name="connsiteX5" fmla="*/ 10000 w 10000"/>
                        <a:gd name="connsiteY5" fmla="*/ 586 h 10340"/>
                        <a:gd name="connsiteX0" fmla="*/ 0 w 9858"/>
                        <a:gd name="connsiteY0" fmla="*/ 2054 h 12394"/>
                        <a:gd name="connsiteX1" fmla="*/ 1067 w 9858"/>
                        <a:gd name="connsiteY1" fmla="*/ 7919 h 12394"/>
                        <a:gd name="connsiteX2" fmla="*/ 2821 w 9858"/>
                        <a:gd name="connsiteY2" fmla="*/ 11733 h 12394"/>
                        <a:gd name="connsiteX3" fmla="*/ 5427 w 9858"/>
                        <a:gd name="connsiteY3" fmla="*/ 12027 h 12394"/>
                        <a:gd name="connsiteX4" fmla="*/ 8246 w 9858"/>
                        <a:gd name="connsiteY4" fmla="*/ 7920 h 12394"/>
                        <a:gd name="connsiteX5" fmla="*/ 9858 w 9858"/>
                        <a:gd name="connsiteY5" fmla="*/ 0 h 12394"/>
                        <a:gd name="connsiteX0" fmla="*/ 0 w 9784"/>
                        <a:gd name="connsiteY0" fmla="*/ 947 h 10000"/>
                        <a:gd name="connsiteX1" fmla="*/ 866 w 9784"/>
                        <a:gd name="connsiteY1" fmla="*/ 6389 h 10000"/>
                        <a:gd name="connsiteX2" fmla="*/ 2646 w 9784"/>
                        <a:gd name="connsiteY2" fmla="*/ 9467 h 10000"/>
                        <a:gd name="connsiteX3" fmla="*/ 5289 w 9784"/>
                        <a:gd name="connsiteY3" fmla="*/ 9704 h 10000"/>
                        <a:gd name="connsiteX4" fmla="*/ 8149 w 9784"/>
                        <a:gd name="connsiteY4" fmla="*/ 6390 h 10000"/>
                        <a:gd name="connsiteX5" fmla="*/ 9784 w 9784"/>
                        <a:gd name="connsiteY5" fmla="*/ 0 h 10000"/>
                        <a:gd name="connsiteX0" fmla="*/ 0 w 10000"/>
                        <a:gd name="connsiteY0" fmla="*/ 947 h 9852"/>
                        <a:gd name="connsiteX1" fmla="*/ 885 w 10000"/>
                        <a:gd name="connsiteY1" fmla="*/ 6389 h 9852"/>
                        <a:gd name="connsiteX2" fmla="*/ 2704 w 10000"/>
                        <a:gd name="connsiteY2" fmla="*/ 9467 h 9852"/>
                        <a:gd name="connsiteX3" fmla="*/ 5406 w 10000"/>
                        <a:gd name="connsiteY3" fmla="*/ 9704 h 9852"/>
                        <a:gd name="connsiteX4" fmla="*/ 8624 w 10000"/>
                        <a:gd name="connsiteY4" fmla="*/ 8520 h 9852"/>
                        <a:gd name="connsiteX5" fmla="*/ 10000 w 10000"/>
                        <a:gd name="connsiteY5" fmla="*/ 0 h 9852"/>
                        <a:gd name="connsiteX0" fmla="*/ 0 w 10221"/>
                        <a:gd name="connsiteY0" fmla="*/ 0 h 9039"/>
                        <a:gd name="connsiteX1" fmla="*/ 885 w 10221"/>
                        <a:gd name="connsiteY1" fmla="*/ 5524 h 9039"/>
                        <a:gd name="connsiteX2" fmla="*/ 2704 w 10221"/>
                        <a:gd name="connsiteY2" fmla="*/ 8648 h 9039"/>
                        <a:gd name="connsiteX3" fmla="*/ 5406 w 10221"/>
                        <a:gd name="connsiteY3" fmla="*/ 8889 h 9039"/>
                        <a:gd name="connsiteX4" fmla="*/ 8624 w 10221"/>
                        <a:gd name="connsiteY4" fmla="*/ 7687 h 9039"/>
                        <a:gd name="connsiteX5" fmla="*/ 10221 w 10221"/>
                        <a:gd name="connsiteY5" fmla="*/ 1201 h 9039"/>
                        <a:gd name="connsiteX0" fmla="*/ 0 w 10000"/>
                        <a:gd name="connsiteY0" fmla="*/ 0 h 10110"/>
                        <a:gd name="connsiteX1" fmla="*/ 866 w 10000"/>
                        <a:gd name="connsiteY1" fmla="*/ 6111 h 10110"/>
                        <a:gd name="connsiteX2" fmla="*/ 2646 w 10000"/>
                        <a:gd name="connsiteY2" fmla="*/ 9567 h 10110"/>
                        <a:gd name="connsiteX3" fmla="*/ 5289 w 10000"/>
                        <a:gd name="connsiteY3" fmla="*/ 9834 h 10110"/>
                        <a:gd name="connsiteX4" fmla="*/ 8438 w 10000"/>
                        <a:gd name="connsiteY4" fmla="*/ 6909 h 10110"/>
                        <a:gd name="connsiteX5" fmla="*/ 10000 w 10000"/>
                        <a:gd name="connsiteY5" fmla="*/ 1329 h 10110"/>
                        <a:gd name="connsiteX0" fmla="*/ 0 w 10144"/>
                        <a:gd name="connsiteY0" fmla="*/ 1860 h 11970"/>
                        <a:gd name="connsiteX1" fmla="*/ 866 w 10144"/>
                        <a:gd name="connsiteY1" fmla="*/ 7971 h 11970"/>
                        <a:gd name="connsiteX2" fmla="*/ 2646 w 10144"/>
                        <a:gd name="connsiteY2" fmla="*/ 11427 h 11970"/>
                        <a:gd name="connsiteX3" fmla="*/ 5289 w 10144"/>
                        <a:gd name="connsiteY3" fmla="*/ 11694 h 11970"/>
                        <a:gd name="connsiteX4" fmla="*/ 8438 w 10144"/>
                        <a:gd name="connsiteY4" fmla="*/ 8769 h 11970"/>
                        <a:gd name="connsiteX5" fmla="*/ 10144 w 10144"/>
                        <a:gd name="connsiteY5" fmla="*/ 0 h 11970"/>
                        <a:gd name="connsiteX0" fmla="*/ 0 w 10000"/>
                        <a:gd name="connsiteY0" fmla="*/ 0 h 10110"/>
                        <a:gd name="connsiteX1" fmla="*/ 866 w 10000"/>
                        <a:gd name="connsiteY1" fmla="*/ 6111 h 10110"/>
                        <a:gd name="connsiteX2" fmla="*/ 2646 w 10000"/>
                        <a:gd name="connsiteY2" fmla="*/ 9567 h 10110"/>
                        <a:gd name="connsiteX3" fmla="*/ 5289 w 10000"/>
                        <a:gd name="connsiteY3" fmla="*/ 9834 h 10110"/>
                        <a:gd name="connsiteX4" fmla="*/ 8438 w 10000"/>
                        <a:gd name="connsiteY4" fmla="*/ 6909 h 10110"/>
                        <a:gd name="connsiteX5" fmla="*/ 10000 w 10000"/>
                        <a:gd name="connsiteY5" fmla="*/ 532 h 10110"/>
                        <a:gd name="connsiteX0" fmla="*/ 0 w 9784"/>
                        <a:gd name="connsiteY0" fmla="*/ 1860 h 11970"/>
                        <a:gd name="connsiteX1" fmla="*/ 866 w 9784"/>
                        <a:gd name="connsiteY1" fmla="*/ 7971 h 11970"/>
                        <a:gd name="connsiteX2" fmla="*/ 2646 w 9784"/>
                        <a:gd name="connsiteY2" fmla="*/ 11427 h 11970"/>
                        <a:gd name="connsiteX3" fmla="*/ 5289 w 9784"/>
                        <a:gd name="connsiteY3" fmla="*/ 11694 h 11970"/>
                        <a:gd name="connsiteX4" fmla="*/ 8438 w 9784"/>
                        <a:gd name="connsiteY4" fmla="*/ 8769 h 11970"/>
                        <a:gd name="connsiteX5" fmla="*/ 9784 w 9784"/>
                        <a:gd name="connsiteY5" fmla="*/ 0 h 11970"/>
                        <a:gd name="connsiteX0" fmla="*/ 0 w 10295"/>
                        <a:gd name="connsiteY0" fmla="*/ 0 h 8446"/>
                        <a:gd name="connsiteX1" fmla="*/ 885 w 10295"/>
                        <a:gd name="connsiteY1" fmla="*/ 5105 h 8446"/>
                        <a:gd name="connsiteX2" fmla="*/ 2704 w 10295"/>
                        <a:gd name="connsiteY2" fmla="*/ 7992 h 8446"/>
                        <a:gd name="connsiteX3" fmla="*/ 5406 w 10295"/>
                        <a:gd name="connsiteY3" fmla="*/ 8215 h 8446"/>
                        <a:gd name="connsiteX4" fmla="*/ 8624 w 10295"/>
                        <a:gd name="connsiteY4" fmla="*/ 5772 h 8446"/>
                        <a:gd name="connsiteX5" fmla="*/ 10295 w 10295"/>
                        <a:gd name="connsiteY5" fmla="*/ 444 h 8446"/>
                        <a:gd name="connsiteX0" fmla="*/ 0 w 10000"/>
                        <a:gd name="connsiteY0" fmla="*/ 0 h 10056"/>
                        <a:gd name="connsiteX1" fmla="*/ 860 w 10000"/>
                        <a:gd name="connsiteY1" fmla="*/ 6044 h 10056"/>
                        <a:gd name="connsiteX2" fmla="*/ 2627 w 10000"/>
                        <a:gd name="connsiteY2" fmla="*/ 9462 h 10056"/>
                        <a:gd name="connsiteX3" fmla="*/ 5251 w 10000"/>
                        <a:gd name="connsiteY3" fmla="*/ 9726 h 10056"/>
                        <a:gd name="connsiteX4" fmla="*/ 9021 w 10000"/>
                        <a:gd name="connsiteY4" fmla="*/ 6046 h 10056"/>
                        <a:gd name="connsiteX5" fmla="*/ 10000 w 10000"/>
                        <a:gd name="connsiteY5" fmla="*/ 526 h 10056"/>
                        <a:gd name="connsiteX0" fmla="*/ 0 w 10000"/>
                        <a:gd name="connsiteY0" fmla="*/ 0 h 9944"/>
                        <a:gd name="connsiteX1" fmla="*/ 860 w 10000"/>
                        <a:gd name="connsiteY1" fmla="*/ 6044 h 9944"/>
                        <a:gd name="connsiteX2" fmla="*/ 2627 w 10000"/>
                        <a:gd name="connsiteY2" fmla="*/ 9462 h 9944"/>
                        <a:gd name="connsiteX3" fmla="*/ 5251 w 10000"/>
                        <a:gd name="connsiteY3" fmla="*/ 9726 h 9944"/>
                        <a:gd name="connsiteX4" fmla="*/ 6925 w 10000"/>
                        <a:gd name="connsiteY4" fmla="*/ 7623 h 9944"/>
                        <a:gd name="connsiteX5" fmla="*/ 9021 w 10000"/>
                        <a:gd name="connsiteY5" fmla="*/ 6046 h 9944"/>
                        <a:gd name="connsiteX6" fmla="*/ 10000 w 10000"/>
                        <a:gd name="connsiteY6" fmla="*/ 526 h 9944"/>
                        <a:gd name="connsiteX0" fmla="*/ 0 w 10000"/>
                        <a:gd name="connsiteY0" fmla="*/ 0 h 10277"/>
                        <a:gd name="connsiteX1" fmla="*/ 860 w 10000"/>
                        <a:gd name="connsiteY1" fmla="*/ 6078 h 10277"/>
                        <a:gd name="connsiteX2" fmla="*/ 2627 w 10000"/>
                        <a:gd name="connsiteY2" fmla="*/ 9515 h 10277"/>
                        <a:gd name="connsiteX3" fmla="*/ 5251 w 10000"/>
                        <a:gd name="connsiteY3" fmla="*/ 9781 h 10277"/>
                        <a:gd name="connsiteX4" fmla="*/ 7355 w 10000"/>
                        <a:gd name="connsiteY4" fmla="*/ 10045 h 10277"/>
                        <a:gd name="connsiteX5" fmla="*/ 9021 w 10000"/>
                        <a:gd name="connsiteY5" fmla="*/ 6080 h 10277"/>
                        <a:gd name="connsiteX6" fmla="*/ 10000 w 10000"/>
                        <a:gd name="connsiteY6" fmla="*/ 529 h 10277"/>
                        <a:gd name="connsiteX0" fmla="*/ 0 w 10000"/>
                        <a:gd name="connsiteY0" fmla="*/ 0 h 10615"/>
                        <a:gd name="connsiteX1" fmla="*/ 860 w 10000"/>
                        <a:gd name="connsiteY1" fmla="*/ 6078 h 10615"/>
                        <a:gd name="connsiteX2" fmla="*/ 2627 w 10000"/>
                        <a:gd name="connsiteY2" fmla="*/ 9515 h 10615"/>
                        <a:gd name="connsiteX3" fmla="*/ 4821 w 10000"/>
                        <a:gd name="connsiteY3" fmla="*/ 10574 h 10615"/>
                        <a:gd name="connsiteX4" fmla="*/ 7355 w 10000"/>
                        <a:gd name="connsiteY4" fmla="*/ 10045 h 10615"/>
                        <a:gd name="connsiteX5" fmla="*/ 9021 w 10000"/>
                        <a:gd name="connsiteY5" fmla="*/ 6080 h 10615"/>
                        <a:gd name="connsiteX6" fmla="*/ 10000 w 10000"/>
                        <a:gd name="connsiteY6" fmla="*/ 529 h 10615"/>
                        <a:gd name="connsiteX0" fmla="*/ 0 w 9857"/>
                        <a:gd name="connsiteY0" fmla="*/ 0 h 10615"/>
                        <a:gd name="connsiteX1" fmla="*/ 860 w 9857"/>
                        <a:gd name="connsiteY1" fmla="*/ 6078 h 10615"/>
                        <a:gd name="connsiteX2" fmla="*/ 2627 w 9857"/>
                        <a:gd name="connsiteY2" fmla="*/ 9515 h 10615"/>
                        <a:gd name="connsiteX3" fmla="*/ 4821 w 9857"/>
                        <a:gd name="connsiteY3" fmla="*/ 10574 h 10615"/>
                        <a:gd name="connsiteX4" fmla="*/ 7355 w 9857"/>
                        <a:gd name="connsiteY4" fmla="*/ 10045 h 10615"/>
                        <a:gd name="connsiteX5" fmla="*/ 9021 w 9857"/>
                        <a:gd name="connsiteY5" fmla="*/ 6080 h 10615"/>
                        <a:gd name="connsiteX6" fmla="*/ 9857 w 9857"/>
                        <a:gd name="connsiteY6" fmla="*/ 1322 h 1061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</a:cxnLst>
                      <a:rect l="l" t="t" r="r" b="b"/>
                      <a:pathLst>
                        <a:path w="9857" h="10615">
                          <a:moveTo>
                            <a:pt x="0" y="0"/>
                          </a:moveTo>
                          <a:cubicBezTo>
                            <a:pt x="180" y="881"/>
                            <a:pt x="422" y="3832"/>
                            <a:pt x="860" y="6078"/>
                          </a:cubicBezTo>
                          <a:cubicBezTo>
                            <a:pt x="1299" y="8325"/>
                            <a:pt x="1967" y="8766"/>
                            <a:pt x="2627" y="9515"/>
                          </a:cubicBezTo>
                          <a:cubicBezTo>
                            <a:pt x="3287" y="10264"/>
                            <a:pt x="4033" y="10486"/>
                            <a:pt x="4821" y="10574"/>
                          </a:cubicBezTo>
                          <a:cubicBezTo>
                            <a:pt x="5609" y="10662"/>
                            <a:pt x="6727" y="10661"/>
                            <a:pt x="7355" y="10045"/>
                          </a:cubicBezTo>
                          <a:cubicBezTo>
                            <a:pt x="7983" y="9428"/>
                            <a:pt x="8509" y="7270"/>
                            <a:pt x="9021" y="6080"/>
                          </a:cubicBezTo>
                          <a:cubicBezTo>
                            <a:pt x="9787" y="4669"/>
                            <a:pt x="9514" y="1584"/>
                            <a:pt x="9857" y="1322"/>
                          </a:cubicBezTo>
                        </a:path>
                      </a:pathLst>
                    </a:custGeom>
                    <a:grpFill/>
                    <a:ln>
                      <a:solidFill>
                        <a:schemeClr val="bg1">
                          <a:lumMod val="5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400" b="1">
                        <a:latin typeface="+mn-ea"/>
                      </a:endParaRPr>
                    </a:p>
                  </p:txBody>
                </p:sp>
              </p:grpSp>
              <p:sp>
                <p:nvSpPr>
                  <p:cNvPr id="8" name="사각형: 둥근 모서리 7">
                    <a:extLst>
                      <a:ext uri="{FF2B5EF4-FFF2-40B4-BE49-F238E27FC236}">
                        <a16:creationId xmlns:a16="http://schemas.microsoft.com/office/drawing/2014/main" id="{A315C82F-081E-0FE6-81D9-05B01637E903}"/>
                      </a:ext>
                    </a:extLst>
                  </p:cNvPr>
                  <p:cNvSpPr/>
                  <p:nvPr/>
                </p:nvSpPr>
                <p:spPr>
                  <a:xfrm>
                    <a:off x="2235083" y="565382"/>
                    <a:ext cx="1103845" cy="2420976"/>
                  </a:xfrm>
                  <a:prstGeom prst="roundRect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571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grpSp>
                <p:nvGrpSpPr>
                  <p:cNvPr id="9" name="그룹 8">
                    <a:extLst>
                      <a:ext uri="{FF2B5EF4-FFF2-40B4-BE49-F238E27FC236}">
                        <a16:creationId xmlns:a16="http://schemas.microsoft.com/office/drawing/2014/main" id="{87B4E142-768B-A01E-4E66-80228EC0B48D}"/>
                      </a:ext>
                    </a:extLst>
                  </p:cNvPr>
                  <p:cNvGrpSpPr/>
                  <p:nvPr/>
                </p:nvGrpSpPr>
                <p:grpSpPr>
                  <a:xfrm>
                    <a:off x="5025061" y="6097261"/>
                    <a:ext cx="934037" cy="1154452"/>
                    <a:chOff x="5284141" y="7108983"/>
                    <a:chExt cx="349659" cy="484965"/>
                  </a:xfrm>
                  <a:gradFill>
                    <a:gsLst>
                      <a:gs pos="100000">
                        <a:schemeClr val="bg1">
                          <a:lumMod val="95000"/>
                        </a:schemeClr>
                      </a:gs>
                      <a:gs pos="0">
                        <a:schemeClr val="accent1">
                          <a:lumMod val="5000"/>
                          <a:lumOff val="95000"/>
                        </a:schemeClr>
                      </a:gs>
                      <a:gs pos="95000">
                        <a:schemeClr val="bg1">
                          <a:lumMod val="75000"/>
                        </a:schemeClr>
                      </a:gs>
                    </a:gsLst>
                    <a:lin ang="5400000" scaled="1"/>
                  </a:gradFill>
                </p:grpSpPr>
                <p:sp>
                  <p:nvSpPr>
                    <p:cNvPr id="251" name="사각형: 둥근 모서리 250">
                      <a:extLst>
                        <a:ext uri="{FF2B5EF4-FFF2-40B4-BE49-F238E27FC236}">
                          <a16:creationId xmlns:a16="http://schemas.microsoft.com/office/drawing/2014/main" id="{109A65F8-1ECC-A688-7844-30047C39D94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284141" y="7108983"/>
                      <a:ext cx="349659" cy="484965"/>
                    </a:xfrm>
                    <a:prstGeom prst="roundRect">
                      <a:avLst/>
                    </a:prstGeom>
                    <a:grpFill/>
                    <a:ln>
                      <a:solidFill>
                        <a:schemeClr val="bg1">
                          <a:lumMod val="75000"/>
                        </a:schemeClr>
                      </a:solidFill>
                    </a:ln>
                    <a:scene3d>
                      <a:camera prst="orthographicFront"/>
                      <a:lightRig rig="threePt" dir="t"/>
                    </a:scene3d>
                    <a:sp3d>
                      <a:bevelT/>
                    </a:sp3d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400" b="1">
                        <a:latin typeface="+mn-ea"/>
                      </a:endParaRPr>
                    </a:p>
                  </p:txBody>
                </p:sp>
                <p:sp>
                  <p:nvSpPr>
                    <p:cNvPr id="252" name="자유형: 도형 251">
                      <a:extLst>
                        <a:ext uri="{FF2B5EF4-FFF2-40B4-BE49-F238E27FC236}">
                          <a16:creationId xmlns:a16="http://schemas.microsoft.com/office/drawing/2014/main" id="{36C70E22-6997-589D-8B51-C6C5AAB1657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294152" y="7130255"/>
                      <a:ext cx="327861" cy="31875"/>
                    </a:xfrm>
                    <a:custGeom>
                      <a:avLst/>
                      <a:gdLst>
                        <a:gd name="connsiteX0" fmla="*/ 0 w 339725"/>
                        <a:gd name="connsiteY0" fmla="*/ 6367 h 6367"/>
                        <a:gd name="connsiteX1" fmla="*/ 76200 w 339725"/>
                        <a:gd name="connsiteY1" fmla="*/ 17 h 6367"/>
                        <a:gd name="connsiteX2" fmla="*/ 339725 w 339725"/>
                        <a:gd name="connsiteY2" fmla="*/ 3192 h 6367"/>
                        <a:gd name="connsiteX0" fmla="*/ 0 w 10000"/>
                        <a:gd name="connsiteY0" fmla="*/ 5057 h 25075"/>
                        <a:gd name="connsiteX1" fmla="*/ 5421 w 10000"/>
                        <a:gd name="connsiteY1" fmla="*/ 25004 h 25075"/>
                        <a:gd name="connsiteX2" fmla="*/ 10000 w 10000"/>
                        <a:gd name="connsiteY2" fmla="*/ 70 h 25075"/>
                        <a:gd name="connsiteX0" fmla="*/ 0 w 10000"/>
                        <a:gd name="connsiteY0" fmla="*/ 5057 h 25428"/>
                        <a:gd name="connsiteX1" fmla="*/ 2804 w 10000"/>
                        <a:gd name="connsiteY1" fmla="*/ 15029 h 25428"/>
                        <a:gd name="connsiteX2" fmla="*/ 5421 w 10000"/>
                        <a:gd name="connsiteY2" fmla="*/ 25004 h 25428"/>
                        <a:gd name="connsiteX3" fmla="*/ 10000 w 10000"/>
                        <a:gd name="connsiteY3" fmla="*/ 70 h 25428"/>
                        <a:gd name="connsiteX0" fmla="*/ 0 w 10000"/>
                        <a:gd name="connsiteY0" fmla="*/ 5057 h 25430"/>
                        <a:gd name="connsiteX1" fmla="*/ 2804 w 10000"/>
                        <a:gd name="connsiteY1" fmla="*/ 15029 h 25430"/>
                        <a:gd name="connsiteX2" fmla="*/ 5421 w 10000"/>
                        <a:gd name="connsiteY2" fmla="*/ 25004 h 25430"/>
                        <a:gd name="connsiteX3" fmla="*/ 10000 w 10000"/>
                        <a:gd name="connsiteY3" fmla="*/ 70 h 25430"/>
                        <a:gd name="connsiteX0" fmla="*/ 0 w 10000"/>
                        <a:gd name="connsiteY0" fmla="*/ 5057 h 35605"/>
                        <a:gd name="connsiteX1" fmla="*/ 2711 w 10000"/>
                        <a:gd name="connsiteY1" fmla="*/ 34976 h 35605"/>
                        <a:gd name="connsiteX2" fmla="*/ 5421 w 10000"/>
                        <a:gd name="connsiteY2" fmla="*/ 25004 h 35605"/>
                        <a:gd name="connsiteX3" fmla="*/ 10000 w 10000"/>
                        <a:gd name="connsiteY3" fmla="*/ 70 h 35605"/>
                        <a:gd name="connsiteX0" fmla="*/ 0 w 9860"/>
                        <a:gd name="connsiteY0" fmla="*/ 0 h 66218"/>
                        <a:gd name="connsiteX1" fmla="*/ 2571 w 9860"/>
                        <a:gd name="connsiteY1" fmla="*/ 63579 h 66218"/>
                        <a:gd name="connsiteX2" fmla="*/ 5281 w 9860"/>
                        <a:gd name="connsiteY2" fmla="*/ 53607 h 66218"/>
                        <a:gd name="connsiteX3" fmla="*/ 9860 w 9860"/>
                        <a:gd name="connsiteY3" fmla="*/ 28673 h 66218"/>
                        <a:gd name="connsiteX0" fmla="*/ 0 w 10000"/>
                        <a:gd name="connsiteY0" fmla="*/ 0 h 9766"/>
                        <a:gd name="connsiteX1" fmla="*/ 1067 w 10000"/>
                        <a:gd name="connsiteY1" fmla="*/ 3765 h 9766"/>
                        <a:gd name="connsiteX2" fmla="*/ 2608 w 10000"/>
                        <a:gd name="connsiteY2" fmla="*/ 9601 h 9766"/>
                        <a:gd name="connsiteX3" fmla="*/ 5356 w 10000"/>
                        <a:gd name="connsiteY3" fmla="*/ 8096 h 9766"/>
                        <a:gd name="connsiteX4" fmla="*/ 10000 w 10000"/>
                        <a:gd name="connsiteY4" fmla="*/ 4330 h 9766"/>
                        <a:gd name="connsiteX0" fmla="*/ 0 w 10000"/>
                        <a:gd name="connsiteY0" fmla="*/ 0 h 8349"/>
                        <a:gd name="connsiteX1" fmla="*/ 1067 w 10000"/>
                        <a:gd name="connsiteY1" fmla="*/ 3855 h 8349"/>
                        <a:gd name="connsiteX2" fmla="*/ 2821 w 10000"/>
                        <a:gd name="connsiteY2" fmla="*/ 6361 h 8349"/>
                        <a:gd name="connsiteX3" fmla="*/ 5356 w 10000"/>
                        <a:gd name="connsiteY3" fmla="*/ 8290 h 8349"/>
                        <a:gd name="connsiteX4" fmla="*/ 10000 w 10000"/>
                        <a:gd name="connsiteY4" fmla="*/ 4434 h 8349"/>
                        <a:gd name="connsiteX0" fmla="*/ 0 w 10000"/>
                        <a:gd name="connsiteY0" fmla="*/ 0 h 8123"/>
                        <a:gd name="connsiteX1" fmla="*/ 1067 w 10000"/>
                        <a:gd name="connsiteY1" fmla="*/ 4617 h 8123"/>
                        <a:gd name="connsiteX2" fmla="*/ 2821 w 10000"/>
                        <a:gd name="connsiteY2" fmla="*/ 7619 h 8123"/>
                        <a:gd name="connsiteX3" fmla="*/ 5427 w 10000"/>
                        <a:gd name="connsiteY3" fmla="*/ 7851 h 8123"/>
                        <a:gd name="connsiteX4" fmla="*/ 10000 w 10000"/>
                        <a:gd name="connsiteY4" fmla="*/ 5311 h 8123"/>
                        <a:gd name="connsiteX0" fmla="*/ 0 w 10000"/>
                        <a:gd name="connsiteY0" fmla="*/ 0 h 9691"/>
                        <a:gd name="connsiteX1" fmla="*/ 1067 w 10000"/>
                        <a:gd name="connsiteY1" fmla="*/ 5684 h 9691"/>
                        <a:gd name="connsiteX2" fmla="*/ 2821 w 10000"/>
                        <a:gd name="connsiteY2" fmla="*/ 9380 h 9691"/>
                        <a:gd name="connsiteX3" fmla="*/ 5427 w 10000"/>
                        <a:gd name="connsiteY3" fmla="*/ 9665 h 9691"/>
                        <a:gd name="connsiteX4" fmla="*/ 10000 w 10000"/>
                        <a:gd name="connsiteY4" fmla="*/ 6538 h 9691"/>
                        <a:gd name="connsiteX0" fmla="*/ 0 w 10000"/>
                        <a:gd name="connsiteY0" fmla="*/ 0 h 10726"/>
                        <a:gd name="connsiteX1" fmla="*/ 1067 w 10000"/>
                        <a:gd name="connsiteY1" fmla="*/ 5865 h 10726"/>
                        <a:gd name="connsiteX2" fmla="*/ 2821 w 10000"/>
                        <a:gd name="connsiteY2" fmla="*/ 9679 h 10726"/>
                        <a:gd name="connsiteX3" fmla="*/ 5427 w 10000"/>
                        <a:gd name="connsiteY3" fmla="*/ 9973 h 10726"/>
                        <a:gd name="connsiteX4" fmla="*/ 10000 w 10000"/>
                        <a:gd name="connsiteY4" fmla="*/ 586 h 10726"/>
                        <a:gd name="connsiteX0" fmla="*/ 0 w 10000"/>
                        <a:gd name="connsiteY0" fmla="*/ 0 h 10597"/>
                        <a:gd name="connsiteX1" fmla="*/ 1067 w 10000"/>
                        <a:gd name="connsiteY1" fmla="*/ 5865 h 10597"/>
                        <a:gd name="connsiteX2" fmla="*/ 2821 w 10000"/>
                        <a:gd name="connsiteY2" fmla="*/ 9679 h 10597"/>
                        <a:gd name="connsiteX3" fmla="*/ 5427 w 10000"/>
                        <a:gd name="connsiteY3" fmla="*/ 9973 h 10597"/>
                        <a:gd name="connsiteX4" fmla="*/ 7962 w 10000"/>
                        <a:gd name="connsiteY4" fmla="*/ 2346 h 10597"/>
                        <a:gd name="connsiteX5" fmla="*/ 10000 w 10000"/>
                        <a:gd name="connsiteY5" fmla="*/ 586 h 10597"/>
                        <a:gd name="connsiteX0" fmla="*/ 0 w 10000"/>
                        <a:gd name="connsiteY0" fmla="*/ 0 h 10216"/>
                        <a:gd name="connsiteX1" fmla="*/ 1067 w 10000"/>
                        <a:gd name="connsiteY1" fmla="*/ 5865 h 10216"/>
                        <a:gd name="connsiteX2" fmla="*/ 2821 w 10000"/>
                        <a:gd name="connsiteY2" fmla="*/ 9679 h 10216"/>
                        <a:gd name="connsiteX3" fmla="*/ 5427 w 10000"/>
                        <a:gd name="connsiteY3" fmla="*/ 9973 h 10216"/>
                        <a:gd name="connsiteX4" fmla="*/ 8033 w 10000"/>
                        <a:gd name="connsiteY4" fmla="*/ 7626 h 10216"/>
                        <a:gd name="connsiteX5" fmla="*/ 10000 w 10000"/>
                        <a:gd name="connsiteY5" fmla="*/ 586 h 10216"/>
                        <a:gd name="connsiteX0" fmla="*/ 0 w 10000"/>
                        <a:gd name="connsiteY0" fmla="*/ 0 h 10156"/>
                        <a:gd name="connsiteX1" fmla="*/ 1067 w 10000"/>
                        <a:gd name="connsiteY1" fmla="*/ 5865 h 10156"/>
                        <a:gd name="connsiteX2" fmla="*/ 2821 w 10000"/>
                        <a:gd name="connsiteY2" fmla="*/ 9679 h 10156"/>
                        <a:gd name="connsiteX3" fmla="*/ 5427 w 10000"/>
                        <a:gd name="connsiteY3" fmla="*/ 9973 h 10156"/>
                        <a:gd name="connsiteX4" fmla="*/ 8317 w 10000"/>
                        <a:gd name="connsiteY4" fmla="*/ 8506 h 10156"/>
                        <a:gd name="connsiteX5" fmla="*/ 10000 w 10000"/>
                        <a:gd name="connsiteY5" fmla="*/ 586 h 10156"/>
                        <a:gd name="connsiteX0" fmla="*/ 0 w 10000"/>
                        <a:gd name="connsiteY0" fmla="*/ 0 h 10340"/>
                        <a:gd name="connsiteX1" fmla="*/ 1067 w 10000"/>
                        <a:gd name="connsiteY1" fmla="*/ 5865 h 10340"/>
                        <a:gd name="connsiteX2" fmla="*/ 2821 w 10000"/>
                        <a:gd name="connsiteY2" fmla="*/ 9679 h 10340"/>
                        <a:gd name="connsiteX3" fmla="*/ 5427 w 10000"/>
                        <a:gd name="connsiteY3" fmla="*/ 9973 h 10340"/>
                        <a:gd name="connsiteX4" fmla="*/ 8246 w 10000"/>
                        <a:gd name="connsiteY4" fmla="*/ 5866 h 10340"/>
                        <a:gd name="connsiteX5" fmla="*/ 10000 w 10000"/>
                        <a:gd name="connsiteY5" fmla="*/ 586 h 10340"/>
                        <a:gd name="connsiteX0" fmla="*/ 0 w 9858"/>
                        <a:gd name="connsiteY0" fmla="*/ 2054 h 12394"/>
                        <a:gd name="connsiteX1" fmla="*/ 1067 w 9858"/>
                        <a:gd name="connsiteY1" fmla="*/ 7919 h 12394"/>
                        <a:gd name="connsiteX2" fmla="*/ 2821 w 9858"/>
                        <a:gd name="connsiteY2" fmla="*/ 11733 h 12394"/>
                        <a:gd name="connsiteX3" fmla="*/ 5427 w 9858"/>
                        <a:gd name="connsiteY3" fmla="*/ 12027 h 12394"/>
                        <a:gd name="connsiteX4" fmla="*/ 8246 w 9858"/>
                        <a:gd name="connsiteY4" fmla="*/ 7920 h 12394"/>
                        <a:gd name="connsiteX5" fmla="*/ 9858 w 9858"/>
                        <a:gd name="connsiteY5" fmla="*/ 0 h 12394"/>
                        <a:gd name="connsiteX0" fmla="*/ 0 w 9784"/>
                        <a:gd name="connsiteY0" fmla="*/ 947 h 10000"/>
                        <a:gd name="connsiteX1" fmla="*/ 866 w 9784"/>
                        <a:gd name="connsiteY1" fmla="*/ 6389 h 10000"/>
                        <a:gd name="connsiteX2" fmla="*/ 2646 w 9784"/>
                        <a:gd name="connsiteY2" fmla="*/ 9467 h 10000"/>
                        <a:gd name="connsiteX3" fmla="*/ 5289 w 9784"/>
                        <a:gd name="connsiteY3" fmla="*/ 9704 h 10000"/>
                        <a:gd name="connsiteX4" fmla="*/ 8149 w 9784"/>
                        <a:gd name="connsiteY4" fmla="*/ 6390 h 10000"/>
                        <a:gd name="connsiteX5" fmla="*/ 9784 w 9784"/>
                        <a:gd name="connsiteY5" fmla="*/ 0 h 10000"/>
                        <a:gd name="connsiteX0" fmla="*/ 0 w 10000"/>
                        <a:gd name="connsiteY0" fmla="*/ 947 h 9852"/>
                        <a:gd name="connsiteX1" fmla="*/ 885 w 10000"/>
                        <a:gd name="connsiteY1" fmla="*/ 6389 h 9852"/>
                        <a:gd name="connsiteX2" fmla="*/ 2704 w 10000"/>
                        <a:gd name="connsiteY2" fmla="*/ 9467 h 9852"/>
                        <a:gd name="connsiteX3" fmla="*/ 5406 w 10000"/>
                        <a:gd name="connsiteY3" fmla="*/ 9704 h 9852"/>
                        <a:gd name="connsiteX4" fmla="*/ 8624 w 10000"/>
                        <a:gd name="connsiteY4" fmla="*/ 8520 h 9852"/>
                        <a:gd name="connsiteX5" fmla="*/ 10000 w 10000"/>
                        <a:gd name="connsiteY5" fmla="*/ 0 h 9852"/>
                        <a:gd name="connsiteX0" fmla="*/ 0 w 10221"/>
                        <a:gd name="connsiteY0" fmla="*/ 0 h 9039"/>
                        <a:gd name="connsiteX1" fmla="*/ 885 w 10221"/>
                        <a:gd name="connsiteY1" fmla="*/ 5524 h 9039"/>
                        <a:gd name="connsiteX2" fmla="*/ 2704 w 10221"/>
                        <a:gd name="connsiteY2" fmla="*/ 8648 h 9039"/>
                        <a:gd name="connsiteX3" fmla="*/ 5406 w 10221"/>
                        <a:gd name="connsiteY3" fmla="*/ 8889 h 9039"/>
                        <a:gd name="connsiteX4" fmla="*/ 8624 w 10221"/>
                        <a:gd name="connsiteY4" fmla="*/ 7687 h 9039"/>
                        <a:gd name="connsiteX5" fmla="*/ 10221 w 10221"/>
                        <a:gd name="connsiteY5" fmla="*/ 1201 h 9039"/>
                        <a:gd name="connsiteX0" fmla="*/ 0 w 10000"/>
                        <a:gd name="connsiteY0" fmla="*/ 0 h 10110"/>
                        <a:gd name="connsiteX1" fmla="*/ 866 w 10000"/>
                        <a:gd name="connsiteY1" fmla="*/ 6111 h 10110"/>
                        <a:gd name="connsiteX2" fmla="*/ 2646 w 10000"/>
                        <a:gd name="connsiteY2" fmla="*/ 9567 h 10110"/>
                        <a:gd name="connsiteX3" fmla="*/ 5289 w 10000"/>
                        <a:gd name="connsiteY3" fmla="*/ 9834 h 10110"/>
                        <a:gd name="connsiteX4" fmla="*/ 8438 w 10000"/>
                        <a:gd name="connsiteY4" fmla="*/ 6909 h 10110"/>
                        <a:gd name="connsiteX5" fmla="*/ 10000 w 10000"/>
                        <a:gd name="connsiteY5" fmla="*/ 1329 h 10110"/>
                        <a:gd name="connsiteX0" fmla="*/ 0 w 10144"/>
                        <a:gd name="connsiteY0" fmla="*/ 1860 h 11970"/>
                        <a:gd name="connsiteX1" fmla="*/ 866 w 10144"/>
                        <a:gd name="connsiteY1" fmla="*/ 7971 h 11970"/>
                        <a:gd name="connsiteX2" fmla="*/ 2646 w 10144"/>
                        <a:gd name="connsiteY2" fmla="*/ 11427 h 11970"/>
                        <a:gd name="connsiteX3" fmla="*/ 5289 w 10144"/>
                        <a:gd name="connsiteY3" fmla="*/ 11694 h 11970"/>
                        <a:gd name="connsiteX4" fmla="*/ 8438 w 10144"/>
                        <a:gd name="connsiteY4" fmla="*/ 8769 h 11970"/>
                        <a:gd name="connsiteX5" fmla="*/ 10144 w 10144"/>
                        <a:gd name="connsiteY5" fmla="*/ 0 h 11970"/>
                        <a:gd name="connsiteX0" fmla="*/ 0 w 10000"/>
                        <a:gd name="connsiteY0" fmla="*/ 0 h 10110"/>
                        <a:gd name="connsiteX1" fmla="*/ 866 w 10000"/>
                        <a:gd name="connsiteY1" fmla="*/ 6111 h 10110"/>
                        <a:gd name="connsiteX2" fmla="*/ 2646 w 10000"/>
                        <a:gd name="connsiteY2" fmla="*/ 9567 h 10110"/>
                        <a:gd name="connsiteX3" fmla="*/ 5289 w 10000"/>
                        <a:gd name="connsiteY3" fmla="*/ 9834 h 10110"/>
                        <a:gd name="connsiteX4" fmla="*/ 8438 w 10000"/>
                        <a:gd name="connsiteY4" fmla="*/ 6909 h 10110"/>
                        <a:gd name="connsiteX5" fmla="*/ 10000 w 10000"/>
                        <a:gd name="connsiteY5" fmla="*/ 532 h 10110"/>
                        <a:gd name="connsiteX0" fmla="*/ 0 w 9784"/>
                        <a:gd name="connsiteY0" fmla="*/ 1860 h 11970"/>
                        <a:gd name="connsiteX1" fmla="*/ 866 w 9784"/>
                        <a:gd name="connsiteY1" fmla="*/ 7971 h 11970"/>
                        <a:gd name="connsiteX2" fmla="*/ 2646 w 9784"/>
                        <a:gd name="connsiteY2" fmla="*/ 11427 h 11970"/>
                        <a:gd name="connsiteX3" fmla="*/ 5289 w 9784"/>
                        <a:gd name="connsiteY3" fmla="*/ 11694 h 11970"/>
                        <a:gd name="connsiteX4" fmla="*/ 8438 w 9784"/>
                        <a:gd name="connsiteY4" fmla="*/ 8769 h 11970"/>
                        <a:gd name="connsiteX5" fmla="*/ 9784 w 9784"/>
                        <a:gd name="connsiteY5" fmla="*/ 0 h 11970"/>
                        <a:gd name="connsiteX0" fmla="*/ 0 w 10295"/>
                        <a:gd name="connsiteY0" fmla="*/ 0 h 8446"/>
                        <a:gd name="connsiteX1" fmla="*/ 885 w 10295"/>
                        <a:gd name="connsiteY1" fmla="*/ 5105 h 8446"/>
                        <a:gd name="connsiteX2" fmla="*/ 2704 w 10295"/>
                        <a:gd name="connsiteY2" fmla="*/ 7992 h 8446"/>
                        <a:gd name="connsiteX3" fmla="*/ 5406 w 10295"/>
                        <a:gd name="connsiteY3" fmla="*/ 8215 h 8446"/>
                        <a:gd name="connsiteX4" fmla="*/ 8624 w 10295"/>
                        <a:gd name="connsiteY4" fmla="*/ 5772 h 8446"/>
                        <a:gd name="connsiteX5" fmla="*/ 10295 w 10295"/>
                        <a:gd name="connsiteY5" fmla="*/ 444 h 8446"/>
                        <a:gd name="connsiteX0" fmla="*/ 0 w 10000"/>
                        <a:gd name="connsiteY0" fmla="*/ 0 h 10056"/>
                        <a:gd name="connsiteX1" fmla="*/ 860 w 10000"/>
                        <a:gd name="connsiteY1" fmla="*/ 6044 h 10056"/>
                        <a:gd name="connsiteX2" fmla="*/ 2627 w 10000"/>
                        <a:gd name="connsiteY2" fmla="*/ 9462 h 10056"/>
                        <a:gd name="connsiteX3" fmla="*/ 5251 w 10000"/>
                        <a:gd name="connsiteY3" fmla="*/ 9726 h 10056"/>
                        <a:gd name="connsiteX4" fmla="*/ 9021 w 10000"/>
                        <a:gd name="connsiteY4" fmla="*/ 6046 h 10056"/>
                        <a:gd name="connsiteX5" fmla="*/ 10000 w 10000"/>
                        <a:gd name="connsiteY5" fmla="*/ 526 h 10056"/>
                        <a:gd name="connsiteX0" fmla="*/ 0 w 10000"/>
                        <a:gd name="connsiteY0" fmla="*/ 0 h 9944"/>
                        <a:gd name="connsiteX1" fmla="*/ 860 w 10000"/>
                        <a:gd name="connsiteY1" fmla="*/ 6044 h 9944"/>
                        <a:gd name="connsiteX2" fmla="*/ 2627 w 10000"/>
                        <a:gd name="connsiteY2" fmla="*/ 9462 h 9944"/>
                        <a:gd name="connsiteX3" fmla="*/ 5251 w 10000"/>
                        <a:gd name="connsiteY3" fmla="*/ 9726 h 9944"/>
                        <a:gd name="connsiteX4" fmla="*/ 6925 w 10000"/>
                        <a:gd name="connsiteY4" fmla="*/ 7623 h 9944"/>
                        <a:gd name="connsiteX5" fmla="*/ 9021 w 10000"/>
                        <a:gd name="connsiteY5" fmla="*/ 6046 h 9944"/>
                        <a:gd name="connsiteX6" fmla="*/ 10000 w 10000"/>
                        <a:gd name="connsiteY6" fmla="*/ 526 h 9944"/>
                        <a:gd name="connsiteX0" fmla="*/ 0 w 10000"/>
                        <a:gd name="connsiteY0" fmla="*/ 0 h 10277"/>
                        <a:gd name="connsiteX1" fmla="*/ 860 w 10000"/>
                        <a:gd name="connsiteY1" fmla="*/ 6078 h 10277"/>
                        <a:gd name="connsiteX2" fmla="*/ 2627 w 10000"/>
                        <a:gd name="connsiteY2" fmla="*/ 9515 h 10277"/>
                        <a:gd name="connsiteX3" fmla="*/ 5251 w 10000"/>
                        <a:gd name="connsiteY3" fmla="*/ 9781 h 10277"/>
                        <a:gd name="connsiteX4" fmla="*/ 7355 w 10000"/>
                        <a:gd name="connsiteY4" fmla="*/ 10045 h 10277"/>
                        <a:gd name="connsiteX5" fmla="*/ 9021 w 10000"/>
                        <a:gd name="connsiteY5" fmla="*/ 6080 h 10277"/>
                        <a:gd name="connsiteX6" fmla="*/ 10000 w 10000"/>
                        <a:gd name="connsiteY6" fmla="*/ 529 h 10277"/>
                        <a:gd name="connsiteX0" fmla="*/ 0 w 10000"/>
                        <a:gd name="connsiteY0" fmla="*/ 0 h 10615"/>
                        <a:gd name="connsiteX1" fmla="*/ 860 w 10000"/>
                        <a:gd name="connsiteY1" fmla="*/ 6078 h 10615"/>
                        <a:gd name="connsiteX2" fmla="*/ 2627 w 10000"/>
                        <a:gd name="connsiteY2" fmla="*/ 9515 h 10615"/>
                        <a:gd name="connsiteX3" fmla="*/ 4821 w 10000"/>
                        <a:gd name="connsiteY3" fmla="*/ 10574 h 10615"/>
                        <a:gd name="connsiteX4" fmla="*/ 7355 w 10000"/>
                        <a:gd name="connsiteY4" fmla="*/ 10045 h 10615"/>
                        <a:gd name="connsiteX5" fmla="*/ 9021 w 10000"/>
                        <a:gd name="connsiteY5" fmla="*/ 6080 h 10615"/>
                        <a:gd name="connsiteX6" fmla="*/ 10000 w 10000"/>
                        <a:gd name="connsiteY6" fmla="*/ 529 h 10615"/>
                        <a:gd name="connsiteX0" fmla="*/ 0 w 9857"/>
                        <a:gd name="connsiteY0" fmla="*/ 0 h 10615"/>
                        <a:gd name="connsiteX1" fmla="*/ 860 w 9857"/>
                        <a:gd name="connsiteY1" fmla="*/ 6078 h 10615"/>
                        <a:gd name="connsiteX2" fmla="*/ 2627 w 9857"/>
                        <a:gd name="connsiteY2" fmla="*/ 9515 h 10615"/>
                        <a:gd name="connsiteX3" fmla="*/ 4821 w 9857"/>
                        <a:gd name="connsiteY3" fmla="*/ 10574 h 10615"/>
                        <a:gd name="connsiteX4" fmla="*/ 7355 w 9857"/>
                        <a:gd name="connsiteY4" fmla="*/ 10045 h 10615"/>
                        <a:gd name="connsiteX5" fmla="*/ 9021 w 9857"/>
                        <a:gd name="connsiteY5" fmla="*/ 6080 h 10615"/>
                        <a:gd name="connsiteX6" fmla="*/ 9857 w 9857"/>
                        <a:gd name="connsiteY6" fmla="*/ 1322 h 1061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</a:cxnLst>
                      <a:rect l="l" t="t" r="r" b="b"/>
                      <a:pathLst>
                        <a:path w="9857" h="10615">
                          <a:moveTo>
                            <a:pt x="0" y="0"/>
                          </a:moveTo>
                          <a:cubicBezTo>
                            <a:pt x="180" y="881"/>
                            <a:pt x="422" y="3832"/>
                            <a:pt x="860" y="6078"/>
                          </a:cubicBezTo>
                          <a:cubicBezTo>
                            <a:pt x="1299" y="8325"/>
                            <a:pt x="1967" y="8766"/>
                            <a:pt x="2627" y="9515"/>
                          </a:cubicBezTo>
                          <a:cubicBezTo>
                            <a:pt x="3287" y="10264"/>
                            <a:pt x="4033" y="10486"/>
                            <a:pt x="4821" y="10574"/>
                          </a:cubicBezTo>
                          <a:cubicBezTo>
                            <a:pt x="5609" y="10662"/>
                            <a:pt x="6727" y="10661"/>
                            <a:pt x="7355" y="10045"/>
                          </a:cubicBezTo>
                          <a:cubicBezTo>
                            <a:pt x="7983" y="9428"/>
                            <a:pt x="8509" y="7270"/>
                            <a:pt x="9021" y="6080"/>
                          </a:cubicBezTo>
                          <a:cubicBezTo>
                            <a:pt x="9787" y="4669"/>
                            <a:pt x="9514" y="1584"/>
                            <a:pt x="9857" y="1322"/>
                          </a:cubicBezTo>
                        </a:path>
                      </a:pathLst>
                    </a:custGeom>
                    <a:grpFill/>
                    <a:ln>
                      <a:solidFill>
                        <a:schemeClr val="bg1">
                          <a:lumMod val="5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400" b="1">
                        <a:latin typeface="+mn-ea"/>
                      </a:endParaRPr>
                    </a:p>
                  </p:txBody>
                </p:sp>
              </p:grpSp>
              <p:sp>
                <p:nvSpPr>
                  <p:cNvPr id="10" name="이등변 삼각형 9">
                    <a:extLst>
                      <a:ext uri="{FF2B5EF4-FFF2-40B4-BE49-F238E27FC236}">
                        <a16:creationId xmlns:a16="http://schemas.microsoft.com/office/drawing/2014/main" id="{19D2D8E2-4F64-7261-3753-5437F9DAEDF3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600249" y="738839"/>
                    <a:ext cx="660392" cy="507292"/>
                  </a:xfrm>
                  <a:prstGeom prst="triangl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19050">
                    <a:solidFill>
                      <a:schemeClr val="tx1"/>
                    </a:solidFill>
                  </a:ln>
                  <a:scene3d>
                    <a:camera prst="orthographicFront"/>
                    <a:lightRig rig="threePt" dir="t"/>
                  </a:scene3d>
                  <a:sp3d>
                    <a:bevelT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 dirty="0">
                      <a:latin typeface="+mn-ea"/>
                    </a:endParaRPr>
                  </a:p>
                </p:txBody>
              </p:sp>
              <p:sp>
                <p:nvSpPr>
                  <p:cNvPr id="11" name="TextBox 10">
                    <a:extLst>
                      <a:ext uri="{FF2B5EF4-FFF2-40B4-BE49-F238E27FC236}">
                        <a16:creationId xmlns:a16="http://schemas.microsoft.com/office/drawing/2014/main" id="{A4F6182A-2772-7162-BED4-AB46F459F50C}"/>
                      </a:ext>
                    </a:extLst>
                  </p:cNvPr>
                  <p:cNvSpPr txBox="1"/>
                  <p:nvPr/>
                </p:nvSpPr>
                <p:spPr>
                  <a:xfrm>
                    <a:off x="35003" y="1381169"/>
                    <a:ext cx="1667266" cy="62931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400" b="1" dirty="0">
                        <a:latin typeface="+mn-ea"/>
                      </a:rPr>
                      <a:t>Compressed</a:t>
                    </a:r>
                  </a:p>
                  <a:p>
                    <a:pPr algn="ctr"/>
                    <a:r>
                      <a:rPr lang="en-US" altLang="ko-KR" sz="400" b="1" dirty="0">
                        <a:latin typeface="+mn-ea"/>
                      </a:rPr>
                      <a:t>Air source</a:t>
                    </a:r>
                    <a:endParaRPr lang="ko-KR" altLang="en-US" sz="400" b="1" dirty="0">
                      <a:latin typeface="+mn-ea"/>
                    </a:endParaRPr>
                  </a:p>
                </p:txBody>
              </p:sp>
              <p:cxnSp>
                <p:nvCxnSpPr>
                  <p:cNvPr id="12" name="직선 연결선 11">
                    <a:extLst>
                      <a:ext uri="{FF2B5EF4-FFF2-40B4-BE49-F238E27FC236}">
                        <a16:creationId xmlns:a16="http://schemas.microsoft.com/office/drawing/2014/main" id="{B168DD82-31F2-C61C-F995-EA57D53CD572}"/>
                      </a:ext>
                    </a:extLst>
                  </p:cNvPr>
                  <p:cNvCxnSpPr>
                    <a:cxnSpLocks/>
                    <a:stCxn id="10" idx="0"/>
                    <a:endCxn id="13" idx="1"/>
                  </p:cNvCxnSpPr>
                  <p:nvPr/>
                </p:nvCxnSpPr>
                <p:spPr>
                  <a:xfrm flipV="1">
                    <a:off x="1184083" y="982390"/>
                    <a:ext cx="471908" cy="10096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" name="직사각형 12">
                    <a:extLst>
                      <a:ext uri="{FF2B5EF4-FFF2-40B4-BE49-F238E27FC236}">
                        <a16:creationId xmlns:a16="http://schemas.microsoft.com/office/drawing/2014/main" id="{EB6C6EE9-1BCE-3077-F7AA-8002B8FD10EC}"/>
                      </a:ext>
                    </a:extLst>
                  </p:cNvPr>
                  <p:cNvSpPr/>
                  <p:nvPr/>
                </p:nvSpPr>
                <p:spPr>
                  <a:xfrm>
                    <a:off x="1655996" y="642087"/>
                    <a:ext cx="319046" cy="680585"/>
                  </a:xfrm>
                  <a:prstGeom prst="rect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19050">
                    <a:solidFill>
                      <a:schemeClr val="tx1"/>
                    </a:solidFill>
                  </a:ln>
                  <a:scene3d>
                    <a:camera prst="orthographicFront"/>
                    <a:lightRig rig="threePt" dir="t"/>
                  </a:scene3d>
                  <a:sp3d>
                    <a:bevelT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4" name="TextBox 13">
                    <a:extLst>
                      <a:ext uri="{FF2B5EF4-FFF2-40B4-BE49-F238E27FC236}">
                        <a16:creationId xmlns:a16="http://schemas.microsoft.com/office/drawing/2014/main" id="{7FAF804A-2BBF-1C1A-5870-9A730E2FA423}"/>
                      </a:ext>
                    </a:extLst>
                  </p:cNvPr>
                  <p:cNvSpPr txBox="1"/>
                  <p:nvPr/>
                </p:nvSpPr>
                <p:spPr>
                  <a:xfrm>
                    <a:off x="1169423" y="1381169"/>
                    <a:ext cx="1417106" cy="62931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400" b="1" dirty="0">
                        <a:latin typeface="+mn-ea"/>
                      </a:rPr>
                      <a:t>Electric</a:t>
                    </a:r>
                  </a:p>
                  <a:p>
                    <a:pPr algn="ctr"/>
                    <a:r>
                      <a:rPr lang="en-US" altLang="ko-KR" sz="400" b="1" dirty="0">
                        <a:latin typeface="+mn-ea"/>
                      </a:rPr>
                      <a:t>Regulator</a:t>
                    </a:r>
                    <a:endParaRPr lang="ko-KR" altLang="en-US" sz="400" b="1" dirty="0">
                      <a:latin typeface="+mn-ea"/>
                    </a:endParaRPr>
                  </a:p>
                </p:txBody>
              </p:sp>
              <p:sp>
                <p:nvSpPr>
                  <p:cNvPr id="15" name="사각형: 둥근 모서리 14">
                    <a:extLst>
                      <a:ext uri="{FF2B5EF4-FFF2-40B4-BE49-F238E27FC236}">
                        <a16:creationId xmlns:a16="http://schemas.microsoft.com/office/drawing/2014/main" id="{AF7DD806-B301-87A7-4794-8DC0ACEBC870}"/>
                      </a:ext>
                    </a:extLst>
                  </p:cNvPr>
                  <p:cNvSpPr/>
                  <p:nvPr/>
                </p:nvSpPr>
                <p:spPr>
                  <a:xfrm>
                    <a:off x="3400728" y="6845700"/>
                    <a:ext cx="2787271" cy="445091"/>
                  </a:xfrm>
                  <a:prstGeom prst="roundRect">
                    <a:avLst/>
                  </a:prstGeom>
                  <a:gradFill>
                    <a:gsLst>
                      <a:gs pos="100000">
                        <a:schemeClr val="bg1">
                          <a:lumMod val="95000"/>
                        </a:schemeClr>
                      </a:gs>
                      <a:gs pos="0">
                        <a:schemeClr val="accent1">
                          <a:lumMod val="5000"/>
                          <a:lumOff val="95000"/>
                        </a:schemeClr>
                      </a:gs>
                      <a:gs pos="83000">
                        <a:schemeClr val="bg1">
                          <a:lumMod val="50000"/>
                        </a:schemeClr>
                      </a:gs>
                    </a:gsLst>
                    <a:lin ang="5400000" scaled="1"/>
                  </a:gradFill>
                  <a:ln>
                    <a:solidFill>
                      <a:schemeClr val="bg1">
                        <a:lumMod val="75000"/>
                      </a:schemeClr>
                    </a:solidFill>
                  </a:ln>
                  <a:scene3d>
                    <a:camera prst="orthographicFront"/>
                    <a:lightRig rig="threePt" dir="t"/>
                  </a:scene3d>
                  <a:sp3d>
                    <a:bevelT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6" name="타원 15">
                    <a:extLst>
                      <a:ext uri="{FF2B5EF4-FFF2-40B4-BE49-F238E27FC236}">
                        <a16:creationId xmlns:a16="http://schemas.microsoft.com/office/drawing/2014/main" id="{E8BE1BF4-C537-383A-5796-1B12DDE59CD5}"/>
                      </a:ext>
                    </a:extLst>
                  </p:cNvPr>
                  <p:cNvSpPr/>
                  <p:nvPr/>
                </p:nvSpPr>
                <p:spPr>
                  <a:xfrm>
                    <a:off x="2423130" y="892925"/>
                    <a:ext cx="699559" cy="660392"/>
                  </a:xfrm>
                  <a:prstGeom prst="ellips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19050">
                    <a:solidFill>
                      <a:schemeClr val="tx1"/>
                    </a:solidFill>
                  </a:ln>
                  <a:scene3d>
                    <a:camera prst="orthographicFront"/>
                    <a:lightRig rig="threePt" dir="t"/>
                  </a:scene3d>
                  <a:sp3d>
                    <a:bevelT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cxnSp>
                <p:nvCxnSpPr>
                  <p:cNvPr id="17" name="직선 연결선 16">
                    <a:extLst>
                      <a:ext uri="{FF2B5EF4-FFF2-40B4-BE49-F238E27FC236}">
                        <a16:creationId xmlns:a16="http://schemas.microsoft.com/office/drawing/2014/main" id="{265353C1-D73F-B8F9-B8C1-FF662D2AB732}"/>
                      </a:ext>
                    </a:extLst>
                  </p:cNvPr>
                  <p:cNvCxnSpPr>
                    <a:cxnSpLocks/>
                    <a:stCxn id="13" idx="3"/>
                    <a:endCxn id="16" idx="1"/>
                  </p:cNvCxnSpPr>
                  <p:nvPr/>
                </p:nvCxnSpPr>
                <p:spPr>
                  <a:xfrm>
                    <a:off x="1975035" y="982380"/>
                    <a:ext cx="550534" cy="7248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8" name="직사각형 17">
                    <a:extLst>
                      <a:ext uri="{FF2B5EF4-FFF2-40B4-BE49-F238E27FC236}">
                        <a16:creationId xmlns:a16="http://schemas.microsoft.com/office/drawing/2014/main" id="{EEA03644-09F4-31F5-EFCE-390923243781}"/>
                      </a:ext>
                    </a:extLst>
                  </p:cNvPr>
                  <p:cNvSpPr/>
                  <p:nvPr/>
                </p:nvSpPr>
                <p:spPr>
                  <a:xfrm>
                    <a:off x="2648125" y="1553307"/>
                    <a:ext cx="295708" cy="962404"/>
                  </a:xfrm>
                  <a:prstGeom prst="rect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19050">
                    <a:solidFill>
                      <a:schemeClr val="tx1"/>
                    </a:solidFill>
                  </a:ln>
                  <a:scene3d>
                    <a:camera prst="orthographicFront"/>
                    <a:lightRig rig="threePt" dir="t"/>
                  </a:scene3d>
                  <a:sp3d>
                    <a:bevelT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cxnSp>
                <p:nvCxnSpPr>
                  <p:cNvPr id="19" name="직선 연결선 18">
                    <a:extLst>
                      <a:ext uri="{FF2B5EF4-FFF2-40B4-BE49-F238E27FC236}">
                        <a16:creationId xmlns:a16="http://schemas.microsoft.com/office/drawing/2014/main" id="{C586DA1F-132F-5674-FCD6-EBBCD00F45A0}"/>
                      </a:ext>
                    </a:extLst>
                  </p:cNvPr>
                  <p:cNvCxnSpPr>
                    <a:cxnSpLocks/>
                    <a:stCxn id="16" idx="7"/>
                    <a:endCxn id="16" idx="4"/>
                  </p:cNvCxnSpPr>
                  <p:nvPr/>
                </p:nvCxnSpPr>
                <p:spPr>
                  <a:xfrm flipH="1">
                    <a:off x="2772909" y="989638"/>
                    <a:ext cx="247330" cy="563680"/>
                  </a:xfrm>
                  <a:prstGeom prst="line">
                    <a:avLst/>
                  </a:prstGeom>
                  <a:ln w="57150">
                    <a:solidFill>
                      <a:srgbClr val="0070C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" name="직선 연결선 19">
                    <a:extLst>
                      <a:ext uri="{FF2B5EF4-FFF2-40B4-BE49-F238E27FC236}">
                        <a16:creationId xmlns:a16="http://schemas.microsoft.com/office/drawing/2014/main" id="{E1F657BB-C7F1-7D30-DE29-FE4470F28798}"/>
                      </a:ext>
                    </a:extLst>
                  </p:cNvPr>
                  <p:cNvCxnSpPr>
                    <a:cxnSpLocks/>
                    <a:stCxn id="16" idx="7"/>
                  </p:cNvCxnSpPr>
                  <p:nvPr/>
                </p:nvCxnSpPr>
                <p:spPr>
                  <a:xfrm>
                    <a:off x="3020231" y="989628"/>
                    <a:ext cx="626363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1" name="TextBox 20">
                    <a:extLst>
                      <a:ext uri="{FF2B5EF4-FFF2-40B4-BE49-F238E27FC236}">
                        <a16:creationId xmlns:a16="http://schemas.microsoft.com/office/drawing/2014/main" id="{29D023AA-D6ED-3A4A-2052-E0076FBC8654}"/>
                      </a:ext>
                    </a:extLst>
                  </p:cNvPr>
                  <p:cNvSpPr txBox="1"/>
                  <p:nvPr/>
                </p:nvSpPr>
                <p:spPr>
                  <a:xfrm>
                    <a:off x="2188550" y="2469048"/>
                    <a:ext cx="1229375" cy="62931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400" b="1" dirty="0">
                        <a:latin typeface="+mn-ea"/>
                      </a:rPr>
                      <a:t>Syringe</a:t>
                    </a:r>
                  </a:p>
                  <a:p>
                    <a:pPr algn="ctr"/>
                    <a:r>
                      <a:rPr lang="en-US" altLang="ko-KR" sz="400" b="1" dirty="0">
                        <a:latin typeface="+mn-ea"/>
                      </a:rPr>
                      <a:t>Pump</a:t>
                    </a:r>
                    <a:endParaRPr lang="ko-KR" altLang="en-US" sz="400" b="1" dirty="0">
                      <a:latin typeface="+mn-ea"/>
                    </a:endParaRPr>
                  </a:p>
                </p:txBody>
              </p:sp>
              <p:sp>
                <p:nvSpPr>
                  <p:cNvPr id="22" name="TextBox 21">
                    <a:extLst>
                      <a:ext uri="{FF2B5EF4-FFF2-40B4-BE49-F238E27FC236}">
                        <a16:creationId xmlns:a16="http://schemas.microsoft.com/office/drawing/2014/main" id="{7C9EA583-84D8-FBAB-DC7F-76C55B2AB1E5}"/>
                      </a:ext>
                    </a:extLst>
                  </p:cNvPr>
                  <p:cNvSpPr txBox="1"/>
                  <p:nvPr/>
                </p:nvSpPr>
                <p:spPr>
                  <a:xfrm>
                    <a:off x="2017280" y="449500"/>
                    <a:ext cx="1642388" cy="4495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400" b="1" dirty="0">
                        <a:latin typeface="+mn-ea"/>
                      </a:rPr>
                      <a:t>3-Way Valve</a:t>
                    </a:r>
                    <a:endParaRPr lang="ko-KR" altLang="en-US" sz="400" b="1" dirty="0">
                      <a:latin typeface="+mn-ea"/>
                    </a:endParaRPr>
                  </a:p>
                </p:txBody>
              </p:sp>
              <p:cxnSp>
                <p:nvCxnSpPr>
                  <p:cNvPr id="23" name="직선 연결선 22">
                    <a:extLst>
                      <a:ext uri="{FF2B5EF4-FFF2-40B4-BE49-F238E27FC236}">
                        <a16:creationId xmlns:a16="http://schemas.microsoft.com/office/drawing/2014/main" id="{EB8A790A-7967-7514-1D8C-879617E0A4B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646594" y="989636"/>
                    <a:ext cx="0" cy="1221283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" name="직선 연결선 24">
                    <a:extLst>
                      <a:ext uri="{FF2B5EF4-FFF2-40B4-BE49-F238E27FC236}">
                        <a16:creationId xmlns:a16="http://schemas.microsoft.com/office/drawing/2014/main" id="{7CB948A4-2E26-D494-D8EB-5019ADCC351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646594" y="2210912"/>
                    <a:ext cx="252000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6" name="직사각형 25">
                    <a:extLst>
                      <a:ext uri="{FF2B5EF4-FFF2-40B4-BE49-F238E27FC236}">
                        <a16:creationId xmlns:a16="http://schemas.microsoft.com/office/drawing/2014/main" id="{F537D582-075D-FAD5-3B00-D8F1FA56552D}"/>
                      </a:ext>
                    </a:extLst>
                  </p:cNvPr>
                  <p:cNvSpPr/>
                  <p:nvPr/>
                </p:nvSpPr>
                <p:spPr>
                  <a:xfrm>
                    <a:off x="3898594" y="2086070"/>
                    <a:ext cx="249777" cy="249684"/>
                  </a:xfrm>
                  <a:prstGeom prst="rect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19050">
                    <a:solidFill>
                      <a:schemeClr val="tx1"/>
                    </a:solidFill>
                  </a:ln>
                  <a:scene3d>
                    <a:camera prst="orthographicFront"/>
                    <a:lightRig rig="threePt" dir="t"/>
                  </a:scene3d>
                  <a:sp3d>
                    <a:bevelT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cxnSp>
                <p:nvCxnSpPr>
                  <p:cNvPr id="27" name="직선 연결선 26">
                    <a:extLst>
                      <a:ext uri="{FF2B5EF4-FFF2-40B4-BE49-F238E27FC236}">
                        <a16:creationId xmlns:a16="http://schemas.microsoft.com/office/drawing/2014/main" id="{09AE6BA7-612A-AE21-3F53-DCF6BDD5509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48371" y="2210912"/>
                    <a:ext cx="252000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" name="직선 연결선 27">
                    <a:extLst>
                      <a:ext uri="{FF2B5EF4-FFF2-40B4-BE49-F238E27FC236}">
                        <a16:creationId xmlns:a16="http://schemas.microsoft.com/office/drawing/2014/main" id="{D7C1D39B-E947-B648-AA13-CF89BB0C362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391070" y="1004424"/>
                    <a:ext cx="0" cy="1221283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9" name="타원 28">
                    <a:extLst>
                      <a:ext uri="{FF2B5EF4-FFF2-40B4-BE49-F238E27FC236}">
                        <a16:creationId xmlns:a16="http://schemas.microsoft.com/office/drawing/2014/main" id="{B7955535-7203-7370-A075-8E09785F35FE}"/>
                      </a:ext>
                    </a:extLst>
                  </p:cNvPr>
                  <p:cNvSpPr/>
                  <p:nvPr/>
                </p:nvSpPr>
                <p:spPr>
                  <a:xfrm>
                    <a:off x="4209898" y="1494532"/>
                    <a:ext cx="349658" cy="317525"/>
                  </a:xfrm>
                  <a:prstGeom prst="ellips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19050">
                    <a:solidFill>
                      <a:schemeClr val="tx1"/>
                    </a:solidFill>
                  </a:ln>
                  <a:scene3d>
                    <a:camera prst="orthographicFront"/>
                    <a:lightRig rig="threePt" dir="t"/>
                  </a:scene3d>
                  <a:sp3d>
                    <a:bevelT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cxnSp>
                <p:nvCxnSpPr>
                  <p:cNvPr id="30" name="직선 연결선 29">
                    <a:extLst>
                      <a:ext uri="{FF2B5EF4-FFF2-40B4-BE49-F238E27FC236}">
                        <a16:creationId xmlns:a16="http://schemas.microsoft.com/office/drawing/2014/main" id="{84B4CD18-9122-019D-514A-D669649F083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381059" y="1002341"/>
                    <a:ext cx="1117746" cy="2082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1" name="TextBox 30">
                    <a:extLst>
                      <a:ext uri="{FF2B5EF4-FFF2-40B4-BE49-F238E27FC236}">
                        <a16:creationId xmlns:a16="http://schemas.microsoft.com/office/drawing/2014/main" id="{53ECFAE7-9B3B-322D-55C0-86C34301D0E6}"/>
                      </a:ext>
                    </a:extLst>
                  </p:cNvPr>
                  <p:cNvSpPr txBox="1"/>
                  <p:nvPr/>
                </p:nvSpPr>
                <p:spPr>
                  <a:xfrm>
                    <a:off x="3973919" y="438714"/>
                    <a:ext cx="1932027" cy="4495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400" b="1" dirty="0">
                        <a:latin typeface="+mn-ea"/>
                      </a:rPr>
                      <a:t>Compressed Air</a:t>
                    </a:r>
                    <a:endParaRPr lang="ko-KR" altLang="en-US" sz="400" b="1" dirty="0">
                      <a:latin typeface="+mn-ea"/>
                    </a:endParaRPr>
                  </a:p>
                </p:txBody>
              </p:sp>
              <p:cxnSp>
                <p:nvCxnSpPr>
                  <p:cNvPr id="32" name="직선 화살표 연결선 31">
                    <a:extLst>
                      <a:ext uri="{FF2B5EF4-FFF2-40B4-BE49-F238E27FC236}">
                        <a16:creationId xmlns:a16="http://schemas.microsoft.com/office/drawing/2014/main" id="{C09EEEEE-4793-EBE9-0C14-8E26AF491CB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468790" y="892916"/>
                    <a:ext cx="994367" cy="0"/>
                  </a:xfrm>
                  <a:prstGeom prst="straightConnector1">
                    <a:avLst/>
                  </a:prstGeom>
                  <a:ln w="19050">
                    <a:solidFill>
                      <a:schemeClr val="accent1">
                        <a:lumMod val="75000"/>
                      </a:schemeClr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3" name="TextBox 32">
                    <a:extLst>
                      <a:ext uri="{FF2B5EF4-FFF2-40B4-BE49-F238E27FC236}">
                        <a16:creationId xmlns:a16="http://schemas.microsoft.com/office/drawing/2014/main" id="{6E27FF27-5805-1BDA-4F79-57FDF6D6C03E}"/>
                      </a:ext>
                    </a:extLst>
                  </p:cNvPr>
                  <p:cNvSpPr txBox="1"/>
                  <p:nvPr/>
                </p:nvSpPr>
                <p:spPr>
                  <a:xfrm>
                    <a:off x="3284519" y="2440060"/>
                    <a:ext cx="1556568" cy="62931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400" b="1" dirty="0">
                        <a:latin typeface="+mn-ea"/>
                      </a:rPr>
                      <a:t>Pressurized</a:t>
                    </a:r>
                  </a:p>
                  <a:p>
                    <a:pPr algn="ctr"/>
                    <a:r>
                      <a:rPr lang="en-US" altLang="ko-KR" sz="400" b="1" dirty="0">
                        <a:latin typeface="+mn-ea"/>
                      </a:rPr>
                      <a:t>Port</a:t>
                    </a:r>
                    <a:endParaRPr lang="ko-KR" altLang="en-US" sz="400" b="1" dirty="0">
                      <a:latin typeface="+mn-ea"/>
                    </a:endParaRPr>
                  </a:p>
                </p:txBody>
              </p:sp>
              <p:sp>
                <p:nvSpPr>
                  <p:cNvPr id="34" name="TextBox 33">
                    <a:extLst>
                      <a:ext uri="{FF2B5EF4-FFF2-40B4-BE49-F238E27FC236}">
                        <a16:creationId xmlns:a16="http://schemas.microsoft.com/office/drawing/2014/main" id="{08BDB57E-F489-E394-875A-7F7B89381A46}"/>
                      </a:ext>
                    </a:extLst>
                  </p:cNvPr>
                  <p:cNvSpPr txBox="1"/>
                  <p:nvPr/>
                </p:nvSpPr>
                <p:spPr>
                  <a:xfrm>
                    <a:off x="3402640" y="1072005"/>
                    <a:ext cx="1240102" cy="62931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400" b="1" dirty="0">
                        <a:latin typeface="+mn-ea"/>
                      </a:rPr>
                      <a:t>Exhaust</a:t>
                    </a:r>
                  </a:p>
                  <a:p>
                    <a:pPr algn="ctr"/>
                    <a:r>
                      <a:rPr lang="en-US" altLang="ko-KR" sz="400" b="1" dirty="0">
                        <a:latin typeface="+mn-ea"/>
                      </a:rPr>
                      <a:t>Port</a:t>
                    </a:r>
                    <a:endParaRPr lang="ko-KR" altLang="en-US" sz="400" b="1" dirty="0">
                      <a:latin typeface="+mn-ea"/>
                    </a:endParaRPr>
                  </a:p>
                </p:txBody>
              </p:sp>
              <p:sp>
                <p:nvSpPr>
                  <p:cNvPr id="35" name="직사각형 34">
                    <a:extLst>
                      <a:ext uri="{FF2B5EF4-FFF2-40B4-BE49-F238E27FC236}">
                        <a16:creationId xmlns:a16="http://schemas.microsoft.com/office/drawing/2014/main" id="{84F8E46E-6930-E7BA-443B-A5B9CFB4127A}"/>
                      </a:ext>
                    </a:extLst>
                  </p:cNvPr>
                  <p:cNvSpPr/>
                  <p:nvPr/>
                </p:nvSpPr>
                <p:spPr>
                  <a:xfrm>
                    <a:off x="5259485" y="1208334"/>
                    <a:ext cx="472537" cy="2034748"/>
                  </a:xfrm>
                  <a:prstGeom prst="rect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19050">
                    <a:solidFill>
                      <a:schemeClr val="tx1"/>
                    </a:solidFill>
                  </a:ln>
                  <a:scene3d>
                    <a:camera prst="orthographicFront"/>
                    <a:lightRig rig="threePt" dir="t"/>
                  </a:scene3d>
                  <a:sp3d>
                    <a:bevelT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36" name="사각형: 둥근 모서리 35">
                    <a:extLst>
                      <a:ext uri="{FF2B5EF4-FFF2-40B4-BE49-F238E27FC236}">
                        <a16:creationId xmlns:a16="http://schemas.microsoft.com/office/drawing/2014/main" id="{91EF32FB-80B2-C08B-E4BC-E9C46ACA7D3B}"/>
                      </a:ext>
                    </a:extLst>
                  </p:cNvPr>
                  <p:cNvSpPr/>
                  <p:nvPr/>
                </p:nvSpPr>
                <p:spPr>
                  <a:xfrm>
                    <a:off x="5332956" y="1902701"/>
                    <a:ext cx="297174" cy="1281354"/>
                  </a:xfrm>
                  <a:prstGeom prst="roundRect">
                    <a:avLst/>
                  </a:prstGeom>
                  <a:blipFill dpi="0" rotWithShape="1">
                    <a:blip r:embed="rId5">
                      <a:alphaModFix amt="57000"/>
                    </a:blip>
                    <a:srcRect/>
                    <a:tile tx="0" ty="0" sx="100000" sy="100000" flip="none" algn="tl"/>
                  </a:blipFill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37" name="타원 36">
                    <a:extLst>
                      <a:ext uri="{FF2B5EF4-FFF2-40B4-BE49-F238E27FC236}">
                        <a16:creationId xmlns:a16="http://schemas.microsoft.com/office/drawing/2014/main" id="{28E9163F-3D64-03EC-C26D-27AD90880C31}"/>
                      </a:ext>
                    </a:extLst>
                  </p:cNvPr>
                  <p:cNvSpPr/>
                  <p:nvPr/>
                </p:nvSpPr>
                <p:spPr>
                  <a:xfrm>
                    <a:off x="5294901" y="1934914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38" name="타원 37">
                    <a:extLst>
                      <a:ext uri="{FF2B5EF4-FFF2-40B4-BE49-F238E27FC236}">
                        <a16:creationId xmlns:a16="http://schemas.microsoft.com/office/drawing/2014/main" id="{CCA08EE0-E92A-9DE2-7E78-311B24C1F17A}"/>
                      </a:ext>
                    </a:extLst>
                  </p:cNvPr>
                  <p:cNvSpPr/>
                  <p:nvPr/>
                </p:nvSpPr>
                <p:spPr>
                  <a:xfrm>
                    <a:off x="5294901" y="1986647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39" name="타원 38">
                    <a:extLst>
                      <a:ext uri="{FF2B5EF4-FFF2-40B4-BE49-F238E27FC236}">
                        <a16:creationId xmlns:a16="http://schemas.microsoft.com/office/drawing/2014/main" id="{501C1790-7D0A-F043-5248-699D38E36BA7}"/>
                      </a:ext>
                    </a:extLst>
                  </p:cNvPr>
                  <p:cNvSpPr/>
                  <p:nvPr/>
                </p:nvSpPr>
                <p:spPr>
                  <a:xfrm>
                    <a:off x="5297175" y="2038377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40" name="타원 39">
                    <a:extLst>
                      <a:ext uri="{FF2B5EF4-FFF2-40B4-BE49-F238E27FC236}">
                        <a16:creationId xmlns:a16="http://schemas.microsoft.com/office/drawing/2014/main" id="{8153431B-6003-CA7B-9FA3-0064022DA0D0}"/>
                      </a:ext>
                    </a:extLst>
                  </p:cNvPr>
                  <p:cNvSpPr/>
                  <p:nvPr/>
                </p:nvSpPr>
                <p:spPr>
                  <a:xfrm>
                    <a:off x="5297175" y="2090107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41" name="타원 40">
                    <a:extLst>
                      <a:ext uri="{FF2B5EF4-FFF2-40B4-BE49-F238E27FC236}">
                        <a16:creationId xmlns:a16="http://schemas.microsoft.com/office/drawing/2014/main" id="{9320C685-8C17-05EE-FA2A-867E97B37C96}"/>
                      </a:ext>
                    </a:extLst>
                  </p:cNvPr>
                  <p:cNvSpPr/>
                  <p:nvPr/>
                </p:nvSpPr>
                <p:spPr>
                  <a:xfrm>
                    <a:off x="5293851" y="2145072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42" name="타원 41">
                    <a:extLst>
                      <a:ext uri="{FF2B5EF4-FFF2-40B4-BE49-F238E27FC236}">
                        <a16:creationId xmlns:a16="http://schemas.microsoft.com/office/drawing/2014/main" id="{0FB8E7DC-B9E2-5173-A84D-26641CF108EF}"/>
                      </a:ext>
                    </a:extLst>
                  </p:cNvPr>
                  <p:cNvSpPr/>
                  <p:nvPr/>
                </p:nvSpPr>
                <p:spPr>
                  <a:xfrm>
                    <a:off x="5293851" y="2196804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43" name="타원 42">
                    <a:extLst>
                      <a:ext uri="{FF2B5EF4-FFF2-40B4-BE49-F238E27FC236}">
                        <a16:creationId xmlns:a16="http://schemas.microsoft.com/office/drawing/2014/main" id="{C5EDA6B7-244E-9D2F-8C6B-C5A02567B7FF}"/>
                      </a:ext>
                    </a:extLst>
                  </p:cNvPr>
                  <p:cNvSpPr/>
                  <p:nvPr/>
                </p:nvSpPr>
                <p:spPr>
                  <a:xfrm>
                    <a:off x="5296126" y="2248534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44" name="타원 43">
                    <a:extLst>
                      <a:ext uri="{FF2B5EF4-FFF2-40B4-BE49-F238E27FC236}">
                        <a16:creationId xmlns:a16="http://schemas.microsoft.com/office/drawing/2014/main" id="{2CB323D6-8424-C6BD-1CE9-190231839D25}"/>
                      </a:ext>
                    </a:extLst>
                  </p:cNvPr>
                  <p:cNvSpPr/>
                  <p:nvPr/>
                </p:nvSpPr>
                <p:spPr>
                  <a:xfrm>
                    <a:off x="5296126" y="2300264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45" name="타원 44">
                    <a:extLst>
                      <a:ext uri="{FF2B5EF4-FFF2-40B4-BE49-F238E27FC236}">
                        <a16:creationId xmlns:a16="http://schemas.microsoft.com/office/drawing/2014/main" id="{93375805-D86D-0727-73E3-29A29B0EF360}"/>
                      </a:ext>
                    </a:extLst>
                  </p:cNvPr>
                  <p:cNvSpPr/>
                  <p:nvPr/>
                </p:nvSpPr>
                <p:spPr>
                  <a:xfrm>
                    <a:off x="5294708" y="2357990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46" name="타원 45">
                    <a:extLst>
                      <a:ext uri="{FF2B5EF4-FFF2-40B4-BE49-F238E27FC236}">
                        <a16:creationId xmlns:a16="http://schemas.microsoft.com/office/drawing/2014/main" id="{F85C5569-0F51-54B6-B265-53C076BFC103}"/>
                      </a:ext>
                    </a:extLst>
                  </p:cNvPr>
                  <p:cNvSpPr/>
                  <p:nvPr/>
                </p:nvSpPr>
                <p:spPr>
                  <a:xfrm>
                    <a:off x="5294708" y="2409720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47" name="타원 46">
                    <a:extLst>
                      <a:ext uri="{FF2B5EF4-FFF2-40B4-BE49-F238E27FC236}">
                        <a16:creationId xmlns:a16="http://schemas.microsoft.com/office/drawing/2014/main" id="{9C3B5E5D-61AB-7720-6251-D102739CE5D2}"/>
                      </a:ext>
                    </a:extLst>
                  </p:cNvPr>
                  <p:cNvSpPr/>
                  <p:nvPr/>
                </p:nvSpPr>
                <p:spPr>
                  <a:xfrm>
                    <a:off x="5296982" y="2461450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48" name="타원 47">
                    <a:extLst>
                      <a:ext uri="{FF2B5EF4-FFF2-40B4-BE49-F238E27FC236}">
                        <a16:creationId xmlns:a16="http://schemas.microsoft.com/office/drawing/2014/main" id="{E2052DAD-91FC-B1B2-E1C1-171E3311D982}"/>
                      </a:ext>
                    </a:extLst>
                  </p:cNvPr>
                  <p:cNvSpPr/>
                  <p:nvPr/>
                </p:nvSpPr>
                <p:spPr>
                  <a:xfrm>
                    <a:off x="5296982" y="2513183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49" name="타원 48">
                    <a:extLst>
                      <a:ext uri="{FF2B5EF4-FFF2-40B4-BE49-F238E27FC236}">
                        <a16:creationId xmlns:a16="http://schemas.microsoft.com/office/drawing/2014/main" id="{C1412B16-4EF3-B0DC-D3F9-4548427248FE}"/>
                      </a:ext>
                    </a:extLst>
                  </p:cNvPr>
                  <p:cNvSpPr/>
                  <p:nvPr/>
                </p:nvSpPr>
                <p:spPr>
                  <a:xfrm>
                    <a:off x="5293660" y="2568145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50" name="타원 49">
                    <a:extLst>
                      <a:ext uri="{FF2B5EF4-FFF2-40B4-BE49-F238E27FC236}">
                        <a16:creationId xmlns:a16="http://schemas.microsoft.com/office/drawing/2014/main" id="{42CA62AD-9683-9523-F3D2-61D1F8C9BA1F}"/>
                      </a:ext>
                    </a:extLst>
                  </p:cNvPr>
                  <p:cNvSpPr/>
                  <p:nvPr/>
                </p:nvSpPr>
                <p:spPr>
                  <a:xfrm>
                    <a:off x="5293660" y="2619877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51" name="타원 50">
                    <a:extLst>
                      <a:ext uri="{FF2B5EF4-FFF2-40B4-BE49-F238E27FC236}">
                        <a16:creationId xmlns:a16="http://schemas.microsoft.com/office/drawing/2014/main" id="{48C218C2-7131-CD35-2C3B-5F591AA19C93}"/>
                      </a:ext>
                    </a:extLst>
                  </p:cNvPr>
                  <p:cNvSpPr/>
                  <p:nvPr/>
                </p:nvSpPr>
                <p:spPr>
                  <a:xfrm>
                    <a:off x="5295933" y="2671607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52" name="타원 51">
                    <a:extLst>
                      <a:ext uri="{FF2B5EF4-FFF2-40B4-BE49-F238E27FC236}">
                        <a16:creationId xmlns:a16="http://schemas.microsoft.com/office/drawing/2014/main" id="{87F8F138-09F4-5CAB-DB91-E4744FB11DAC}"/>
                      </a:ext>
                    </a:extLst>
                  </p:cNvPr>
                  <p:cNvSpPr/>
                  <p:nvPr/>
                </p:nvSpPr>
                <p:spPr>
                  <a:xfrm>
                    <a:off x="5295933" y="2723340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53" name="타원 52">
                    <a:extLst>
                      <a:ext uri="{FF2B5EF4-FFF2-40B4-BE49-F238E27FC236}">
                        <a16:creationId xmlns:a16="http://schemas.microsoft.com/office/drawing/2014/main" id="{49B352B8-0548-0A9F-E091-80246AF46105}"/>
                      </a:ext>
                    </a:extLst>
                  </p:cNvPr>
                  <p:cNvSpPr/>
                  <p:nvPr/>
                </p:nvSpPr>
                <p:spPr>
                  <a:xfrm>
                    <a:off x="5291385" y="2778302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54" name="타원 53">
                    <a:extLst>
                      <a:ext uri="{FF2B5EF4-FFF2-40B4-BE49-F238E27FC236}">
                        <a16:creationId xmlns:a16="http://schemas.microsoft.com/office/drawing/2014/main" id="{A375E094-7818-B330-06BD-11E8B83AC35B}"/>
                      </a:ext>
                    </a:extLst>
                  </p:cNvPr>
                  <p:cNvSpPr/>
                  <p:nvPr/>
                </p:nvSpPr>
                <p:spPr>
                  <a:xfrm>
                    <a:off x="5291385" y="2830034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55" name="타원 54">
                    <a:extLst>
                      <a:ext uri="{FF2B5EF4-FFF2-40B4-BE49-F238E27FC236}">
                        <a16:creationId xmlns:a16="http://schemas.microsoft.com/office/drawing/2014/main" id="{842849FE-F77A-9B07-8EA3-561629FB7CD7}"/>
                      </a:ext>
                    </a:extLst>
                  </p:cNvPr>
                  <p:cNvSpPr/>
                  <p:nvPr/>
                </p:nvSpPr>
                <p:spPr>
                  <a:xfrm>
                    <a:off x="5293660" y="2881766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56" name="타원 55">
                    <a:extLst>
                      <a:ext uri="{FF2B5EF4-FFF2-40B4-BE49-F238E27FC236}">
                        <a16:creationId xmlns:a16="http://schemas.microsoft.com/office/drawing/2014/main" id="{5392B3EA-ED49-A259-D010-339C32454631}"/>
                      </a:ext>
                    </a:extLst>
                  </p:cNvPr>
                  <p:cNvSpPr/>
                  <p:nvPr/>
                </p:nvSpPr>
                <p:spPr>
                  <a:xfrm>
                    <a:off x="5293660" y="2933496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57" name="타원 56">
                    <a:extLst>
                      <a:ext uri="{FF2B5EF4-FFF2-40B4-BE49-F238E27FC236}">
                        <a16:creationId xmlns:a16="http://schemas.microsoft.com/office/drawing/2014/main" id="{048FC618-3913-2ACC-4441-ECBB4606B931}"/>
                      </a:ext>
                    </a:extLst>
                  </p:cNvPr>
                  <p:cNvSpPr/>
                  <p:nvPr/>
                </p:nvSpPr>
                <p:spPr>
                  <a:xfrm>
                    <a:off x="5291385" y="2963129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58" name="타원 57">
                    <a:extLst>
                      <a:ext uri="{FF2B5EF4-FFF2-40B4-BE49-F238E27FC236}">
                        <a16:creationId xmlns:a16="http://schemas.microsoft.com/office/drawing/2014/main" id="{5C1C6A1E-691B-7645-770C-C519CEBE8B96}"/>
                      </a:ext>
                    </a:extLst>
                  </p:cNvPr>
                  <p:cNvSpPr/>
                  <p:nvPr/>
                </p:nvSpPr>
                <p:spPr>
                  <a:xfrm>
                    <a:off x="5291385" y="3014863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59" name="타원 58">
                    <a:extLst>
                      <a:ext uri="{FF2B5EF4-FFF2-40B4-BE49-F238E27FC236}">
                        <a16:creationId xmlns:a16="http://schemas.microsoft.com/office/drawing/2014/main" id="{BBA794F9-D1E3-C705-1B5A-582E7114C8CD}"/>
                      </a:ext>
                    </a:extLst>
                  </p:cNvPr>
                  <p:cNvSpPr/>
                  <p:nvPr/>
                </p:nvSpPr>
                <p:spPr>
                  <a:xfrm>
                    <a:off x="5293660" y="3066593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60" name="타원 59">
                    <a:extLst>
                      <a:ext uri="{FF2B5EF4-FFF2-40B4-BE49-F238E27FC236}">
                        <a16:creationId xmlns:a16="http://schemas.microsoft.com/office/drawing/2014/main" id="{EEF1916B-3F5F-A515-4424-3EA758772C9C}"/>
                      </a:ext>
                    </a:extLst>
                  </p:cNvPr>
                  <p:cNvSpPr/>
                  <p:nvPr/>
                </p:nvSpPr>
                <p:spPr>
                  <a:xfrm>
                    <a:off x="5293660" y="3118323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61" name="타원 60">
                    <a:extLst>
                      <a:ext uri="{FF2B5EF4-FFF2-40B4-BE49-F238E27FC236}">
                        <a16:creationId xmlns:a16="http://schemas.microsoft.com/office/drawing/2014/main" id="{11E63173-82BE-A89F-B874-AA9077DB8DD5}"/>
                      </a:ext>
                    </a:extLst>
                  </p:cNvPr>
                  <p:cNvSpPr/>
                  <p:nvPr/>
                </p:nvSpPr>
                <p:spPr>
                  <a:xfrm>
                    <a:off x="5291385" y="1883508"/>
                    <a:ext cx="373282" cy="84638"/>
                  </a:xfrm>
                  <a:prstGeom prst="ellipse">
                    <a:avLst/>
                  </a:prstGeom>
                  <a:noFill/>
                  <a:ln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cxnSp>
                <p:nvCxnSpPr>
                  <p:cNvPr id="62" name="직선 연결선 61">
                    <a:extLst>
                      <a:ext uri="{FF2B5EF4-FFF2-40B4-BE49-F238E27FC236}">
                        <a16:creationId xmlns:a16="http://schemas.microsoft.com/office/drawing/2014/main" id="{1ABE1B65-952C-1C0C-00C6-01EC187F4AA0}"/>
                      </a:ext>
                    </a:extLst>
                  </p:cNvPr>
                  <p:cNvCxnSpPr>
                    <a:cxnSpLocks/>
                    <a:endCxn id="35" idx="0"/>
                  </p:cNvCxnSpPr>
                  <p:nvPr/>
                </p:nvCxnSpPr>
                <p:spPr>
                  <a:xfrm flipH="1">
                    <a:off x="5495753" y="989635"/>
                    <a:ext cx="3052" cy="218699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3" name="순서도: 준비 62">
                    <a:extLst>
                      <a:ext uri="{FF2B5EF4-FFF2-40B4-BE49-F238E27FC236}">
                        <a16:creationId xmlns:a16="http://schemas.microsoft.com/office/drawing/2014/main" id="{A823AAB5-45F3-5F4E-7B55-810DD9F36B8D}"/>
                      </a:ext>
                    </a:extLst>
                  </p:cNvPr>
                  <p:cNvSpPr/>
                  <p:nvPr/>
                </p:nvSpPr>
                <p:spPr>
                  <a:xfrm>
                    <a:off x="5281733" y="3248222"/>
                    <a:ext cx="410676" cy="445090"/>
                  </a:xfrm>
                  <a:prstGeom prst="flowChartPreparation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19050">
                    <a:solidFill>
                      <a:schemeClr val="tx1"/>
                    </a:solidFill>
                  </a:ln>
                  <a:scene3d>
                    <a:camera prst="orthographicFront"/>
                    <a:lightRig rig="threePt" dir="t"/>
                  </a:scene3d>
                  <a:sp3d>
                    <a:bevelT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64" name="TextBox 63">
                    <a:extLst>
                      <a:ext uri="{FF2B5EF4-FFF2-40B4-BE49-F238E27FC236}">
                        <a16:creationId xmlns:a16="http://schemas.microsoft.com/office/drawing/2014/main" id="{6CED8759-D79D-CE7D-A9A0-223029464B3A}"/>
                      </a:ext>
                    </a:extLst>
                  </p:cNvPr>
                  <p:cNvSpPr txBox="1"/>
                  <p:nvPr/>
                </p:nvSpPr>
                <p:spPr>
                  <a:xfrm>
                    <a:off x="3913264" y="3253479"/>
                    <a:ext cx="1519018" cy="62931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400" b="1" dirty="0">
                        <a:latin typeface="+mn-ea"/>
                      </a:rPr>
                      <a:t>Dispensing</a:t>
                    </a:r>
                  </a:p>
                  <a:p>
                    <a:pPr algn="ctr"/>
                    <a:r>
                      <a:rPr lang="en-US" altLang="ko-KR" sz="400" b="1" dirty="0">
                        <a:latin typeface="+mn-ea"/>
                      </a:rPr>
                      <a:t>Head</a:t>
                    </a:r>
                    <a:endParaRPr lang="ko-KR" altLang="en-US" sz="400" b="1" dirty="0">
                      <a:latin typeface="+mn-ea"/>
                    </a:endParaRPr>
                  </a:p>
                </p:txBody>
              </p:sp>
              <p:sp>
                <p:nvSpPr>
                  <p:cNvPr id="65" name="TextBox 64">
                    <a:extLst>
                      <a:ext uri="{FF2B5EF4-FFF2-40B4-BE49-F238E27FC236}">
                        <a16:creationId xmlns:a16="http://schemas.microsoft.com/office/drawing/2014/main" id="{3E47D025-9D4C-D175-C37D-757A56317639}"/>
                      </a:ext>
                    </a:extLst>
                  </p:cNvPr>
                  <p:cNvSpPr txBox="1"/>
                  <p:nvPr/>
                </p:nvSpPr>
                <p:spPr>
                  <a:xfrm>
                    <a:off x="4182022" y="1893751"/>
                    <a:ext cx="1331286" cy="62931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400" b="1" dirty="0">
                        <a:latin typeface="+mn-ea"/>
                      </a:rPr>
                      <a:t>Solenoid</a:t>
                    </a:r>
                  </a:p>
                  <a:p>
                    <a:pPr algn="ctr"/>
                    <a:r>
                      <a:rPr lang="en-US" altLang="ko-KR" sz="400" b="1" dirty="0">
                        <a:latin typeface="+mn-ea"/>
                      </a:rPr>
                      <a:t>Valve</a:t>
                    </a:r>
                    <a:endParaRPr lang="ko-KR" altLang="en-US" sz="400" b="1" dirty="0">
                      <a:latin typeface="+mn-ea"/>
                    </a:endParaRPr>
                  </a:p>
                </p:txBody>
              </p:sp>
              <p:sp>
                <p:nvSpPr>
                  <p:cNvPr id="66" name="순서도: 지연 65">
                    <a:extLst>
                      <a:ext uri="{FF2B5EF4-FFF2-40B4-BE49-F238E27FC236}">
                        <a16:creationId xmlns:a16="http://schemas.microsoft.com/office/drawing/2014/main" id="{9736F694-9314-7F0C-FD5B-BB8D3C880CE2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4791156" y="4212058"/>
                    <a:ext cx="1397349" cy="349658"/>
                  </a:xfrm>
                  <a:prstGeom prst="flowChartDelay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28575">
                    <a:solidFill>
                      <a:schemeClr val="tx1"/>
                    </a:solidFill>
                  </a:ln>
                  <a:scene3d>
                    <a:camera prst="orthographicFront"/>
                    <a:lightRig rig="threePt" dir="t"/>
                  </a:scene3d>
                  <a:sp3d>
                    <a:bevelT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67" name="TextBox 66">
                    <a:extLst>
                      <a:ext uri="{FF2B5EF4-FFF2-40B4-BE49-F238E27FC236}">
                        <a16:creationId xmlns:a16="http://schemas.microsoft.com/office/drawing/2014/main" id="{AC7CECD1-F288-52E1-FC19-5C434A0B671D}"/>
                      </a:ext>
                    </a:extLst>
                  </p:cNvPr>
                  <p:cNvSpPr txBox="1"/>
                  <p:nvPr/>
                </p:nvSpPr>
                <p:spPr>
                  <a:xfrm>
                    <a:off x="3912250" y="4131343"/>
                    <a:ext cx="1513655" cy="62931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400" b="1" dirty="0">
                        <a:latin typeface="+mn-ea"/>
                      </a:rPr>
                      <a:t>Disposable</a:t>
                    </a:r>
                  </a:p>
                  <a:p>
                    <a:pPr algn="ctr"/>
                    <a:r>
                      <a:rPr lang="en-US" altLang="ko-KR" sz="400" b="1" dirty="0">
                        <a:latin typeface="+mn-ea"/>
                      </a:rPr>
                      <a:t>Nozzle</a:t>
                    </a:r>
                    <a:endParaRPr lang="ko-KR" altLang="en-US" sz="400" b="1" dirty="0">
                      <a:latin typeface="+mn-ea"/>
                    </a:endParaRPr>
                  </a:p>
                </p:txBody>
              </p:sp>
              <p:sp>
                <p:nvSpPr>
                  <p:cNvPr id="68" name="순서도: 지연 770">
                    <a:extLst>
                      <a:ext uri="{FF2B5EF4-FFF2-40B4-BE49-F238E27FC236}">
                        <a16:creationId xmlns:a16="http://schemas.microsoft.com/office/drawing/2014/main" id="{9E798811-8B78-33F5-254C-ACACB1A0AEE5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903998" y="5587490"/>
                    <a:ext cx="557249" cy="681967"/>
                  </a:xfrm>
                  <a:custGeom>
                    <a:avLst/>
                    <a:gdLst>
                      <a:gd name="connsiteX0" fmla="*/ 0 w 524463"/>
                      <a:gd name="connsiteY0" fmla="*/ 0 h 821164"/>
                      <a:gd name="connsiteX1" fmla="*/ 262232 w 524463"/>
                      <a:gd name="connsiteY1" fmla="*/ 0 h 821164"/>
                      <a:gd name="connsiteX2" fmla="*/ 524464 w 524463"/>
                      <a:gd name="connsiteY2" fmla="*/ 410582 h 821164"/>
                      <a:gd name="connsiteX3" fmla="*/ 262232 w 524463"/>
                      <a:gd name="connsiteY3" fmla="*/ 821164 h 821164"/>
                      <a:gd name="connsiteX4" fmla="*/ 0 w 524463"/>
                      <a:gd name="connsiteY4" fmla="*/ 821164 h 821164"/>
                      <a:gd name="connsiteX5" fmla="*/ 0 w 524463"/>
                      <a:gd name="connsiteY5" fmla="*/ 0 h 821164"/>
                      <a:gd name="connsiteX0" fmla="*/ 19050 w 524464"/>
                      <a:gd name="connsiteY0" fmla="*/ 50803 h 821164"/>
                      <a:gd name="connsiteX1" fmla="*/ 262232 w 524464"/>
                      <a:gd name="connsiteY1" fmla="*/ 0 h 821164"/>
                      <a:gd name="connsiteX2" fmla="*/ 524464 w 524464"/>
                      <a:gd name="connsiteY2" fmla="*/ 410582 h 821164"/>
                      <a:gd name="connsiteX3" fmla="*/ 262232 w 524464"/>
                      <a:gd name="connsiteY3" fmla="*/ 821164 h 821164"/>
                      <a:gd name="connsiteX4" fmla="*/ 0 w 524464"/>
                      <a:gd name="connsiteY4" fmla="*/ 821164 h 821164"/>
                      <a:gd name="connsiteX5" fmla="*/ 19050 w 524464"/>
                      <a:gd name="connsiteY5" fmla="*/ 50803 h 821164"/>
                      <a:gd name="connsiteX0" fmla="*/ 0 w 505414"/>
                      <a:gd name="connsiteY0" fmla="*/ 50803 h 821164"/>
                      <a:gd name="connsiteX1" fmla="*/ 243182 w 505414"/>
                      <a:gd name="connsiteY1" fmla="*/ 0 h 821164"/>
                      <a:gd name="connsiteX2" fmla="*/ 505414 w 505414"/>
                      <a:gd name="connsiteY2" fmla="*/ 410582 h 821164"/>
                      <a:gd name="connsiteX3" fmla="*/ 243182 w 505414"/>
                      <a:gd name="connsiteY3" fmla="*/ 821164 h 821164"/>
                      <a:gd name="connsiteX4" fmla="*/ 6350 w 505414"/>
                      <a:gd name="connsiteY4" fmla="*/ 789414 h 821164"/>
                      <a:gd name="connsiteX5" fmla="*/ 0 w 505414"/>
                      <a:gd name="connsiteY5" fmla="*/ 50803 h 821164"/>
                      <a:gd name="connsiteX0" fmla="*/ 0 w 505414"/>
                      <a:gd name="connsiteY0" fmla="*/ 75333 h 845694"/>
                      <a:gd name="connsiteX1" fmla="*/ 243182 w 505414"/>
                      <a:gd name="connsiteY1" fmla="*/ 24530 h 845694"/>
                      <a:gd name="connsiteX2" fmla="*/ 505414 w 505414"/>
                      <a:gd name="connsiteY2" fmla="*/ 435112 h 845694"/>
                      <a:gd name="connsiteX3" fmla="*/ 243182 w 505414"/>
                      <a:gd name="connsiteY3" fmla="*/ 845694 h 845694"/>
                      <a:gd name="connsiteX4" fmla="*/ 6350 w 505414"/>
                      <a:gd name="connsiteY4" fmla="*/ 813944 h 845694"/>
                      <a:gd name="connsiteX5" fmla="*/ 0 w 505414"/>
                      <a:gd name="connsiteY5" fmla="*/ 75333 h 845694"/>
                      <a:gd name="connsiteX0" fmla="*/ 0 w 505414"/>
                      <a:gd name="connsiteY0" fmla="*/ 62182 h 832543"/>
                      <a:gd name="connsiteX1" fmla="*/ 243182 w 505414"/>
                      <a:gd name="connsiteY1" fmla="*/ 11379 h 832543"/>
                      <a:gd name="connsiteX2" fmla="*/ 505414 w 505414"/>
                      <a:gd name="connsiteY2" fmla="*/ 421961 h 832543"/>
                      <a:gd name="connsiteX3" fmla="*/ 243182 w 505414"/>
                      <a:gd name="connsiteY3" fmla="*/ 832543 h 832543"/>
                      <a:gd name="connsiteX4" fmla="*/ 6350 w 505414"/>
                      <a:gd name="connsiteY4" fmla="*/ 800793 h 832543"/>
                      <a:gd name="connsiteX5" fmla="*/ 0 w 505414"/>
                      <a:gd name="connsiteY5" fmla="*/ 62182 h 832543"/>
                      <a:gd name="connsiteX0" fmla="*/ 0 w 518115"/>
                      <a:gd name="connsiteY0" fmla="*/ 176337 h 832395"/>
                      <a:gd name="connsiteX1" fmla="*/ 255883 w 518115"/>
                      <a:gd name="connsiteY1" fmla="*/ 11231 h 832395"/>
                      <a:gd name="connsiteX2" fmla="*/ 518115 w 518115"/>
                      <a:gd name="connsiteY2" fmla="*/ 421813 h 832395"/>
                      <a:gd name="connsiteX3" fmla="*/ 255883 w 518115"/>
                      <a:gd name="connsiteY3" fmla="*/ 832395 h 832395"/>
                      <a:gd name="connsiteX4" fmla="*/ 19051 w 518115"/>
                      <a:gd name="connsiteY4" fmla="*/ 800645 h 832395"/>
                      <a:gd name="connsiteX5" fmla="*/ 0 w 518115"/>
                      <a:gd name="connsiteY5" fmla="*/ 176337 h 832395"/>
                      <a:gd name="connsiteX0" fmla="*/ 0 w 519401"/>
                      <a:gd name="connsiteY0" fmla="*/ 184794 h 840852"/>
                      <a:gd name="connsiteX1" fmla="*/ 255883 w 519401"/>
                      <a:gd name="connsiteY1" fmla="*/ 19688 h 840852"/>
                      <a:gd name="connsiteX2" fmla="*/ 352107 w 519401"/>
                      <a:gd name="connsiteY2" fmla="*/ 48956 h 840852"/>
                      <a:gd name="connsiteX3" fmla="*/ 518115 w 519401"/>
                      <a:gd name="connsiteY3" fmla="*/ 430270 h 840852"/>
                      <a:gd name="connsiteX4" fmla="*/ 255883 w 519401"/>
                      <a:gd name="connsiteY4" fmla="*/ 840852 h 840852"/>
                      <a:gd name="connsiteX5" fmla="*/ 19051 w 519401"/>
                      <a:gd name="connsiteY5" fmla="*/ 809102 h 840852"/>
                      <a:gd name="connsiteX6" fmla="*/ 0 w 519401"/>
                      <a:gd name="connsiteY6" fmla="*/ 184794 h 840852"/>
                      <a:gd name="connsiteX0" fmla="*/ 0 w 522056"/>
                      <a:gd name="connsiteY0" fmla="*/ 168859 h 824917"/>
                      <a:gd name="connsiteX1" fmla="*/ 255883 w 522056"/>
                      <a:gd name="connsiteY1" fmla="*/ 3753 h 824917"/>
                      <a:gd name="connsiteX2" fmla="*/ 402907 w 522056"/>
                      <a:gd name="connsiteY2" fmla="*/ 83824 h 824917"/>
                      <a:gd name="connsiteX3" fmla="*/ 518115 w 522056"/>
                      <a:gd name="connsiteY3" fmla="*/ 414335 h 824917"/>
                      <a:gd name="connsiteX4" fmla="*/ 255883 w 522056"/>
                      <a:gd name="connsiteY4" fmla="*/ 824917 h 824917"/>
                      <a:gd name="connsiteX5" fmla="*/ 19051 w 522056"/>
                      <a:gd name="connsiteY5" fmla="*/ 793167 h 824917"/>
                      <a:gd name="connsiteX6" fmla="*/ 0 w 522056"/>
                      <a:gd name="connsiteY6" fmla="*/ 168859 h 824917"/>
                      <a:gd name="connsiteX0" fmla="*/ 0 w 521019"/>
                      <a:gd name="connsiteY0" fmla="*/ 168859 h 824917"/>
                      <a:gd name="connsiteX1" fmla="*/ 255883 w 521019"/>
                      <a:gd name="connsiteY1" fmla="*/ 3753 h 824917"/>
                      <a:gd name="connsiteX2" fmla="*/ 402907 w 521019"/>
                      <a:gd name="connsiteY2" fmla="*/ 83824 h 824917"/>
                      <a:gd name="connsiteX3" fmla="*/ 518115 w 521019"/>
                      <a:gd name="connsiteY3" fmla="*/ 414335 h 824917"/>
                      <a:gd name="connsiteX4" fmla="*/ 466407 w 521019"/>
                      <a:gd name="connsiteY4" fmla="*/ 687074 h 824917"/>
                      <a:gd name="connsiteX5" fmla="*/ 255883 w 521019"/>
                      <a:gd name="connsiteY5" fmla="*/ 824917 h 824917"/>
                      <a:gd name="connsiteX6" fmla="*/ 19051 w 521019"/>
                      <a:gd name="connsiteY6" fmla="*/ 793167 h 824917"/>
                      <a:gd name="connsiteX7" fmla="*/ 0 w 521019"/>
                      <a:gd name="connsiteY7" fmla="*/ 168859 h 824917"/>
                      <a:gd name="connsiteX0" fmla="*/ 0 w 518998"/>
                      <a:gd name="connsiteY0" fmla="*/ 167272 h 823330"/>
                      <a:gd name="connsiteX1" fmla="*/ 255883 w 518998"/>
                      <a:gd name="connsiteY1" fmla="*/ 2166 h 823330"/>
                      <a:gd name="connsiteX2" fmla="*/ 402907 w 518998"/>
                      <a:gd name="connsiteY2" fmla="*/ 82237 h 823330"/>
                      <a:gd name="connsiteX3" fmla="*/ 491807 w 518998"/>
                      <a:gd name="connsiteY3" fmla="*/ 209234 h 823330"/>
                      <a:gd name="connsiteX4" fmla="*/ 518115 w 518998"/>
                      <a:gd name="connsiteY4" fmla="*/ 412748 h 823330"/>
                      <a:gd name="connsiteX5" fmla="*/ 466407 w 518998"/>
                      <a:gd name="connsiteY5" fmla="*/ 685487 h 823330"/>
                      <a:gd name="connsiteX6" fmla="*/ 255883 w 518998"/>
                      <a:gd name="connsiteY6" fmla="*/ 823330 h 823330"/>
                      <a:gd name="connsiteX7" fmla="*/ 19051 w 518998"/>
                      <a:gd name="connsiteY7" fmla="*/ 791580 h 823330"/>
                      <a:gd name="connsiteX8" fmla="*/ 0 w 518998"/>
                      <a:gd name="connsiteY8" fmla="*/ 167272 h 823330"/>
                      <a:gd name="connsiteX0" fmla="*/ 21253 w 540251"/>
                      <a:gd name="connsiteY0" fmla="*/ 167272 h 823330"/>
                      <a:gd name="connsiteX1" fmla="*/ 277136 w 540251"/>
                      <a:gd name="connsiteY1" fmla="*/ 2166 h 823330"/>
                      <a:gd name="connsiteX2" fmla="*/ 424160 w 540251"/>
                      <a:gd name="connsiteY2" fmla="*/ 82237 h 823330"/>
                      <a:gd name="connsiteX3" fmla="*/ 513060 w 540251"/>
                      <a:gd name="connsiteY3" fmla="*/ 209234 h 823330"/>
                      <a:gd name="connsiteX4" fmla="*/ 539368 w 540251"/>
                      <a:gd name="connsiteY4" fmla="*/ 412748 h 823330"/>
                      <a:gd name="connsiteX5" fmla="*/ 487660 w 540251"/>
                      <a:gd name="connsiteY5" fmla="*/ 685487 h 823330"/>
                      <a:gd name="connsiteX6" fmla="*/ 277136 w 540251"/>
                      <a:gd name="connsiteY6" fmla="*/ 823330 h 823330"/>
                      <a:gd name="connsiteX7" fmla="*/ 40304 w 540251"/>
                      <a:gd name="connsiteY7" fmla="*/ 791580 h 823330"/>
                      <a:gd name="connsiteX8" fmla="*/ 11411 w 540251"/>
                      <a:gd name="connsiteY8" fmla="*/ 615633 h 823330"/>
                      <a:gd name="connsiteX9" fmla="*/ 21253 w 540251"/>
                      <a:gd name="connsiteY9" fmla="*/ 167272 h 823330"/>
                      <a:gd name="connsiteX0" fmla="*/ 54342 w 573340"/>
                      <a:gd name="connsiteY0" fmla="*/ 167272 h 823330"/>
                      <a:gd name="connsiteX1" fmla="*/ 310225 w 573340"/>
                      <a:gd name="connsiteY1" fmla="*/ 2166 h 823330"/>
                      <a:gd name="connsiteX2" fmla="*/ 457249 w 573340"/>
                      <a:gd name="connsiteY2" fmla="*/ 82237 h 823330"/>
                      <a:gd name="connsiteX3" fmla="*/ 546149 w 573340"/>
                      <a:gd name="connsiteY3" fmla="*/ 209234 h 823330"/>
                      <a:gd name="connsiteX4" fmla="*/ 572457 w 573340"/>
                      <a:gd name="connsiteY4" fmla="*/ 412748 h 823330"/>
                      <a:gd name="connsiteX5" fmla="*/ 520749 w 573340"/>
                      <a:gd name="connsiteY5" fmla="*/ 685487 h 823330"/>
                      <a:gd name="connsiteX6" fmla="*/ 310225 w 573340"/>
                      <a:gd name="connsiteY6" fmla="*/ 823330 h 823330"/>
                      <a:gd name="connsiteX7" fmla="*/ 73393 w 573340"/>
                      <a:gd name="connsiteY7" fmla="*/ 791580 h 823330"/>
                      <a:gd name="connsiteX8" fmla="*/ 44500 w 573340"/>
                      <a:gd name="connsiteY8" fmla="*/ 615633 h 823330"/>
                      <a:gd name="connsiteX9" fmla="*/ 50 w 573340"/>
                      <a:gd name="connsiteY9" fmla="*/ 240987 h 823330"/>
                      <a:gd name="connsiteX10" fmla="*/ 54342 w 573340"/>
                      <a:gd name="connsiteY10" fmla="*/ 167272 h 823330"/>
                      <a:gd name="connsiteX0" fmla="*/ 54342 w 573340"/>
                      <a:gd name="connsiteY0" fmla="*/ 155040 h 811098"/>
                      <a:gd name="connsiteX1" fmla="*/ 253075 w 573340"/>
                      <a:gd name="connsiteY1" fmla="*/ 2634 h 811098"/>
                      <a:gd name="connsiteX2" fmla="*/ 457249 w 573340"/>
                      <a:gd name="connsiteY2" fmla="*/ 70005 h 811098"/>
                      <a:gd name="connsiteX3" fmla="*/ 546149 w 573340"/>
                      <a:gd name="connsiteY3" fmla="*/ 197002 h 811098"/>
                      <a:gd name="connsiteX4" fmla="*/ 572457 w 573340"/>
                      <a:gd name="connsiteY4" fmla="*/ 400516 h 811098"/>
                      <a:gd name="connsiteX5" fmla="*/ 520749 w 573340"/>
                      <a:gd name="connsiteY5" fmla="*/ 673255 h 811098"/>
                      <a:gd name="connsiteX6" fmla="*/ 310225 w 573340"/>
                      <a:gd name="connsiteY6" fmla="*/ 811098 h 811098"/>
                      <a:gd name="connsiteX7" fmla="*/ 73393 w 573340"/>
                      <a:gd name="connsiteY7" fmla="*/ 779348 h 811098"/>
                      <a:gd name="connsiteX8" fmla="*/ 44500 w 573340"/>
                      <a:gd name="connsiteY8" fmla="*/ 603401 h 811098"/>
                      <a:gd name="connsiteX9" fmla="*/ 50 w 573340"/>
                      <a:gd name="connsiteY9" fmla="*/ 228755 h 811098"/>
                      <a:gd name="connsiteX10" fmla="*/ 54342 w 573340"/>
                      <a:gd name="connsiteY10" fmla="*/ 155040 h 811098"/>
                      <a:gd name="connsiteX0" fmla="*/ 54342 w 573340"/>
                      <a:gd name="connsiteY0" fmla="*/ 155040 h 798398"/>
                      <a:gd name="connsiteX1" fmla="*/ 253075 w 573340"/>
                      <a:gd name="connsiteY1" fmla="*/ 2634 h 798398"/>
                      <a:gd name="connsiteX2" fmla="*/ 457249 w 573340"/>
                      <a:gd name="connsiteY2" fmla="*/ 70005 h 798398"/>
                      <a:gd name="connsiteX3" fmla="*/ 546149 w 573340"/>
                      <a:gd name="connsiteY3" fmla="*/ 197002 h 798398"/>
                      <a:gd name="connsiteX4" fmla="*/ 572457 w 573340"/>
                      <a:gd name="connsiteY4" fmla="*/ 400516 h 798398"/>
                      <a:gd name="connsiteX5" fmla="*/ 520749 w 573340"/>
                      <a:gd name="connsiteY5" fmla="*/ 673255 h 798398"/>
                      <a:gd name="connsiteX6" fmla="*/ 272125 w 573340"/>
                      <a:gd name="connsiteY6" fmla="*/ 798398 h 798398"/>
                      <a:gd name="connsiteX7" fmla="*/ 73393 w 573340"/>
                      <a:gd name="connsiteY7" fmla="*/ 779348 h 798398"/>
                      <a:gd name="connsiteX8" fmla="*/ 44500 w 573340"/>
                      <a:gd name="connsiteY8" fmla="*/ 603401 h 798398"/>
                      <a:gd name="connsiteX9" fmla="*/ 50 w 573340"/>
                      <a:gd name="connsiteY9" fmla="*/ 228755 h 798398"/>
                      <a:gd name="connsiteX10" fmla="*/ 54342 w 573340"/>
                      <a:gd name="connsiteY10" fmla="*/ 155040 h 798398"/>
                      <a:gd name="connsiteX0" fmla="*/ 54342 w 575221"/>
                      <a:gd name="connsiteY0" fmla="*/ 155040 h 798398"/>
                      <a:gd name="connsiteX1" fmla="*/ 253075 w 575221"/>
                      <a:gd name="connsiteY1" fmla="*/ 2634 h 798398"/>
                      <a:gd name="connsiteX2" fmla="*/ 457249 w 575221"/>
                      <a:gd name="connsiteY2" fmla="*/ 70005 h 798398"/>
                      <a:gd name="connsiteX3" fmla="*/ 546149 w 575221"/>
                      <a:gd name="connsiteY3" fmla="*/ 197002 h 798398"/>
                      <a:gd name="connsiteX4" fmla="*/ 572457 w 575221"/>
                      <a:gd name="connsiteY4" fmla="*/ 400516 h 798398"/>
                      <a:gd name="connsiteX5" fmla="*/ 488999 w 575221"/>
                      <a:gd name="connsiteY5" fmla="*/ 666905 h 798398"/>
                      <a:gd name="connsiteX6" fmla="*/ 272125 w 575221"/>
                      <a:gd name="connsiteY6" fmla="*/ 798398 h 798398"/>
                      <a:gd name="connsiteX7" fmla="*/ 73393 w 575221"/>
                      <a:gd name="connsiteY7" fmla="*/ 779348 h 798398"/>
                      <a:gd name="connsiteX8" fmla="*/ 44500 w 575221"/>
                      <a:gd name="connsiteY8" fmla="*/ 603401 h 798398"/>
                      <a:gd name="connsiteX9" fmla="*/ 50 w 575221"/>
                      <a:gd name="connsiteY9" fmla="*/ 228755 h 798398"/>
                      <a:gd name="connsiteX10" fmla="*/ 54342 w 575221"/>
                      <a:gd name="connsiteY10" fmla="*/ 155040 h 798398"/>
                      <a:gd name="connsiteX0" fmla="*/ 54342 w 575221"/>
                      <a:gd name="connsiteY0" fmla="*/ 155040 h 798398"/>
                      <a:gd name="connsiteX1" fmla="*/ 253075 w 575221"/>
                      <a:gd name="connsiteY1" fmla="*/ 2634 h 798398"/>
                      <a:gd name="connsiteX2" fmla="*/ 457249 w 575221"/>
                      <a:gd name="connsiteY2" fmla="*/ 70005 h 798398"/>
                      <a:gd name="connsiteX3" fmla="*/ 546149 w 575221"/>
                      <a:gd name="connsiteY3" fmla="*/ 197002 h 798398"/>
                      <a:gd name="connsiteX4" fmla="*/ 572457 w 575221"/>
                      <a:gd name="connsiteY4" fmla="*/ 400516 h 798398"/>
                      <a:gd name="connsiteX5" fmla="*/ 488999 w 575221"/>
                      <a:gd name="connsiteY5" fmla="*/ 666905 h 798398"/>
                      <a:gd name="connsiteX6" fmla="*/ 272125 w 575221"/>
                      <a:gd name="connsiteY6" fmla="*/ 798398 h 798398"/>
                      <a:gd name="connsiteX7" fmla="*/ 73393 w 575221"/>
                      <a:gd name="connsiteY7" fmla="*/ 779348 h 798398"/>
                      <a:gd name="connsiteX8" fmla="*/ 44500 w 575221"/>
                      <a:gd name="connsiteY8" fmla="*/ 603401 h 798398"/>
                      <a:gd name="connsiteX9" fmla="*/ 50 w 575221"/>
                      <a:gd name="connsiteY9" fmla="*/ 228755 h 798398"/>
                      <a:gd name="connsiteX10" fmla="*/ 54342 w 575221"/>
                      <a:gd name="connsiteY10" fmla="*/ 155040 h 798398"/>
                      <a:gd name="connsiteX0" fmla="*/ 54342 w 575221"/>
                      <a:gd name="connsiteY0" fmla="*/ 155040 h 798398"/>
                      <a:gd name="connsiteX1" fmla="*/ 253075 w 575221"/>
                      <a:gd name="connsiteY1" fmla="*/ 2634 h 798398"/>
                      <a:gd name="connsiteX2" fmla="*/ 457249 w 575221"/>
                      <a:gd name="connsiteY2" fmla="*/ 70005 h 798398"/>
                      <a:gd name="connsiteX3" fmla="*/ 546149 w 575221"/>
                      <a:gd name="connsiteY3" fmla="*/ 197002 h 798398"/>
                      <a:gd name="connsiteX4" fmla="*/ 572457 w 575221"/>
                      <a:gd name="connsiteY4" fmla="*/ 400516 h 798398"/>
                      <a:gd name="connsiteX5" fmla="*/ 488999 w 575221"/>
                      <a:gd name="connsiteY5" fmla="*/ 666905 h 798398"/>
                      <a:gd name="connsiteX6" fmla="*/ 272125 w 575221"/>
                      <a:gd name="connsiteY6" fmla="*/ 798398 h 798398"/>
                      <a:gd name="connsiteX7" fmla="*/ 73393 w 575221"/>
                      <a:gd name="connsiteY7" fmla="*/ 779348 h 798398"/>
                      <a:gd name="connsiteX8" fmla="*/ 44500 w 575221"/>
                      <a:gd name="connsiteY8" fmla="*/ 603401 h 798398"/>
                      <a:gd name="connsiteX9" fmla="*/ 50 w 575221"/>
                      <a:gd name="connsiteY9" fmla="*/ 228755 h 798398"/>
                      <a:gd name="connsiteX10" fmla="*/ 54342 w 575221"/>
                      <a:gd name="connsiteY10" fmla="*/ 155040 h 798398"/>
                      <a:gd name="connsiteX0" fmla="*/ 54342 w 575221"/>
                      <a:gd name="connsiteY0" fmla="*/ 155040 h 798398"/>
                      <a:gd name="connsiteX1" fmla="*/ 253075 w 575221"/>
                      <a:gd name="connsiteY1" fmla="*/ 2634 h 798398"/>
                      <a:gd name="connsiteX2" fmla="*/ 457249 w 575221"/>
                      <a:gd name="connsiteY2" fmla="*/ 70005 h 798398"/>
                      <a:gd name="connsiteX3" fmla="*/ 546149 w 575221"/>
                      <a:gd name="connsiteY3" fmla="*/ 197002 h 798398"/>
                      <a:gd name="connsiteX4" fmla="*/ 572457 w 575221"/>
                      <a:gd name="connsiteY4" fmla="*/ 400516 h 798398"/>
                      <a:gd name="connsiteX5" fmla="*/ 488999 w 575221"/>
                      <a:gd name="connsiteY5" fmla="*/ 666905 h 798398"/>
                      <a:gd name="connsiteX6" fmla="*/ 272125 w 575221"/>
                      <a:gd name="connsiteY6" fmla="*/ 798398 h 798398"/>
                      <a:gd name="connsiteX7" fmla="*/ 73393 w 575221"/>
                      <a:gd name="connsiteY7" fmla="*/ 779348 h 798398"/>
                      <a:gd name="connsiteX8" fmla="*/ 44500 w 575221"/>
                      <a:gd name="connsiteY8" fmla="*/ 603401 h 798398"/>
                      <a:gd name="connsiteX9" fmla="*/ 50 w 575221"/>
                      <a:gd name="connsiteY9" fmla="*/ 228755 h 798398"/>
                      <a:gd name="connsiteX10" fmla="*/ 54342 w 575221"/>
                      <a:gd name="connsiteY10" fmla="*/ 155040 h 798398"/>
                      <a:gd name="connsiteX0" fmla="*/ 47992 w 575221"/>
                      <a:gd name="connsiteY0" fmla="*/ 121896 h 797001"/>
                      <a:gd name="connsiteX1" fmla="*/ 253075 w 575221"/>
                      <a:gd name="connsiteY1" fmla="*/ 1237 h 797001"/>
                      <a:gd name="connsiteX2" fmla="*/ 457249 w 575221"/>
                      <a:gd name="connsiteY2" fmla="*/ 68608 h 797001"/>
                      <a:gd name="connsiteX3" fmla="*/ 546149 w 575221"/>
                      <a:gd name="connsiteY3" fmla="*/ 195605 h 797001"/>
                      <a:gd name="connsiteX4" fmla="*/ 572457 w 575221"/>
                      <a:gd name="connsiteY4" fmla="*/ 399119 h 797001"/>
                      <a:gd name="connsiteX5" fmla="*/ 488999 w 575221"/>
                      <a:gd name="connsiteY5" fmla="*/ 665508 h 797001"/>
                      <a:gd name="connsiteX6" fmla="*/ 272125 w 575221"/>
                      <a:gd name="connsiteY6" fmla="*/ 797001 h 797001"/>
                      <a:gd name="connsiteX7" fmla="*/ 73393 w 575221"/>
                      <a:gd name="connsiteY7" fmla="*/ 777951 h 797001"/>
                      <a:gd name="connsiteX8" fmla="*/ 44500 w 575221"/>
                      <a:gd name="connsiteY8" fmla="*/ 602004 h 797001"/>
                      <a:gd name="connsiteX9" fmla="*/ 50 w 575221"/>
                      <a:gd name="connsiteY9" fmla="*/ 227358 h 797001"/>
                      <a:gd name="connsiteX10" fmla="*/ 47992 w 575221"/>
                      <a:gd name="connsiteY10" fmla="*/ 121896 h 797001"/>
                      <a:gd name="connsiteX0" fmla="*/ 51978 w 579207"/>
                      <a:gd name="connsiteY0" fmla="*/ 121896 h 797001"/>
                      <a:gd name="connsiteX1" fmla="*/ 257061 w 579207"/>
                      <a:gd name="connsiteY1" fmla="*/ 1237 h 797001"/>
                      <a:gd name="connsiteX2" fmla="*/ 461235 w 579207"/>
                      <a:gd name="connsiteY2" fmla="*/ 68608 h 797001"/>
                      <a:gd name="connsiteX3" fmla="*/ 550135 w 579207"/>
                      <a:gd name="connsiteY3" fmla="*/ 195605 h 797001"/>
                      <a:gd name="connsiteX4" fmla="*/ 576443 w 579207"/>
                      <a:gd name="connsiteY4" fmla="*/ 399119 h 797001"/>
                      <a:gd name="connsiteX5" fmla="*/ 492985 w 579207"/>
                      <a:gd name="connsiteY5" fmla="*/ 665508 h 797001"/>
                      <a:gd name="connsiteX6" fmla="*/ 276111 w 579207"/>
                      <a:gd name="connsiteY6" fmla="*/ 797001 h 797001"/>
                      <a:gd name="connsiteX7" fmla="*/ 77379 w 579207"/>
                      <a:gd name="connsiteY7" fmla="*/ 777951 h 797001"/>
                      <a:gd name="connsiteX8" fmla="*/ 3243 w 579207"/>
                      <a:gd name="connsiteY8" fmla="*/ 609148 h 797001"/>
                      <a:gd name="connsiteX9" fmla="*/ 4036 w 579207"/>
                      <a:gd name="connsiteY9" fmla="*/ 227358 h 797001"/>
                      <a:gd name="connsiteX10" fmla="*/ 51978 w 579207"/>
                      <a:gd name="connsiteY10" fmla="*/ 121896 h 797001"/>
                      <a:gd name="connsiteX0" fmla="*/ 44834 w 579207"/>
                      <a:gd name="connsiteY0" fmla="*/ 109558 h 796569"/>
                      <a:gd name="connsiteX1" fmla="*/ 257061 w 579207"/>
                      <a:gd name="connsiteY1" fmla="*/ 805 h 796569"/>
                      <a:gd name="connsiteX2" fmla="*/ 461235 w 579207"/>
                      <a:gd name="connsiteY2" fmla="*/ 68176 h 796569"/>
                      <a:gd name="connsiteX3" fmla="*/ 550135 w 579207"/>
                      <a:gd name="connsiteY3" fmla="*/ 195173 h 796569"/>
                      <a:gd name="connsiteX4" fmla="*/ 576443 w 579207"/>
                      <a:gd name="connsiteY4" fmla="*/ 398687 h 796569"/>
                      <a:gd name="connsiteX5" fmla="*/ 492985 w 579207"/>
                      <a:gd name="connsiteY5" fmla="*/ 665076 h 796569"/>
                      <a:gd name="connsiteX6" fmla="*/ 276111 w 579207"/>
                      <a:gd name="connsiteY6" fmla="*/ 796569 h 796569"/>
                      <a:gd name="connsiteX7" fmla="*/ 77379 w 579207"/>
                      <a:gd name="connsiteY7" fmla="*/ 777519 h 796569"/>
                      <a:gd name="connsiteX8" fmla="*/ 3243 w 579207"/>
                      <a:gd name="connsiteY8" fmla="*/ 608716 h 796569"/>
                      <a:gd name="connsiteX9" fmla="*/ 4036 w 579207"/>
                      <a:gd name="connsiteY9" fmla="*/ 226926 h 796569"/>
                      <a:gd name="connsiteX10" fmla="*/ 44834 w 579207"/>
                      <a:gd name="connsiteY10" fmla="*/ 109558 h 796569"/>
                      <a:gd name="connsiteX0" fmla="*/ 44834 w 579207"/>
                      <a:gd name="connsiteY0" fmla="*/ 109558 h 796569"/>
                      <a:gd name="connsiteX1" fmla="*/ 257061 w 579207"/>
                      <a:gd name="connsiteY1" fmla="*/ 805 h 796569"/>
                      <a:gd name="connsiteX2" fmla="*/ 461235 w 579207"/>
                      <a:gd name="connsiteY2" fmla="*/ 68176 h 796569"/>
                      <a:gd name="connsiteX3" fmla="*/ 550135 w 579207"/>
                      <a:gd name="connsiteY3" fmla="*/ 195173 h 796569"/>
                      <a:gd name="connsiteX4" fmla="*/ 576443 w 579207"/>
                      <a:gd name="connsiteY4" fmla="*/ 398687 h 796569"/>
                      <a:gd name="connsiteX5" fmla="*/ 492985 w 579207"/>
                      <a:gd name="connsiteY5" fmla="*/ 665076 h 796569"/>
                      <a:gd name="connsiteX6" fmla="*/ 276111 w 579207"/>
                      <a:gd name="connsiteY6" fmla="*/ 796569 h 796569"/>
                      <a:gd name="connsiteX7" fmla="*/ 77379 w 579207"/>
                      <a:gd name="connsiteY7" fmla="*/ 777519 h 796569"/>
                      <a:gd name="connsiteX8" fmla="*/ 3243 w 579207"/>
                      <a:gd name="connsiteY8" fmla="*/ 608716 h 796569"/>
                      <a:gd name="connsiteX9" fmla="*/ 4036 w 579207"/>
                      <a:gd name="connsiteY9" fmla="*/ 226926 h 796569"/>
                      <a:gd name="connsiteX10" fmla="*/ 44834 w 579207"/>
                      <a:gd name="connsiteY10" fmla="*/ 109558 h 796569"/>
                      <a:gd name="connsiteX0" fmla="*/ 44834 w 579207"/>
                      <a:gd name="connsiteY0" fmla="*/ 109558 h 796569"/>
                      <a:gd name="connsiteX1" fmla="*/ 257061 w 579207"/>
                      <a:gd name="connsiteY1" fmla="*/ 805 h 796569"/>
                      <a:gd name="connsiteX2" fmla="*/ 461235 w 579207"/>
                      <a:gd name="connsiteY2" fmla="*/ 68176 h 796569"/>
                      <a:gd name="connsiteX3" fmla="*/ 550135 w 579207"/>
                      <a:gd name="connsiteY3" fmla="*/ 195173 h 796569"/>
                      <a:gd name="connsiteX4" fmla="*/ 576443 w 579207"/>
                      <a:gd name="connsiteY4" fmla="*/ 398687 h 796569"/>
                      <a:gd name="connsiteX5" fmla="*/ 492985 w 579207"/>
                      <a:gd name="connsiteY5" fmla="*/ 665076 h 796569"/>
                      <a:gd name="connsiteX6" fmla="*/ 276111 w 579207"/>
                      <a:gd name="connsiteY6" fmla="*/ 796569 h 796569"/>
                      <a:gd name="connsiteX7" fmla="*/ 77379 w 579207"/>
                      <a:gd name="connsiteY7" fmla="*/ 777519 h 796569"/>
                      <a:gd name="connsiteX8" fmla="*/ 3243 w 579207"/>
                      <a:gd name="connsiteY8" fmla="*/ 608716 h 796569"/>
                      <a:gd name="connsiteX9" fmla="*/ 4036 w 579207"/>
                      <a:gd name="connsiteY9" fmla="*/ 226926 h 796569"/>
                      <a:gd name="connsiteX10" fmla="*/ 44834 w 579207"/>
                      <a:gd name="connsiteY10" fmla="*/ 109558 h 796569"/>
                      <a:gd name="connsiteX0" fmla="*/ 44834 w 579207"/>
                      <a:gd name="connsiteY0" fmla="*/ 109558 h 796569"/>
                      <a:gd name="connsiteX1" fmla="*/ 257061 w 579207"/>
                      <a:gd name="connsiteY1" fmla="*/ 805 h 796569"/>
                      <a:gd name="connsiteX2" fmla="*/ 461235 w 579207"/>
                      <a:gd name="connsiteY2" fmla="*/ 68176 h 796569"/>
                      <a:gd name="connsiteX3" fmla="*/ 550135 w 579207"/>
                      <a:gd name="connsiteY3" fmla="*/ 195173 h 796569"/>
                      <a:gd name="connsiteX4" fmla="*/ 576443 w 579207"/>
                      <a:gd name="connsiteY4" fmla="*/ 398687 h 796569"/>
                      <a:gd name="connsiteX5" fmla="*/ 492985 w 579207"/>
                      <a:gd name="connsiteY5" fmla="*/ 665076 h 796569"/>
                      <a:gd name="connsiteX6" fmla="*/ 276111 w 579207"/>
                      <a:gd name="connsiteY6" fmla="*/ 796569 h 796569"/>
                      <a:gd name="connsiteX7" fmla="*/ 77379 w 579207"/>
                      <a:gd name="connsiteY7" fmla="*/ 777519 h 796569"/>
                      <a:gd name="connsiteX8" fmla="*/ 3243 w 579207"/>
                      <a:gd name="connsiteY8" fmla="*/ 608716 h 796569"/>
                      <a:gd name="connsiteX9" fmla="*/ 4036 w 579207"/>
                      <a:gd name="connsiteY9" fmla="*/ 226926 h 796569"/>
                      <a:gd name="connsiteX10" fmla="*/ 44834 w 579207"/>
                      <a:gd name="connsiteY10" fmla="*/ 109558 h 796569"/>
                      <a:gd name="connsiteX0" fmla="*/ 44834 w 579207"/>
                      <a:gd name="connsiteY0" fmla="*/ 93345 h 780356"/>
                      <a:gd name="connsiteX1" fmla="*/ 247536 w 579207"/>
                      <a:gd name="connsiteY1" fmla="*/ 1261 h 780356"/>
                      <a:gd name="connsiteX2" fmla="*/ 461235 w 579207"/>
                      <a:gd name="connsiteY2" fmla="*/ 51963 h 780356"/>
                      <a:gd name="connsiteX3" fmla="*/ 550135 w 579207"/>
                      <a:gd name="connsiteY3" fmla="*/ 178960 h 780356"/>
                      <a:gd name="connsiteX4" fmla="*/ 576443 w 579207"/>
                      <a:gd name="connsiteY4" fmla="*/ 382474 h 780356"/>
                      <a:gd name="connsiteX5" fmla="*/ 492985 w 579207"/>
                      <a:gd name="connsiteY5" fmla="*/ 648863 h 780356"/>
                      <a:gd name="connsiteX6" fmla="*/ 276111 w 579207"/>
                      <a:gd name="connsiteY6" fmla="*/ 780356 h 780356"/>
                      <a:gd name="connsiteX7" fmla="*/ 77379 w 579207"/>
                      <a:gd name="connsiteY7" fmla="*/ 761306 h 780356"/>
                      <a:gd name="connsiteX8" fmla="*/ 3243 w 579207"/>
                      <a:gd name="connsiteY8" fmla="*/ 592503 h 780356"/>
                      <a:gd name="connsiteX9" fmla="*/ 4036 w 579207"/>
                      <a:gd name="connsiteY9" fmla="*/ 210713 h 780356"/>
                      <a:gd name="connsiteX10" fmla="*/ 44834 w 579207"/>
                      <a:gd name="connsiteY10" fmla="*/ 93345 h 780356"/>
                      <a:gd name="connsiteX0" fmla="*/ 44834 w 579207"/>
                      <a:gd name="connsiteY0" fmla="*/ 92586 h 779597"/>
                      <a:gd name="connsiteX1" fmla="*/ 247536 w 579207"/>
                      <a:gd name="connsiteY1" fmla="*/ 502 h 779597"/>
                      <a:gd name="connsiteX2" fmla="*/ 439804 w 579207"/>
                      <a:gd name="connsiteY2" fmla="*/ 63113 h 779597"/>
                      <a:gd name="connsiteX3" fmla="*/ 550135 w 579207"/>
                      <a:gd name="connsiteY3" fmla="*/ 178201 h 779597"/>
                      <a:gd name="connsiteX4" fmla="*/ 576443 w 579207"/>
                      <a:gd name="connsiteY4" fmla="*/ 381715 h 779597"/>
                      <a:gd name="connsiteX5" fmla="*/ 492985 w 579207"/>
                      <a:gd name="connsiteY5" fmla="*/ 648104 h 779597"/>
                      <a:gd name="connsiteX6" fmla="*/ 276111 w 579207"/>
                      <a:gd name="connsiteY6" fmla="*/ 779597 h 779597"/>
                      <a:gd name="connsiteX7" fmla="*/ 77379 w 579207"/>
                      <a:gd name="connsiteY7" fmla="*/ 760547 h 779597"/>
                      <a:gd name="connsiteX8" fmla="*/ 3243 w 579207"/>
                      <a:gd name="connsiteY8" fmla="*/ 591744 h 779597"/>
                      <a:gd name="connsiteX9" fmla="*/ 4036 w 579207"/>
                      <a:gd name="connsiteY9" fmla="*/ 209954 h 779597"/>
                      <a:gd name="connsiteX10" fmla="*/ 44834 w 579207"/>
                      <a:gd name="connsiteY10" fmla="*/ 92586 h 779597"/>
                      <a:gd name="connsiteX0" fmla="*/ 44834 w 579207"/>
                      <a:gd name="connsiteY0" fmla="*/ 82080 h 769091"/>
                      <a:gd name="connsiteX1" fmla="*/ 247536 w 579207"/>
                      <a:gd name="connsiteY1" fmla="*/ 4284 h 769091"/>
                      <a:gd name="connsiteX2" fmla="*/ 439804 w 579207"/>
                      <a:gd name="connsiteY2" fmla="*/ 52607 h 769091"/>
                      <a:gd name="connsiteX3" fmla="*/ 550135 w 579207"/>
                      <a:gd name="connsiteY3" fmla="*/ 167695 h 769091"/>
                      <a:gd name="connsiteX4" fmla="*/ 576443 w 579207"/>
                      <a:gd name="connsiteY4" fmla="*/ 371209 h 769091"/>
                      <a:gd name="connsiteX5" fmla="*/ 492985 w 579207"/>
                      <a:gd name="connsiteY5" fmla="*/ 637598 h 769091"/>
                      <a:gd name="connsiteX6" fmla="*/ 276111 w 579207"/>
                      <a:gd name="connsiteY6" fmla="*/ 769091 h 769091"/>
                      <a:gd name="connsiteX7" fmla="*/ 77379 w 579207"/>
                      <a:gd name="connsiteY7" fmla="*/ 750041 h 769091"/>
                      <a:gd name="connsiteX8" fmla="*/ 3243 w 579207"/>
                      <a:gd name="connsiteY8" fmla="*/ 581238 h 769091"/>
                      <a:gd name="connsiteX9" fmla="*/ 4036 w 579207"/>
                      <a:gd name="connsiteY9" fmla="*/ 199448 h 769091"/>
                      <a:gd name="connsiteX10" fmla="*/ 44834 w 579207"/>
                      <a:gd name="connsiteY10" fmla="*/ 82080 h 769091"/>
                      <a:gd name="connsiteX0" fmla="*/ 44834 w 579207"/>
                      <a:gd name="connsiteY0" fmla="*/ 78633 h 765644"/>
                      <a:gd name="connsiteX1" fmla="*/ 104842 w 579207"/>
                      <a:gd name="connsiteY1" fmla="*/ 22959 h 765644"/>
                      <a:gd name="connsiteX2" fmla="*/ 247536 w 579207"/>
                      <a:gd name="connsiteY2" fmla="*/ 837 h 765644"/>
                      <a:gd name="connsiteX3" fmla="*/ 439804 w 579207"/>
                      <a:gd name="connsiteY3" fmla="*/ 49160 h 765644"/>
                      <a:gd name="connsiteX4" fmla="*/ 550135 w 579207"/>
                      <a:gd name="connsiteY4" fmla="*/ 164248 h 765644"/>
                      <a:gd name="connsiteX5" fmla="*/ 576443 w 579207"/>
                      <a:gd name="connsiteY5" fmla="*/ 367762 h 765644"/>
                      <a:gd name="connsiteX6" fmla="*/ 492985 w 579207"/>
                      <a:gd name="connsiteY6" fmla="*/ 634151 h 765644"/>
                      <a:gd name="connsiteX7" fmla="*/ 276111 w 579207"/>
                      <a:gd name="connsiteY7" fmla="*/ 765644 h 765644"/>
                      <a:gd name="connsiteX8" fmla="*/ 77379 w 579207"/>
                      <a:gd name="connsiteY8" fmla="*/ 746594 h 765644"/>
                      <a:gd name="connsiteX9" fmla="*/ 3243 w 579207"/>
                      <a:gd name="connsiteY9" fmla="*/ 577791 h 765644"/>
                      <a:gd name="connsiteX10" fmla="*/ 4036 w 579207"/>
                      <a:gd name="connsiteY10" fmla="*/ 196001 h 765644"/>
                      <a:gd name="connsiteX11" fmla="*/ 44834 w 579207"/>
                      <a:gd name="connsiteY11" fmla="*/ 78633 h 765644"/>
                      <a:gd name="connsiteX0" fmla="*/ 44834 w 577756"/>
                      <a:gd name="connsiteY0" fmla="*/ 78633 h 765644"/>
                      <a:gd name="connsiteX1" fmla="*/ 104842 w 577756"/>
                      <a:gd name="connsiteY1" fmla="*/ 22959 h 765644"/>
                      <a:gd name="connsiteX2" fmla="*/ 247536 w 577756"/>
                      <a:gd name="connsiteY2" fmla="*/ 837 h 765644"/>
                      <a:gd name="connsiteX3" fmla="*/ 439804 w 577756"/>
                      <a:gd name="connsiteY3" fmla="*/ 49160 h 765644"/>
                      <a:gd name="connsiteX4" fmla="*/ 538229 w 577756"/>
                      <a:gd name="connsiteY4" fmla="*/ 178539 h 765644"/>
                      <a:gd name="connsiteX5" fmla="*/ 576443 w 577756"/>
                      <a:gd name="connsiteY5" fmla="*/ 367762 h 765644"/>
                      <a:gd name="connsiteX6" fmla="*/ 492985 w 577756"/>
                      <a:gd name="connsiteY6" fmla="*/ 634151 h 765644"/>
                      <a:gd name="connsiteX7" fmla="*/ 276111 w 577756"/>
                      <a:gd name="connsiteY7" fmla="*/ 765644 h 765644"/>
                      <a:gd name="connsiteX8" fmla="*/ 77379 w 577756"/>
                      <a:gd name="connsiteY8" fmla="*/ 746594 h 765644"/>
                      <a:gd name="connsiteX9" fmla="*/ 3243 w 577756"/>
                      <a:gd name="connsiteY9" fmla="*/ 577791 h 765644"/>
                      <a:gd name="connsiteX10" fmla="*/ 4036 w 577756"/>
                      <a:gd name="connsiteY10" fmla="*/ 196001 h 765644"/>
                      <a:gd name="connsiteX11" fmla="*/ 44834 w 577756"/>
                      <a:gd name="connsiteY11" fmla="*/ 78633 h 765644"/>
                      <a:gd name="connsiteX0" fmla="*/ 44834 w 577756"/>
                      <a:gd name="connsiteY0" fmla="*/ 79401 h 766412"/>
                      <a:gd name="connsiteX1" fmla="*/ 104842 w 577756"/>
                      <a:gd name="connsiteY1" fmla="*/ 23727 h 766412"/>
                      <a:gd name="connsiteX2" fmla="*/ 247536 w 577756"/>
                      <a:gd name="connsiteY2" fmla="*/ 1605 h 766412"/>
                      <a:gd name="connsiteX3" fmla="*/ 430279 w 577756"/>
                      <a:gd name="connsiteY3" fmla="*/ 64216 h 766412"/>
                      <a:gd name="connsiteX4" fmla="*/ 538229 w 577756"/>
                      <a:gd name="connsiteY4" fmla="*/ 179307 h 766412"/>
                      <a:gd name="connsiteX5" fmla="*/ 576443 w 577756"/>
                      <a:gd name="connsiteY5" fmla="*/ 368530 h 766412"/>
                      <a:gd name="connsiteX6" fmla="*/ 492985 w 577756"/>
                      <a:gd name="connsiteY6" fmla="*/ 634919 h 766412"/>
                      <a:gd name="connsiteX7" fmla="*/ 276111 w 577756"/>
                      <a:gd name="connsiteY7" fmla="*/ 766412 h 766412"/>
                      <a:gd name="connsiteX8" fmla="*/ 77379 w 577756"/>
                      <a:gd name="connsiteY8" fmla="*/ 747362 h 766412"/>
                      <a:gd name="connsiteX9" fmla="*/ 3243 w 577756"/>
                      <a:gd name="connsiteY9" fmla="*/ 578559 h 766412"/>
                      <a:gd name="connsiteX10" fmla="*/ 4036 w 577756"/>
                      <a:gd name="connsiteY10" fmla="*/ 196769 h 766412"/>
                      <a:gd name="connsiteX11" fmla="*/ 44834 w 577756"/>
                      <a:gd name="connsiteY11" fmla="*/ 79401 h 766412"/>
                      <a:gd name="connsiteX0" fmla="*/ 44834 w 577756"/>
                      <a:gd name="connsiteY0" fmla="*/ 65900 h 752911"/>
                      <a:gd name="connsiteX1" fmla="*/ 104842 w 577756"/>
                      <a:gd name="connsiteY1" fmla="*/ 10226 h 752911"/>
                      <a:gd name="connsiteX2" fmla="*/ 240392 w 577756"/>
                      <a:gd name="connsiteY2" fmla="*/ 4773 h 752911"/>
                      <a:gd name="connsiteX3" fmla="*/ 430279 w 577756"/>
                      <a:gd name="connsiteY3" fmla="*/ 50715 h 752911"/>
                      <a:gd name="connsiteX4" fmla="*/ 538229 w 577756"/>
                      <a:gd name="connsiteY4" fmla="*/ 165806 h 752911"/>
                      <a:gd name="connsiteX5" fmla="*/ 576443 w 577756"/>
                      <a:gd name="connsiteY5" fmla="*/ 355029 h 752911"/>
                      <a:gd name="connsiteX6" fmla="*/ 492985 w 577756"/>
                      <a:gd name="connsiteY6" fmla="*/ 621418 h 752911"/>
                      <a:gd name="connsiteX7" fmla="*/ 276111 w 577756"/>
                      <a:gd name="connsiteY7" fmla="*/ 752911 h 752911"/>
                      <a:gd name="connsiteX8" fmla="*/ 77379 w 577756"/>
                      <a:gd name="connsiteY8" fmla="*/ 733861 h 752911"/>
                      <a:gd name="connsiteX9" fmla="*/ 3243 w 577756"/>
                      <a:gd name="connsiteY9" fmla="*/ 565058 h 752911"/>
                      <a:gd name="connsiteX10" fmla="*/ 4036 w 577756"/>
                      <a:gd name="connsiteY10" fmla="*/ 183268 h 752911"/>
                      <a:gd name="connsiteX11" fmla="*/ 44834 w 577756"/>
                      <a:gd name="connsiteY11" fmla="*/ 65900 h 752911"/>
                      <a:gd name="connsiteX0" fmla="*/ 44834 w 577756"/>
                      <a:gd name="connsiteY0" fmla="*/ 62406 h 749417"/>
                      <a:gd name="connsiteX1" fmla="*/ 107223 w 577756"/>
                      <a:gd name="connsiteY1" fmla="*/ 18642 h 749417"/>
                      <a:gd name="connsiteX2" fmla="*/ 240392 w 577756"/>
                      <a:gd name="connsiteY2" fmla="*/ 1279 h 749417"/>
                      <a:gd name="connsiteX3" fmla="*/ 430279 w 577756"/>
                      <a:gd name="connsiteY3" fmla="*/ 47221 h 749417"/>
                      <a:gd name="connsiteX4" fmla="*/ 538229 w 577756"/>
                      <a:gd name="connsiteY4" fmla="*/ 162312 h 749417"/>
                      <a:gd name="connsiteX5" fmla="*/ 576443 w 577756"/>
                      <a:gd name="connsiteY5" fmla="*/ 351535 h 749417"/>
                      <a:gd name="connsiteX6" fmla="*/ 492985 w 577756"/>
                      <a:gd name="connsiteY6" fmla="*/ 617924 h 749417"/>
                      <a:gd name="connsiteX7" fmla="*/ 276111 w 577756"/>
                      <a:gd name="connsiteY7" fmla="*/ 749417 h 749417"/>
                      <a:gd name="connsiteX8" fmla="*/ 77379 w 577756"/>
                      <a:gd name="connsiteY8" fmla="*/ 730367 h 749417"/>
                      <a:gd name="connsiteX9" fmla="*/ 3243 w 577756"/>
                      <a:gd name="connsiteY9" fmla="*/ 561564 h 749417"/>
                      <a:gd name="connsiteX10" fmla="*/ 4036 w 577756"/>
                      <a:gd name="connsiteY10" fmla="*/ 179774 h 749417"/>
                      <a:gd name="connsiteX11" fmla="*/ 44834 w 577756"/>
                      <a:gd name="connsiteY11" fmla="*/ 62406 h 749417"/>
                      <a:gd name="connsiteX0" fmla="*/ 44834 w 577338"/>
                      <a:gd name="connsiteY0" fmla="*/ 62406 h 749417"/>
                      <a:gd name="connsiteX1" fmla="*/ 107223 w 577338"/>
                      <a:gd name="connsiteY1" fmla="*/ 18642 h 749417"/>
                      <a:gd name="connsiteX2" fmla="*/ 240392 w 577338"/>
                      <a:gd name="connsiteY2" fmla="*/ 1279 h 749417"/>
                      <a:gd name="connsiteX3" fmla="*/ 430279 w 577338"/>
                      <a:gd name="connsiteY3" fmla="*/ 47221 h 749417"/>
                      <a:gd name="connsiteX4" fmla="*/ 538229 w 577338"/>
                      <a:gd name="connsiteY4" fmla="*/ 162312 h 749417"/>
                      <a:gd name="connsiteX5" fmla="*/ 576443 w 577338"/>
                      <a:gd name="connsiteY5" fmla="*/ 351535 h 749417"/>
                      <a:gd name="connsiteX6" fmla="*/ 502510 w 577338"/>
                      <a:gd name="connsiteY6" fmla="*/ 617927 h 749417"/>
                      <a:gd name="connsiteX7" fmla="*/ 276111 w 577338"/>
                      <a:gd name="connsiteY7" fmla="*/ 749417 h 749417"/>
                      <a:gd name="connsiteX8" fmla="*/ 77379 w 577338"/>
                      <a:gd name="connsiteY8" fmla="*/ 730367 h 749417"/>
                      <a:gd name="connsiteX9" fmla="*/ 3243 w 577338"/>
                      <a:gd name="connsiteY9" fmla="*/ 561564 h 749417"/>
                      <a:gd name="connsiteX10" fmla="*/ 4036 w 577338"/>
                      <a:gd name="connsiteY10" fmla="*/ 179774 h 749417"/>
                      <a:gd name="connsiteX11" fmla="*/ 44834 w 577338"/>
                      <a:gd name="connsiteY11" fmla="*/ 62406 h 749417"/>
                      <a:gd name="connsiteX0" fmla="*/ 44834 w 577338"/>
                      <a:gd name="connsiteY0" fmla="*/ 62406 h 749417"/>
                      <a:gd name="connsiteX1" fmla="*/ 107223 w 577338"/>
                      <a:gd name="connsiteY1" fmla="*/ 18642 h 749417"/>
                      <a:gd name="connsiteX2" fmla="*/ 240392 w 577338"/>
                      <a:gd name="connsiteY2" fmla="*/ 1279 h 749417"/>
                      <a:gd name="connsiteX3" fmla="*/ 430279 w 577338"/>
                      <a:gd name="connsiteY3" fmla="*/ 47221 h 749417"/>
                      <a:gd name="connsiteX4" fmla="*/ 538229 w 577338"/>
                      <a:gd name="connsiteY4" fmla="*/ 162312 h 749417"/>
                      <a:gd name="connsiteX5" fmla="*/ 576443 w 577338"/>
                      <a:gd name="connsiteY5" fmla="*/ 351535 h 749417"/>
                      <a:gd name="connsiteX6" fmla="*/ 502510 w 577338"/>
                      <a:gd name="connsiteY6" fmla="*/ 617927 h 749417"/>
                      <a:gd name="connsiteX7" fmla="*/ 385827 w 577338"/>
                      <a:gd name="connsiteY7" fmla="*/ 709202 h 749417"/>
                      <a:gd name="connsiteX8" fmla="*/ 276111 w 577338"/>
                      <a:gd name="connsiteY8" fmla="*/ 749417 h 749417"/>
                      <a:gd name="connsiteX9" fmla="*/ 77379 w 577338"/>
                      <a:gd name="connsiteY9" fmla="*/ 730367 h 749417"/>
                      <a:gd name="connsiteX10" fmla="*/ 3243 w 577338"/>
                      <a:gd name="connsiteY10" fmla="*/ 561564 h 749417"/>
                      <a:gd name="connsiteX11" fmla="*/ 4036 w 577338"/>
                      <a:gd name="connsiteY11" fmla="*/ 179774 h 749417"/>
                      <a:gd name="connsiteX12" fmla="*/ 44834 w 577338"/>
                      <a:gd name="connsiteY12" fmla="*/ 62406 h 749417"/>
                      <a:gd name="connsiteX0" fmla="*/ 44834 w 576847"/>
                      <a:gd name="connsiteY0" fmla="*/ 62406 h 749417"/>
                      <a:gd name="connsiteX1" fmla="*/ 107223 w 576847"/>
                      <a:gd name="connsiteY1" fmla="*/ 18642 h 749417"/>
                      <a:gd name="connsiteX2" fmla="*/ 240392 w 576847"/>
                      <a:gd name="connsiteY2" fmla="*/ 1279 h 749417"/>
                      <a:gd name="connsiteX3" fmla="*/ 430279 w 576847"/>
                      <a:gd name="connsiteY3" fmla="*/ 47221 h 749417"/>
                      <a:gd name="connsiteX4" fmla="*/ 538229 w 576847"/>
                      <a:gd name="connsiteY4" fmla="*/ 162312 h 749417"/>
                      <a:gd name="connsiteX5" fmla="*/ 576443 w 576847"/>
                      <a:gd name="connsiteY5" fmla="*/ 351535 h 749417"/>
                      <a:gd name="connsiteX6" fmla="*/ 554899 w 576847"/>
                      <a:gd name="connsiteY6" fmla="*/ 497271 h 749417"/>
                      <a:gd name="connsiteX7" fmla="*/ 502510 w 576847"/>
                      <a:gd name="connsiteY7" fmla="*/ 617927 h 749417"/>
                      <a:gd name="connsiteX8" fmla="*/ 385827 w 576847"/>
                      <a:gd name="connsiteY8" fmla="*/ 709202 h 749417"/>
                      <a:gd name="connsiteX9" fmla="*/ 276111 w 576847"/>
                      <a:gd name="connsiteY9" fmla="*/ 749417 h 749417"/>
                      <a:gd name="connsiteX10" fmla="*/ 77379 w 576847"/>
                      <a:gd name="connsiteY10" fmla="*/ 730367 h 749417"/>
                      <a:gd name="connsiteX11" fmla="*/ 3243 w 576847"/>
                      <a:gd name="connsiteY11" fmla="*/ 561564 h 749417"/>
                      <a:gd name="connsiteX12" fmla="*/ 4036 w 576847"/>
                      <a:gd name="connsiteY12" fmla="*/ 179774 h 749417"/>
                      <a:gd name="connsiteX13" fmla="*/ 44834 w 576847"/>
                      <a:gd name="connsiteY13" fmla="*/ 62406 h 749417"/>
                      <a:gd name="connsiteX0" fmla="*/ 44834 w 576847"/>
                      <a:gd name="connsiteY0" fmla="*/ 62406 h 749417"/>
                      <a:gd name="connsiteX1" fmla="*/ 107223 w 576847"/>
                      <a:gd name="connsiteY1" fmla="*/ 18642 h 749417"/>
                      <a:gd name="connsiteX2" fmla="*/ 240392 w 576847"/>
                      <a:gd name="connsiteY2" fmla="*/ 1279 h 749417"/>
                      <a:gd name="connsiteX3" fmla="*/ 430279 w 576847"/>
                      <a:gd name="connsiteY3" fmla="*/ 47221 h 749417"/>
                      <a:gd name="connsiteX4" fmla="*/ 538229 w 576847"/>
                      <a:gd name="connsiteY4" fmla="*/ 162312 h 749417"/>
                      <a:gd name="connsiteX5" fmla="*/ 576443 w 576847"/>
                      <a:gd name="connsiteY5" fmla="*/ 351535 h 749417"/>
                      <a:gd name="connsiteX6" fmla="*/ 554899 w 576847"/>
                      <a:gd name="connsiteY6" fmla="*/ 497271 h 749417"/>
                      <a:gd name="connsiteX7" fmla="*/ 502510 w 576847"/>
                      <a:gd name="connsiteY7" fmla="*/ 617927 h 749417"/>
                      <a:gd name="connsiteX8" fmla="*/ 385827 w 576847"/>
                      <a:gd name="connsiteY8" fmla="*/ 709202 h 749417"/>
                      <a:gd name="connsiteX9" fmla="*/ 276111 w 576847"/>
                      <a:gd name="connsiteY9" fmla="*/ 749417 h 749417"/>
                      <a:gd name="connsiteX10" fmla="*/ 161993 w 576847"/>
                      <a:gd name="connsiteY10" fmla="*/ 709199 h 749417"/>
                      <a:gd name="connsiteX11" fmla="*/ 77379 w 576847"/>
                      <a:gd name="connsiteY11" fmla="*/ 730367 h 749417"/>
                      <a:gd name="connsiteX12" fmla="*/ 3243 w 576847"/>
                      <a:gd name="connsiteY12" fmla="*/ 561564 h 749417"/>
                      <a:gd name="connsiteX13" fmla="*/ 4036 w 576847"/>
                      <a:gd name="connsiteY13" fmla="*/ 179774 h 749417"/>
                      <a:gd name="connsiteX14" fmla="*/ 44834 w 576847"/>
                      <a:gd name="connsiteY14" fmla="*/ 62406 h 749417"/>
                      <a:gd name="connsiteX0" fmla="*/ 44834 w 576847"/>
                      <a:gd name="connsiteY0" fmla="*/ 62406 h 730367"/>
                      <a:gd name="connsiteX1" fmla="*/ 107223 w 576847"/>
                      <a:gd name="connsiteY1" fmla="*/ 18642 h 730367"/>
                      <a:gd name="connsiteX2" fmla="*/ 240392 w 576847"/>
                      <a:gd name="connsiteY2" fmla="*/ 1279 h 730367"/>
                      <a:gd name="connsiteX3" fmla="*/ 430279 w 576847"/>
                      <a:gd name="connsiteY3" fmla="*/ 47221 h 730367"/>
                      <a:gd name="connsiteX4" fmla="*/ 538229 w 576847"/>
                      <a:gd name="connsiteY4" fmla="*/ 162312 h 730367"/>
                      <a:gd name="connsiteX5" fmla="*/ 576443 w 576847"/>
                      <a:gd name="connsiteY5" fmla="*/ 351535 h 730367"/>
                      <a:gd name="connsiteX6" fmla="*/ 554899 w 576847"/>
                      <a:gd name="connsiteY6" fmla="*/ 497271 h 730367"/>
                      <a:gd name="connsiteX7" fmla="*/ 502510 w 576847"/>
                      <a:gd name="connsiteY7" fmla="*/ 617927 h 730367"/>
                      <a:gd name="connsiteX8" fmla="*/ 385827 w 576847"/>
                      <a:gd name="connsiteY8" fmla="*/ 709202 h 730367"/>
                      <a:gd name="connsiteX9" fmla="*/ 278493 w 576847"/>
                      <a:gd name="connsiteY9" fmla="*/ 723224 h 730367"/>
                      <a:gd name="connsiteX10" fmla="*/ 161993 w 576847"/>
                      <a:gd name="connsiteY10" fmla="*/ 709199 h 730367"/>
                      <a:gd name="connsiteX11" fmla="*/ 77379 w 576847"/>
                      <a:gd name="connsiteY11" fmla="*/ 730367 h 730367"/>
                      <a:gd name="connsiteX12" fmla="*/ 3243 w 576847"/>
                      <a:gd name="connsiteY12" fmla="*/ 561564 h 730367"/>
                      <a:gd name="connsiteX13" fmla="*/ 4036 w 576847"/>
                      <a:gd name="connsiteY13" fmla="*/ 179774 h 730367"/>
                      <a:gd name="connsiteX14" fmla="*/ 44834 w 576847"/>
                      <a:gd name="connsiteY14" fmla="*/ 62406 h 730367"/>
                      <a:gd name="connsiteX0" fmla="*/ 44834 w 576847"/>
                      <a:gd name="connsiteY0" fmla="*/ 62406 h 723224"/>
                      <a:gd name="connsiteX1" fmla="*/ 107223 w 576847"/>
                      <a:gd name="connsiteY1" fmla="*/ 18642 h 723224"/>
                      <a:gd name="connsiteX2" fmla="*/ 240392 w 576847"/>
                      <a:gd name="connsiteY2" fmla="*/ 1279 h 723224"/>
                      <a:gd name="connsiteX3" fmla="*/ 430279 w 576847"/>
                      <a:gd name="connsiteY3" fmla="*/ 47221 h 723224"/>
                      <a:gd name="connsiteX4" fmla="*/ 538229 w 576847"/>
                      <a:gd name="connsiteY4" fmla="*/ 162312 h 723224"/>
                      <a:gd name="connsiteX5" fmla="*/ 576443 w 576847"/>
                      <a:gd name="connsiteY5" fmla="*/ 351535 h 723224"/>
                      <a:gd name="connsiteX6" fmla="*/ 554899 w 576847"/>
                      <a:gd name="connsiteY6" fmla="*/ 497271 h 723224"/>
                      <a:gd name="connsiteX7" fmla="*/ 502510 w 576847"/>
                      <a:gd name="connsiteY7" fmla="*/ 617927 h 723224"/>
                      <a:gd name="connsiteX8" fmla="*/ 385827 w 576847"/>
                      <a:gd name="connsiteY8" fmla="*/ 709202 h 723224"/>
                      <a:gd name="connsiteX9" fmla="*/ 278493 w 576847"/>
                      <a:gd name="connsiteY9" fmla="*/ 723224 h 723224"/>
                      <a:gd name="connsiteX10" fmla="*/ 161993 w 576847"/>
                      <a:gd name="connsiteY10" fmla="*/ 709199 h 723224"/>
                      <a:gd name="connsiteX11" fmla="*/ 65473 w 576847"/>
                      <a:gd name="connsiteY11" fmla="*/ 680361 h 723224"/>
                      <a:gd name="connsiteX12" fmla="*/ 3243 w 576847"/>
                      <a:gd name="connsiteY12" fmla="*/ 561564 h 723224"/>
                      <a:gd name="connsiteX13" fmla="*/ 4036 w 576847"/>
                      <a:gd name="connsiteY13" fmla="*/ 179774 h 723224"/>
                      <a:gd name="connsiteX14" fmla="*/ 44834 w 576847"/>
                      <a:gd name="connsiteY14" fmla="*/ 62406 h 723224"/>
                      <a:gd name="connsiteX0" fmla="*/ 41078 w 573091"/>
                      <a:gd name="connsiteY0" fmla="*/ 62406 h 723224"/>
                      <a:gd name="connsiteX1" fmla="*/ 103467 w 573091"/>
                      <a:gd name="connsiteY1" fmla="*/ 18642 h 723224"/>
                      <a:gd name="connsiteX2" fmla="*/ 236636 w 573091"/>
                      <a:gd name="connsiteY2" fmla="*/ 1279 h 723224"/>
                      <a:gd name="connsiteX3" fmla="*/ 426523 w 573091"/>
                      <a:gd name="connsiteY3" fmla="*/ 47221 h 723224"/>
                      <a:gd name="connsiteX4" fmla="*/ 534473 w 573091"/>
                      <a:gd name="connsiteY4" fmla="*/ 162312 h 723224"/>
                      <a:gd name="connsiteX5" fmla="*/ 572687 w 573091"/>
                      <a:gd name="connsiteY5" fmla="*/ 351535 h 723224"/>
                      <a:gd name="connsiteX6" fmla="*/ 551143 w 573091"/>
                      <a:gd name="connsiteY6" fmla="*/ 497271 h 723224"/>
                      <a:gd name="connsiteX7" fmla="*/ 498754 w 573091"/>
                      <a:gd name="connsiteY7" fmla="*/ 617927 h 723224"/>
                      <a:gd name="connsiteX8" fmla="*/ 382071 w 573091"/>
                      <a:gd name="connsiteY8" fmla="*/ 709202 h 723224"/>
                      <a:gd name="connsiteX9" fmla="*/ 274737 w 573091"/>
                      <a:gd name="connsiteY9" fmla="*/ 723224 h 723224"/>
                      <a:gd name="connsiteX10" fmla="*/ 158237 w 573091"/>
                      <a:gd name="connsiteY10" fmla="*/ 709199 h 723224"/>
                      <a:gd name="connsiteX11" fmla="*/ 61717 w 573091"/>
                      <a:gd name="connsiteY11" fmla="*/ 680361 h 723224"/>
                      <a:gd name="connsiteX12" fmla="*/ 11393 w 573091"/>
                      <a:gd name="connsiteY12" fmla="*/ 554423 h 723224"/>
                      <a:gd name="connsiteX13" fmla="*/ 280 w 573091"/>
                      <a:gd name="connsiteY13" fmla="*/ 179774 h 723224"/>
                      <a:gd name="connsiteX14" fmla="*/ 41078 w 573091"/>
                      <a:gd name="connsiteY14" fmla="*/ 62406 h 723224"/>
                      <a:gd name="connsiteX0" fmla="*/ 43044 w 575057"/>
                      <a:gd name="connsiteY0" fmla="*/ 62406 h 723224"/>
                      <a:gd name="connsiteX1" fmla="*/ 105433 w 575057"/>
                      <a:gd name="connsiteY1" fmla="*/ 18642 h 723224"/>
                      <a:gd name="connsiteX2" fmla="*/ 238602 w 575057"/>
                      <a:gd name="connsiteY2" fmla="*/ 1279 h 723224"/>
                      <a:gd name="connsiteX3" fmla="*/ 428489 w 575057"/>
                      <a:gd name="connsiteY3" fmla="*/ 47221 h 723224"/>
                      <a:gd name="connsiteX4" fmla="*/ 536439 w 575057"/>
                      <a:gd name="connsiteY4" fmla="*/ 162312 h 723224"/>
                      <a:gd name="connsiteX5" fmla="*/ 574653 w 575057"/>
                      <a:gd name="connsiteY5" fmla="*/ 351535 h 723224"/>
                      <a:gd name="connsiteX6" fmla="*/ 553109 w 575057"/>
                      <a:gd name="connsiteY6" fmla="*/ 497271 h 723224"/>
                      <a:gd name="connsiteX7" fmla="*/ 500720 w 575057"/>
                      <a:gd name="connsiteY7" fmla="*/ 617927 h 723224"/>
                      <a:gd name="connsiteX8" fmla="*/ 384037 w 575057"/>
                      <a:gd name="connsiteY8" fmla="*/ 709202 h 723224"/>
                      <a:gd name="connsiteX9" fmla="*/ 276703 w 575057"/>
                      <a:gd name="connsiteY9" fmla="*/ 723224 h 723224"/>
                      <a:gd name="connsiteX10" fmla="*/ 160203 w 575057"/>
                      <a:gd name="connsiteY10" fmla="*/ 709199 h 723224"/>
                      <a:gd name="connsiteX11" fmla="*/ 63683 w 575057"/>
                      <a:gd name="connsiteY11" fmla="*/ 680361 h 723224"/>
                      <a:gd name="connsiteX12" fmla="*/ 13359 w 575057"/>
                      <a:gd name="connsiteY12" fmla="*/ 554423 h 723224"/>
                      <a:gd name="connsiteX13" fmla="*/ 2246 w 575057"/>
                      <a:gd name="connsiteY13" fmla="*/ 179774 h 723224"/>
                      <a:gd name="connsiteX14" fmla="*/ 43044 w 575057"/>
                      <a:gd name="connsiteY14" fmla="*/ 62406 h 723224"/>
                      <a:gd name="connsiteX0" fmla="*/ 46838 w 578851"/>
                      <a:gd name="connsiteY0" fmla="*/ 62406 h 723224"/>
                      <a:gd name="connsiteX1" fmla="*/ 109227 w 578851"/>
                      <a:gd name="connsiteY1" fmla="*/ 18642 h 723224"/>
                      <a:gd name="connsiteX2" fmla="*/ 242396 w 578851"/>
                      <a:gd name="connsiteY2" fmla="*/ 1279 h 723224"/>
                      <a:gd name="connsiteX3" fmla="*/ 432283 w 578851"/>
                      <a:gd name="connsiteY3" fmla="*/ 47221 h 723224"/>
                      <a:gd name="connsiteX4" fmla="*/ 540233 w 578851"/>
                      <a:gd name="connsiteY4" fmla="*/ 162312 h 723224"/>
                      <a:gd name="connsiteX5" fmla="*/ 578447 w 578851"/>
                      <a:gd name="connsiteY5" fmla="*/ 351535 h 723224"/>
                      <a:gd name="connsiteX6" fmla="*/ 556903 w 578851"/>
                      <a:gd name="connsiteY6" fmla="*/ 497271 h 723224"/>
                      <a:gd name="connsiteX7" fmla="*/ 504514 w 578851"/>
                      <a:gd name="connsiteY7" fmla="*/ 617927 h 723224"/>
                      <a:gd name="connsiteX8" fmla="*/ 387831 w 578851"/>
                      <a:gd name="connsiteY8" fmla="*/ 709202 h 723224"/>
                      <a:gd name="connsiteX9" fmla="*/ 280497 w 578851"/>
                      <a:gd name="connsiteY9" fmla="*/ 723224 h 723224"/>
                      <a:gd name="connsiteX10" fmla="*/ 163997 w 578851"/>
                      <a:gd name="connsiteY10" fmla="*/ 709199 h 723224"/>
                      <a:gd name="connsiteX11" fmla="*/ 67477 w 578851"/>
                      <a:gd name="connsiteY11" fmla="*/ 680361 h 723224"/>
                      <a:gd name="connsiteX12" fmla="*/ 10009 w 578851"/>
                      <a:gd name="connsiteY12" fmla="*/ 554426 h 723224"/>
                      <a:gd name="connsiteX13" fmla="*/ 6040 w 578851"/>
                      <a:gd name="connsiteY13" fmla="*/ 179774 h 723224"/>
                      <a:gd name="connsiteX14" fmla="*/ 46838 w 578851"/>
                      <a:gd name="connsiteY14" fmla="*/ 62406 h 723224"/>
                      <a:gd name="connsiteX0" fmla="*/ 46838 w 578851"/>
                      <a:gd name="connsiteY0" fmla="*/ 62406 h 723224"/>
                      <a:gd name="connsiteX1" fmla="*/ 109227 w 578851"/>
                      <a:gd name="connsiteY1" fmla="*/ 18642 h 723224"/>
                      <a:gd name="connsiteX2" fmla="*/ 242396 w 578851"/>
                      <a:gd name="connsiteY2" fmla="*/ 1279 h 723224"/>
                      <a:gd name="connsiteX3" fmla="*/ 432283 w 578851"/>
                      <a:gd name="connsiteY3" fmla="*/ 47221 h 723224"/>
                      <a:gd name="connsiteX4" fmla="*/ 540233 w 578851"/>
                      <a:gd name="connsiteY4" fmla="*/ 162312 h 723224"/>
                      <a:gd name="connsiteX5" fmla="*/ 578447 w 578851"/>
                      <a:gd name="connsiteY5" fmla="*/ 351535 h 723224"/>
                      <a:gd name="connsiteX6" fmla="*/ 556903 w 578851"/>
                      <a:gd name="connsiteY6" fmla="*/ 497271 h 723224"/>
                      <a:gd name="connsiteX7" fmla="*/ 504514 w 578851"/>
                      <a:gd name="connsiteY7" fmla="*/ 617927 h 723224"/>
                      <a:gd name="connsiteX8" fmla="*/ 387831 w 578851"/>
                      <a:gd name="connsiteY8" fmla="*/ 709202 h 723224"/>
                      <a:gd name="connsiteX9" fmla="*/ 280497 w 578851"/>
                      <a:gd name="connsiteY9" fmla="*/ 723224 h 723224"/>
                      <a:gd name="connsiteX10" fmla="*/ 163997 w 578851"/>
                      <a:gd name="connsiteY10" fmla="*/ 709199 h 723224"/>
                      <a:gd name="connsiteX11" fmla="*/ 67477 w 578851"/>
                      <a:gd name="connsiteY11" fmla="*/ 680361 h 723224"/>
                      <a:gd name="connsiteX12" fmla="*/ 10009 w 578851"/>
                      <a:gd name="connsiteY12" fmla="*/ 554426 h 723224"/>
                      <a:gd name="connsiteX13" fmla="*/ 6040 w 578851"/>
                      <a:gd name="connsiteY13" fmla="*/ 179774 h 723224"/>
                      <a:gd name="connsiteX14" fmla="*/ 46838 w 578851"/>
                      <a:gd name="connsiteY14" fmla="*/ 62406 h 723224"/>
                      <a:gd name="connsiteX0" fmla="*/ 46838 w 578851"/>
                      <a:gd name="connsiteY0" fmla="*/ 62406 h 723224"/>
                      <a:gd name="connsiteX1" fmla="*/ 109227 w 578851"/>
                      <a:gd name="connsiteY1" fmla="*/ 18642 h 723224"/>
                      <a:gd name="connsiteX2" fmla="*/ 242396 w 578851"/>
                      <a:gd name="connsiteY2" fmla="*/ 1279 h 723224"/>
                      <a:gd name="connsiteX3" fmla="*/ 432283 w 578851"/>
                      <a:gd name="connsiteY3" fmla="*/ 47221 h 723224"/>
                      <a:gd name="connsiteX4" fmla="*/ 540233 w 578851"/>
                      <a:gd name="connsiteY4" fmla="*/ 162312 h 723224"/>
                      <a:gd name="connsiteX5" fmla="*/ 578447 w 578851"/>
                      <a:gd name="connsiteY5" fmla="*/ 351535 h 723224"/>
                      <a:gd name="connsiteX6" fmla="*/ 556903 w 578851"/>
                      <a:gd name="connsiteY6" fmla="*/ 497271 h 723224"/>
                      <a:gd name="connsiteX7" fmla="*/ 504514 w 578851"/>
                      <a:gd name="connsiteY7" fmla="*/ 617927 h 723224"/>
                      <a:gd name="connsiteX8" fmla="*/ 387831 w 578851"/>
                      <a:gd name="connsiteY8" fmla="*/ 709202 h 723224"/>
                      <a:gd name="connsiteX9" fmla="*/ 280497 w 578851"/>
                      <a:gd name="connsiteY9" fmla="*/ 723224 h 723224"/>
                      <a:gd name="connsiteX10" fmla="*/ 163997 w 578851"/>
                      <a:gd name="connsiteY10" fmla="*/ 709199 h 723224"/>
                      <a:gd name="connsiteX11" fmla="*/ 67477 w 578851"/>
                      <a:gd name="connsiteY11" fmla="*/ 680361 h 723224"/>
                      <a:gd name="connsiteX12" fmla="*/ 10009 w 578851"/>
                      <a:gd name="connsiteY12" fmla="*/ 554426 h 723224"/>
                      <a:gd name="connsiteX13" fmla="*/ 6040 w 578851"/>
                      <a:gd name="connsiteY13" fmla="*/ 179774 h 723224"/>
                      <a:gd name="connsiteX14" fmla="*/ 46838 w 578851"/>
                      <a:gd name="connsiteY14" fmla="*/ 62406 h 723224"/>
                      <a:gd name="connsiteX0" fmla="*/ 46838 w 578851"/>
                      <a:gd name="connsiteY0" fmla="*/ 62406 h 723224"/>
                      <a:gd name="connsiteX1" fmla="*/ 109227 w 578851"/>
                      <a:gd name="connsiteY1" fmla="*/ 18642 h 723224"/>
                      <a:gd name="connsiteX2" fmla="*/ 242396 w 578851"/>
                      <a:gd name="connsiteY2" fmla="*/ 1279 h 723224"/>
                      <a:gd name="connsiteX3" fmla="*/ 432283 w 578851"/>
                      <a:gd name="connsiteY3" fmla="*/ 47221 h 723224"/>
                      <a:gd name="connsiteX4" fmla="*/ 540233 w 578851"/>
                      <a:gd name="connsiteY4" fmla="*/ 162312 h 723224"/>
                      <a:gd name="connsiteX5" fmla="*/ 578447 w 578851"/>
                      <a:gd name="connsiteY5" fmla="*/ 351535 h 723224"/>
                      <a:gd name="connsiteX6" fmla="*/ 556903 w 578851"/>
                      <a:gd name="connsiteY6" fmla="*/ 497271 h 723224"/>
                      <a:gd name="connsiteX7" fmla="*/ 504514 w 578851"/>
                      <a:gd name="connsiteY7" fmla="*/ 617927 h 723224"/>
                      <a:gd name="connsiteX8" fmla="*/ 387831 w 578851"/>
                      <a:gd name="connsiteY8" fmla="*/ 709202 h 723224"/>
                      <a:gd name="connsiteX9" fmla="*/ 280497 w 578851"/>
                      <a:gd name="connsiteY9" fmla="*/ 723224 h 723224"/>
                      <a:gd name="connsiteX10" fmla="*/ 163997 w 578851"/>
                      <a:gd name="connsiteY10" fmla="*/ 709199 h 723224"/>
                      <a:gd name="connsiteX11" fmla="*/ 67477 w 578851"/>
                      <a:gd name="connsiteY11" fmla="*/ 680361 h 723224"/>
                      <a:gd name="connsiteX12" fmla="*/ 10009 w 578851"/>
                      <a:gd name="connsiteY12" fmla="*/ 554426 h 723224"/>
                      <a:gd name="connsiteX13" fmla="*/ 6040 w 578851"/>
                      <a:gd name="connsiteY13" fmla="*/ 179774 h 723224"/>
                      <a:gd name="connsiteX14" fmla="*/ 46838 w 578851"/>
                      <a:gd name="connsiteY14" fmla="*/ 62406 h 723224"/>
                      <a:gd name="connsiteX0" fmla="*/ 46838 w 578851"/>
                      <a:gd name="connsiteY0" fmla="*/ 63632 h 724450"/>
                      <a:gd name="connsiteX1" fmla="*/ 109227 w 578851"/>
                      <a:gd name="connsiteY1" fmla="*/ 19868 h 724450"/>
                      <a:gd name="connsiteX2" fmla="*/ 242396 w 578851"/>
                      <a:gd name="connsiteY2" fmla="*/ 2505 h 724450"/>
                      <a:gd name="connsiteX3" fmla="*/ 427520 w 578851"/>
                      <a:gd name="connsiteY3" fmla="*/ 67500 h 724450"/>
                      <a:gd name="connsiteX4" fmla="*/ 540233 w 578851"/>
                      <a:gd name="connsiteY4" fmla="*/ 163538 h 724450"/>
                      <a:gd name="connsiteX5" fmla="*/ 578447 w 578851"/>
                      <a:gd name="connsiteY5" fmla="*/ 352761 h 724450"/>
                      <a:gd name="connsiteX6" fmla="*/ 556903 w 578851"/>
                      <a:gd name="connsiteY6" fmla="*/ 498497 h 724450"/>
                      <a:gd name="connsiteX7" fmla="*/ 504514 w 578851"/>
                      <a:gd name="connsiteY7" fmla="*/ 619153 h 724450"/>
                      <a:gd name="connsiteX8" fmla="*/ 387831 w 578851"/>
                      <a:gd name="connsiteY8" fmla="*/ 710428 h 724450"/>
                      <a:gd name="connsiteX9" fmla="*/ 280497 w 578851"/>
                      <a:gd name="connsiteY9" fmla="*/ 724450 h 724450"/>
                      <a:gd name="connsiteX10" fmla="*/ 163997 w 578851"/>
                      <a:gd name="connsiteY10" fmla="*/ 710425 h 724450"/>
                      <a:gd name="connsiteX11" fmla="*/ 67477 w 578851"/>
                      <a:gd name="connsiteY11" fmla="*/ 681587 h 724450"/>
                      <a:gd name="connsiteX12" fmla="*/ 10009 w 578851"/>
                      <a:gd name="connsiteY12" fmla="*/ 555652 h 724450"/>
                      <a:gd name="connsiteX13" fmla="*/ 6040 w 578851"/>
                      <a:gd name="connsiteY13" fmla="*/ 181000 h 724450"/>
                      <a:gd name="connsiteX14" fmla="*/ 46838 w 578851"/>
                      <a:gd name="connsiteY14" fmla="*/ 63632 h 724450"/>
                      <a:gd name="connsiteX0" fmla="*/ 46838 w 578851"/>
                      <a:gd name="connsiteY0" fmla="*/ 49621 h 710439"/>
                      <a:gd name="connsiteX1" fmla="*/ 109227 w 578851"/>
                      <a:gd name="connsiteY1" fmla="*/ 5857 h 710439"/>
                      <a:gd name="connsiteX2" fmla="*/ 247158 w 578851"/>
                      <a:gd name="connsiteY2" fmla="*/ 12309 h 710439"/>
                      <a:gd name="connsiteX3" fmla="*/ 427520 w 578851"/>
                      <a:gd name="connsiteY3" fmla="*/ 53489 h 710439"/>
                      <a:gd name="connsiteX4" fmla="*/ 540233 w 578851"/>
                      <a:gd name="connsiteY4" fmla="*/ 149527 h 710439"/>
                      <a:gd name="connsiteX5" fmla="*/ 578447 w 578851"/>
                      <a:gd name="connsiteY5" fmla="*/ 338750 h 710439"/>
                      <a:gd name="connsiteX6" fmla="*/ 556903 w 578851"/>
                      <a:gd name="connsiteY6" fmla="*/ 484486 h 710439"/>
                      <a:gd name="connsiteX7" fmla="*/ 504514 w 578851"/>
                      <a:gd name="connsiteY7" fmla="*/ 605142 h 710439"/>
                      <a:gd name="connsiteX8" fmla="*/ 387831 w 578851"/>
                      <a:gd name="connsiteY8" fmla="*/ 696417 h 710439"/>
                      <a:gd name="connsiteX9" fmla="*/ 280497 w 578851"/>
                      <a:gd name="connsiteY9" fmla="*/ 710439 h 710439"/>
                      <a:gd name="connsiteX10" fmla="*/ 163997 w 578851"/>
                      <a:gd name="connsiteY10" fmla="*/ 696414 h 710439"/>
                      <a:gd name="connsiteX11" fmla="*/ 67477 w 578851"/>
                      <a:gd name="connsiteY11" fmla="*/ 667576 h 710439"/>
                      <a:gd name="connsiteX12" fmla="*/ 10009 w 578851"/>
                      <a:gd name="connsiteY12" fmla="*/ 541641 h 710439"/>
                      <a:gd name="connsiteX13" fmla="*/ 6040 w 578851"/>
                      <a:gd name="connsiteY13" fmla="*/ 166989 h 710439"/>
                      <a:gd name="connsiteX14" fmla="*/ 46838 w 578851"/>
                      <a:gd name="connsiteY14" fmla="*/ 49621 h 710439"/>
                      <a:gd name="connsiteX0" fmla="*/ 46838 w 578851"/>
                      <a:gd name="connsiteY0" fmla="*/ 38306 h 699124"/>
                      <a:gd name="connsiteX1" fmla="*/ 113989 w 578851"/>
                      <a:gd name="connsiteY1" fmla="*/ 18355 h 699124"/>
                      <a:gd name="connsiteX2" fmla="*/ 247158 w 578851"/>
                      <a:gd name="connsiteY2" fmla="*/ 994 h 699124"/>
                      <a:gd name="connsiteX3" fmla="*/ 427520 w 578851"/>
                      <a:gd name="connsiteY3" fmla="*/ 42174 h 699124"/>
                      <a:gd name="connsiteX4" fmla="*/ 540233 w 578851"/>
                      <a:gd name="connsiteY4" fmla="*/ 138212 h 699124"/>
                      <a:gd name="connsiteX5" fmla="*/ 578447 w 578851"/>
                      <a:gd name="connsiteY5" fmla="*/ 327435 h 699124"/>
                      <a:gd name="connsiteX6" fmla="*/ 556903 w 578851"/>
                      <a:gd name="connsiteY6" fmla="*/ 473171 h 699124"/>
                      <a:gd name="connsiteX7" fmla="*/ 504514 w 578851"/>
                      <a:gd name="connsiteY7" fmla="*/ 593827 h 699124"/>
                      <a:gd name="connsiteX8" fmla="*/ 387831 w 578851"/>
                      <a:gd name="connsiteY8" fmla="*/ 685102 h 699124"/>
                      <a:gd name="connsiteX9" fmla="*/ 280497 w 578851"/>
                      <a:gd name="connsiteY9" fmla="*/ 699124 h 699124"/>
                      <a:gd name="connsiteX10" fmla="*/ 163997 w 578851"/>
                      <a:gd name="connsiteY10" fmla="*/ 685099 h 699124"/>
                      <a:gd name="connsiteX11" fmla="*/ 67477 w 578851"/>
                      <a:gd name="connsiteY11" fmla="*/ 656261 h 699124"/>
                      <a:gd name="connsiteX12" fmla="*/ 10009 w 578851"/>
                      <a:gd name="connsiteY12" fmla="*/ 530326 h 699124"/>
                      <a:gd name="connsiteX13" fmla="*/ 6040 w 578851"/>
                      <a:gd name="connsiteY13" fmla="*/ 155674 h 699124"/>
                      <a:gd name="connsiteX14" fmla="*/ 46838 w 578851"/>
                      <a:gd name="connsiteY14" fmla="*/ 38306 h 699124"/>
                      <a:gd name="connsiteX0" fmla="*/ 56363 w 578851"/>
                      <a:gd name="connsiteY0" fmla="*/ 64503 h 699124"/>
                      <a:gd name="connsiteX1" fmla="*/ 113989 w 578851"/>
                      <a:gd name="connsiteY1" fmla="*/ 18355 h 699124"/>
                      <a:gd name="connsiteX2" fmla="*/ 247158 w 578851"/>
                      <a:gd name="connsiteY2" fmla="*/ 994 h 699124"/>
                      <a:gd name="connsiteX3" fmla="*/ 427520 w 578851"/>
                      <a:gd name="connsiteY3" fmla="*/ 42174 h 699124"/>
                      <a:gd name="connsiteX4" fmla="*/ 540233 w 578851"/>
                      <a:gd name="connsiteY4" fmla="*/ 138212 h 699124"/>
                      <a:gd name="connsiteX5" fmla="*/ 578447 w 578851"/>
                      <a:gd name="connsiteY5" fmla="*/ 327435 h 699124"/>
                      <a:gd name="connsiteX6" fmla="*/ 556903 w 578851"/>
                      <a:gd name="connsiteY6" fmla="*/ 473171 h 699124"/>
                      <a:gd name="connsiteX7" fmla="*/ 504514 w 578851"/>
                      <a:gd name="connsiteY7" fmla="*/ 593827 h 699124"/>
                      <a:gd name="connsiteX8" fmla="*/ 387831 w 578851"/>
                      <a:gd name="connsiteY8" fmla="*/ 685102 h 699124"/>
                      <a:gd name="connsiteX9" fmla="*/ 280497 w 578851"/>
                      <a:gd name="connsiteY9" fmla="*/ 699124 h 699124"/>
                      <a:gd name="connsiteX10" fmla="*/ 163997 w 578851"/>
                      <a:gd name="connsiteY10" fmla="*/ 685099 h 699124"/>
                      <a:gd name="connsiteX11" fmla="*/ 67477 w 578851"/>
                      <a:gd name="connsiteY11" fmla="*/ 656261 h 699124"/>
                      <a:gd name="connsiteX12" fmla="*/ 10009 w 578851"/>
                      <a:gd name="connsiteY12" fmla="*/ 530326 h 699124"/>
                      <a:gd name="connsiteX13" fmla="*/ 6040 w 578851"/>
                      <a:gd name="connsiteY13" fmla="*/ 155674 h 699124"/>
                      <a:gd name="connsiteX14" fmla="*/ 56363 w 578851"/>
                      <a:gd name="connsiteY14" fmla="*/ 64503 h 699124"/>
                      <a:gd name="connsiteX0" fmla="*/ 54888 w 577376"/>
                      <a:gd name="connsiteY0" fmla="*/ 64503 h 699124"/>
                      <a:gd name="connsiteX1" fmla="*/ 112514 w 577376"/>
                      <a:gd name="connsiteY1" fmla="*/ 18355 h 699124"/>
                      <a:gd name="connsiteX2" fmla="*/ 245683 w 577376"/>
                      <a:gd name="connsiteY2" fmla="*/ 994 h 699124"/>
                      <a:gd name="connsiteX3" fmla="*/ 426045 w 577376"/>
                      <a:gd name="connsiteY3" fmla="*/ 42174 h 699124"/>
                      <a:gd name="connsiteX4" fmla="*/ 538758 w 577376"/>
                      <a:gd name="connsiteY4" fmla="*/ 138212 h 699124"/>
                      <a:gd name="connsiteX5" fmla="*/ 576972 w 577376"/>
                      <a:gd name="connsiteY5" fmla="*/ 327435 h 699124"/>
                      <a:gd name="connsiteX6" fmla="*/ 555428 w 577376"/>
                      <a:gd name="connsiteY6" fmla="*/ 473171 h 699124"/>
                      <a:gd name="connsiteX7" fmla="*/ 503039 w 577376"/>
                      <a:gd name="connsiteY7" fmla="*/ 593827 h 699124"/>
                      <a:gd name="connsiteX8" fmla="*/ 386356 w 577376"/>
                      <a:gd name="connsiteY8" fmla="*/ 685102 h 699124"/>
                      <a:gd name="connsiteX9" fmla="*/ 279022 w 577376"/>
                      <a:gd name="connsiteY9" fmla="*/ 699124 h 699124"/>
                      <a:gd name="connsiteX10" fmla="*/ 162522 w 577376"/>
                      <a:gd name="connsiteY10" fmla="*/ 685099 h 699124"/>
                      <a:gd name="connsiteX11" fmla="*/ 66002 w 577376"/>
                      <a:gd name="connsiteY11" fmla="*/ 656261 h 699124"/>
                      <a:gd name="connsiteX12" fmla="*/ 8534 w 577376"/>
                      <a:gd name="connsiteY12" fmla="*/ 530326 h 699124"/>
                      <a:gd name="connsiteX13" fmla="*/ 9327 w 577376"/>
                      <a:gd name="connsiteY13" fmla="*/ 162821 h 699124"/>
                      <a:gd name="connsiteX14" fmla="*/ 54888 w 577376"/>
                      <a:gd name="connsiteY14" fmla="*/ 64503 h 699124"/>
                      <a:gd name="connsiteX0" fmla="*/ 46430 w 568918"/>
                      <a:gd name="connsiteY0" fmla="*/ 64503 h 699124"/>
                      <a:gd name="connsiteX1" fmla="*/ 104056 w 568918"/>
                      <a:gd name="connsiteY1" fmla="*/ 18355 h 699124"/>
                      <a:gd name="connsiteX2" fmla="*/ 237225 w 568918"/>
                      <a:gd name="connsiteY2" fmla="*/ 994 h 699124"/>
                      <a:gd name="connsiteX3" fmla="*/ 417587 w 568918"/>
                      <a:gd name="connsiteY3" fmla="*/ 42174 h 699124"/>
                      <a:gd name="connsiteX4" fmla="*/ 530300 w 568918"/>
                      <a:gd name="connsiteY4" fmla="*/ 138212 h 699124"/>
                      <a:gd name="connsiteX5" fmla="*/ 568514 w 568918"/>
                      <a:gd name="connsiteY5" fmla="*/ 327435 h 699124"/>
                      <a:gd name="connsiteX6" fmla="*/ 546970 w 568918"/>
                      <a:gd name="connsiteY6" fmla="*/ 473171 h 699124"/>
                      <a:gd name="connsiteX7" fmla="*/ 494581 w 568918"/>
                      <a:gd name="connsiteY7" fmla="*/ 593827 h 699124"/>
                      <a:gd name="connsiteX8" fmla="*/ 377898 w 568918"/>
                      <a:gd name="connsiteY8" fmla="*/ 685102 h 699124"/>
                      <a:gd name="connsiteX9" fmla="*/ 270564 w 568918"/>
                      <a:gd name="connsiteY9" fmla="*/ 699124 h 699124"/>
                      <a:gd name="connsiteX10" fmla="*/ 154064 w 568918"/>
                      <a:gd name="connsiteY10" fmla="*/ 685099 h 699124"/>
                      <a:gd name="connsiteX11" fmla="*/ 57544 w 568918"/>
                      <a:gd name="connsiteY11" fmla="*/ 656261 h 699124"/>
                      <a:gd name="connsiteX12" fmla="*/ 16745 w 568918"/>
                      <a:gd name="connsiteY12" fmla="*/ 518420 h 699124"/>
                      <a:gd name="connsiteX13" fmla="*/ 869 w 568918"/>
                      <a:gd name="connsiteY13" fmla="*/ 162821 h 699124"/>
                      <a:gd name="connsiteX14" fmla="*/ 46430 w 568918"/>
                      <a:gd name="connsiteY14" fmla="*/ 64503 h 699124"/>
                      <a:gd name="connsiteX0" fmla="*/ 46430 w 568918"/>
                      <a:gd name="connsiteY0" fmla="*/ 64503 h 699124"/>
                      <a:gd name="connsiteX1" fmla="*/ 104056 w 568918"/>
                      <a:gd name="connsiteY1" fmla="*/ 18355 h 699124"/>
                      <a:gd name="connsiteX2" fmla="*/ 237225 w 568918"/>
                      <a:gd name="connsiteY2" fmla="*/ 994 h 699124"/>
                      <a:gd name="connsiteX3" fmla="*/ 417587 w 568918"/>
                      <a:gd name="connsiteY3" fmla="*/ 42174 h 699124"/>
                      <a:gd name="connsiteX4" fmla="*/ 530300 w 568918"/>
                      <a:gd name="connsiteY4" fmla="*/ 138212 h 699124"/>
                      <a:gd name="connsiteX5" fmla="*/ 568514 w 568918"/>
                      <a:gd name="connsiteY5" fmla="*/ 327435 h 699124"/>
                      <a:gd name="connsiteX6" fmla="*/ 546970 w 568918"/>
                      <a:gd name="connsiteY6" fmla="*/ 473171 h 699124"/>
                      <a:gd name="connsiteX7" fmla="*/ 494581 w 568918"/>
                      <a:gd name="connsiteY7" fmla="*/ 593827 h 699124"/>
                      <a:gd name="connsiteX8" fmla="*/ 377898 w 568918"/>
                      <a:gd name="connsiteY8" fmla="*/ 685102 h 699124"/>
                      <a:gd name="connsiteX9" fmla="*/ 270564 w 568918"/>
                      <a:gd name="connsiteY9" fmla="*/ 699124 h 699124"/>
                      <a:gd name="connsiteX10" fmla="*/ 154064 w 568918"/>
                      <a:gd name="connsiteY10" fmla="*/ 685099 h 699124"/>
                      <a:gd name="connsiteX11" fmla="*/ 71831 w 568918"/>
                      <a:gd name="connsiteY11" fmla="*/ 641973 h 699124"/>
                      <a:gd name="connsiteX12" fmla="*/ 16745 w 568918"/>
                      <a:gd name="connsiteY12" fmla="*/ 518420 h 699124"/>
                      <a:gd name="connsiteX13" fmla="*/ 869 w 568918"/>
                      <a:gd name="connsiteY13" fmla="*/ 162821 h 699124"/>
                      <a:gd name="connsiteX14" fmla="*/ 46430 w 568918"/>
                      <a:gd name="connsiteY14" fmla="*/ 64503 h 699124"/>
                      <a:gd name="connsiteX0" fmla="*/ 46430 w 568918"/>
                      <a:gd name="connsiteY0" fmla="*/ 64503 h 699124"/>
                      <a:gd name="connsiteX1" fmla="*/ 104056 w 568918"/>
                      <a:gd name="connsiteY1" fmla="*/ 18355 h 699124"/>
                      <a:gd name="connsiteX2" fmla="*/ 237225 w 568918"/>
                      <a:gd name="connsiteY2" fmla="*/ 994 h 699124"/>
                      <a:gd name="connsiteX3" fmla="*/ 417587 w 568918"/>
                      <a:gd name="connsiteY3" fmla="*/ 42174 h 699124"/>
                      <a:gd name="connsiteX4" fmla="*/ 530300 w 568918"/>
                      <a:gd name="connsiteY4" fmla="*/ 138212 h 699124"/>
                      <a:gd name="connsiteX5" fmla="*/ 568514 w 568918"/>
                      <a:gd name="connsiteY5" fmla="*/ 327435 h 699124"/>
                      <a:gd name="connsiteX6" fmla="*/ 546970 w 568918"/>
                      <a:gd name="connsiteY6" fmla="*/ 473171 h 699124"/>
                      <a:gd name="connsiteX7" fmla="*/ 494581 w 568918"/>
                      <a:gd name="connsiteY7" fmla="*/ 593827 h 699124"/>
                      <a:gd name="connsiteX8" fmla="*/ 377898 w 568918"/>
                      <a:gd name="connsiteY8" fmla="*/ 685102 h 699124"/>
                      <a:gd name="connsiteX9" fmla="*/ 270564 w 568918"/>
                      <a:gd name="connsiteY9" fmla="*/ 699124 h 699124"/>
                      <a:gd name="connsiteX10" fmla="*/ 163589 w 568918"/>
                      <a:gd name="connsiteY10" fmla="*/ 675574 h 699124"/>
                      <a:gd name="connsiteX11" fmla="*/ 71831 w 568918"/>
                      <a:gd name="connsiteY11" fmla="*/ 641973 h 699124"/>
                      <a:gd name="connsiteX12" fmla="*/ 16745 w 568918"/>
                      <a:gd name="connsiteY12" fmla="*/ 518420 h 699124"/>
                      <a:gd name="connsiteX13" fmla="*/ 869 w 568918"/>
                      <a:gd name="connsiteY13" fmla="*/ 162821 h 699124"/>
                      <a:gd name="connsiteX14" fmla="*/ 46430 w 568918"/>
                      <a:gd name="connsiteY14" fmla="*/ 64503 h 699124"/>
                      <a:gd name="connsiteX0" fmla="*/ 46430 w 568918"/>
                      <a:gd name="connsiteY0" fmla="*/ 64503 h 694429"/>
                      <a:gd name="connsiteX1" fmla="*/ 104056 w 568918"/>
                      <a:gd name="connsiteY1" fmla="*/ 18355 h 694429"/>
                      <a:gd name="connsiteX2" fmla="*/ 237225 w 568918"/>
                      <a:gd name="connsiteY2" fmla="*/ 994 h 694429"/>
                      <a:gd name="connsiteX3" fmla="*/ 417587 w 568918"/>
                      <a:gd name="connsiteY3" fmla="*/ 42174 h 694429"/>
                      <a:gd name="connsiteX4" fmla="*/ 530300 w 568918"/>
                      <a:gd name="connsiteY4" fmla="*/ 138212 h 694429"/>
                      <a:gd name="connsiteX5" fmla="*/ 568514 w 568918"/>
                      <a:gd name="connsiteY5" fmla="*/ 327435 h 694429"/>
                      <a:gd name="connsiteX6" fmla="*/ 546970 w 568918"/>
                      <a:gd name="connsiteY6" fmla="*/ 473171 h 694429"/>
                      <a:gd name="connsiteX7" fmla="*/ 494581 w 568918"/>
                      <a:gd name="connsiteY7" fmla="*/ 593827 h 694429"/>
                      <a:gd name="connsiteX8" fmla="*/ 377898 w 568918"/>
                      <a:gd name="connsiteY8" fmla="*/ 685102 h 694429"/>
                      <a:gd name="connsiteX9" fmla="*/ 275327 w 568918"/>
                      <a:gd name="connsiteY9" fmla="*/ 687217 h 694429"/>
                      <a:gd name="connsiteX10" fmla="*/ 163589 w 568918"/>
                      <a:gd name="connsiteY10" fmla="*/ 675574 h 694429"/>
                      <a:gd name="connsiteX11" fmla="*/ 71831 w 568918"/>
                      <a:gd name="connsiteY11" fmla="*/ 641973 h 694429"/>
                      <a:gd name="connsiteX12" fmla="*/ 16745 w 568918"/>
                      <a:gd name="connsiteY12" fmla="*/ 518420 h 694429"/>
                      <a:gd name="connsiteX13" fmla="*/ 869 w 568918"/>
                      <a:gd name="connsiteY13" fmla="*/ 162821 h 694429"/>
                      <a:gd name="connsiteX14" fmla="*/ 46430 w 568918"/>
                      <a:gd name="connsiteY14" fmla="*/ 64503 h 694429"/>
                      <a:gd name="connsiteX0" fmla="*/ 46430 w 568918"/>
                      <a:gd name="connsiteY0" fmla="*/ 64503 h 687217"/>
                      <a:gd name="connsiteX1" fmla="*/ 104056 w 568918"/>
                      <a:gd name="connsiteY1" fmla="*/ 18355 h 687217"/>
                      <a:gd name="connsiteX2" fmla="*/ 237225 w 568918"/>
                      <a:gd name="connsiteY2" fmla="*/ 994 h 687217"/>
                      <a:gd name="connsiteX3" fmla="*/ 417587 w 568918"/>
                      <a:gd name="connsiteY3" fmla="*/ 42174 h 687217"/>
                      <a:gd name="connsiteX4" fmla="*/ 530300 w 568918"/>
                      <a:gd name="connsiteY4" fmla="*/ 138212 h 687217"/>
                      <a:gd name="connsiteX5" fmla="*/ 568514 w 568918"/>
                      <a:gd name="connsiteY5" fmla="*/ 327435 h 687217"/>
                      <a:gd name="connsiteX6" fmla="*/ 546970 w 568918"/>
                      <a:gd name="connsiteY6" fmla="*/ 473171 h 687217"/>
                      <a:gd name="connsiteX7" fmla="*/ 494581 w 568918"/>
                      <a:gd name="connsiteY7" fmla="*/ 593827 h 687217"/>
                      <a:gd name="connsiteX8" fmla="*/ 375514 w 568918"/>
                      <a:gd name="connsiteY8" fmla="*/ 666055 h 687217"/>
                      <a:gd name="connsiteX9" fmla="*/ 275327 w 568918"/>
                      <a:gd name="connsiteY9" fmla="*/ 687217 h 687217"/>
                      <a:gd name="connsiteX10" fmla="*/ 163589 w 568918"/>
                      <a:gd name="connsiteY10" fmla="*/ 675574 h 687217"/>
                      <a:gd name="connsiteX11" fmla="*/ 71831 w 568918"/>
                      <a:gd name="connsiteY11" fmla="*/ 641973 h 687217"/>
                      <a:gd name="connsiteX12" fmla="*/ 16745 w 568918"/>
                      <a:gd name="connsiteY12" fmla="*/ 518420 h 687217"/>
                      <a:gd name="connsiteX13" fmla="*/ 869 w 568918"/>
                      <a:gd name="connsiteY13" fmla="*/ 162821 h 687217"/>
                      <a:gd name="connsiteX14" fmla="*/ 46430 w 568918"/>
                      <a:gd name="connsiteY14" fmla="*/ 64503 h 687217"/>
                      <a:gd name="connsiteX0" fmla="*/ 46430 w 568918"/>
                      <a:gd name="connsiteY0" fmla="*/ 64503 h 687217"/>
                      <a:gd name="connsiteX1" fmla="*/ 104056 w 568918"/>
                      <a:gd name="connsiteY1" fmla="*/ 18355 h 687217"/>
                      <a:gd name="connsiteX2" fmla="*/ 237225 w 568918"/>
                      <a:gd name="connsiteY2" fmla="*/ 994 h 687217"/>
                      <a:gd name="connsiteX3" fmla="*/ 417587 w 568918"/>
                      <a:gd name="connsiteY3" fmla="*/ 42174 h 687217"/>
                      <a:gd name="connsiteX4" fmla="*/ 530300 w 568918"/>
                      <a:gd name="connsiteY4" fmla="*/ 138212 h 687217"/>
                      <a:gd name="connsiteX5" fmla="*/ 568514 w 568918"/>
                      <a:gd name="connsiteY5" fmla="*/ 327435 h 687217"/>
                      <a:gd name="connsiteX6" fmla="*/ 546970 w 568918"/>
                      <a:gd name="connsiteY6" fmla="*/ 473171 h 687217"/>
                      <a:gd name="connsiteX7" fmla="*/ 494581 w 568918"/>
                      <a:gd name="connsiteY7" fmla="*/ 586686 h 687217"/>
                      <a:gd name="connsiteX8" fmla="*/ 375514 w 568918"/>
                      <a:gd name="connsiteY8" fmla="*/ 666055 h 687217"/>
                      <a:gd name="connsiteX9" fmla="*/ 275327 w 568918"/>
                      <a:gd name="connsiteY9" fmla="*/ 687217 h 687217"/>
                      <a:gd name="connsiteX10" fmla="*/ 163589 w 568918"/>
                      <a:gd name="connsiteY10" fmla="*/ 675574 h 687217"/>
                      <a:gd name="connsiteX11" fmla="*/ 71831 w 568918"/>
                      <a:gd name="connsiteY11" fmla="*/ 641973 h 687217"/>
                      <a:gd name="connsiteX12" fmla="*/ 16745 w 568918"/>
                      <a:gd name="connsiteY12" fmla="*/ 518420 h 687217"/>
                      <a:gd name="connsiteX13" fmla="*/ 869 w 568918"/>
                      <a:gd name="connsiteY13" fmla="*/ 162821 h 687217"/>
                      <a:gd name="connsiteX14" fmla="*/ 46430 w 568918"/>
                      <a:gd name="connsiteY14" fmla="*/ 64503 h 687217"/>
                      <a:gd name="connsiteX0" fmla="*/ 46430 w 568918"/>
                      <a:gd name="connsiteY0" fmla="*/ 64503 h 687217"/>
                      <a:gd name="connsiteX1" fmla="*/ 104056 w 568918"/>
                      <a:gd name="connsiteY1" fmla="*/ 18355 h 687217"/>
                      <a:gd name="connsiteX2" fmla="*/ 237225 w 568918"/>
                      <a:gd name="connsiteY2" fmla="*/ 994 h 687217"/>
                      <a:gd name="connsiteX3" fmla="*/ 417587 w 568918"/>
                      <a:gd name="connsiteY3" fmla="*/ 42174 h 687217"/>
                      <a:gd name="connsiteX4" fmla="*/ 530300 w 568918"/>
                      <a:gd name="connsiteY4" fmla="*/ 138212 h 687217"/>
                      <a:gd name="connsiteX5" fmla="*/ 568514 w 568918"/>
                      <a:gd name="connsiteY5" fmla="*/ 327435 h 687217"/>
                      <a:gd name="connsiteX6" fmla="*/ 546970 w 568918"/>
                      <a:gd name="connsiteY6" fmla="*/ 473171 h 687217"/>
                      <a:gd name="connsiteX7" fmla="*/ 494581 w 568918"/>
                      <a:gd name="connsiteY7" fmla="*/ 586686 h 687217"/>
                      <a:gd name="connsiteX8" fmla="*/ 375514 w 568918"/>
                      <a:gd name="connsiteY8" fmla="*/ 666055 h 687217"/>
                      <a:gd name="connsiteX9" fmla="*/ 275327 w 568918"/>
                      <a:gd name="connsiteY9" fmla="*/ 687217 h 687217"/>
                      <a:gd name="connsiteX10" fmla="*/ 163589 w 568918"/>
                      <a:gd name="connsiteY10" fmla="*/ 675574 h 687217"/>
                      <a:gd name="connsiteX11" fmla="*/ 71831 w 568918"/>
                      <a:gd name="connsiteY11" fmla="*/ 641973 h 687217"/>
                      <a:gd name="connsiteX12" fmla="*/ 16745 w 568918"/>
                      <a:gd name="connsiteY12" fmla="*/ 518420 h 687217"/>
                      <a:gd name="connsiteX13" fmla="*/ 869 w 568918"/>
                      <a:gd name="connsiteY13" fmla="*/ 200924 h 687217"/>
                      <a:gd name="connsiteX14" fmla="*/ 46430 w 568918"/>
                      <a:gd name="connsiteY14" fmla="*/ 64503 h 687217"/>
                      <a:gd name="connsiteX0" fmla="*/ 50686 w 573174"/>
                      <a:gd name="connsiteY0" fmla="*/ 64503 h 687217"/>
                      <a:gd name="connsiteX1" fmla="*/ 108312 w 573174"/>
                      <a:gd name="connsiteY1" fmla="*/ 18355 h 687217"/>
                      <a:gd name="connsiteX2" fmla="*/ 241481 w 573174"/>
                      <a:gd name="connsiteY2" fmla="*/ 994 h 687217"/>
                      <a:gd name="connsiteX3" fmla="*/ 421843 w 573174"/>
                      <a:gd name="connsiteY3" fmla="*/ 42174 h 687217"/>
                      <a:gd name="connsiteX4" fmla="*/ 534556 w 573174"/>
                      <a:gd name="connsiteY4" fmla="*/ 138212 h 687217"/>
                      <a:gd name="connsiteX5" fmla="*/ 572770 w 573174"/>
                      <a:gd name="connsiteY5" fmla="*/ 327435 h 687217"/>
                      <a:gd name="connsiteX6" fmla="*/ 551226 w 573174"/>
                      <a:gd name="connsiteY6" fmla="*/ 473171 h 687217"/>
                      <a:gd name="connsiteX7" fmla="*/ 498837 w 573174"/>
                      <a:gd name="connsiteY7" fmla="*/ 586686 h 687217"/>
                      <a:gd name="connsiteX8" fmla="*/ 379770 w 573174"/>
                      <a:gd name="connsiteY8" fmla="*/ 666055 h 687217"/>
                      <a:gd name="connsiteX9" fmla="*/ 279583 w 573174"/>
                      <a:gd name="connsiteY9" fmla="*/ 687217 h 687217"/>
                      <a:gd name="connsiteX10" fmla="*/ 167845 w 573174"/>
                      <a:gd name="connsiteY10" fmla="*/ 675574 h 687217"/>
                      <a:gd name="connsiteX11" fmla="*/ 76087 w 573174"/>
                      <a:gd name="connsiteY11" fmla="*/ 641973 h 687217"/>
                      <a:gd name="connsiteX12" fmla="*/ 21001 w 573174"/>
                      <a:gd name="connsiteY12" fmla="*/ 518420 h 687217"/>
                      <a:gd name="connsiteX13" fmla="*/ 361 w 573174"/>
                      <a:gd name="connsiteY13" fmla="*/ 296177 h 687217"/>
                      <a:gd name="connsiteX14" fmla="*/ 50686 w 573174"/>
                      <a:gd name="connsiteY14" fmla="*/ 64503 h 687217"/>
                      <a:gd name="connsiteX0" fmla="*/ 41161 w 573174"/>
                      <a:gd name="connsiteY0" fmla="*/ 95462 h 687217"/>
                      <a:gd name="connsiteX1" fmla="*/ 108312 w 573174"/>
                      <a:gd name="connsiteY1" fmla="*/ 18355 h 687217"/>
                      <a:gd name="connsiteX2" fmla="*/ 241481 w 573174"/>
                      <a:gd name="connsiteY2" fmla="*/ 994 h 687217"/>
                      <a:gd name="connsiteX3" fmla="*/ 421843 w 573174"/>
                      <a:gd name="connsiteY3" fmla="*/ 42174 h 687217"/>
                      <a:gd name="connsiteX4" fmla="*/ 534556 w 573174"/>
                      <a:gd name="connsiteY4" fmla="*/ 138212 h 687217"/>
                      <a:gd name="connsiteX5" fmla="*/ 572770 w 573174"/>
                      <a:gd name="connsiteY5" fmla="*/ 327435 h 687217"/>
                      <a:gd name="connsiteX6" fmla="*/ 551226 w 573174"/>
                      <a:gd name="connsiteY6" fmla="*/ 473171 h 687217"/>
                      <a:gd name="connsiteX7" fmla="*/ 498837 w 573174"/>
                      <a:gd name="connsiteY7" fmla="*/ 586686 h 687217"/>
                      <a:gd name="connsiteX8" fmla="*/ 379770 w 573174"/>
                      <a:gd name="connsiteY8" fmla="*/ 666055 h 687217"/>
                      <a:gd name="connsiteX9" fmla="*/ 279583 w 573174"/>
                      <a:gd name="connsiteY9" fmla="*/ 687217 h 687217"/>
                      <a:gd name="connsiteX10" fmla="*/ 167845 w 573174"/>
                      <a:gd name="connsiteY10" fmla="*/ 675574 h 687217"/>
                      <a:gd name="connsiteX11" fmla="*/ 76087 w 573174"/>
                      <a:gd name="connsiteY11" fmla="*/ 641973 h 687217"/>
                      <a:gd name="connsiteX12" fmla="*/ 21001 w 573174"/>
                      <a:gd name="connsiteY12" fmla="*/ 518420 h 687217"/>
                      <a:gd name="connsiteX13" fmla="*/ 361 w 573174"/>
                      <a:gd name="connsiteY13" fmla="*/ 296177 h 687217"/>
                      <a:gd name="connsiteX14" fmla="*/ 41161 w 573174"/>
                      <a:gd name="connsiteY14" fmla="*/ 95462 h 687217"/>
                      <a:gd name="connsiteX0" fmla="*/ 41161 w 573489"/>
                      <a:gd name="connsiteY0" fmla="*/ 95462 h 687217"/>
                      <a:gd name="connsiteX1" fmla="*/ 108312 w 573489"/>
                      <a:gd name="connsiteY1" fmla="*/ 18355 h 687217"/>
                      <a:gd name="connsiteX2" fmla="*/ 241481 w 573489"/>
                      <a:gd name="connsiteY2" fmla="*/ 994 h 687217"/>
                      <a:gd name="connsiteX3" fmla="*/ 421843 w 573489"/>
                      <a:gd name="connsiteY3" fmla="*/ 42174 h 687217"/>
                      <a:gd name="connsiteX4" fmla="*/ 527412 w 573489"/>
                      <a:gd name="connsiteY4" fmla="*/ 142978 h 687217"/>
                      <a:gd name="connsiteX5" fmla="*/ 572770 w 573489"/>
                      <a:gd name="connsiteY5" fmla="*/ 327435 h 687217"/>
                      <a:gd name="connsiteX6" fmla="*/ 551226 w 573489"/>
                      <a:gd name="connsiteY6" fmla="*/ 473171 h 687217"/>
                      <a:gd name="connsiteX7" fmla="*/ 498837 w 573489"/>
                      <a:gd name="connsiteY7" fmla="*/ 586686 h 687217"/>
                      <a:gd name="connsiteX8" fmla="*/ 379770 w 573489"/>
                      <a:gd name="connsiteY8" fmla="*/ 666055 h 687217"/>
                      <a:gd name="connsiteX9" fmla="*/ 279583 w 573489"/>
                      <a:gd name="connsiteY9" fmla="*/ 687217 h 687217"/>
                      <a:gd name="connsiteX10" fmla="*/ 167845 w 573489"/>
                      <a:gd name="connsiteY10" fmla="*/ 675574 h 687217"/>
                      <a:gd name="connsiteX11" fmla="*/ 76087 w 573489"/>
                      <a:gd name="connsiteY11" fmla="*/ 641973 h 687217"/>
                      <a:gd name="connsiteX12" fmla="*/ 21001 w 573489"/>
                      <a:gd name="connsiteY12" fmla="*/ 518420 h 687217"/>
                      <a:gd name="connsiteX13" fmla="*/ 361 w 573489"/>
                      <a:gd name="connsiteY13" fmla="*/ 296177 h 687217"/>
                      <a:gd name="connsiteX14" fmla="*/ 41161 w 573489"/>
                      <a:gd name="connsiteY14" fmla="*/ 95462 h 687217"/>
                      <a:gd name="connsiteX0" fmla="*/ 41161 w 566836"/>
                      <a:gd name="connsiteY0" fmla="*/ 95462 h 687217"/>
                      <a:gd name="connsiteX1" fmla="*/ 108312 w 566836"/>
                      <a:gd name="connsiteY1" fmla="*/ 18355 h 687217"/>
                      <a:gd name="connsiteX2" fmla="*/ 241481 w 566836"/>
                      <a:gd name="connsiteY2" fmla="*/ 994 h 687217"/>
                      <a:gd name="connsiteX3" fmla="*/ 421843 w 566836"/>
                      <a:gd name="connsiteY3" fmla="*/ 42174 h 687217"/>
                      <a:gd name="connsiteX4" fmla="*/ 527412 w 566836"/>
                      <a:gd name="connsiteY4" fmla="*/ 142978 h 687217"/>
                      <a:gd name="connsiteX5" fmla="*/ 565626 w 566836"/>
                      <a:gd name="connsiteY5" fmla="*/ 327435 h 687217"/>
                      <a:gd name="connsiteX6" fmla="*/ 551226 w 566836"/>
                      <a:gd name="connsiteY6" fmla="*/ 473171 h 687217"/>
                      <a:gd name="connsiteX7" fmla="*/ 498837 w 566836"/>
                      <a:gd name="connsiteY7" fmla="*/ 586686 h 687217"/>
                      <a:gd name="connsiteX8" fmla="*/ 379770 w 566836"/>
                      <a:gd name="connsiteY8" fmla="*/ 666055 h 687217"/>
                      <a:gd name="connsiteX9" fmla="*/ 279583 w 566836"/>
                      <a:gd name="connsiteY9" fmla="*/ 687217 h 687217"/>
                      <a:gd name="connsiteX10" fmla="*/ 167845 w 566836"/>
                      <a:gd name="connsiteY10" fmla="*/ 675574 h 687217"/>
                      <a:gd name="connsiteX11" fmla="*/ 76087 w 566836"/>
                      <a:gd name="connsiteY11" fmla="*/ 641973 h 687217"/>
                      <a:gd name="connsiteX12" fmla="*/ 21001 w 566836"/>
                      <a:gd name="connsiteY12" fmla="*/ 518420 h 687217"/>
                      <a:gd name="connsiteX13" fmla="*/ 361 w 566836"/>
                      <a:gd name="connsiteY13" fmla="*/ 296177 h 687217"/>
                      <a:gd name="connsiteX14" fmla="*/ 41161 w 566836"/>
                      <a:gd name="connsiteY14" fmla="*/ 95462 h 687217"/>
                      <a:gd name="connsiteX0" fmla="*/ 41161 w 566479"/>
                      <a:gd name="connsiteY0" fmla="*/ 95462 h 687217"/>
                      <a:gd name="connsiteX1" fmla="*/ 108312 w 566479"/>
                      <a:gd name="connsiteY1" fmla="*/ 18355 h 687217"/>
                      <a:gd name="connsiteX2" fmla="*/ 241481 w 566479"/>
                      <a:gd name="connsiteY2" fmla="*/ 994 h 687217"/>
                      <a:gd name="connsiteX3" fmla="*/ 421843 w 566479"/>
                      <a:gd name="connsiteY3" fmla="*/ 42174 h 687217"/>
                      <a:gd name="connsiteX4" fmla="*/ 527412 w 566479"/>
                      <a:gd name="connsiteY4" fmla="*/ 142978 h 687217"/>
                      <a:gd name="connsiteX5" fmla="*/ 565626 w 566479"/>
                      <a:gd name="connsiteY5" fmla="*/ 327435 h 687217"/>
                      <a:gd name="connsiteX6" fmla="*/ 548844 w 566479"/>
                      <a:gd name="connsiteY6" fmla="*/ 463649 h 687217"/>
                      <a:gd name="connsiteX7" fmla="*/ 498837 w 566479"/>
                      <a:gd name="connsiteY7" fmla="*/ 586686 h 687217"/>
                      <a:gd name="connsiteX8" fmla="*/ 379770 w 566479"/>
                      <a:gd name="connsiteY8" fmla="*/ 666055 h 687217"/>
                      <a:gd name="connsiteX9" fmla="*/ 279583 w 566479"/>
                      <a:gd name="connsiteY9" fmla="*/ 687217 h 687217"/>
                      <a:gd name="connsiteX10" fmla="*/ 167845 w 566479"/>
                      <a:gd name="connsiteY10" fmla="*/ 675574 h 687217"/>
                      <a:gd name="connsiteX11" fmla="*/ 76087 w 566479"/>
                      <a:gd name="connsiteY11" fmla="*/ 641973 h 687217"/>
                      <a:gd name="connsiteX12" fmla="*/ 21001 w 566479"/>
                      <a:gd name="connsiteY12" fmla="*/ 518420 h 687217"/>
                      <a:gd name="connsiteX13" fmla="*/ 361 w 566479"/>
                      <a:gd name="connsiteY13" fmla="*/ 296177 h 687217"/>
                      <a:gd name="connsiteX14" fmla="*/ 41161 w 566479"/>
                      <a:gd name="connsiteY14" fmla="*/ 95462 h 687217"/>
                      <a:gd name="connsiteX0" fmla="*/ 41161 w 566479"/>
                      <a:gd name="connsiteY0" fmla="*/ 95462 h 687217"/>
                      <a:gd name="connsiteX1" fmla="*/ 108312 w 566479"/>
                      <a:gd name="connsiteY1" fmla="*/ 18355 h 687217"/>
                      <a:gd name="connsiteX2" fmla="*/ 241481 w 566479"/>
                      <a:gd name="connsiteY2" fmla="*/ 994 h 687217"/>
                      <a:gd name="connsiteX3" fmla="*/ 421843 w 566479"/>
                      <a:gd name="connsiteY3" fmla="*/ 42174 h 687217"/>
                      <a:gd name="connsiteX4" fmla="*/ 527412 w 566479"/>
                      <a:gd name="connsiteY4" fmla="*/ 142978 h 687217"/>
                      <a:gd name="connsiteX5" fmla="*/ 565626 w 566479"/>
                      <a:gd name="connsiteY5" fmla="*/ 327435 h 687217"/>
                      <a:gd name="connsiteX6" fmla="*/ 548844 w 566479"/>
                      <a:gd name="connsiteY6" fmla="*/ 463649 h 687217"/>
                      <a:gd name="connsiteX7" fmla="*/ 489312 w 566479"/>
                      <a:gd name="connsiteY7" fmla="*/ 574780 h 687217"/>
                      <a:gd name="connsiteX8" fmla="*/ 379770 w 566479"/>
                      <a:gd name="connsiteY8" fmla="*/ 666055 h 687217"/>
                      <a:gd name="connsiteX9" fmla="*/ 279583 w 566479"/>
                      <a:gd name="connsiteY9" fmla="*/ 687217 h 687217"/>
                      <a:gd name="connsiteX10" fmla="*/ 167845 w 566479"/>
                      <a:gd name="connsiteY10" fmla="*/ 675574 h 687217"/>
                      <a:gd name="connsiteX11" fmla="*/ 76087 w 566479"/>
                      <a:gd name="connsiteY11" fmla="*/ 641973 h 687217"/>
                      <a:gd name="connsiteX12" fmla="*/ 21001 w 566479"/>
                      <a:gd name="connsiteY12" fmla="*/ 518420 h 687217"/>
                      <a:gd name="connsiteX13" fmla="*/ 361 w 566479"/>
                      <a:gd name="connsiteY13" fmla="*/ 296177 h 687217"/>
                      <a:gd name="connsiteX14" fmla="*/ 41161 w 566479"/>
                      <a:gd name="connsiteY14" fmla="*/ 95462 h 687217"/>
                      <a:gd name="connsiteX0" fmla="*/ 41161 w 566479"/>
                      <a:gd name="connsiteY0" fmla="*/ 95462 h 687217"/>
                      <a:gd name="connsiteX1" fmla="*/ 108312 w 566479"/>
                      <a:gd name="connsiteY1" fmla="*/ 18355 h 687217"/>
                      <a:gd name="connsiteX2" fmla="*/ 241481 w 566479"/>
                      <a:gd name="connsiteY2" fmla="*/ 994 h 687217"/>
                      <a:gd name="connsiteX3" fmla="*/ 421843 w 566479"/>
                      <a:gd name="connsiteY3" fmla="*/ 42174 h 687217"/>
                      <a:gd name="connsiteX4" fmla="*/ 527412 w 566479"/>
                      <a:gd name="connsiteY4" fmla="*/ 142978 h 687217"/>
                      <a:gd name="connsiteX5" fmla="*/ 565626 w 566479"/>
                      <a:gd name="connsiteY5" fmla="*/ 327435 h 687217"/>
                      <a:gd name="connsiteX6" fmla="*/ 548844 w 566479"/>
                      <a:gd name="connsiteY6" fmla="*/ 463649 h 687217"/>
                      <a:gd name="connsiteX7" fmla="*/ 489312 w 566479"/>
                      <a:gd name="connsiteY7" fmla="*/ 574780 h 687217"/>
                      <a:gd name="connsiteX8" fmla="*/ 370245 w 566479"/>
                      <a:gd name="connsiteY8" fmla="*/ 647005 h 687217"/>
                      <a:gd name="connsiteX9" fmla="*/ 279583 w 566479"/>
                      <a:gd name="connsiteY9" fmla="*/ 687217 h 687217"/>
                      <a:gd name="connsiteX10" fmla="*/ 167845 w 566479"/>
                      <a:gd name="connsiteY10" fmla="*/ 675574 h 687217"/>
                      <a:gd name="connsiteX11" fmla="*/ 76087 w 566479"/>
                      <a:gd name="connsiteY11" fmla="*/ 641973 h 687217"/>
                      <a:gd name="connsiteX12" fmla="*/ 21001 w 566479"/>
                      <a:gd name="connsiteY12" fmla="*/ 518420 h 687217"/>
                      <a:gd name="connsiteX13" fmla="*/ 361 w 566479"/>
                      <a:gd name="connsiteY13" fmla="*/ 296177 h 687217"/>
                      <a:gd name="connsiteX14" fmla="*/ 41161 w 566479"/>
                      <a:gd name="connsiteY14" fmla="*/ 95462 h 687217"/>
                      <a:gd name="connsiteX0" fmla="*/ 41161 w 566479"/>
                      <a:gd name="connsiteY0" fmla="*/ 95462 h 675574"/>
                      <a:gd name="connsiteX1" fmla="*/ 108312 w 566479"/>
                      <a:gd name="connsiteY1" fmla="*/ 18355 h 675574"/>
                      <a:gd name="connsiteX2" fmla="*/ 241481 w 566479"/>
                      <a:gd name="connsiteY2" fmla="*/ 994 h 675574"/>
                      <a:gd name="connsiteX3" fmla="*/ 421843 w 566479"/>
                      <a:gd name="connsiteY3" fmla="*/ 42174 h 675574"/>
                      <a:gd name="connsiteX4" fmla="*/ 527412 w 566479"/>
                      <a:gd name="connsiteY4" fmla="*/ 142978 h 675574"/>
                      <a:gd name="connsiteX5" fmla="*/ 565626 w 566479"/>
                      <a:gd name="connsiteY5" fmla="*/ 327435 h 675574"/>
                      <a:gd name="connsiteX6" fmla="*/ 548844 w 566479"/>
                      <a:gd name="connsiteY6" fmla="*/ 463649 h 675574"/>
                      <a:gd name="connsiteX7" fmla="*/ 489312 w 566479"/>
                      <a:gd name="connsiteY7" fmla="*/ 574780 h 675574"/>
                      <a:gd name="connsiteX8" fmla="*/ 370245 w 566479"/>
                      <a:gd name="connsiteY8" fmla="*/ 647005 h 675574"/>
                      <a:gd name="connsiteX9" fmla="*/ 267677 w 566479"/>
                      <a:gd name="connsiteY9" fmla="*/ 661023 h 675574"/>
                      <a:gd name="connsiteX10" fmla="*/ 167845 w 566479"/>
                      <a:gd name="connsiteY10" fmla="*/ 675574 h 675574"/>
                      <a:gd name="connsiteX11" fmla="*/ 76087 w 566479"/>
                      <a:gd name="connsiteY11" fmla="*/ 641973 h 675574"/>
                      <a:gd name="connsiteX12" fmla="*/ 21001 w 566479"/>
                      <a:gd name="connsiteY12" fmla="*/ 518420 h 675574"/>
                      <a:gd name="connsiteX13" fmla="*/ 361 w 566479"/>
                      <a:gd name="connsiteY13" fmla="*/ 296177 h 675574"/>
                      <a:gd name="connsiteX14" fmla="*/ 41161 w 566479"/>
                      <a:gd name="connsiteY14" fmla="*/ 95462 h 675574"/>
                      <a:gd name="connsiteX0" fmla="*/ 41161 w 566479"/>
                      <a:gd name="connsiteY0" fmla="*/ 95462 h 661023"/>
                      <a:gd name="connsiteX1" fmla="*/ 108312 w 566479"/>
                      <a:gd name="connsiteY1" fmla="*/ 18355 h 661023"/>
                      <a:gd name="connsiteX2" fmla="*/ 241481 w 566479"/>
                      <a:gd name="connsiteY2" fmla="*/ 994 h 661023"/>
                      <a:gd name="connsiteX3" fmla="*/ 421843 w 566479"/>
                      <a:gd name="connsiteY3" fmla="*/ 42174 h 661023"/>
                      <a:gd name="connsiteX4" fmla="*/ 527412 w 566479"/>
                      <a:gd name="connsiteY4" fmla="*/ 142978 h 661023"/>
                      <a:gd name="connsiteX5" fmla="*/ 565626 w 566479"/>
                      <a:gd name="connsiteY5" fmla="*/ 327435 h 661023"/>
                      <a:gd name="connsiteX6" fmla="*/ 548844 w 566479"/>
                      <a:gd name="connsiteY6" fmla="*/ 463649 h 661023"/>
                      <a:gd name="connsiteX7" fmla="*/ 489312 w 566479"/>
                      <a:gd name="connsiteY7" fmla="*/ 574780 h 661023"/>
                      <a:gd name="connsiteX8" fmla="*/ 370245 w 566479"/>
                      <a:gd name="connsiteY8" fmla="*/ 647005 h 661023"/>
                      <a:gd name="connsiteX9" fmla="*/ 267677 w 566479"/>
                      <a:gd name="connsiteY9" fmla="*/ 661023 h 661023"/>
                      <a:gd name="connsiteX10" fmla="*/ 155936 w 566479"/>
                      <a:gd name="connsiteY10" fmla="*/ 649383 h 661023"/>
                      <a:gd name="connsiteX11" fmla="*/ 76087 w 566479"/>
                      <a:gd name="connsiteY11" fmla="*/ 641973 h 661023"/>
                      <a:gd name="connsiteX12" fmla="*/ 21001 w 566479"/>
                      <a:gd name="connsiteY12" fmla="*/ 518420 h 661023"/>
                      <a:gd name="connsiteX13" fmla="*/ 361 w 566479"/>
                      <a:gd name="connsiteY13" fmla="*/ 296177 h 661023"/>
                      <a:gd name="connsiteX14" fmla="*/ 41161 w 566479"/>
                      <a:gd name="connsiteY14" fmla="*/ 95462 h 661023"/>
                      <a:gd name="connsiteX0" fmla="*/ 41161 w 566479"/>
                      <a:gd name="connsiteY0" fmla="*/ 95462 h 661023"/>
                      <a:gd name="connsiteX1" fmla="*/ 108312 w 566479"/>
                      <a:gd name="connsiteY1" fmla="*/ 18355 h 661023"/>
                      <a:gd name="connsiteX2" fmla="*/ 241481 w 566479"/>
                      <a:gd name="connsiteY2" fmla="*/ 994 h 661023"/>
                      <a:gd name="connsiteX3" fmla="*/ 421843 w 566479"/>
                      <a:gd name="connsiteY3" fmla="*/ 42174 h 661023"/>
                      <a:gd name="connsiteX4" fmla="*/ 527412 w 566479"/>
                      <a:gd name="connsiteY4" fmla="*/ 142978 h 661023"/>
                      <a:gd name="connsiteX5" fmla="*/ 565626 w 566479"/>
                      <a:gd name="connsiteY5" fmla="*/ 327435 h 661023"/>
                      <a:gd name="connsiteX6" fmla="*/ 548844 w 566479"/>
                      <a:gd name="connsiteY6" fmla="*/ 463649 h 661023"/>
                      <a:gd name="connsiteX7" fmla="*/ 489312 w 566479"/>
                      <a:gd name="connsiteY7" fmla="*/ 574780 h 661023"/>
                      <a:gd name="connsiteX8" fmla="*/ 370245 w 566479"/>
                      <a:gd name="connsiteY8" fmla="*/ 647005 h 661023"/>
                      <a:gd name="connsiteX9" fmla="*/ 267677 w 566479"/>
                      <a:gd name="connsiteY9" fmla="*/ 661023 h 661023"/>
                      <a:gd name="connsiteX10" fmla="*/ 155936 w 566479"/>
                      <a:gd name="connsiteY10" fmla="*/ 649383 h 661023"/>
                      <a:gd name="connsiteX11" fmla="*/ 68943 w 566479"/>
                      <a:gd name="connsiteY11" fmla="*/ 613398 h 661023"/>
                      <a:gd name="connsiteX12" fmla="*/ 21001 w 566479"/>
                      <a:gd name="connsiteY12" fmla="*/ 518420 h 661023"/>
                      <a:gd name="connsiteX13" fmla="*/ 361 w 566479"/>
                      <a:gd name="connsiteY13" fmla="*/ 296177 h 661023"/>
                      <a:gd name="connsiteX14" fmla="*/ 41161 w 566479"/>
                      <a:gd name="connsiteY14" fmla="*/ 95462 h 661023"/>
                      <a:gd name="connsiteX0" fmla="*/ 41161 w 566479"/>
                      <a:gd name="connsiteY0" fmla="*/ 95462 h 661023"/>
                      <a:gd name="connsiteX1" fmla="*/ 108312 w 566479"/>
                      <a:gd name="connsiteY1" fmla="*/ 18355 h 661023"/>
                      <a:gd name="connsiteX2" fmla="*/ 241481 w 566479"/>
                      <a:gd name="connsiteY2" fmla="*/ 994 h 661023"/>
                      <a:gd name="connsiteX3" fmla="*/ 421843 w 566479"/>
                      <a:gd name="connsiteY3" fmla="*/ 42174 h 661023"/>
                      <a:gd name="connsiteX4" fmla="*/ 527412 w 566479"/>
                      <a:gd name="connsiteY4" fmla="*/ 142978 h 661023"/>
                      <a:gd name="connsiteX5" fmla="*/ 565626 w 566479"/>
                      <a:gd name="connsiteY5" fmla="*/ 327435 h 661023"/>
                      <a:gd name="connsiteX6" fmla="*/ 548844 w 566479"/>
                      <a:gd name="connsiteY6" fmla="*/ 463649 h 661023"/>
                      <a:gd name="connsiteX7" fmla="*/ 489312 w 566479"/>
                      <a:gd name="connsiteY7" fmla="*/ 574780 h 661023"/>
                      <a:gd name="connsiteX8" fmla="*/ 370245 w 566479"/>
                      <a:gd name="connsiteY8" fmla="*/ 647005 h 661023"/>
                      <a:gd name="connsiteX9" fmla="*/ 267677 w 566479"/>
                      <a:gd name="connsiteY9" fmla="*/ 661023 h 661023"/>
                      <a:gd name="connsiteX10" fmla="*/ 155936 w 566479"/>
                      <a:gd name="connsiteY10" fmla="*/ 649383 h 661023"/>
                      <a:gd name="connsiteX11" fmla="*/ 68943 w 566479"/>
                      <a:gd name="connsiteY11" fmla="*/ 613398 h 661023"/>
                      <a:gd name="connsiteX12" fmla="*/ 21001 w 566479"/>
                      <a:gd name="connsiteY12" fmla="*/ 518420 h 661023"/>
                      <a:gd name="connsiteX13" fmla="*/ 361 w 566479"/>
                      <a:gd name="connsiteY13" fmla="*/ 296177 h 661023"/>
                      <a:gd name="connsiteX14" fmla="*/ 41161 w 566479"/>
                      <a:gd name="connsiteY14" fmla="*/ 95462 h 661023"/>
                      <a:gd name="connsiteX0" fmla="*/ 42225 w 567543"/>
                      <a:gd name="connsiteY0" fmla="*/ 95462 h 661023"/>
                      <a:gd name="connsiteX1" fmla="*/ 109376 w 567543"/>
                      <a:gd name="connsiteY1" fmla="*/ 18355 h 661023"/>
                      <a:gd name="connsiteX2" fmla="*/ 242545 w 567543"/>
                      <a:gd name="connsiteY2" fmla="*/ 994 h 661023"/>
                      <a:gd name="connsiteX3" fmla="*/ 422907 w 567543"/>
                      <a:gd name="connsiteY3" fmla="*/ 42174 h 661023"/>
                      <a:gd name="connsiteX4" fmla="*/ 528476 w 567543"/>
                      <a:gd name="connsiteY4" fmla="*/ 142978 h 661023"/>
                      <a:gd name="connsiteX5" fmla="*/ 566690 w 567543"/>
                      <a:gd name="connsiteY5" fmla="*/ 327435 h 661023"/>
                      <a:gd name="connsiteX6" fmla="*/ 549908 w 567543"/>
                      <a:gd name="connsiteY6" fmla="*/ 463649 h 661023"/>
                      <a:gd name="connsiteX7" fmla="*/ 490376 w 567543"/>
                      <a:gd name="connsiteY7" fmla="*/ 574780 h 661023"/>
                      <a:gd name="connsiteX8" fmla="*/ 371309 w 567543"/>
                      <a:gd name="connsiteY8" fmla="*/ 647005 h 661023"/>
                      <a:gd name="connsiteX9" fmla="*/ 268741 w 567543"/>
                      <a:gd name="connsiteY9" fmla="*/ 661023 h 661023"/>
                      <a:gd name="connsiteX10" fmla="*/ 157000 w 567543"/>
                      <a:gd name="connsiteY10" fmla="*/ 649383 h 661023"/>
                      <a:gd name="connsiteX11" fmla="*/ 70007 w 567543"/>
                      <a:gd name="connsiteY11" fmla="*/ 613398 h 661023"/>
                      <a:gd name="connsiteX12" fmla="*/ 14921 w 567543"/>
                      <a:gd name="connsiteY12" fmla="*/ 489845 h 661023"/>
                      <a:gd name="connsiteX13" fmla="*/ 1425 w 567543"/>
                      <a:gd name="connsiteY13" fmla="*/ 296177 h 661023"/>
                      <a:gd name="connsiteX14" fmla="*/ 42225 w 567543"/>
                      <a:gd name="connsiteY14" fmla="*/ 95462 h 661023"/>
                      <a:gd name="connsiteX0" fmla="*/ 42225 w 567543"/>
                      <a:gd name="connsiteY0" fmla="*/ 95462 h 661023"/>
                      <a:gd name="connsiteX1" fmla="*/ 109376 w 567543"/>
                      <a:gd name="connsiteY1" fmla="*/ 18355 h 661023"/>
                      <a:gd name="connsiteX2" fmla="*/ 242545 w 567543"/>
                      <a:gd name="connsiteY2" fmla="*/ 994 h 661023"/>
                      <a:gd name="connsiteX3" fmla="*/ 422907 w 567543"/>
                      <a:gd name="connsiteY3" fmla="*/ 42174 h 661023"/>
                      <a:gd name="connsiteX4" fmla="*/ 528476 w 567543"/>
                      <a:gd name="connsiteY4" fmla="*/ 142978 h 661023"/>
                      <a:gd name="connsiteX5" fmla="*/ 566690 w 567543"/>
                      <a:gd name="connsiteY5" fmla="*/ 327435 h 661023"/>
                      <a:gd name="connsiteX6" fmla="*/ 549908 w 567543"/>
                      <a:gd name="connsiteY6" fmla="*/ 463649 h 661023"/>
                      <a:gd name="connsiteX7" fmla="*/ 490376 w 567543"/>
                      <a:gd name="connsiteY7" fmla="*/ 574780 h 661023"/>
                      <a:gd name="connsiteX8" fmla="*/ 371309 w 567543"/>
                      <a:gd name="connsiteY8" fmla="*/ 647005 h 661023"/>
                      <a:gd name="connsiteX9" fmla="*/ 268741 w 567543"/>
                      <a:gd name="connsiteY9" fmla="*/ 661023 h 661023"/>
                      <a:gd name="connsiteX10" fmla="*/ 157000 w 567543"/>
                      <a:gd name="connsiteY10" fmla="*/ 649383 h 661023"/>
                      <a:gd name="connsiteX11" fmla="*/ 70007 w 567543"/>
                      <a:gd name="connsiteY11" fmla="*/ 613398 h 661023"/>
                      <a:gd name="connsiteX12" fmla="*/ 14921 w 567543"/>
                      <a:gd name="connsiteY12" fmla="*/ 489845 h 661023"/>
                      <a:gd name="connsiteX13" fmla="*/ 1425 w 567543"/>
                      <a:gd name="connsiteY13" fmla="*/ 296177 h 661023"/>
                      <a:gd name="connsiteX14" fmla="*/ 42225 w 567543"/>
                      <a:gd name="connsiteY14" fmla="*/ 95462 h 661023"/>
                      <a:gd name="connsiteX0" fmla="*/ 40943 w 566261"/>
                      <a:gd name="connsiteY0" fmla="*/ 95462 h 661023"/>
                      <a:gd name="connsiteX1" fmla="*/ 108094 w 566261"/>
                      <a:gd name="connsiteY1" fmla="*/ 18355 h 661023"/>
                      <a:gd name="connsiteX2" fmla="*/ 241263 w 566261"/>
                      <a:gd name="connsiteY2" fmla="*/ 994 h 661023"/>
                      <a:gd name="connsiteX3" fmla="*/ 421625 w 566261"/>
                      <a:gd name="connsiteY3" fmla="*/ 42174 h 661023"/>
                      <a:gd name="connsiteX4" fmla="*/ 527194 w 566261"/>
                      <a:gd name="connsiteY4" fmla="*/ 142978 h 661023"/>
                      <a:gd name="connsiteX5" fmla="*/ 565408 w 566261"/>
                      <a:gd name="connsiteY5" fmla="*/ 327435 h 661023"/>
                      <a:gd name="connsiteX6" fmla="*/ 548626 w 566261"/>
                      <a:gd name="connsiteY6" fmla="*/ 463649 h 661023"/>
                      <a:gd name="connsiteX7" fmla="*/ 489094 w 566261"/>
                      <a:gd name="connsiteY7" fmla="*/ 574780 h 661023"/>
                      <a:gd name="connsiteX8" fmla="*/ 370027 w 566261"/>
                      <a:gd name="connsiteY8" fmla="*/ 647005 h 661023"/>
                      <a:gd name="connsiteX9" fmla="*/ 267459 w 566261"/>
                      <a:gd name="connsiteY9" fmla="*/ 661023 h 661023"/>
                      <a:gd name="connsiteX10" fmla="*/ 155718 w 566261"/>
                      <a:gd name="connsiteY10" fmla="*/ 649383 h 661023"/>
                      <a:gd name="connsiteX11" fmla="*/ 68725 w 566261"/>
                      <a:gd name="connsiteY11" fmla="*/ 613398 h 661023"/>
                      <a:gd name="connsiteX12" fmla="*/ 13639 w 566261"/>
                      <a:gd name="connsiteY12" fmla="*/ 489845 h 661023"/>
                      <a:gd name="connsiteX13" fmla="*/ 143 w 566261"/>
                      <a:gd name="connsiteY13" fmla="*/ 296177 h 661023"/>
                      <a:gd name="connsiteX14" fmla="*/ 40943 w 566261"/>
                      <a:gd name="connsiteY14" fmla="*/ 95462 h 661023"/>
                      <a:gd name="connsiteX0" fmla="*/ 40943 w 566261"/>
                      <a:gd name="connsiteY0" fmla="*/ 95462 h 661023"/>
                      <a:gd name="connsiteX1" fmla="*/ 108094 w 566261"/>
                      <a:gd name="connsiteY1" fmla="*/ 18355 h 661023"/>
                      <a:gd name="connsiteX2" fmla="*/ 241263 w 566261"/>
                      <a:gd name="connsiteY2" fmla="*/ 994 h 661023"/>
                      <a:gd name="connsiteX3" fmla="*/ 421625 w 566261"/>
                      <a:gd name="connsiteY3" fmla="*/ 42174 h 661023"/>
                      <a:gd name="connsiteX4" fmla="*/ 527194 w 566261"/>
                      <a:gd name="connsiteY4" fmla="*/ 142978 h 661023"/>
                      <a:gd name="connsiteX5" fmla="*/ 565408 w 566261"/>
                      <a:gd name="connsiteY5" fmla="*/ 327435 h 661023"/>
                      <a:gd name="connsiteX6" fmla="*/ 548626 w 566261"/>
                      <a:gd name="connsiteY6" fmla="*/ 463649 h 661023"/>
                      <a:gd name="connsiteX7" fmla="*/ 489094 w 566261"/>
                      <a:gd name="connsiteY7" fmla="*/ 574780 h 661023"/>
                      <a:gd name="connsiteX8" fmla="*/ 370027 w 566261"/>
                      <a:gd name="connsiteY8" fmla="*/ 647005 h 661023"/>
                      <a:gd name="connsiteX9" fmla="*/ 267459 w 566261"/>
                      <a:gd name="connsiteY9" fmla="*/ 661023 h 661023"/>
                      <a:gd name="connsiteX10" fmla="*/ 155718 w 566261"/>
                      <a:gd name="connsiteY10" fmla="*/ 649383 h 661023"/>
                      <a:gd name="connsiteX11" fmla="*/ 68725 w 566261"/>
                      <a:gd name="connsiteY11" fmla="*/ 613398 h 661023"/>
                      <a:gd name="connsiteX12" fmla="*/ 13639 w 566261"/>
                      <a:gd name="connsiteY12" fmla="*/ 489845 h 661023"/>
                      <a:gd name="connsiteX13" fmla="*/ 143 w 566261"/>
                      <a:gd name="connsiteY13" fmla="*/ 296177 h 661023"/>
                      <a:gd name="connsiteX14" fmla="*/ 40943 w 566261"/>
                      <a:gd name="connsiteY14" fmla="*/ 95462 h 661023"/>
                      <a:gd name="connsiteX0" fmla="*/ 41075 w 566393"/>
                      <a:gd name="connsiteY0" fmla="*/ 95462 h 661023"/>
                      <a:gd name="connsiteX1" fmla="*/ 108226 w 566393"/>
                      <a:gd name="connsiteY1" fmla="*/ 18355 h 661023"/>
                      <a:gd name="connsiteX2" fmla="*/ 241395 w 566393"/>
                      <a:gd name="connsiteY2" fmla="*/ 994 h 661023"/>
                      <a:gd name="connsiteX3" fmla="*/ 421757 w 566393"/>
                      <a:gd name="connsiteY3" fmla="*/ 42174 h 661023"/>
                      <a:gd name="connsiteX4" fmla="*/ 527326 w 566393"/>
                      <a:gd name="connsiteY4" fmla="*/ 142978 h 661023"/>
                      <a:gd name="connsiteX5" fmla="*/ 565540 w 566393"/>
                      <a:gd name="connsiteY5" fmla="*/ 327435 h 661023"/>
                      <a:gd name="connsiteX6" fmla="*/ 548758 w 566393"/>
                      <a:gd name="connsiteY6" fmla="*/ 463649 h 661023"/>
                      <a:gd name="connsiteX7" fmla="*/ 489226 w 566393"/>
                      <a:gd name="connsiteY7" fmla="*/ 574780 h 661023"/>
                      <a:gd name="connsiteX8" fmla="*/ 370159 w 566393"/>
                      <a:gd name="connsiteY8" fmla="*/ 647005 h 661023"/>
                      <a:gd name="connsiteX9" fmla="*/ 267591 w 566393"/>
                      <a:gd name="connsiteY9" fmla="*/ 661023 h 661023"/>
                      <a:gd name="connsiteX10" fmla="*/ 155850 w 566393"/>
                      <a:gd name="connsiteY10" fmla="*/ 649383 h 661023"/>
                      <a:gd name="connsiteX11" fmla="*/ 68857 w 566393"/>
                      <a:gd name="connsiteY11" fmla="*/ 613398 h 661023"/>
                      <a:gd name="connsiteX12" fmla="*/ 13771 w 566393"/>
                      <a:gd name="connsiteY12" fmla="*/ 489845 h 661023"/>
                      <a:gd name="connsiteX13" fmla="*/ 275 w 566393"/>
                      <a:gd name="connsiteY13" fmla="*/ 296177 h 661023"/>
                      <a:gd name="connsiteX14" fmla="*/ 41075 w 566393"/>
                      <a:gd name="connsiteY14" fmla="*/ 95462 h 661023"/>
                      <a:gd name="connsiteX0" fmla="*/ 41075 w 566393"/>
                      <a:gd name="connsiteY0" fmla="*/ 94702 h 660263"/>
                      <a:gd name="connsiteX1" fmla="*/ 112989 w 566393"/>
                      <a:gd name="connsiteY1" fmla="*/ 27120 h 660263"/>
                      <a:gd name="connsiteX2" fmla="*/ 241395 w 566393"/>
                      <a:gd name="connsiteY2" fmla="*/ 234 h 660263"/>
                      <a:gd name="connsiteX3" fmla="*/ 421757 w 566393"/>
                      <a:gd name="connsiteY3" fmla="*/ 41414 h 660263"/>
                      <a:gd name="connsiteX4" fmla="*/ 527326 w 566393"/>
                      <a:gd name="connsiteY4" fmla="*/ 142218 h 660263"/>
                      <a:gd name="connsiteX5" fmla="*/ 565540 w 566393"/>
                      <a:gd name="connsiteY5" fmla="*/ 326675 h 660263"/>
                      <a:gd name="connsiteX6" fmla="*/ 548758 w 566393"/>
                      <a:gd name="connsiteY6" fmla="*/ 462889 h 660263"/>
                      <a:gd name="connsiteX7" fmla="*/ 489226 w 566393"/>
                      <a:gd name="connsiteY7" fmla="*/ 574020 h 660263"/>
                      <a:gd name="connsiteX8" fmla="*/ 370159 w 566393"/>
                      <a:gd name="connsiteY8" fmla="*/ 646245 h 660263"/>
                      <a:gd name="connsiteX9" fmla="*/ 267591 w 566393"/>
                      <a:gd name="connsiteY9" fmla="*/ 660263 h 660263"/>
                      <a:gd name="connsiteX10" fmla="*/ 155850 w 566393"/>
                      <a:gd name="connsiteY10" fmla="*/ 648623 h 660263"/>
                      <a:gd name="connsiteX11" fmla="*/ 68857 w 566393"/>
                      <a:gd name="connsiteY11" fmla="*/ 612638 h 660263"/>
                      <a:gd name="connsiteX12" fmla="*/ 13771 w 566393"/>
                      <a:gd name="connsiteY12" fmla="*/ 489085 h 660263"/>
                      <a:gd name="connsiteX13" fmla="*/ 275 w 566393"/>
                      <a:gd name="connsiteY13" fmla="*/ 295417 h 660263"/>
                      <a:gd name="connsiteX14" fmla="*/ 41075 w 566393"/>
                      <a:gd name="connsiteY14" fmla="*/ 94702 h 660263"/>
                      <a:gd name="connsiteX0" fmla="*/ 41075 w 566393"/>
                      <a:gd name="connsiteY0" fmla="*/ 94702 h 662768"/>
                      <a:gd name="connsiteX1" fmla="*/ 112989 w 566393"/>
                      <a:gd name="connsiteY1" fmla="*/ 27120 h 662768"/>
                      <a:gd name="connsiteX2" fmla="*/ 241395 w 566393"/>
                      <a:gd name="connsiteY2" fmla="*/ 234 h 662768"/>
                      <a:gd name="connsiteX3" fmla="*/ 421757 w 566393"/>
                      <a:gd name="connsiteY3" fmla="*/ 41414 h 662768"/>
                      <a:gd name="connsiteX4" fmla="*/ 527326 w 566393"/>
                      <a:gd name="connsiteY4" fmla="*/ 142218 h 662768"/>
                      <a:gd name="connsiteX5" fmla="*/ 565540 w 566393"/>
                      <a:gd name="connsiteY5" fmla="*/ 326675 h 662768"/>
                      <a:gd name="connsiteX6" fmla="*/ 548758 w 566393"/>
                      <a:gd name="connsiteY6" fmla="*/ 462889 h 662768"/>
                      <a:gd name="connsiteX7" fmla="*/ 489226 w 566393"/>
                      <a:gd name="connsiteY7" fmla="*/ 574020 h 662768"/>
                      <a:gd name="connsiteX8" fmla="*/ 370159 w 566393"/>
                      <a:gd name="connsiteY8" fmla="*/ 646245 h 662768"/>
                      <a:gd name="connsiteX9" fmla="*/ 267591 w 566393"/>
                      <a:gd name="connsiteY9" fmla="*/ 660263 h 662768"/>
                      <a:gd name="connsiteX10" fmla="*/ 155850 w 566393"/>
                      <a:gd name="connsiteY10" fmla="*/ 648623 h 662768"/>
                      <a:gd name="connsiteX11" fmla="*/ 35520 w 566393"/>
                      <a:gd name="connsiteY11" fmla="*/ 660263 h 662768"/>
                      <a:gd name="connsiteX12" fmla="*/ 13771 w 566393"/>
                      <a:gd name="connsiteY12" fmla="*/ 489085 h 662768"/>
                      <a:gd name="connsiteX13" fmla="*/ 275 w 566393"/>
                      <a:gd name="connsiteY13" fmla="*/ 295417 h 662768"/>
                      <a:gd name="connsiteX14" fmla="*/ 41075 w 566393"/>
                      <a:gd name="connsiteY14" fmla="*/ 94702 h 662768"/>
                      <a:gd name="connsiteX0" fmla="*/ 41075 w 566393"/>
                      <a:gd name="connsiteY0" fmla="*/ 94702 h 681964"/>
                      <a:gd name="connsiteX1" fmla="*/ 112989 w 566393"/>
                      <a:gd name="connsiteY1" fmla="*/ 27120 h 681964"/>
                      <a:gd name="connsiteX2" fmla="*/ 241395 w 566393"/>
                      <a:gd name="connsiteY2" fmla="*/ 234 h 681964"/>
                      <a:gd name="connsiteX3" fmla="*/ 421757 w 566393"/>
                      <a:gd name="connsiteY3" fmla="*/ 41414 h 681964"/>
                      <a:gd name="connsiteX4" fmla="*/ 527326 w 566393"/>
                      <a:gd name="connsiteY4" fmla="*/ 142218 h 681964"/>
                      <a:gd name="connsiteX5" fmla="*/ 565540 w 566393"/>
                      <a:gd name="connsiteY5" fmla="*/ 326675 h 681964"/>
                      <a:gd name="connsiteX6" fmla="*/ 548758 w 566393"/>
                      <a:gd name="connsiteY6" fmla="*/ 462889 h 681964"/>
                      <a:gd name="connsiteX7" fmla="*/ 489226 w 566393"/>
                      <a:gd name="connsiteY7" fmla="*/ 574020 h 681964"/>
                      <a:gd name="connsiteX8" fmla="*/ 370159 w 566393"/>
                      <a:gd name="connsiteY8" fmla="*/ 646245 h 681964"/>
                      <a:gd name="connsiteX9" fmla="*/ 267591 w 566393"/>
                      <a:gd name="connsiteY9" fmla="*/ 660263 h 681964"/>
                      <a:gd name="connsiteX10" fmla="*/ 146322 w 566393"/>
                      <a:gd name="connsiteY10" fmla="*/ 681964 h 681964"/>
                      <a:gd name="connsiteX11" fmla="*/ 35520 w 566393"/>
                      <a:gd name="connsiteY11" fmla="*/ 660263 h 681964"/>
                      <a:gd name="connsiteX12" fmla="*/ 13771 w 566393"/>
                      <a:gd name="connsiteY12" fmla="*/ 489085 h 681964"/>
                      <a:gd name="connsiteX13" fmla="*/ 275 w 566393"/>
                      <a:gd name="connsiteY13" fmla="*/ 295417 h 681964"/>
                      <a:gd name="connsiteX14" fmla="*/ 41075 w 566393"/>
                      <a:gd name="connsiteY14" fmla="*/ 94702 h 681964"/>
                      <a:gd name="connsiteX0" fmla="*/ 50771 w 576089"/>
                      <a:gd name="connsiteY0" fmla="*/ 94702 h 681964"/>
                      <a:gd name="connsiteX1" fmla="*/ 122685 w 576089"/>
                      <a:gd name="connsiteY1" fmla="*/ 27120 h 681964"/>
                      <a:gd name="connsiteX2" fmla="*/ 251091 w 576089"/>
                      <a:gd name="connsiteY2" fmla="*/ 234 h 681964"/>
                      <a:gd name="connsiteX3" fmla="*/ 431453 w 576089"/>
                      <a:gd name="connsiteY3" fmla="*/ 41414 h 681964"/>
                      <a:gd name="connsiteX4" fmla="*/ 537022 w 576089"/>
                      <a:gd name="connsiteY4" fmla="*/ 142218 h 681964"/>
                      <a:gd name="connsiteX5" fmla="*/ 575236 w 576089"/>
                      <a:gd name="connsiteY5" fmla="*/ 326675 h 681964"/>
                      <a:gd name="connsiteX6" fmla="*/ 558454 w 576089"/>
                      <a:gd name="connsiteY6" fmla="*/ 462889 h 681964"/>
                      <a:gd name="connsiteX7" fmla="*/ 498922 w 576089"/>
                      <a:gd name="connsiteY7" fmla="*/ 574020 h 681964"/>
                      <a:gd name="connsiteX8" fmla="*/ 379855 w 576089"/>
                      <a:gd name="connsiteY8" fmla="*/ 646245 h 681964"/>
                      <a:gd name="connsiteX9" fmla="*/ 277287 w 576089"/>
                      <a:gd name="connsiteY9" fmla="*/ 660263 h 681964"/>
                      <a:gd name="connsiteX10" fmla="*/ 156018 w 576089"/>
                      <a:gd name="connsiteY10" fmla="*/ 681964 h 681964"/>
                      <a:gd name="connsiteX11" fmla="*/ 45216 w 576089"/>
                      <a:gd name="connsiteY11" fmla="*/ 660263 h 681964"/>
                      <a:gd name="connsiteX12" fmla="*/ 4416 w 576089"/>
                      <a:gd name="connsiteY12" fmla="*/ 484326 h 681964"/>
                      <a:gd name="connsiteX13" fmla="*/ 9971 w 576089"/>
                      <a:gd name="connsiteY13" fmla="*/ 295417 h 681964"/>
                      <a:gd name="connsiteX14" fmla="*/ 50771 w 576089"/>
                      <a:gd name="connsiteY14" fmla="*/ 94702 h 681964"/>
                      <a:gd name="connsiteX0" fmla="*/ 40905 w 575748"/>
                      <a:gd name="connsiteY0" fmla="*/ 80422 h 681968"/>
                      <a:gd name="connsiteX1" fmla="*/ 122344 w 575748"/>
                      <a:gd name="connsiteY1" fmla="*/ 27124 h 681968"/>
                      <a:gd name="connsiteX2" fmla="*/ 250750 w 575748"/>
                      <a:gd name="connsiteY2" fmla="*/ 238 h 681968"/>
                      <a:gd name="connsiteX3" fmla="*/ 431112 w 575748"/>
                      <a:gd name="connsiteY3" fmla="*/ 41418 h 681968"/>
                      <a:gd name="connsiteX4" fmla="*/ 536681 w 575748"/>
                      <a:gd name="connsiteY4" fmla="*/ 142222 h 681968"/>
                      <a:gd name="connsiteX5" fmla="*/ 574895 w 575748"/>
                      <a:gd name="connsiteY5" fmla="*/ 326679 h 681968"/>
                      <a:gd name="connsiteX6" fmla="*/ 558113 w 575748"/>
                      <a:gd name="connsiteY6" fmla="*/ 462893 h 681968"/>
                      <a:gd name="connsiteX7" fmla="*/ 498581 w 575748"/>
                      <a:gd name="connsiteY7" fmla="*/ 574024 h 681968"/>
                      <a:gd name="connsiteX8" fmla="*/ 379514 w 575748"/>
                      <a:gd name="connsiteY8" fmla="*/ 646249 h 681968"/>
                      <a:gd name="connsiteX9" fmla="*/ 276946 w 575748"/>
                      <a:gd name="connsiteY9" fmla="*/ 660267 h 681968"/>
                      <a:gd name="connsiteX10" fmla="*/ 155677 w 575748"/>
                      <a:gd name="connsiteY10" fmla="*/ 681968 h 681968"/>
                      <a:gd name="connsiteX11" fmla="*/ 44875 w 575748"/>
                      <a:gd name="connsiteY11" fmla="*/ 660267 h 681968"/>
                      <a:gd name="connsiteX12" fmla="*/ 4075 w 575748"/>
                      <a:gd name="connsiteY12" fmla="*/ 484330 h 681968"/>
                      <a:gd name="connsiteX13" fmla="*/ 9630 w 575748"/>
                      <a:gd name="connsiteY13" fmla="*/ 295421 h 681968"/>
                      <a:gd name="connsiteX14" fmla="*/ 40905 w 575748"/>
                      <a:gd name="connsiteY14" fmla="*/ 80422 h 681968"/>
                      <a:gd name="connsiteX0" fmla="*/ 39021 w 573864"/>
                      <a:gd name="connsiteY0" fmla="*/ 80422 h 681968"/>
                      <a:gd name="connsiteX1" fmla="*/ 120460 w 573864"/>
                      <a:gd name="connsiteY1" fmla="*/ 27124 h 681968"/>
                      <a:gd name="connsiteX2" fmla="*/ 248866 w 573864"/>
                      <a:gd name="connsiteY2" fmla="*/ 238 h 681968"/>
                      <a:gd name="connsiteX3" fmla="*/ 429228 w 573864"/>
                      <a:gd name="connsiteY3" fmla="*/ 41418 h 681968"/>
                      <a:gd name="connsiteX4" fmla="*/ 534797 w 573864"/>
                      <a:gd name="connsiteY4" fmla="*/ 142222 h 681968"/>
                      <a:gd name="connsiteX5" fmla="*/ 573011 w 573864"/>
                      <a:gd name="connsiteY5" fmla="*/ 326679 h 681968"/>
                      <a:gd name="connsiteX6" fmla="*/ 556229 w 573864"/>
                      <a:gd name="connsiteY6" fmla="*/ 462893 h 681968"/>
                      <a:gd name="connsiteX7" fmla="*/ 496697 w 573864"/>
                      <a:gd name="connsiteY7" fmla="*/ 574024 h 681968"/>
                      <a:gd name="connsiteX8" fmla="*/ 377630 w 573864"/>
                      <a:gd name="connsiteY8" fmla="*/ 646249 h 681968"/>
                      <a:gd name="connsiteX9" fmla="*/ 275062 w 573864"/>
                      <a:gd name="connsiteY9" fmla="*/ 660267 h 681968"/>
                      <a:gd name="connsiteX10" fmla="*/ 153793 w 573864"/>
                      <a:gd name="connsiteY10" fmla="*/ 681968 h 681968"/>
                      <a:gd name="connsiteX11" fmla="*/ 42991 w 573864"/>
                      <a:gd name="connsiteY11" fmla="*/ 660267 h 681968"/>
                      <a:gd name="connsiteX12" fmla="*/ 2191 w 573864"/>
                      <a:gd name="connsiteY12" fmla="*/ 484330 h 681968"/>
                      <a:gd name="connsiteX13" fmla="*/ 22033 w 573864"/>
                      <a:gd name="connsiteY13" fmla="*/ 290658 h 681968"/>
                      <a:gd name="connsiteX14" fmla="*/ 39021 w 573864"/>
                      <a:gd name="connsiteY14" fmla="*/ 80422 h 681968"/>
                      <a:gd name="connsiteX0" fmla="*/ 22405 w 557248"/>
                      <a:gd name="connsiteY0" fmla="*/ 80422 h 681968"/>
                      <a:gd name="connsiteX1" fmla="*/ 103844 w 557248"/>
                      <a:gd name="connsiteY1" fmla="*/ 27124 h 681968"/>
                      <a:gd name="connsiteX2" fmla="*/ 232250 w 557248"/>
                      <a:gd name="connsiteY2" fmla="*/ 238 h 681968"/>
                      <a:gd name="connsiteX3" fmla="*/ 412612 w 557248"/>
                      <a:gd name="connsiteY3" fmla="*/ 41418 h 681968"/>
                      <a:gd name="connsiteX4" fmla="*/ 518181 w 557248"/>
                      <a:gd name="connsiteY4" fmla="*/ 142222 h 681968"/>
                      <a:gd name="connsiteX5" fmla="*/ 556395 w 557248"/>
                      <a:gd name="connsiteY5" fmla="*/ 326679 h 681968"/>
                      <a:gd name="connsiteX6" fmla="*/ 539613 w 557248"/>
                      <a:gd name="connsiteY6" fmla="*/ 462893 h 681968"/>
                      <a:gd name="connsiteX7" fmla="*/ 480081 w 557248"/>
                      <a:gd name="connsiteY7" fmla="*/ 574024 h 681968"/>
                      <a:gd name="connsiteX8" fmla="*/ 361014 w 557248"/>
                      <a:gd name="connsiteY8" fmla="*/ 646249 h 681968"/>
                      <a:gd name="connsiteX9" fmla="*/ 258446 w 557248"/>
                      <a:gd name="connsiteY9" fmla="*/ 660267 h 681968"/>
                      <a:gd name="connsiteX10" fmla="*/ 137177 w 557248"/>
                      <a:gd name="connsiteY10" fmla="*/ 681968 h 681968"/>
                      <a:gd name="connsiteX11" fmla="*/ 26375 w 557248"/>
                      <a:gd name="connsiteY11" fmla="*/ 660267 h 681968"/>
                      <a:gd name="connsiteX12" fmla="*/ 4625 w 557248"/>
                      <a:gd name="connsiteY12" fmla="*/ 498617 h 681968"/>
                      <a:gd name="connsiteX13" fmla="*/ 5417 w 557248"/>
                      <a:gd name="connsiteY13" fmla="*/ 290658 h 681968"/>
                      <a:gd name="connsiteX14" fmla="*/ 22405 w 557248"/>
                      <a:gd name="connsiteY14" fmla="*/ 80422 h 681968"/>
                      <a:gd name="connsiteX0" fmla="*/ 22405 w 557248"/>
                      <a:gd name="connsiteY0" fmla="*/ 80422 h 681968"/>
                      <a:gd name="connsiteX1" fmla="*/ 103844 w 557248"/>
                      <a:gd name="connsiteY1" fmla="*/ 27124 h 681968"/>
                      <a:gd name="connsiteX2" fmla="*/ 232250 w 557248"/>
                      <a:gd name="connsiteY2" fmla="*/ 238 h 681968"/>
                      <a:gd name="connsiteX3" fmla="*/ 412612 w 557248"/>
                      <a:gd name="connsiteY3" fmla="*/ 41418 h 681968"/>
                      <a:gd name="connsiteX4" fmla="*/ 518181 w 557248"/>
                      <a:gd name="connsiteY4" fmla="*/ 142222 h 681968"/>
                      <a:gd name="connsiteX5" fmla="*/ 556395 w 557248"/>
                      <a:gd name="connsiteY5" fmla="*/ 326679 h 681968"/>
                      <a:gd name="connsiteX6" fmla="*/ 539613 w 557248"/>
                      <a:gd name="connsiteY6" fmla="*/ 462893 h 681968"/>
                      <a:gd name="connsiteX7" fmla="*/ 480081 w 557248"/>
                      <a:gd name="connsiteY7" fmla="*/ 574024 h 681968"/>
                      <a:gd name="connsiteX8" fmla="*/ 361014 w 557248"/>
                      <a:gd name="connsiteY8" fmla="*/ 646249 h 681968"/>
                      <a:gd name="connsiteX9" fmla="*/ 258446 w 557248"/>
                      <a:gd name="connsiteY9" fmla="*/ 660267 h 681968"/>
                      <a:gd name="connsiteX10" fmla="*/ 137177 w 557248"/>
                      <a:gd name="connsiteY10" fmla="*/ 681968 h 681968"/>
                      <a:gd name="connsiteX11" fmla="*/ 26375 w 557248"/>
                      <a:gd name="connsiteY11" fmla="*/ 660267 h 681968"/>
                      <a:gd name="connsiteX12" fmla="*/ 4625 w 557248"/>
                      <a:gd name="connsiteY12" fmla="*/ 498617 h 681968"/>
                      <a:gd name="connsiteX13" fmla="*/ 5417 w 557248"/>
                      <a:gd name="connsiteY13" fmla="*/ 290658 h 681968"/>
                      <a:gd name="connsiteX14" fmla="*/ 22405 w 557248"/>
                      <a:gd name="connsiteY14" fmla="*/ 80422 h 681968"/>
                      <a:gd name="connsiteX0" fmla="*/ 22405 w 557248"/>
                      <a:gd name="connsiteY0" fmla="*/ 80422 h 681968"/>
                      <a:gd name="connsiteX1" fmla="*/ 103844 w 557248"/>
                      <a:gd name="connsiteY1" fmla="*/ 27124 h 681968"/>
                      <a:gd name="connsiteX2" fmla="*/ 232250 w 557248"/>
                      <a:gd name="connsiteY2" fmla="*/ 238 h 681968"/>
                      <a:gd name="connsiteX3" fmla="*/ 412612 w 557248"/>
                      <a:gd name="connsiteY3" fmla="*/ 41418 h 681968"/>
                      <a:gd name="connsiteX4" fmla="*/ 518181 w 557248"/>
                      <a:gd name="connsiteY4" fmla="*/ 142222 h 681968"/>
                      <a:gd name="connsiteX5" fmla="*/ 556395 w 557248"/>
                      <a:gd name="connsiteY5" fmla="*/ 326679 h 681968"/>
                      <a:gd name="connsiteX6" fmla="*/ 539613 w 557248"/>
                      <a:gd name="connsiteY6" fmla="*/ 462893 h 681968"/>
                      <a:gd name="connsiteX7" fmla="*/ 480081 w 557248"/>
                      <a:gd name="connsiteY7" fmla="*/ 574024 h 681968"/>
                      <a:gd name="connsiteX8" fmla="*/ 361014 w 557248"/>
                      <a:gd name="connsiteY8" fmla="*/ 646249 h 681968"/>
                      <a:gd name="connsiteX9" fmla="*/ 258446 w 557248"/>
                      <a:gd name="connsiteY9" fmla="*/ 660267 h 681968"/>
                      <a:gd name="connsiteX10" fmla="*/ 137177 w 557248"/>
                      <a:gd name="connsiteY10" fmla="*/ 681968 h 681968"/>
                      <a:gd name="connsiteX11" fmla="*/ 26375 w 557248"/>
                      <a:gd name="connsiteY11" fmla="*/ 660267 h 681968"/>
                      <a:gd name="connsiteX12" fmla="*/ 4625 w 557248"/>
                      <a:gd name="connsiteY12" fmla="*/ 498617 h 681968"/>
                      <a:gd name="connsiteX13" fmla="*/ 5417 w 557248"/>
                      <a:gd name="connsiteY13" fmla="*/ 290658 h 681968"/>
                      <a:gd name="connsiteX14" fmla="*/ 22405 w 557248"/>
                      <a:gd name="connsiteY14" fmla="*/ 80422 h 681968"/>
                      <a:gd name="connsiteX0" fmla="*/ 22405 w 557248"/>
                      <a:gd name="connsiteY0" fmla="*/ 80422 h 681968"/>
                      <a:gd name="connsiteX1" fmla="*/ 103844 w 557248"/>
                      <a:gd name="connsiteY1" fmla="*/ 27124 h 681968"/>
                      <a:gd name="connsiteX2" fmla="*/ 232250 w 557248"/>
                      <a:gd name="connsiteY2" fmla="*/ 238 h 681968"/>
                      <a:gd name="connsiteX3" fmla="*/ 412612 w 557248"/>
                      <a:gd name="connsiteY3" fmla="*/ 41418 h 681968"/>
                      <a:gd name="connsiteX4" fmla="*/ 518181 w 557248"/>
                      <a:gd name="connsiteY4" fmla="*/ 142222 h 681968"/>
                      <a:gd name="connsiteX5" fmla="*/ 556395 w 557248"/>
                      <a:gd name="connsiteY5" fmla="*/ 326679 h 681968"/>
                      <a:gd name="connsiteX6" fmla="*/ 539613 w 557248"/>
                      <a:gd name="connsiteY6" fmla="*/ 462893 h 681968"/>
                      <a:gd name="connsiteX7" fmla="*/ 480081 w 557248"/>
                      <a:gd name="connsiteY7" fmla="*/ 574024 h 681968"/>
                      <a:gd name="connsiteX8" fmla="*/ 361014 w 557248"/>
                      <a:gd name="connsiteY8" fmla="*/ 646249 h 681968"/>
                      <a:gd name="connsiteX9" fmla="*/ 258446 w 557248"/>
                      <a:gd name="connsiteY9" fmla="*/ 679317 h 681968"/>
                      <a:gd name="connsiteX10" fmla="*/ 137177 w 557248"/>
                      <a:gd name="connsiteY10" fmla="*/ 681968 h 681968"/>
                      <a:gd name="connsiteX11" fmla="*/ 26375 w 557248"/>
                      <a:gd name="connsiteY11" fmla="*/ 660267 h 681968"/>
                      <a:gd name="connsiteX12" fmla="*/ 4625 w 557248"/>
                      <a:gd name="connsiteY12" fmla="*/ 498617 h 681968"/>
                      <a:gd name="connsiteX13" fmla="*/ 5417 w 557248"/>
                      <a:gd name="connsiteY13" fmla="*/ 290658 h 681968"/>
                      <a:gd name="connsiteX14" fmla="*/ 22405 w 557248"/>
                      <a:gd name="connsiteY14" fmla="*/ 80422 h 681968"/>
                      <a:gd name="connsiteX0" fmla="*/ 22405 w 557248"/>
                      <a:gd name="connsiteY0" fmla="*/ 80422 h 681968"/>
                      <a:gd name="connsiteX1" fmla="*/ 103844 w 557248"/>
                      <a:gd name="connsiteY1" fmla="*/ 27124 h 681968"/>
                      <a:gd name="connsiteX2" fmla="*/ 232250 w 557248"/>
                      <a:gd name="connsiteY2" fmla="*/ 238 h 681968"/>
                      <a:gd name="connsiteX3" fmla="*/ 412612 w 557248"/>
                      <a:gd name="connsiteY3" fmla="*/ 41418 h 681968"/>
                      <a:gd name="connsiteX4" fmla="*/ 518181 w 557248"/>
                      <a:gd name="connsiteY4" fmla="*/ 142222 h 681968"/>
                      <a:gd name="connsiteX5" fmla="*/ 556395 w 557248"/>
                      <a:gd name="connsiteY5" fmla="*/ 326679 h 681968"/>
                      <a:gd name="connsiteX6" fmla="*/ 539613 w 557248"/>
                      <a:gd name="connsiteY6" fmla="*/ 462893 h 681968"/>
                      <a:gd name="connsiteX7" fmla="*/ 480081 w 557248"/>
                      <a:gd name="connsiteY7" fmla="*/ 574024 h 681968"/>
                      <a:gd name="connsiteX8" fmla="*/ 361014 w 557248"/>
                      <a:gd name="connsiteY8" fmla="*/ 646249 h 681968"/>
                      <a:gd name="connsiteX9" fmla="*/ 258446 w 557248"/>
                      <a:gd name="connsiteY9" fmla="*/ 679317 h 681968"/>
                      <a:gd name="connsiteX10" fmla="*/ 137177 w 557248"/>
                      <a:gd name="connsiteY10" fmla="*/ 681968 h 681968"/>
                      <a:gd name="connsiteX11" fmla="*/ 40663 w 557248"/>
                      <a:gd name="connsiteY11" fmla="*/ 643598 h 681968"/>
                      <a:gd name="connsiteX12" fmla="*/ 4625 w 557248"/>
                      <a:gd name="connsiteY12" fmla="*/ 498617 h 681968"/>
                      <a:gd name="connsiteX13" fmla="*/ 5417 w 557248"/>
                      <a:gd name="connsiteY13" fmla="*/ 290658 h 681968"/>
                      <a:gd name="connsiteX14" fmla="*/ 22405 w 557248"/>
                      <a:gd name="connsiteY14" fmla="*/ 80422 h 681968"/>
                      <a:gd name="connsiteX0" fmla="*/ 22405 w 557248"/>
                      <a:gd name="connsiteY0" fmla="*/ 80422 h 681968"/>
                      <a:gd name="connsiteX1" fmla="*/ 103844 w 557248"/>
                      <a:gd name="connsiteY1" fmla="*/ 27124 h 681968"/>
                      <a:gd name="connsiteX2" fmla="*/ 232250 w 557248"/>
                      <a:gd name="connsiteY2" fmla="*/ 238 h 681968"/>
                      <a:gd name="connsiteX3" fmla="*/ 412612 w 557248"/>
                      <a:gd name="connsiteY3" fmla="*/ 41418 h 681968"/>
                      <a:gd name="connsiteX4" fmla="*/ 518181 w 557248"/>
                      <a:gd name="connsiteY4" fmla="*/ 142222 h 681968"/>
                      <a:gd name="connsiteX5" fmla="*/ 556395 w 557248"/>
                      <a:gd name="connsiteY5" fmla="*/ 326679 h 681968"/>
                      <a:gd name="connsiteX6" fmla="*/ 539613 w 557248"/>
                      <a:gd name="connsiteY6" fmla="*/ 462893 h 681968"/>
                      <a:gd name="connsiteX7" fmla="*/ 480081 w 557248"/>
                      <a:gd name="connsiteY7" fmla="*/ 574024 h 681968"/>
                      <a:gd name="connsiteX8" fmla="*/ 361014 w 557248"/>
                      <a:gd name="connsiteY8" fmla="*/ 646249 h 681968"/>
                      <a:gd name="connsiteX9" fmla="*/ 258446 w 557248"/>
                      <a:gd name="connsiteY9" fmla="*/ 679317 h 681968"/>
                      <a:gd name="connsiteX10" fmla="*/ 137177 w 557248"/>
                      <a:gd name="connsiteY10" fmla="*/ 681968 h 681968"/>
                      <a:gd name="connsiteX11" fmla="*/ 40663 w 557248"/>
                      <a:gd name="connsiteY11" fmla="*/ 643598 h 681968"/>
                      <a:gd name="connsiteX12" fmla="*/ 4625 w 557248"/>
                      <a:gd name="connsiteY12" fmla="*/ 498617 h 681968"/>
                      <a:gd name="connsiteX13" fmla="*/ 5417 w 557248"/>
                      <a:gd name="connsiteY13" fmla="*/ 290658 h 681968"/>
                      <a:gd name="connsiteX14" fmla="*/ 22405 w 557248"/>
                      <a:gd name="connsiteY14" fmla="*/ 80422 h 681968"/>
                      <a:gd name="connsiteX0" fmla="*/ 22405 w 557248"/>
                      <a:gd name="connsiteY0" fmla="*/ 80422 h 681968"/>
                      <a:gd name="connsiteX1" fmla="*/ 103844 w 557248"/>
                      <a:gd name="connsiteY1" fmla="*/ 27124 h 681968"/>
                      <a:gd name="connsiteX2" fmla="*/ 232250 w 557248"/>
                      <a:gd name="connsiteY2" fmla="*/ 238 h 681968"/>
                      <a:gd name="connsiteX3" fmla="*/ 412612 w 557248"/>
                      <a:gd name="connsiteY3" fmla="*/ 41418 h 681968"/>
                      <a:gd name="connsiteX4" fmla="*/ 518181 w 557248"/>
                      <a:gd name="connsiteY4" fmla="*/ 142222 h 681968"/>
                      <a:gd name="connsiteX5" fmla="*/ 556395 w 557248"/>
                      <a:gd name="connsiteY5" fmla="*/ 326679 h 681968"/>
                      <a:gd name="connsiteX6" fmla="*/ 539613 w 557248"/>
                      <a:gd name="connsiteY6" fmla="*/ 462893 h 681968"/>
                      <a:gd name="connsiteX7" fmla="*/ 480081 w 557248"/>
                      <a:gd name="connsiteY7" fmla="*/ 574024 h 681968"/>
                      <a:gd name="connsiteX8" fmla="*/ 361014 w 557248"/>
                      <a:gd name="connsiteY8" fmla="*/ 646249 h 681968"/>
                      <a:gd name="connsiteX9" fmla="*/ 258446 w 557248"/>
                      <a:gd name="connsiteY9" fmla="*/ 679317 h 681968"/>
                      <a:gd name="connsiteX10" fmla="*/ 137177 w 557248"/>
                      <a:gd name="connsiteY10" fmla="*/ 681968 h 681968"/>
                      <a:gd name="connsiteX11" fmla="*/ 40663 w 557248"/>
                      <a:gd name="connsiteY11" fmla="*/ 643598 h 681968"/>
                      <a:gd name="connsiteX12" fmla="*/ 4625 w 557248"/>
                      <a:gd name="connsiteY12" fmla="*/ 498617 h 681968"/>
                      <a:gd name="connsiteX13" fmla="*/ 5417 w 557248"/>
                      <a:gd name="connsiteY13" fmla="*/ 290658 h 681968"/>
                      <a:gd name="connsiteX14" fmla="*/ 22405 w 557248"/>
                      <a:gd name="connsiteY14" fmla="*/ 80422 h 681968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</a:cxnLst>
                    <a:rect l="l" t="t" r="r" b="b"/>
                    <a:pathLst>
                      <a:path w="557248" h="681968">
                        <a:moveTo>
                          <a:pt x="22405" y="80422"/>
                        </a:moveTo>
                        <a:cubicBezTo>
                          <a:pt x="38015" y="48804"/>
                          <a:pt x="68870" y="40488"/>
                          <a:pt x="103844" y="27124"/>
                        </a:cubicBezTo>
                        <a:cubicBezTo>
                          <a:pt x="138818" y="13760"/>
                          <a:pt x="180789" y="-2144"/>
                          <a:pt x="232250" y="238"/>
                        </a:cubicBezTo>
                        <a:cubicBezTo>
                          <a:pt x="283711" y="2620"/>
                          <a:pt x="375408" y="5848"/>
                          <a:pt x="412612" y="41418"/>
                        </a:cubicBezTo>
                        <a:cubicBezTo>
                          <a:pt x="449816" y="76988"/>
                          <a:pt x="494217" y="94679"/>
                          <a:pt x="518181" y="142222"/>
                        </a:cubicBezTo>
                        <a:cubicBezTo>
                          <a:pt x="542145" y="189766"/>
                          <a:pt x="552823" y="273234"/>
                          <a:pt x="556395" y="326679"/>
                        </a:cubicBezTo>
                        <a:cubicBezTo>
                          <a:pt x="559967" y="380124"/>
                          <a:pt x="551935" y="418494"/>
                          <a:pt x="539613" y="462893"/>
                        </a:cubicBezTo>
                        <a:cubicBezTo>
                          <a:pt x="527291" y="507292"/>
                          <a:pt x="507863" y="538702"/>
                          <a:pt x="480081" y="574024"/>
                        </a:cubicBezTo>
                        <a:cubicBezTo>
                          <a:pt x="452299" y="609346"/>
                          <a:pt x="397953" y="628700"/>
                          <a:pt x="361014" y="646249"/>
                        </a:cubicBezTo>
                        <a:cubicBezTo>
                          <a:pt x="324075" y="663798"/>
                          <a:pt x="295752" y="674952"/>
                          <a:pt x="258446" y="679317"/>
                        </a:cubicBezTo>
                        <a:lnTo>
                          <a:pt x="137177" y="681968"/>
                        </a:lnTo>
                        <a:cubicBezTo>
                          <a:pt x="108179" y="669973"/>
                          <a:pt x="69661" y="655593"/>
                          <a:pt x="40663" y="643598"/>
                        </a:cubicBezTo>
                        <a:cubicBezTo>
                          <a:pt x="1668" y="538602"/>
                          <a:pt x="17325" y="612193"/>
                          <a:pt x="4625" y="498617"/>
                        </a:cubicBezTo>
                        <a:cubicBezTo>
                          <a:pt x="-4688" y="411352"/>
                          <a:pt x="2454" y="360357"/>
                          <a:pt x="5417" y="290658"/>
                        </a:cubicBezTo>
                        <a:cubicBezTo>
                          <a:pt x="8380" y="220959"/>
                          <a:pt x="-7330" y="129486"/>
                          <a:pt x="22405" y="80422"/>
                        </a:cubicBezTo>
                        <a:close/>
                      </a:path>
                    </a:pathLst>
                  </a:custGeom>
                  <a:blipFill dpi="0" rotWithShape="1">
                    <a:blip r:embed="rId6">
                      <a:alphaModFix amt="90000"/>
                    </a:blip>
                    <a:srcRect/>
                    <a:tile tx="0" ty="0" sx="100000" sy="100000" flip="none" algn="tl"/>
                  </a:blipFill>
                  <a:ln w="9525">
                    <a:noFill/>
                  </a:ln>
                  <a:scene3d>
                    <a:camera prst="orthographicFront"/>
                    <a:lightRig rig="threePt" dir="t"/>
                  </a:scene3d>
                  <a:sp3d>
                    <a:bevelT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69" name="순서도: 지연 770">
                    <a:extLst>
                      <a:ext uri="{FF2B5EF4-FFF2-40B4-BE49-F238E27FC236}">
                        <a16:creationId xmlns:a16="http://schemas.microsoft.com/office/drawing/2014/main" id="{336DBC71-834C-2DB6-1BC1-E11BD2817433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5101426" y="5337539"/>
                    <a:ext cx="763235" cy="416711"/>
                  </a:xfrm>
                  <a:custGeom>
                    <a:avLst/>
                    <a:gdLst>
                      <a:gd name="connsiteX0" fmla="*/ 0 w 524463"/>
                      <a:gd name="connsiteY0" fmla="*/ 0 h 821164"/>
                      <a:gd name="connsiteX1" fmla="*/ 262232 w 524463"/>
                      <a:gd name="connsiteY1" fmla="*/ 0 h 821164"/>
                      <a:gd name="connsiteX2" fmla="*/ 524464 w 524463"/>
                      <a:gd name="connsiteY2" fmla="*/ 410582 h 821164"/>
                      <a:gd name="connsiteX3" fmla="*/ 262232 w 524463"/>
                      <a:gd name="connsiteY3" fmla="*/ 821164 h 821164"/>
                      <a:gd name="connsiteX4" fmla="*/ 0 w 524463"/>
                      <a:gd name="connsiteY4" fmla="*/ 821164 h 821164"/>
                      <a:gd name="connsiteX5" fmla="*/ 0 w 524463"/>
                      <a:gd name="connsiteY5" fmla="*/ 0 h 821164"/>
                      <a:gd name="connsiteX0" fmla="*/ 19050 w 524464"/>
                      <a:gd name="connsiteY0" fmla="*/ 50803 h 821164"/>
                      <a:gd name="connsiteX1" fmla="*/ 262232 w 524464"/>
                      <a:gd name="connsiteY1" fmla="*/ 0 h 821164"/>
                      <a:gd name="connsiteX2" fmla="*/ 524464 w 524464"/>
                      <a:gd name="connsiteY2" fmla="*/ 410582 h 821164"/>
                      <a:gd name="connsiteX3" fmla="*/ 262232 w 524464"/>
                      <a:gd name="connsiteY3" fmla="*/ 821164 h 821164"/>
                      <a:gd name="connsiteX4" fmla="*/ 0 w 524464"/>
                      <a:gd name="connsiteY4" fmla="*/ 821164 h 821164"/>
                      <a:gd name="connsiteX5" fmla="*/ 19050 w 524464"/>
                      <a:gd name="connsiteY5" fmla="*/ 50803 h 821164"/>
                      <a:gd name="connsiteX0" fmla="*/ 0 w 505414"/>
                      <a:gd name="connsiteY0" fmla="*/ 50803 h 821164"/>
                      <a:gd name="connsiteX1" fmla="*/ 243182 w 505414"/>
                      <a:gd name="connsiteY1" fmla="*/ 0 h 821164"/>
                      <a:gd name="connsiteX2" fmla="*/ 505414 w 505414"/>
                      <a:gd name="connsiteY2" fmla="*/ 410582 h 821164"/>
                      <a:gd name="connsiteX3" fmla="*/ 243182 w 505414"/>
                      <a:gd name="connsiteY3" fmla="*/ 821164 h 821164"/>
                      <a:gd name="connsiteX4" fmla="*/ 6350 w 505414"/>
                      <a:gd name="connsiteY4" fmla="*/ 789414 h 821164"/>
                      <a:gd name="connsiteX5" fmla="*/ 0 w 505414"/>
                      <a:gd name="connsiteY5" fmla="*/ 50803 h 821164"/>
                      <a:gd name="connsiteX0" fmla="*/ 0 w 505414"/>
                      <a:gd name="connsiteY0" fmla="*/ 75333 h 845694"/>
                      <a:gd name="connsiteX1" fmla="*/ 243182 w 505414"/>
                      <a:gd name="connsiteY1" fmla="*/ 24530 h 845694"/>
                      <a:gd name="connsiteX2" fmla="*/ 505414 w 505414"/>
                      <a:gd name="connsiteY2" fmla="*/ 435112 h 845694"/>
                      <a:gd name="connsiteX3" fmla="*/ 243182 w 505414"/>
                      <a:gd name="connsiteY3" fmla="*/ 845694 h 845694"/>
                      <a:gd name="connsiteX4" fmla="*/ 6350 w 505414"/>
                      <a:gd name="connsiteY4" fmla="*/ 813944 h 845694"/>
                      <a:gd name="connsiteX5" fmla="*/ 0 w 505414"/>
                      <a:gd name="connsiteY5" fmla="*/ 75333 h 845694"/>
                      <a:gd name="connsiteX0" fmla="*/ 0 w 505414"/>
                      <a:gd name="connsiteY0" fmla="*/ 62182 h 832543"/>
                      <a:gd name="connsiteX1" fmla="*/ 243182 w 505414"/>
                      <a:gd name="connsiteY1" fmla="*/ 11379 h 832543"/>
                      <a:gd name="connsiteX2" fmla="*/ 505414 w 505414"/>
                      <a:gd name="connsiteY2" fmla="*/ 421961 h 832543"/>
                      <a:gd name="connsiteX3" fmla="*/ 243182 w 505414"/>
                      <a:gd name="connsiteY3" fmla="*/ 832543 h 832543"/>
                      <a:gd name="connsiteX4" fmla="*/ 6350 w 505414"/>
                      <a:gd name="connsiteY4" fmla="*/ 800793 h 832543"/>
                      <a:gd name="connsiteX5" fmla="*/ 0 w 505414"/>
                      <a:gd name="connsiteY5" fmla="*/ 62182 h 832543"/>
                      <a:gd name="connsiteX0" fmla="*/ 0 w 518115"/>
                      <a:gd name="connsiteY0" fmla="*/ 176337 h 832395"/>
                      <a:gd name="connsiteX1" fmla="*/ 255883 w 518115"/>
                      <a:gd name="connsiteY1" fmla="*/ 11231 h 832395"/>
                      <a:gd name="connsiteX2" fmla="*/ 518115 w 518115"/>
                      <a:gd name="connsiteY2" fmla="*/ 421813 h 832395"/>
                      <a:gd name="connsiteX3" fmla="*/ 255883 w 518115"/>
                      <a:gd name="connsiteY3" fmla="*/ 832395 h 832395"/>
                      <a:gd name="connsiteX4" fmla="*/ 19051 w 518115"/>
                      <a:gd name="connsiteY4" fmla="*/ 800645 h 832395"/>
                      <a:gd name="connsiteX5" fmla="*/ 0 w 518115"/>
                      <a:gd name="connsiteY5" fmla="*/ 176337 h 832395"/>
                      <a:gd name="connsiteX0" fmla="*/ 0 w 519401"/>
                      <a:gd name="connsiteY0" fmla="*/ 184794 h 840852"/>
                      <a:gd name="connsiteX1" fmla="*/ 255883 w 519401"/>
                      <a:gd name="connsiteY1" fmla="*/ 19688 h 840852"/>
                      <a:gd name="connsiteX2" fmla="*/ 352107 w 519401"/>
                      <a:gd name="connsiteY2" fmla="*/ 48956 h 840852"/>
                      <a:gd name="connsiteX3" fmla="*/ 518115 w 519401"/>
                      <a:gd name="connsiteY3" fmla="*/ 430270 h 840852"/>
                      <a:gd name="connsiteX4" fmla="*/ 255883 w 519401"/>
                      <a:gd name="connsiteY4" fmla="*/ 840852 h 840852"/>
                      <a:gd name="connsiteX5" fmla="*/ 19051 w 519401"/>
                      <a:gd name="connsiteY5" fmla="*/ 809102 h 840852"/>
                      <a:gd name="connsiteX6" fmla="*/ 0 w 519401"/>
                      <a:gd name="connsiteY6" fmla="*/ 184794 h 840852"/>
                      <a:gd name="connsiteX0" fmla="*/ 0 w 522056"/>
                      <a:gd name="connsiteY0" fmla="*/ 168859 h 824917"/>
                      <a:gd name="connsiteX1" fmla="*/ 255883 w 522056"/>
                      <a:gd name="connsiteY1" fmla="*/ 3753 h 824917"/>
                      <a:gd name="connsiteX2" fmla="*/ 402907 w 522056"/>
                      <a:gd name="connsiteY2" fmla="*/ 83824 h 824917"/>
                      <a:gd name="connsiteX3" fmla="*/ 518115 w 522056"/>
                      <a:gd name="connsiteY3" fmla="*/ 414335 h 824917"/>
                      <a:gd name="connsiteX4" fmla="*/ 255883 w 522056"/>
                      <a:gd name="connsiteY4" fmla="*/ 824917 h 824917"/>
                      <a:gd name="connsiteX5" fmla="*/ 19051 w 522056"/>
                      <a:gd name="connsiteY5" fmla="*/ 793167 h 824917"/>
                      <a:gd name="connsiteX6" fmla="*/ 0 w 522056"/>
                      <a:gd name="connsiteY6" fmla="*/ 168859 h 824917"/>
                      <a:gd name="connsiteX0" fmla="*/ 0 w 521019"/>
                      <a:gd name="connsiteY0" fmla="*/ 168859 h 824917"/>
                      <a:gd name="connsiteX1" fmla="*/ 255883 w 521019"/>
                      <a:gd name="connsiteY1" fmla="*/ 3753 h 824917"/>
                      <a:gd name="connsiteX2" fmla="*/ 402907 w 521019"/>
                      <a:gd name="connsiteY2" fmla="*/ 83824 h 824917"/>
                      <a:gd name="connsiteX3" fmla="*/ 518115 w 521019"/>
                      <a:gd name="connsiteY3" fmla="*/ 414335 h 824917"/>
                      <a:gd name="connsiteX4" fmla="*/ 466407 w 521019"/>
                      <a:gd name="connsiteY4" fmla="*/ 687074 h 824917"/>
                      <a:gd name="connsiteX5" fmla="*/ 255883 w 521019"/>
                      <a:gd name="connsiteY5" fmla="*/ 824917 h 824917"/>
                      <a:gd name="connsiteX6" fmla="*/ 19051 w 521019"/>
                      <a:gd name="connsiteY6" fmla="*/ 793167 h 824917"/>
                      <a:gd name="connsiteX7" fmla="*/ 0 w 521019"/>
                      <a:gd name="connsiteY7" fmla="*/ 168859 h 824917"/>
                      <a:gd name="connsiteX0" fmla="*/ 0 w 518998"/>
                      <a:gd name="connsiteY0" fmla="*/ 167272 h 823330"/>
                      <a:gd name="connsiteX1" fmla="*/ 255883 w 518998"/>
                      <a:gd name="connsiteY1" fmla="*/ 2166 h 823330"/>
                      <a:gd name="connsiteX2" fmla="*/ 402907 w 518998"/>
                      <a:gd name="connsiteY2" fmla="*/ 82237 h 823330"/>
                      <a:gd name="connsiteX3" fmla="*/ 491807 w 518998"/>
                      <a:gd name="connsiteY3" fmla="*/ 209234 h 823330"/>
                      <a:gd name="connsiteX4" fmla="*/ 518115 w 518998"/>
                      <a:gd name="connsiteY4" fmla="*/ 412748 h 823330"/>
                      <a:gd name="connsiteX5" fmla="*/ 466407 w 518998"/>
                      <a:gd name="connsiteY5" fmla="*/ 685487 h 823330"/>
                      <a:gd name="connsiteX6" fmla="*/ 255883 w 518998"/>
                      <a:gd name="connsiteY6" fmla="*/ 823330 h 823330"/>
                      <a:gd name="connsiteX7" fmla="*/ 19051 w 518998"/>
                      <a:gd name="connsiteY7" fmla="*/ 791580 h 823330"/>
                      <a:gd name="connsiteX8" fmla="*/ 0 w 518998"/>
                      <a:gd name="connsiteY8" fmla="*/ 167272 h 823330"/>
                      <a:gd name="connsiteX0" fmla="*/ 21253 w 540251"/>
                      <a:gd name="connsiteY0" fmla="*/ 167272 h 823330"/>
                      <a:gd name="connsiteX1" fmla="*/ 277136 w 540251"/>
                      <a:gd name="connsiteY1" fmla="*/ 2166 h 823330"/>
                      <a:gd name="connsiteX2" fmla="*/ 424160 w 540251"/>
                      <a:gd name="connsiteY2" fmla="*/ 82237 h 823330"/>
                      <a:gd name="connsiteX3" fmla="*/ 513060 w 540251"/>
                      <a:gd name="connsiteY3" fmla="*/ 209234 h 823330"/>
                      <a:gd name="connsiteX4" fmla="*/ 539368 w 540251"/>
                      <a:gd name="connsiteY4" fmla="*/ 412748 h 823330"/>
                      <a:gd name="connsiteX5" fmla="*/ 487660 w 540251"/>
                      <a:gd name="connsiteY5" fmla="*/ 685487 h 823330"/>
                      <a:gd name="connsiteX6" fmla="*/ 277136 w 540251"/>
                      <a:gd name="connsiteY6" fmla="*/ 823330 h 823330"/>
                      <a:gd name="connsiteX7" fmla="*/ 40304 w 540251"/>
                      <a:gd name="connsiteY7" fmla="*/ 791580 h 823330"/>
                      <a:gd name="connsiteX8" fmla="*/ 11411 w 540251"/>
                      <a:gd name="connsiteY8" fmla="*/ 615633 h 823330"/>
                      <a:gd name="connsiteX9" fmla="*/ 21253 w 540251"/>
                      <a:gd name="connsiteY9" fmla="*/ 167272 h 823330"/>
                      <a:gd name="connsiteX0" fmla="*/ 54342 w 573340"/>
                      <a:gd name="connsiteY0" fmla="*/ 167272 h 823330"/>
                      <a:gd name="connsiteX1" fmla="*/ 310225 w 573340"/>
                      <a:gd name="connsiteY1" fmla="*/ 2166 h 823330"/>
                      <a:gd name="connsiteX2" fmla="*/ 457249 w 573340"/>
                      <a:gd name="connsiteY2" fmla="*/ 82237 h 823330"/>
                      <a:gd name="connsiteX3" fmla="*/ 546149 w 573340"/>
                      <a:gd name="connsiteY3" fmla="*/ 209234 h 823330"/>
                      <a:gd name="connsiteX4" fmla="*/ 572457 w 573340"/>
                      <a:gd name="connsiteY4" fmla="*/ 412748 h 823330"/>
                      <a:gd name="connsiteX5" fmla="*/ 520749 w 573340"/>
                      <a:gd name="connsiteY5" fmla="*/ 685487 h 823330"/>
                      <a:gd name="connsiteX6" fmla="*/ 310225 w 573340"/>
                      <a:gd name="connsiteY6" fmla="*/ 823330 h 823330"/>
                      <a:gd name="connsiteX7" fmla="*/ 73393 w 573340"/>
                      <a:gd name="connsiteY7" fmla="*/ 791580 h 823330"/>
                      <a:gd name="connsiteX8" fmla="*/ 44500 w 573340"/>
                      <a:gd name="connsiteY8" fmla="*/ 615633 h 823330"/>
                      <a:gd name="connsiteX9" fmla="*/ 50 w 573340"/>
                      <a:gd name="connsiteY9" fmla="*/ 240987 h 823330"/>
                      <a:gd name="connsiteX10" fmla="*/ 54342 w 573340"/>
                      <a:gd name="connsiteY10" fmla="*/ 167272 h 823330"/>
                      <a:gd name="connsiteX0" fmla="*/ 54342 w 573340"/>
                      <a:gd name="connsiteY0" fmla="*/ 155040 h 811098"/>
                      <a:gd name="connsiteX1" fmla="*/ 253075 w 573340"/>
                      <a:gd name="connsiteY1" fmla="*/ 2634 h 811098"/>
                      <a:gd name="connsiteX2" fmla="*/ 457249 w 573340"/>
                      <a:gd name="connsiteY2" fmla="*/ 70005 h 811098"/>
                      <a:gd name="connsiteX3" fmla="*/ 546149 w 573340"/>
                      <a:gd name="connsiteY3" fmla="*/ 197002 h 811098"/>
                      <a:gd name="connsiteX4" fmla="*/ 572457 w 573340"/>
                      <a:gd name="connsiteY4" fmla="*/ 400516 h 811098"/>
                      <a:gd name="connsiteX5" fmla="*/ 520749 w 573340"/>
                      <a:gd name="connsiteY5" fmla="*/ 673255 h 811098"/>
                      <a:gd name="connsiteX6" fmla="*/ 310225 w 573340"/>
                      <a:gd name="connsiteY6" fmla="*/ 811098 h 811098"/>
                      <a:gd name="connsiteX7" fmla="*/ 73393 w 573340"/>
                      <a:gd name="connsiteY7" fmla="*/ 779348 h 811098"/>
                      <a:gd name="connsiteX8" fmla="*/ 44500 w 573340"/>
                      <a:gd name="connsiteY8" fmla="*/ 603401 h 811098"/>
                      <a:gd name="connsiteX9" fmla="*/ 50 w 573340"/>
                      <a:gd name="connsiteY9" fmla="*/ 228755 h 811098"/>
                      <a:gd name="connsiteX10" fmla="*/ 54342 w 573340"/>
                      <a:gd name="connsiteY10" fmla="*/ 155040 h 811098"/>
                      <a:gd name="connsiteX0" fmla="*/ 54342 w 573340"/>
                      <a:gd name="connsiteY0" fmla="*/ 155040 h 798398"/>
                      <a:gd name="connsiteX1" fmla="*/ 253075 w 573340"/>
                      <a:gd name="connsiteY1" fmla="*/ 2634 h 798398"/>
                      <a:gd name="connsiteX2" fmla="*/ 457249 w 573340"/>
                      <a:gd name="connsiteY2" fmla="*/ 70005 h 798398"/>
                      <a:gd name="connsiteX3" fmla="*/ 546149 w 573340"/>
                      <a:gd name="connsiteY3" fmla="*/ 197002 h 798398"/>
                      <a:gd name="connsiteX4" fmla="*/ 572457 w 573340"/>
                      <a:gd name="connsiteY4" fmla="*/ 400516 h 798398"/>
                      <a:gd name="connsiteX5" fmla="*/ 520749 w 573340"/>
                      <a:gd name="connsiteY5" fmla="*/ 673255 h 798398"/>
                      <a:gd name="connsiteX6" fmla="*/ 272125 w 573340"/>
                      <a:gd name="connsiteY6" fmla="*/ 798398 h 798398"/>
                      <a:gd name="connsiteX7" fmla="*/ 73393 w 573340"/>
                      <a:gd name="connsiteY7" fmla="*/ 779348 h 798398"/>
                      <a:gd name="connsiteX8" fmla="*/ 44500 w 573340"/>
                      <a:gd name="connsiteY8" fmla="*/ 603401 h 798398"/>
                      <a:gd name="connsiteX9" fmla="*/ 50 w 573340"/>
                      <a:gd name="connsiteY9" fmla="*/ 228755 h 798398"/>
                      <a:gd name="connsiteX10" fmla="*/ 54342 w 573340"/>
                      <a:gd name="connsiteY10" fmla="*/ 155040 h 798398"/>
                      <a:gd name="connsiteX0" fmla="*/ 54342 w 575221"/>
                      <a:gd name="connsiteY0" fmla="*/ 155040 h 798398"/>
                      <a:gd name="connsiteX1" fmla="*/ 253075 w 575221"/>
                      <a:gd name="connsiteY1" fmla="*/ 2634 h 798398"/>
                      <a:gd name="connsiteX2" fmla="*/ 457249 w 575221"/>
                      <a:gd name="connsiteY2" fmla="*/ 70005 h 798398"/>
                      <a:gd name="connsiteX3" fmla="*/ 546149 w 575221"/>
                      <a:gd name="connsiteY3" fmla="*/ 197002 h 798398"/>
                      <a:gd name="connsiteX4" fmla="*/ 572457 w 575221"/>
                      <a:gd name="connsiteY4" fmla="*/ 400516 h 798398"/>
                      <a:gd name="connsiteX5" fmla="*/ 488999 w 575221"/>
                      <a:gd name="connsiteY5" fmla="*/ 666905 h 798398"/>
                      <a:gd name="connsiteX6" fmla="*/ 272125 w 575221"/>
                      <a:gd name="connsiteY6" fmla="*/ 798398 h 798398"/>
                      <a:gd name="connsiteX7" fmla="*/ 73393 w 575221"/>
                      <a:gd name="connsiteY7" fmla="*/ 779348 h 798398"/>
                      <a:gd name="connsiteX8" fmla="*/ 44500 w 575221"/>
                      <a:gd name="connsiteY8" fmla="*/ 603401 h 798398"/>
                      <a:gd name="connsiteX9" fmla="*/ 50 w 575221"/>
                      <a:gd name="connsiteY9" fmla="*/ 228755 h 798398"/>
                      <a:gd name="connsiteX10" fmla="*/ 54342 w 575221"/>
                      <a:gd name="connsiteY10" fmla="*/ 155040 h 798398"/>
                      <a:gd name="connsiteX0" fmla="*/ 54342 w 575221"/>
                      <a:gd name="connsiteY0" fmla="*/ 155040 h 798398"/>
                      <a:gd name="connsiteX1" fmla="*/ 253075 w 575221"/>
                      <a:gd name="connsiteY1" fmla="*/ 2634 h 798398"/>
                      <a:gd name="connsiteX2" fmla="*/ 457249 w 575221"/>
                      <a:gd name="connsiteY2" fmla="*/ 70005 h 798398"/>
                      <a:gd name="connsiteX3" fmla="*/ 546149 w 575221"/>
                      <a:gd name="connsiteY3" fmla="*/ 197002 h 798398"/>
                      <a:gd name="connsiteX4" fmla="*/ 572457 w 575221"/>
                      <a:gd name="connsiteY4" fmla="*/ 400516 h 798398"/>
                      <a:gd name="connsiteX5" fmla="*/ 488999 w 575221"/>
                      <a:gd name="connsiteY5" fmla="*/ 666905 h 798398"/>
                      <a:gd name="connsiteX6" fmla="*/ 272125 w 575221"/>
                      <a:gd name="connsiteY6" fmla="*/ 798398 h 798398"/>
                      <a:gd name="connsiteX7" fmla="*/ 73393 w 575221"/>
                      <a:gd name="connsiteY7" fmla="*/ 779348 h 798398"/>
                      <a:gd name="connsiteX8" fmla="*/ 44500 w 575221"/>
                      <a:gd name="connsiteY8" fmla="*/ 603401 h 798398"/>
                      <a:gd name="connsiteX9" fmla="*/ 50 w 575221"/>
                      <a:gd name="connsiteY9" fmla="*/ 228755 h 798398"/>
                      <a:gd name="connsiteX10" fmla="*/ 54342 w 575221"/>
                      <a:gd name="connsiteY10" fmla="*/ 155040 h 798398"/>
                      <a:gd name="connsiteX0" fmla="*/ 54342 w 575221"/>
                      <a:gd name="connsiteY0" fmla="*/ 155040 h 798398"/>
                      <a:gd name="connsiteX1" fmla="*/ 253075 w 575221"/>
                      <a:gd name="connsiteY1" fmla="*/ 2634 h 798398"/>
                      <a:gd name="connsiteX2" fmla="*/ 457249 w 575221"/>
                      <a:gd name="connsiteY2" fmla="*/ 70005 h 798398"/>
                      <a:gd name="connsiteX3" fmla="*/ 546149 w 575221"/>
                      <a:gd name="connsiteY3" fmla="*/ 197002 h 798398"/>
                      <a:gd name="connsiteX4" fmla="*/ 572457 w 575221"/>
                      <a:gd name="connsiteY4" fmla="*/ 400516 h 798398"/>
                      <a:gd name="connsiteX5" fmla="*/ 488999 w 575221"/>
                      <a:gd name="connsiteY5" fmla="*/ 666905 h 798398"/>
                      <a:gd name="connsiteX6" fmla="*/ 272125 w 575221"/>
                      <a:gd name="connsiteY6" fmla="*/ 798398 h 798398"/>
                      <a:gd name="connsiteX7" fmla="*/ 73393 w 575221"/>
                      <a:gd name="connsiteY7" fmla="*/ 779348 h 798398"/>
                      <a:gd name="connsiteX8" fmla="*/ 44500 w 575221"/>
                      <a:gd name="connsiteY8" fmla="*/ 603401 h 798398"/>
                      <a:gd name="connsiteX9" fmla="*/ 50 w 575221"/>
                      <a:gd name="connsiteY9" fmla="*/ 228755 h 798398"/>
                      <a:gd name="connsiteX10" fmla="*/ 54342 w 575221"/>
                      <a:gd name="connsiteY10" fmla="*/ 155040 h 798398"/>
                      <a:gd name="connsiteX0" fmla="*/ 54342 w 575221"/>
                      <a:gd name="connsiteY0" fmla="*/ 155040 h 798398"/>
                      <a:gd name="connsiteX1" fmla="*/ 253075 w 575221"/>
                      <a:gd name="connsiteY1" fmla="*/ 2634 h 798398"/>
                      <a:gd name="connsiteX2" fmla="*/ 457249 w 575221"/>
                      <a:gd name="connsiteY2" fmla="*/ 70005 h 798398"/>
                      <a:gd name="connsiteX3" fmla="*/ 546149 w 575221"/>
                      <a:gd name="connsiteY3" fmla="*/ 197002 h 798398"/>
                      <a:gd name="connsiteX4" fmla="*/ 572457 w 575221"/>
                      <a:gd name="connsiteY4" fmla="*/ 400516 h 798398"/>
                      <a:gd name="connsiteX5" fmla="*/ 488999 w 575221"/>
                      <a:gd name="connsiteY5" fmla="*/ 666905 h 798398"/>
                      <a:gd name="connsiteX6" fmla="*/ 272125 w 575221"/>
                      <a:gd name="connsiteY6" fmla="*/ 798398 h 798398"/>
                      <a:gd name="connsiteX7" fmla="*/ 73393 w 575221"/>
                      <a:gd name="connsiteY7" fmla="*/ 779348 h 798398"/>
                      <a:gd name="connsiteX8" fmla="*/ 44500 w 575221"/>
                      <a:gd name="connsiteY8" fmla="*/ 603401 h 798398"/>
                      <a:gd name="connsiteX9" fmla="*/ 50 w 575221"/>
                      <a:gd name="connsiteY9" fmla="*/ 228755 h 798398"/>
                      <a:gd name="connsiteX10" fmla="*/ 54342 w 575221"/>
                      <a:gd name="connsiteY10" fmla="*/ 155040 h 798398"/>
                      <a:gd name="connsiteX0" fmla="*/ 47992 w 575221"/>
                      <a:gd name="connsiteY0" fmla="*/ 121896 h 797001"/>
                      <a:gd name="connsiteX1" fmla="*/ 253075 w 575221"/>
                      <a:gd name="connsiteY1" fmla="*/ 1237 h 797001"/>
                      <a:gd name="connsiteX2" fmla="*/ 457249 w 575221"/>
                      <a:gd name="connsiteY2" fmla="*/ 68608 h 797001"/>
                      <a:gd name="connsiteX3" fmla="*/ 546149 w 575221"/>
                      <a:gd name="connsiteY3" fmla="*/ 195605 h 797001"/>
                      <a:gd name="connsiteX4" fmla="*/ 572457 w 575221"/>
                      <a:gd name="connsiteY4" fmla="*/ 399119 h 797001"/>
                      <a:gd name="connsiteX5" fmla="*/ 488999 w 575221"/>
                      <a:gd name="connsiteY5" fmla="*/ 665508 h 797001"/>
                      <a:gd name="connsiteX6" fmla="*/ 272125 w 575221"/>
                      <a:gd name="connsiteY6" fmla="*/ 797001 h 797001"/>
                      <a:gd name="connsiteX7" fmla="*/ 73393 w 575221"/>
                      <a:gd name="connsiteY7" fmla="*/ 777951 h 797001"/>
                      <a:gd name="connsiteX8" fmla="*/ 44500 w 575221"/>
                      <a:gd name="connsiteY8" fmla="*/ 602004 h 797001"/>
                      <a:gd name="connsiteX9" fmla="*/ 50 w 575221"/>
                      <a:gd name="connsiteY9" fmla="*/ 227358 h 797001"/>
                      <a:gd name="connsiteX10" fmla="*/ 47992 w 575221"/>
                      <a:gd name="connsiteY10" fmla="*/ 121896 h 797001"/>
                      <a:gd name="connsiteX0" fmla="*/ 51978 w 579207"/>
                      <a:gd name="connsiteY0" fmla="*/ 121896 h 797001"/>
                      <a:gd name="connsiteX1" fmla="*/ 257061 w 579207"/>
                      <a:gd name="connsiteY1" fmla="*/ 1237 h 797001"/>
                      <a:gd name="connsiteX2" fmla="*/ 461235 w 579207"/>
                      <a:gd name="connsiteY2" fmla="*/ 68608 h 797001"/>
                      <a:gd name="connsiteX3" fmla="*/ 550135 w 579207"/>
                      <a:gd name="connsiteY3" fmla="*/ 195605 h 797001"/>
                      <a:gd name="connsiteX4" fmla="*/ 576443 w 579207"/>
                      <a:gd name="connsiteY4" fmla="*/ 399119 h 797001"/>
                      <a:gd name="connsiteX5" fmla="*/ 492985 w 579207"/>
                      <a:gd name="connsiteY5" fmla="*/ 665508 h 797001"/>
                      <a:gd name="connsiteX6" fmla="*/ 276111 w 579207"/>
                      <a:gd name="connsiteY6" fmla="*/ 797001 h 797001"/>
                      <a:gd name="connsiteX7" fmla="*/ 77379 w 579207"/>
                      <a:gd name="connsiteY7" fmla="*/ 777951 h 797001"/>
                      <a:gd name="connsiteX8" fmla="*/ 3243 w 579207"/>
                      <a:gd name="connsiteY8" fmla="*/ 609148 h 797001"/>
                      <a:gd name="connsiteX9" fmla="*/ 4036 w 579207"/>
                      <a:gd name="connsiteY9" fmla="*/ 227358 h 797001"/>
                      <a:gd name="connsiteX10" fmla="*/ 51978 w 579207"/>
                      <a:gd name="connsiteY10" fmla="*/ 121896 h 797001"/>
                      <a:gd name="connsiteX0" fmla="*/ 44834 w 579207"/>
                      <a:gd name="connsiteY0" fmla="*/ 109558 h 796569"/>
                      <a:gd name="connsiteX1" fmla="*/ 257061 w 579207"/>
                      <a:gd name="connsiteY1" fmla="*/ 805 h 796569"/>
                      <a:gd name="connsiteX2" fmla="*/ 461235 w 579207"/>
                      <a:gd name="connsiteY2" fmla="*/ 68176 h 796569"/>
                      <a:gd name="connsiteX3" fmla="*/ 550135 w 579207"/>
                      <a:gd name="connsiteY3" fmla="*/ 195173 h 796569"/>
                      <a:gd name="connsiteX4" fmla="*/ 576443 w 579207"/>
                      <a:gd name="connsiteY4" fmla="*/ 398687 h 796569"/>
                      <a:gd name="connsiteX5" fmla="*/ 492985 w 579207"/>
                      <a:gd name="connsiteY5" fmla="*/ 665076 h 796569"/>
                      <a:gd name="connsiteX6" fmla="*/ 276111 w 579207"/>
                      <a:gd name="connsiteY6" fmla="*/ 796569 h 796569"/>
                      <a:gd name="connsiteX7" fmla="*/ 77379 w 579207"/>
                      <a:gd name="connsiteY7" fmla="*/ 777519 h 796569"/>
                      <a:gd name="connsiteX8" fmla="*/ 3243 w 579207"/>
                      <a:gd name="connsiteY8" fmla="*/ 608716 h 796569"/>
                      <a:gd name="connsiteX9" fmla="*/ 4036 w 579207"/>
                      <a:gd name="connsiteY9" fmla="*/ 226926 h 796569"/>
                      <a:gd name="connsiteX10" fmla="*/ 44834 w 579207"/>
                      <a:gd name="connsiteY10" fmla="*/ 109558 h 796569"/>
                      <a:gd name="connsiteX0" fmla="*/ 44834 w 579207"/>
                      <a:gd name="connsiteY0" fmla="*/ 109558 h 796569"/>
                      <a:gd name="connsiteX1" fmla="*/ 257061 w 579207"/>
                      <a:gd name="connsiteY1" fmla="*/ 805 h 796569"/>
                      <a:gd name="connsiteX2" fmla="*/ 461235 w 579207"/>
                      <a:gd name="connsiteY2" fmla="*/ 68176 h 796569"/>
                      <a:gd name="connsiteX3" fmla="*/ 550135 w 579207"/>
                      <a:gd name="connsiteY3" fmla="*/ 195173 h 796569"/>
                      <a:gd name="connsiteX4" fmla="*/ 576443 w 579207"/>
                      <a:gd name="connsiteY4" fmla="*/ 398687 h 796569"/>
                      <a:gd name="connsiteX5" fmla="*/ 492985 w 579207"/>
                      <a:gd name="connsiteY5" fmla="*/ 665076 h 796569"/>
                      <a:gd name="connsiteX6" fmla="*/ 276111 w 579207"/>
                      <a:gd name="connsiteY6" fmla="*/ 796569 h 796569"/>
                      <a:gd name="connsiteX7" fmla="*/ 77379 w 579207"/>
                      <a:gd name="connsiteY7" fmla="*/ 777519 h 796569"/>
                      <a:gd name="connsiteX8" fmla="*/ 3243 w 579207"/>
                      <a:gd name="connsiteY8" fmla="*/ 608716 h 796569"/>
                      <a:gd name="connsiteX9" fmla="*/ 4036 w 579207"/>
                      <a:gd name="connsiteY9" fmla="*/ 226926 h 796569"/>
                      <a:gd name="connsiteX10" fmla="*/ 44834 w 579207"/>
                      <a:gd name="connsiteY10" fmla="*/ 109558 h 796569"/>
                      <a:gd name="connsiteX0" fmla="*/ 44834 w 579207"/>
                      <a:gd name="connsiteY0" fmla="*/ 109558 h 796569"/>
                      <a:gd name="connsiteX1" fmla="*/ 257061 w 579207"/>
                      <a:gd name="connsiteY1" fmla="*/ 805 h 796569"/>
                      <a:gd name="connsiteX2" fmla="*/ 461235 w 579207"/>
                      <a:gd name="connsiteY2" fmla="*/ 68176 h 796569"/>
                      <a:gd name="connsiteX3" fmla="*/ 550135 w 579207"/>
                      <a:gd name="connsiteY3" fmla="*/ 195173 h 796569"/>
                      <a:gd name="connsiteX4" fmla="*/ 576443 w 579207"/>
                      <a:gd name="connsiteY4" fmla="*/ 398687 h 796569"/>
                      <a:gd name="connsiteX5" fmla="*/ 492985 w 579207"/>
                      <a:gd name="connsiteY5" fmla="*/ 665076 h 796569"/>
                      <a:gd name="connsiteX6" fmla="*/ 276111 w 579207"/>
                      <a:gd name="connsiteY6" fmla="*/ 796569 h 796569"/>
                      <a:gd name="connsiteX7" fmla="*/ 77379 w 579207"/>
                      <a:gd name="connsiteY7" fmla="*/ 777519 h 796569"/>
                      <a:gd name="connsiteX8" fmla="*/ 3243 w 579207"/>
                      <a:gd name="connsiteY8" fmla="*/ 608716 h 796569"/>
                      <a:gd name="connsiteX9" fmla="*/ 4036 w 579207"/>
                      <a:gd name="connsiteY9" fmla="*/ 226926 h 796569"/>
                      <a:gd name="connsiteX10" fmla="*/ 44834 w 579207"/>
                      <a:gd name="connsiteY10" fmla="*/ 109558 h 796569"/>
                      <a:gd name="connsiteX0" fmla="*/ 44834 w 579207"/>
                      <a:gd name="connsiteY0" fmla="*/ 109558 h 796569"/>
                      <a:gd name="connsiteX1" fmla="*/ 257061 w 579207"/>
                      <a:gd name="connsiteY1" fmla="*/ 805 h 796569"/>
                      <a:gd name="connsiteX2" fmla="*/ 461235 w 579207"/>
                      <a:gd name="connsiteY2" fmla="*/ 68176 h 796569"/>
                      <a:gd name="connsiteX3" fmla="*/ 550135 w 579207"/>
                      <a:gd name="connsiteY3" fmla="*/ 195173 h 796569"/>
                      <a:gd name="connsiteX4" fmla="*/ 576443 w 579207"/>
                      <a:gd name="connsiteY4" fmla="*/ 398687 h 796569"/>
                      <a:gd name="connsiteX5" fmla="*/ 492985 w 579207"/>
                      <a:gd name="connsiteY5" fmla="*/ 665076 h 796569"/>
                      <a:gd name="connsiteX6" fmla="*/ 276111 w 579207"/>
                      <a:gd name="connsiteY6" fmla="*/ 796569 h 796569"/>
                      <a:gd name="connsiteX7" fmla="*/ 77379 w 579207"/>
                      <a:gd name="connsiteY7" fmla="*/ 777519 h 796569"/>
                      <a:gd name="connsiteX8" fmla="*/ 3243 w 579207"/>
                      <a:gd name="connsiteY8" fmla="*/ 608716 h 796569"/>
                      <a:gd name="connsiteX9" fmla="*/ 4036 w 579207"/>
                      <a:gd name="connsiteY9" fmla="*/ 226926 h 796569"/>
                      <a:gd name="connsiteX10" fmla="*/ 44834 w 579207"/>
                      <a:gd name="connsiteY10" fmla="*/ 109558 h 796569"/>
                      <a:gd name="connsiteX0" fmla="*/ 44834 w 579207"/>
                      <a:gd name="connsiteY0" fmla="*/ 93345 h 780356"/>
                      <a:gd name="connsiteX1" fmla="*/ 247536 w 579207"/>
                      <a:gd name="connsiteY1" fmla="*/ 1261 h 780356"/>
                      <a:gd name="connsiteX2" fmla="*/ 461235 w 579207"/>
                      <a:gd name="connsiteY2" fmla="*/ 51963 h 780356"/>
                      <a:gd name="connsiteX3" fmla="*/ 550135 w 579207"/>
                      <a:gd name="connsiteY3" fmla="*/ 178960 h 780356"/>
                      <a:gd name="connsiteX4" fmla="*/ 576443 w 579207"/>
                      <a:gd name="connsiteY4" fmla="*/ 382474 h 780356"/>
                      <a:gd name="connsiteX5" fmla="*/ 492985 w 579207"/>
                      <a:gd name="connsiteY5" fmla="*/ 648863 h 780356"/>
                      <a:gd name="connsiteX6" fmla="*/ 276111 w 579207"/>
                      <a:gd name="connsiteY6" fmla="*/ 780356 h 780356"/>
                      <a:gd name="connsiteX7" fmla="*/ 77379 w 579207"/>
                      <a:gd name="connsiteY7" fmla="*/ 761306 h 780356"/>
                      <a:gd name="connsiteX8" fmla="*/ 3243 w 579207"/>
                      <a:gd name="connsiteY8" fmla="*/ 592503 h 780356"/>
                      <a:gd name="connsiteX9" fmla="*/ 4036 w 579207"/>
                      <a:gd name="connsiteY9" fmla="*/ 210713 h 780356"/>
                      <a:gd name="connsiteX10" fmla="*/ 44834 w 579207"/>
                      <a:gd name="connsiteY10" fmla="*/ 93345 h 780356"/>
                      <a:gd name="connsiteX0" fmla="*/ 44834 w 579207"/>
                      <a:gd name="connsiteY0" fmla="*/ 92586 h 779597"/>
                      <a:gd name="connsiteX1" fmla="*/ 247536 w 579207"/>
                      <a:gd name="connsiteY1" fmla="*/ 502 h 779597"/>
                      <a:gd name="connsiteX2" fmla="*/ 439804 w 579207"/>
                      <a:gd name="connsiteY2" fmla="*/ 63113 h 779597"/>
                      <a:gd name="connsiteX3" fmla="*/ 550135 w 579207"/>
                      <a:gd name="connsiteY3" fmla="*/ 178201 h 779597"/>
                      <a:gd name="connsiteX4" fmla="*/ 576443 w 579207"/>
                      <a:gd name="connsiteY4" fmla="*/ 381715 h 779597"/>
                      <a:gd name="connsiteX5" fmla="*/ 492985 w 579207"/>
                      <a:gd name="connsiteY5" fmla="*/ 648104 h 779597"/>
                      <a:gd name="connsiteX6" fmla="*/ 276111 w 579207"/>
                      <a:gd name="connsiteY6" fmla="*/ 779597 h 779597"/>
                      <a:gd name="connsiteX7" fmla="*/ 77379 w 579207"/>
                      <a:gd name="connsiteY7" fmla="*/ 760547 h 779597"/>
                      <a:gd name="connsiteX8" fmla="*/ 3243 w 579207"/>
                      <a:gd name="connsiteY8" fmla="*/ 591744 h 779597"/>
                      <a:gd name="connsiteX9" fmla="*/ 4036 w 579207"/>
                      <a:gd name="connsiteY9" fmla="*/ 209954 h 779597"/>
                      <a:gd name="connsiteX10" fmla="*/ 44834 w 579207"/>
                      <a:gd name="connsiteY10" fmla="*/ 92586 h 779597"/>
                      <a:gd name="connsiteX0" fmla="*/ 44834 w 579207"/>
                      <a:gd name="connsiteY0" fmla="*/ 82080 h 769091"/>
                      <a:gd name="connsiteX1" fmla="*/ 247536 w 579207"/>
                      <a:gd name="connsiteY1" fmla="*/ 4284 h 769091"/>
                      <a:gd name="connsiteX2" fmla="*/ 439804 w 579207"/>
                      <a:gd name="connsiteY2" fmla="*/ 52607 h 769091"/>
                      <a:gd name="connsiteX3" fmla="*/ 550135 w 579207"/>
                      <a:gd name="connsiteY3" fmla="*/ 167695 h 769091"/>
                      <a:gd name="connsiteX4" fmla="*/ 576443 w 579207"/>
                      <a:gd name="connsiteY4" fmla="*/ 371209 h 769091"/>
                      <a:gd name="connsiteX5" fmla="*/ 492985 w 579207"/>
                      <a:gd name="connsiteY5" fmla="*/ 637598 h 769091"/>
                      <a:gd name="connsiteX6" fmla="*/ 276111 w 579207"/>
                      <a:gd name="connsiteY6" fmla="*/ 769091 h 769091"/>
                      <a:gd name="connsiteX7" fmla="*/ 77379 w 579207"/>
                      <a:gd name="connsiteY7" fmla="*/ 750041 h 769091"/>
                      <a:gd name="connsiteX8" fmla="*/ 3243 w 579207"/>
                      <a:gd name="connsiteY8" fmla="*/ 581238 h 769091"/>
                      <a:gd name="connsiteX9" fmla="*/ 4036 w 579207"/>
                      <a:gd name="connsiteY9" fmla="*/ 199448 h 769091"/>
                      <a:gd name="connsiteX10" fmla="*/ 44834 w 579207"/>
                      <a:gd name="connsiteY10" fmla="*/ 82080 h 769091"/>
                      <a:gd name="connsiteX0" fmla="*/ 44834 w 579207"/>
                      <a:gd name="connsiteY0" fmla="*/ 78633 h 765644"/>
                      <a:gd name="connsiteX1" fmla="*/ 104842 w 579207"/>
                      <a:gd name="connsiteY1" fmla="*/ 22959 h 765644"/>
                      <a:gd name="connsiteX2" fmla="*/ 247536 w 579207"/>
                      <a:gd name="connsiteY2" fmla="*/ 837 h 765644"/>
                      <a:gd name="connsiteX3" fmla="*/ 439804 w 579207"/>
                      <a:gd name="connsiteY3" fmla="*/ 49160 h 765644"/>
                      <a:gd name="connsiteX4" fmla="*/ 550135 w 579207"/>
                      <a:gd name="connsiteY4" fmla="*/ 164248 h 765644"/>
                      <a:gd name="connsiteX5" fmla="*/ 576443 w 579207"/>
                      <a:gd name="connsiteY5" fmla="*/ 367762 h 765644"/>
                      <a:gd name="connsiteX6" fmla="*/ 492985 w 579207"/>
                      <a:gd name="connsiteY6" fmla="*/ 634151 h 765644"/>
                      <a:gd name="connsiteX7" fmla="*/ 276111 w 579207"/>
                      <a:gd name="connsiteY7" fmla="*/ 765644 h 765644"/>
                      <a:gd name="connsiteX8" fmla="*/ 77379 w 579207"/>
                      <a:gd name="connsiteY8" fmla="*/ 746594 h 765644"/>
                      <a:gd name="connsiteX9" fmla="*/ 3243 w 579207"/>
                      <a:gd name="connsiteY9" fmla="*/ 577791 h 765644"/>
                      <a:gd name="connsiteX10" fmla="*/ 4036 w 579207"/>
                      <a:gd name="connsiteY10" fmla="*/ 196001 h 765644"/>
                      <a:gd name="connsiteX11" fmla="*/ 44834 w 579207"/>
                      <a:gd name="connsiteY11" fmla="*/ 78633 h 765644"/>
                      <a:gd name="connsiteX0" fmla="*/ 44834 w 577756"/>
                      <a:gd name="connsiteY0" fmla="*/ 78633 h 765644"/>
                      <a:gd name="connsiteX1" fmla="*/ 104842 w 577756"/>
                      <a:gd name="connsiteY1" fmla="*/ 22959 h 765644"/>
                      <a:gd name="connsiteX2" fmla="*/ 247536 w 577756"/>
                      <a:gd name="connsiteY2" fmla="*/ 837 h 765644"/>
                      <a:gd name="connsiteX3" fmla="*/ 439804 w 577756"/>
                      <a:gd name="connsiteY3" fmla="*/ 49160 h 765644"/>
                      <a:gd name="connsiteX4" fmla="*/ 538229 w 577756"/>
                      <a:gd name="connsiteY4" fmla="*/ 178539 h 765644"/>
                      <a:gd name="connsiteX5" fmla="*/ 576443 w 577756"/>
                      <a:gd name="connsiteY5" fmla="*/ 367762 h 765644"/>
                      <a:gd name="connsiteX6" fmla="*/ 492985 w 577756"/>
                      <a:gd name="connsiteY6" fmla="*/ 634151 h 765644"/>
                      <a:gd name="connsiteX7" fmla="*/ 276111 w 577756"/>
                      <a:gd name="connsiteY7" fmla="*/ 765644 h 765644"/>
                      <a:gd name="connsiteX8" fmla="*/ 77379 w 577756"/>
                      <a:gd name="connsiteY8" fmla="*/ 746594 h 765644"/>
                      <a:gd name="connsiteX9" fmla="*/ 3243 w 577756"/>
                      <a:gd name="connsiteY9" fmla="*/ 577791 h 765644"/>
                      <a:gd name="connsiteX10" fmla="*/ 4036 w 577756"/>
                      <a:gd name="connsiteY10" fmla="*/ 196001 h 765644"/>
                      <a:gd name="connsiteX11" fmla="*/ 44834 w 577756"/>
                      <a:gd name="connsiteY11" fmla="*/ 78633 h 765644"/>
                      <a:gd name="connsiteX0" fmla="*/ 44834 w 577756"/>
                      <a:gd name="connsiteY0" fmla="*/ 79401 h 766412"/>
                      <a:gd name="connsiteX1" fmla="*/ 104842 w 577756"/>
                      <a:gd name="connsiteY1" fmla="*/ 23727 h 766412"/>
                      <a:gd name="connsiteX2" fmla="*/ 247536 w 577756"/>
                      <a:gd name="connsiteY2" fmla="*/ 1605 h 766412"/>
                      <a:gd name="connsiteX3" fmla="*/ 430279 w 577756"/>
                      <a:gd name="connsiteY3" fmla="*/ 64216 h 766412"/>
                      <a:gd name="connsiteX4" fmla="*/ 538229 w 577756"/>
                      <a:gd name="connsiteY4" fmla="*/ 179307 h 766412"/>
                      <a:gd name="connsiteX5" fmla="*/ 576443 w 577756"/>
                      <a:gd name="connsiteY5" fmla="*/ 368530 h 766412"/>
                      <a:gd name="connsiteX6" fmla="*/ 492985 w 577756"/>
                      <a:gd name="connsiteY6" fmla="*/ 634919 h 766412"/>
                      <a:gd name="connsiteX7" fmla="*/ 276111 w 577756"/>
                      <a:gd name="connsiteY7" fmla="*/ 766412 h 766412"/>
                      <a:gd name="connsiteX8" fmla="*/ 77379 w 577756"/>
                      <a:gd name="connsiteY8" fmla="*/ 747362 h 766412"/>
                      <a:gd name="connsiteX9" fmla="*/ 3243 w 577756"/>
                      <a:gd name="connsiteY9" fmla="*/ 578559 h 766412"/>
                      <a:gd name="connsiteX10" fmla="*/ 4036 w 577756"/>
                      <a:gd name="connsiteY10" fmla="*/ 196769 h 766412"/>
                      <a:gd name="connsiteX11" fmla="*/ 44834 w 577756"/>
                      <a:gd name="connsiteY11" fmla="*/ 79401 h 766412"/>
                      <a:gd name="connsiteX0" fmla="*/ 44834 w 577756"/>
                      <a:gd name="connsiteY0" fmla="*/ 65900 h 752911"/>
                      <a:gd name="connsiteX1" fmla="*/ 104842 w 577756"/>
                      <a:gd name="connsiteY1" fmla="*/ 10226 h 752911"/>
                      <a:gd name="connsiteX2" fmla="*/ 240392 w 577756"/>
                      <a:gd name="connsiteY2" fmla="*/ 4773 h 752911"/>
                      <a:gd name="connsiteX3" fmla="*/ 430279 w 577756"/>
                      <a:gd name="connsiteY3" fmla="*/ 50715 h 752911"/>
                      <a:gd name="connsiteX4" fmla="*/ 538229 w 577756"/>
                      <a:gd name="connsiteY4" fmla="*/ 165806 h 752911"/>
                      <a:gd name="connsiteX5" fmla="*/ 576443 w 577756"/>
                      <a:gd name="connsiteY5" fmla="*/ 355029 h 752911"/>
                      <a:gd name="connsiteX6" fmla="*/ 492985 w 577756"/>
                      <a:gd name="connsiteY6" fmla="*/ 621418 h 752911"/>
                      <a:gd name="connsiteX7" fmla="*/ 276111 w 577756"/>
                      <a:gd name="connsiteY7" fmla="*/ 752911 h 752911"/>
                      <a:gd name="connsiteX8" fmla="*/ 77379 w 577756"/>
                      <a:gd name="connsiteY8" fmla="*/ 733861 h 752911"/>
                      <a:gd name="connsiteX9" fmla="*/ 3243 w 577756"/>
                      <a:gd name="connsiteY9" fmla="*/ 565058 h 752911"/>
                      <a:gd name="connsiteX10" fmla="*/ 4036 w 577756"/>
                      <a:gd name="connsiteY10" fmla="*/ 183268 h 752911"/>
                      <a:gd name="connsiteX11" fmla="*/ 44834 w 577756"/>
                      <a:gd name="connsiteY11" fmla="*/ 65900 h 752911"/>
                      <a:gd name="connsiteX0" fmla="*/ 44834 w 577756"/>
                      <a:gd name="connsiteY0" fmla="*/ 62406 h 749417"/>
                      <a:gd name="connsiteX1" fmla="*/ 107223 w 577756"/>
                      <a:gd name="connsiteY1" fmla="*/ 18642 h 749417"/>
                      <a:gd name="connsiteX2" fmla="*/ 240392 w 577756"/>
                      <a:gd name="connsiteY2" fmla="*/ 1279 h 749417"/>
                      <a:gd name="connsiteX3" fmla="*/ 430279 w 577756"/>
                      <a:gd name="connsiteY3" fmla="*/ 47221 h 749417"/>
                      <a:gd name="connsiteX4" fmla="*/ 538229 w 577756"/>
                      <a:gd name="connsiteY4" fmla="*/ 162312 h 749417"/>
                      <a:gd name="connsiteX5" fmla="*/ 576443 w 577756"/>
                      <a:gd name="connsiteY5" fmla="*/ 351535 h 749417"/>
                      <a:gd name="connsiteX6" fmla="*/ 492985 w 577756"/>
                      <a:gd name="connsiteY6" fmla="*/ 617924 h 749417"/>
                      <a:gd name="connsiteX7" fmla="*/ 276111 w 577756"/>
                      <a:gd name="connsiteY7" fmla="*/ 749417 h 749417"/>
                      <a:gd name="connsiteX8" fmla="*/ 77379 w 577756"/>
                      <a:gd name="connsiteY8" fmla="*/ 730367 h 749417"/>
                      <a:gd name="connsiteX9" fmla="*/ 3243 w 577756"/>
                      <a:gd name="connsiteY9" fmla="*/ 561564 h 749417"/>
                      <a:gd name="connsiteX10" fmla="*/ 4036 w 577756"/>
                      <a:gd name="connsiteY10" fmla="*/ 179774 h 749417"/>
                      <a:gd name="connsiteX11" fmla="*/ 44834 w 577756"/>
                      <a:gd name="connsiteY11" fmla="*/ 62406 h 749417"/>
                      <a:gd name="connsiteX0" fmla="*/ 44834 w 577338"/>
                      <a:gd name="connsiteY0" fmla="*/ 62406 h 749417"/>
                      <a:gd name="connsiteX1" fmla="*/ 107223 w 577338"/>
                      <a:gd name="connsiteY1" fmla="*/ 18642 h 749417"/>
                      <a:gd name="connsiteX2" fmla="*/ 240392 w 577338"/>
                      <a:gd name="connsiteY2" fmla="*/ 1279 h 749417"/>
                      <a:gd name="connsiteX3" fmla="*/ 430279 w 577338"/>
                      <a:gd name="connsiteY3" fmla="*/ 47221 h 749417"/>
                      <a:gd name="connsiteX4" fmla="*/ 538229 w 577338"/>
                      <a:gd name="connsiteY4" fmla="*/ 162312 h 749417"/>
                      <a:gd name="connsiteX5" fmla="*/ 576443 w 577338"/>
                      <a:gd name="connsiteY5" fmla="*/ 351535 h 749417"/>
                      <a:gd name="connsiteX6" fmla="*/ 502510 w 577338"/>
                      <a:gd name="connsiteY6" fmla="*/ 617927 h 749417"/>
                      <a:gd name="connsiteX7" fmla="*/ 276111 w 577338"/>
                      <a:gd name="connsiteY7" fmla="*/ 749417 h 749417"/>
                      <a:gd name="connsiteX8" fmla="*/ 77379 w 577338"/>
                      <a:gd name="connsiteY8" fmla="*/ 730367 h 749417"/>
                      <a:gd name="connsiteX9" fmla="*/ 3243 w 577338"/>
                      <a:gd name="connsiteY9" fmla="*/ 561564 h 749417"/>
                      <a:gd name="connsiteX10" fmla="*/ 4036 w 577338"/>
                      <a:gd name="connsiteY10" fmla="*/ 179774 h 749417"/>
                      <a:gd name="connsiteX11" fmla="*/ 44834 w 577338"/>
                      <a:gd name="connsiteY11" fmla="*/ 62406 h 749417"/>
                      <a:gd name="connsiteX0" fmla="*/ 44834 w 577338"/>
                      <a:gd name="connsiteY0" fmla="*/ 62406 h 749417"/>
                      <a:gd name="connsiteX1" fmla="*/ 107223 w 577338"/>
                      <a:gd name="connsiteY1" fmla="*/ 18642 h 749417"/>
                      <a:gd name="connsiteX2" fmla="*/ 240392 w 577338"/>
                      <a:gd name="connsiteY2" fmla="*/ 1279 h 749417"/>
                      <a:gd name="connsiteX3" fmla="*/ 430279 w 577338"/>
                      <a:gd name="connsiteY3" fmla="*/ 47221 h 749417"/>
                      <a:gd name="connsiteX4" fmla="*/ 538229 w 577338"/>
                      <a:gd name="connsiteY4" fmla="*/ 162312 h 749417"/>
                      <a:gd name="connsiteX5" fmla="*/ 576443 w 577338"/>
                      <a:gd name="connsiteY5" fmla="*/ 351535 h 749417"/>
                      <a:gd name="connsiteX6" fmla="*/ 502510 w 577338"/>
                      <a:gd name="connsiteY6" fmla="*/ 617927 h 749417"/>
                      <a:gd name="connsiteX7" fmla="*/ 385827 w 577338"/>
                      <a:gd name="connsiteY7" fmla="*/ 709202 h 749417"/>
                      <a:gd name="connsiteX8" fmla="*/ 276111 w 577338"/>
                      <a:gd name="connsiteY8" fmla="*/ 749417 h 749417"/>
                      <a:gd name="connsiteX9" fmla="*/ 77379 w 577338"/>
                      <a:gd name="connsiteY9" fmla="*/ 730367 h 749417"/>
                      <a:gd name="connsiteX10" fmla="*/ 3243 w 577338"/>
                      <a:gd name="connsiteY10" fmla="*/ 561564 h 749417"/>
                      <a:gd name="connsiteX11" fmla="*/ 4036 w 577338"/>
                      <a:gd name="connsiteY11" fmla="*/ 179774 h 749417"/>
                      <a:gd name="connsiteX12" fmla="*/ 44834 w 577338"/>
                      <a:gd name="connsiteY12" fmla="*/ 62406 h 749417"/>
                      <a:gd name="connsiteX0" fmla="*/ 44834 w 576847"/>
                      <a:gd name="connsiteY0" fmla="*/ 62406 h 749417"/>
                      <a:gd name="connsiteX1" fmla="*/ 107223 w 576847"/>
                      <a:gd name="connsiteY1" fmla="*/ 18642 h 749417"/>
                      <a:gd name="connsiteX2" fmla="*/ 240392 w 576847"/>
                      <a:gd name="connsiteY2" fmla="*/ 1279 h 749417"/>
                      <a:gd name="connsiteX3" fmla="*/ 430279 w 576847"/>
                      <a:gd name="connsiteY3" fmla="*/ 47221 h 749417"/>
                      <a:gd name="connsiteX4" fmla="*/ 538229 w 576847"/>
                      <a:gd name="connsiteY4" fmla="*/ 162312 h 749417"/>
                      <a:gd name="connsiteX5" fmla="*/ 576443 w 576847"/>
                      <a:gd name="connsiteY5" fmla="*/ 351535 h 749417"/>
                      <a:gd name="connsiteX6" fmla="*/ 554899 w 576847"/>
                      <a:gd name="connsiteY6" fmla="*/ 497271 h 749417"/>
                      <a:gd name="connsiteX7" fmla="*/ 502510 w 576847"/>
                      <a:gd name="connsiteY7" fmla="*/ 617927 h 749417"/>
                      <a:gd name="connsiteX8" fmla="*/ 385827 w 576847"/>
                      <a:gd name="connsiteY8" fmla="*/ 709202 h 749417"/>
                      <a:gd name="connsiteX9" fmla="*/ 276111 w 576847"/>
                      <a:gd name="connsiteY9" fmla="*/ 749417 h 749417"/>
                      <a:gd name="connsiteX10" fmla="*/ 77379 w 576847"/>
                      <a:gd name="connsiteY10" fmla="*/ 730367 h 749417"/>
                      <a:gd name="connsiteX11" fmla="*/ 3243 w 576847"/>
                      <a:gd name="connsiteY11" fmla="*/ 561564 h 749417"/>
                      <a:gd name="connsiteX12" fmla="*/ 4036 w 576847"/>
                      <a:gd name="connsiteY12" fmla="*/ 179774 h 749417"/>
                      <a:gd name="connsiteX13" fmla="*/ 44834 w 576847"/>
                      <a:gd name="connsiteY13" fmla="*/ 62406 h 749417"/>
                      <a:gd name="connsiteX0" fmla="*/ 44834 w 576847"/>
                      <a:gd name="connsiteY0" fmla="*/ 62406 h 749417"/>
                      <a:gd name="connsiteX1" fmla="*/ 107223 w 576847"/>
                      <a:gd name="connsiteY1" fmla="*/ 18642 h 749417"/>
                      <a:gd name="connsiteX2" fmla="*/ 240392 w 576847"/>
                      <a:gd name="connsiteY2" fmla="*/ 1279 h 749417"/>
                      <a:gd name="connsiteX3" fmla="*/ 430279 w 576847"/>
                      <a:gd name="connsiteY3" fmla="*/ 47221 h 749417"/>
                      <a:gd name="connsiteX4" fmla="*/ 538229 w 576847"/>
                      <a:gd name="connsiteY4" fmla="*/ 162312 h 749417"/>
                      <a:gd name="connsiteX5" fmla="*/ 576443 w 576847"/>
                      <a:gd name="connsiteY5" fmla="*/ 351535 h 749417"/>
                      <a:gd name="connsiteX6" fmla="*/ 554899 w 576847"/>
                      <a:gd name="connsiteY6" fmla="*/ 497271 h 749417"/>
                      <a:gd name="connsiteX7" fmla="*/ 502510 w 576847"/>
                      <a:gd name="connsiteY7" fmla="*/ 617927 h 749417"/>
                      <a:gd name="connsiteX8" fmla="*/ 385827 w 576847"/>
                      <a:gd name="connsiteY8" fmla="*/ 709202 h 749417"/>
                      <a:gd name="connsiteX9" fmla="*/ 276111 w 576847"/>
                      <a:gd name="connsiteY9" fmla="*/ 749417 h 749417"/>
                      <a:gd name="connsiteX10" fmla="*/ 161993 w 576847"/>
                      <a:gd name="connsiteY10" fmla="*/ 709199 h 749417"/>
                      <a:gd name="connsiteX11" fmla="*/ 77379 w 576847"/>
                      <a:gd name="connsiteY11" fmla="*/ 730367 h 749417"/>
                      <a:gd name="connsiteX12" fmla="*/ 3243 w 576847"/>
                      <a:gd name="connsiteY12" fmla="*/ 561564 h 749417"/>
                      <a:gd name="connsiteX13" fmla="*/ 4036 w 576847"/>
                      <a:gd name="connsiteY13" fmla="*/ 179774 h 749417"/>
                      <a:gd name="connsiteX14" fmla="*/ 44834 w 576847"/>
                      <a:gd name="connsiteY14" fmla="*/ 62406 h 749417"/>
                      <a:gd name="connsiteX0" fmla="*/ 44834 w 576847"/>
                      <a:gd name="connsiteY0" fmla="*/ 62406 h 730367"/>
                      <a:gd name="connsiteX1" fmla="*/ 107223 w 576847"/>
                      <a:gd name="connsiteY1" fmla="*/ 18642 h 730367"/>
                      <a:gd name="connsiteX2" fmla="*/ 240392 w 576847"/>
                      <a:gd name="connsiteY2" fmla="*/ 1279 h 730367"/>
                      <a:gd name="connsiteX3" fmla="*/ 430279 w 576847"/>
                      <a:gd name="connsiteY3" fmla="*/ 47221 h 730367"/>
                      <a:gd name="connsiteX4" fmla="*/ 538229 w 576847"/>
                      <a:gd name="connsiteY4" fmla="*/ 162312 h 730367"/>
                      <a:gd name="connsiteX5" fmla="*/ 576443 w 576847"/>
                      <a:gd name="connsiteY5" fmla="*/ 351535 h 730367"/>
                      <a:gd name="connsiteX6" fmla="*/ 554899 w 576847"/>
                      <a:gd name="connsiteY6" fmla="*/ 497271 h 730367"/>
                      <a:gd name="connsiteX7" fmla="*/ 502510 w 576847"/>
                      <a:gd name="connsiteY7" fmla="*/ 617927 h 730367"/>
                      <a:gd name="connsiteX8" fmla="*/ 385827 w 576847"/>
                      <a:gd name="connsiteY8" fmla="*/ 709202 h 730367"/>
                      <a:gd name="connsiteX9" fmla="*/ 278493 w 576847"/>
                      <a:gd name="connsiteY9" fmla="*/ 723224 h 730367"/>
                      <a:gd name="connsiteX10" fmla="*/ 161993 w 576847"/>
                      <a:gd name="connsiteY10" fmla="*/ 709199 h 730367"/>
                      <a:gd name="connsiteX11" fmla="*/ 77379 w 576847"/>
                      <a:gd name="connsiteY11" fmla="*/ 730367 h 730367"/>
                      <a:gd name="connsiteX12" fmla="*/ 3243 w 576847"/>
                      <a:gd name="connsiteY12" fmla="*/ 561564 h 730367"/>
                      <a:gd name="connsiteX13" fmla="*/ 4036 w 576847"/>
                      <a:gd name="connsiteY13" fmla="*/ 179774 h 730367"/>
                      <a:gd name="connsiteX14" fmla="*/ 44834 w 576847"/>
                      <a:gd name="connsiteY14" fmla="*/ 62406 h 730367"/>
                      <a:gd name="connsiteX0" fmla="*/ 44834 w 576847"/>
                      <a:gd name="connsiteY0" fmla="*/ 62406 h 723224"/>
                      <a:gd name="connsiteX1" fmla="*/ 107223 w 576847"/>
                      <a:gd name="connsiteY1" fmla="*/ 18642 h 723224"/>
                      <a:gd name="connsiteX2" fmla="*/ 240392 w 576847"/>
                      <a:gd name="connsiteY2" fmla="*/ 1279 h 723224"/>
                      <a:gd name="connsiteX3" fmla="*/ 430279 w 576847"/>
                      <a:gd name="connsiteY3" fmla="*/ 47221 h 723224"/>
                      <a:gd name="connsiteX4" fmla="*/ 538229 w 576847"/>
                      <a:gd name="connsiteY4" fmla="*/ 162312 h 723224"/>
                      <a:gd name="connsiteX5" fmla="*/ 576443 w 576847"/>
                      <a:gd name="connsiteY5" fmla="*/ 351535 h 723224"/>
                      <a:gd name="connsiteX6" fmla="*/ 554899 w 576847"/>
                      <a:gd name="connsiteY6" fmla="*/ 497271 h 723224"/>
                      <a:gd name="connsiteX7" fmla="*/ 502510 w 576847"/>
                      <a:gd name="connsiteY7" fmla="*/ 617927 h 723224"/>
                      <a:gd name="connsiteX8" fmla="*/ 385827 w 576847"/>
                      <a:gd name="connsiteY8" fmla="*/ 709202 h 723224"/>
                      <a:gd name="connsiteX9" fmla="*/ 278493 w 576847"/>
                      <a:gd name="connsiteY9" fmla="*/ 723224 h 723224"/>
                      <a:gd name="connsiteX10" fmla="*/ 161993 w 576847"/>
                      <a:gd name="connsiteY10" fmla="*/ 709199 h 723224"/>
                      <a:gd name="connsiteX11" fmla="*/ 65473 w 576847"/>
                      <a:gd name="connsiteY11" fmla="*/ 680361 h 723224"/>
                      <a:gd name="connsiteX12" fmla="*/ 3243 w 576847"/>
                      <a:gd name="connsiteY12" fmla="*/ 561564 h 723224"/>
                      <a:gd name="connsiteX13" fmla="*/ 4036 w 576847"/>
                      <a:gd name="connsiteY13" fmla="*/ 179774 h 723224"/>
                      <a:gd name="connsiteX14" fmla="*/ 44834 w 576847"/>
                      <a:gd name="connsiteY14" fmla="*/ 62406 h 723224"/>
                      <a:gd name="connsiteX0" fmla="*/ 41078 w 573091"/>
                      <a:gd name="connsiteY0" fmla="*/ 62406 h 723224"/>
                      <a:gd name="connsiteX1" fmla="*/ 103467 w 573091"/>
                      <a:gd name="connsiteY1" fmla="*/ 18642 h 723224"/>
                      <a:gd name="connsiteX2" fmla="*/ 236636 w 573091"/>
                      <a:gd name="connsiteY2" fmla="*/ 1279 h 723224"/>
                      <a:gd name="connsiteX3" fmla="*/ 426523 w 573091"/>
                      <a:gd name="connsiteY3" fmla="*/ 47221 h 723224"/>
                      <a:gd name="connsiteX4" fmla="*/ 534473 w 573091"/>
                      <a:gd name="connsiteY4" fmla="*/ 162312 h 723224"/>
                      <a:gd name="connsiteX5" fmla="*/ 572687 w 573091"/>
                      <a:gd name="connsiteY5" fmla="*/ 351535 h 723224"/>
                      <a:gd name="connsiteX6" fmla="*/ 551143 w 573091"/>
                      <a:gd name="connsiteY6" fmla="*/ 497271 h 723224"/>
                      <a:gd name="connsiteX7" fmla="*/ 498754 w 573091"/>
                      <a:gd name="connsiteY7" fmla="*/ 617927 h 723224"/>
                      <a:gd name="connsiteX8" fmla="*/ 382071 w 573091"/>
                      <a:gd name="connsiteY8" fmla="*/ 709202 h 723224"/>
                      <a:gd name="connsiteX9" fmla="*/ 274737 w 573091"/>
                      <a:gd name="connsiteY9" fmla="*/ 723224 h 723224"/>
                      <a:gd name="connsiteX10" fmla="*/ 158237 w 573091"/>
                      <a:gd name="connsiteY10" fmla="*/ 709199 h 723224"/>
                      <a:gd name="connsiteX11" fmla="*/ 61717 w 573091"/>
                      <a:gd name="connsiteY11" fmla="*/ 680361 h 723224"/>
                      <a:gd name="connsiteX12" fmla="*/ 11393 w 573091"/>
                      <a:gd name="connsiteY12" fmla="*/ 554423 h 723224"/>
                      <a:gd name="connsiteX13" fmla="*/ 280 w 573091"/>
                      <a:gd name="connsiteY13" fmla="*/ 179774 h 723224"/>
                      <a:gd name="connsiteX14" fmla="*/ 41078 w 573091"/>
                      <a:gd name="connsiteY14" fmla="*/ 62406 h 723224"/>
                      <a:gd name="connsiteX0" fmla="*/ 43044 w 575057"/>
                      <a:gd name="connsiteY0" fmla="*/ 62406 h 723224"/>
                      <a:gd name="connsiteX1" fmla="*/ 105433 w 575057"/>
                      <a:gd name="connsiteY1" fmla="*/ 18642 h 723224"/>
                      <a:gd name="connsiteX2" fmla="*/ 238602 w 575057"/>
                      <a:gd name="connsiteY2" fmla="*/ 1279 h 723224"/>
                      <a:gd name="connsiteX3" fmla="*/ 428489 w 575057"/>
                      <a:gd name="connsiteY3" fmla="*/ 47221 h 723224"/>
                      <a:gd name="connsiteX4" fmla="*/ 536439 w 575057"/>
                      <a:gd name="connsiteY4" fmla="*/ 162312 h 723224"/>
                      <a:gd name="connsiteX5" fmla="*/ 574653 w 575057"/>
                      <a:gd name="connsiteY5" fmla="*/ 351535 h 723224"/>
                      <a:gd name="connsiteX6" fmla="*/ 553109 w 575057"/>
                      <a:gd name="connsiteY6" fmla="*/ 497271 h 723224"/>
                      <a:gd name="connsiteX7" fmla="*/ 500720 w 575057"/>
                      <a:gd name="connsiteY7" fmla="*/ 617927 h 723224"/>
                      <a:gd name="connsiteX8" fmla="*/ 384037 w 575057"/>
                      <a:gd name="connsiteY8" fmla="*/ 709202 h 723224"/>
                      <a:gd name="connsiteX9" fmla="*/ 276703 w 575057"/>
                      <a:gd name="connsiteY9" fmla="*/ 723224 h 723224"/>
                      <a:gd name="connsiteX10" fmla="*/ 160203 w 575057"/>
                      <a:gd name="connsiteY10" fmla="*/ 709199 h 723224"/>
                      <a:gd name="connsiteX11" fmla="*/ 63683 w 575057"/>
                      <a:gd name="connsiteY11" fmla="*/ 680361 h 723224"/>
                      <a:gd name="connsiteX12" fmla="*/ 13359 w 575057"/>
                      <a:gd name="connsiteY12" fmla="*/ 554423 h 723224"/>
                      <a:gd name="connsiteX13" fmla="*/ 2246 w 575057"/>
                      <a:gd name="connsiteY13" fmla="*/ 179774 h 723224"/>
                      <a:gd name="connsiteX14" fmla="*/ 43044 w 575057"/>
                      <a:gd name="connsiteY14" fmla="*/ 62406 h 723224"/>
                      <a:gd name="connsiteX0" fmla="*/ 46838 w 578851"/>
                      <a:gd name="connsiteY0" fmla="*/ 62406 h 723224"/>
                      <a:gd name="connsiteX1" fmla="*/ 109227 w 578851"/>
                      <a:gd name="connsiteY1" fmla="*/ 18642 h 723224"/>
                      <a:gd name="connsiteX2" fmla="*/ 242396 w 578851"/>
                      <a:gd name="connsiteY2" fmla="*/ 1279 h 723224"/>
                      <a:gd name="connsiteX3" fmla="*/ 432283 w 578851"/>
                      <a:gd name="connsiteY3" fmla="*/ 47221 h 723224"/>
                      <a:gd name="connsiteX4" fmla="*/ 540233 w 578851"/>
                      <a:gd name="connsiteY4" fmla="*/ 162312 h 723224"/>
                      <a:gd name="connsiteX5" fmla="*/ 578447 w 578851"/>
                      <a:gd name="connsiteY5" fmla="*/ 351535 h 723224"/>
                      <a:gd name="connsiteX6" fmla="*/ 556903 w 578851"/>
                      <a:gd name="connsiteY6" fmla="*/ 497271 h 723224"/>
                      <a:gd name="connsiteX7" fmla="*/ 504514 w 578851"/>
                      <a:gd name="connsiteY7" fmla="*/ 617927 h 723224"/>
                      <a:gd name="connsiteX8" fmla="*/ 387831 w 578851"/>
                      <a:gd name="connsiteY8" fmla="*/ 709202 h 723224"/>
                      <a:gd name="connsiteX9" fmla="*/ 280497 w 578851"/>
                      <a:gd name="connsiteY9" fmla="*/ 723224 h 723224"/>
                      <a:gd name="connsiteX10" fmla="*/ 163997 w 578851"/>
                      <a:gd name="connsiteY10" fmla="*/ 709199 h 723224"/>
                      <a:gd name="connsiteX11" fmla="*/ 67477 w 578851"/>
                      <a:gd name="connsiteY11" fmla="*/ 680361 h 723224"/>
                      <a:gd name="connsiteX12" fmla="*/ 10009 w 578851"/>
                      <a:gd name="connsiteY12" fmla="*/ 554426 h 723224"/>
                      <a:gd name="connsiteX13" fmla="*/ 6040 w 578851"/>
                      <a:gd name="connsiteY13" fmla="*/ 179774 h 723224"/>
                      <a:gd name="connsiteX14" fmla="*/ 46838 w 578851"/>
                      <a:gd name="connsiteY14" fmla="*/ 62406 h 723224"/>
                      <a:gd name="connsiteX0" fmla="*/ 46838 w 813420"/>
                      <a:gd name="connsiteY0" fmla="*/ 62406 h 723224"/>
                      <a:gd name="connsiteX1" fmla="*/ 109227 w 813420"/>
                      <a:gd name="connsiteY1" fmla="*/ 18642 h 723224"/>
                      <a:gd name="connsiteX2" fmla="*/ 242396 w 813420"/>
                      <a:gd name="connsiteY2" fmla="*/ 1279 h 723224"/>
                      <a:gd name="connsiteX3" fmla="*/ 432283 w 813420"/>
                      <a:gd name="connsiteY3" fmla="*/ 47221 h 723224"/>
                      <a:gd name="connsiteX4" fmla="*/ 540233 w 813420"/>
                      <a:gd name="connsiteY4" fmla="*/ 162312 h 723224"/>
                      <a:gd name="connsiteX5" fmla="*/ 813397 w 813420"/>
                      <a:gd name="connsiteY5" fmla="*/ 380110 h 723224"/>
                      <a:gd name="connsiteX6" fmla="*/ 556903 w 813420"/>
                      <a:gd name="connsiteY6" fmla="*/ 497271 h 723224"/>
                      <a:gd name="connsiteX7" fmla="*/ 504514 w 813420"/>
                      <a:gd name="connsiteY7" fmla="*/ 617927 h 723224"/>
                      <a:gd name="connsiteX8" fmla="*/ 387831 w 813420"/>
                      <a:gd name="connsiteY8" fmla="*/ 709202 h 723224"/>
                      <a:gd name="connsiteX9" fmla="*/ 280497 w 813420"/>
                      <a:gd name="connsiteY9" fmla="*/ 723224 h 723224"/>
                      <a:gd name="connsiteX10" fmla="*/ 163997 w 813420"/>
                      <a:gd name="connsiteY10" fmla="*/ 709199 h 723224"/>
                      <a:gd name="connsiteX11" fmla="*/ 67477 w 813420"/>
                      <a:gd name="connsiteY11" fmla="*/ 680361 h 723224"/>
                      <a:gd name="connsiteX12" fmla="*/ 10009 w 813420"/>
                      <a:gd name="connsiteY12" fmla="*/ 554426 h 723224"/>
                      <a:gd name="connsiteX13" fmla="*/ 6040 w 813420"/>
                      <a:gd name="connsiteY13" fmla="*/ 179774 h 723224"/>
                      <a:gd name="connsiteX14" fmla="*/ 46838 w 813420"/>
                      <a:gd name="connsiteY14" fmla="*/ 62406 h 723224"/>
                      <a:gd name="connsiteX0" fmla="*/ 46838 w 794372"/>
                      <a:gd name="connsiteY0" fmla="*/ 62406 h 723224"/>
                      <a:gd name="connsiteX1" fmla="*/ 109227 w 794372"/>
                      <a:gd name="connsiteY1" fmla="*/ 18642 h 723224"/>
                      <a:gd name="connsiteX2" fmla="*/ 242396 w 794372"/>
                      <a:gd name="connsiteY2" fmla="*/ 1279 h 723224"/>
                      <a:gd name="connsiteX3" fmla="*/ 432283 w 794372"/>
                      <a:gd name="connsiteY3" fmla="*/ 47221 h 723224"/>
                      <a:gd name="connsiteX4" fmla="*/ 540233 w 794372"/>
                      <a:gd name="connsiteY4" fmla="*/ 162312 h 723224"/>
                      <a:gd name="connsiteX5" fmla="*/ 794347 w 794372"/>
                      <a:gd name="connsiteY5" fmla="*/ 237235 h 723224"/>
                      <a:gd name="connsiteX6" fmla="*/ 556903 w 794372"/>
                      <a:gd name="connsiteY6" fmla="*/ 497271 h 723224"/>
                      <a:gd name="connsiteX7" fmla="*/ 504514 w 794372"/>
                      <a:gd name="connsiteY7" fmla="*/ 617927 h 723224"/>
                      <a:gd name="connsiteX8" fmla="*/ 387831 w 794372"/>
                      <a:gd name="connsiteY8" fmla="*/ 709202 h 723224"/>
                      <a:gd name="connsiteX9" fmla="*/ 280497 w 794372"/>
                      <a:gd name="connsiteY9" fmla="*/ 723224 h 723224"/>
                      <a:gd name="connsiteX10" fmla="*/ 163997 w 794372"/>
                      <a:gd name="connsiteY10" fmla="*/ 709199 h 723224"/>
                      <a:gd name="connsiteX11" fmla="*/ 67477 w 794372"/>
                      <a:gd name="connsiteY11" fmla="*/ 680361 h 723224"/>
                      <a:gd name="connsiteX12" fmla="*/ 10009 w 794372"/>
                      <a:gd name="connsiteY12" fmla="*/ 554426 h 723224"/>
                      <a:gd name="connsiteX13" fmla="*/ 6040 w 794372"/>
                      <a:gd name="connsiteY13" fmla="*/ 179774 h 723224"/>
                      <a:gd name="connsiteX14" fmla="*/ 46838 w 794372"/>
                      <a:gd name="connsiteY14" fmla="*/ 62406 h 723224"/>
                      <a:gd name="connsiteX0" fmla="*/ 46838 w 718184"/>
                      <a:gd name="connsiteY0" fmla="*/ 62406 h 723224"/>
                      <a:gd name="connsiteX1" fmla="*/ 109227 w 718184"/>
                      <a:gd name="connsiteY1" fmla="*/ 18642 h 723224"/>
                      <a:gd name="connsiteX2" fmla="*/ 242396 w 718184"/>
                      <a:gd name="connsiteY2" fmla="*/ 1279 h 723224"/>
                      <a:gd name="connsiteX3" fmla="*/ 432283 w 718184"/>
                      <a:gd name="connsiteY3" fmla="*/ 47221 h 723224"/>
                      <a:gd name="connsiteX4" fmla="*/ 540233 w 718184"/>
                      <a:gd name="connsiteY4" fmla="*/ 162312 h 723224"/>
                      <a:gd name="connsiteX5" fmla="*/ 718147 w 718184"/>
                      <a:gd name="connsiteY5" fmla="*/ 345185 h 723224"/>
                      <a:gd name="connsiteX6" fmla="*/ 556903 w 718184"/>
                      <a:gd name="connsiteY6" fmla="*/ 497271 h 723224"/>
                      <a:gd name="connsiteX7" fmla="*/ 504514 w 718184"/>
                      <a:gd name="connsiteY7" fmla="*/ 617927 h 723224"/>
                      <a:gd name="connsiteX8" fmla="*/ 387831 w 718184"/>
                      <a:gd name="connsiteY8" fmla="*/ 709202 h 723224"/>
                      <a:gd name="connsiteX9" fmla="*/ 280497 w 718184"/>
                      <a:gd name="connsiteY9" fmla="*/ 723224 h 723224"/>
                      <a:gd name="connsiteX10" fmla="*/ 163997 w 718184"/>
                      <a:gd name="connsiteY10" fmla="*/ 709199 h 723224"/>
                      <a:gd name="connsiteX11" fmla="*/ 67477 w 718184"/>
                      <a:gd name="connsiteY11" fmla="*/ 680361 h 723224"/>
                      <a:gd name="connsiteX12" fmla="*/ 10009 w 718184"/>
                      <a:gd name="connsiteY12" fmla="*/ 554426 h 723224"/>
                      <a:gd name="connsiteX13" fmla="*/ 6040 w 718184"/>
                      <a:gd name="connsiteY13" fmla="*/ 179774 h 723224"/>
                      <a:gd name="connsiteX14" fmla="*/ 46838 w 718184"/>
                      <a:gd name="connsiteY14" fmla="*/ 62406 h 723224"/>
                      <a:gd name="connsiteX0" fmla="*/ 46838 w 718410"/>
                      <a:gd name="connsiteY0" fmla="*/ 62406 h 723224"/>
                      <a:gd name="connsiteX1" fmla="*/ 109227 w 718410"/>
                      <a:gd name="connsiteY1" fmla="*/ 18642 h 723224"/>
                      <a:gd name="connsiteX2" fmla="*/ 242396 w 718410"/>
                      <a:gd name="connsiteY2" fmla="*/ 1279 h 723224"/>
                      <a:gd name="connsiteX3" fmla="*/ 432283 w 718410"/>
                      <a:gd name="connsiteY3" fmla="*/ 47221 h 723224"/>
                      <a:gd name="connsiteX4" fmla="*/ 511658 w 718410"/>
                      <a:gd name="connsiteY4" fmla="*/ 184537 h 723224"/>
                      <a:gd name="connsiteX5" fmla="*/ 718147 w 718410"/>
                      <a:gd name="connsiteY5" fmla="*/ 345185 h 723224"/>
                      <a:gd name="connsiteX6" fmla="*/ 556903 w 718410"/>
                      <a:gd name="connsiteY6" fmla="*/ 497271 h 723224"/>
                      <a:gd name="connsiteX7" fmla="*/ 504514 w 718410"/>
                      <a:gd name="connsiteY7" fmla="*/ 617927 h 723224"/>
                      <a:gd name="connsiteX8" fmla="*/ 387831 w 718410"/>
                      <a:gd name="connsiteY8" fmla="*/ 709202 h 723224"/>
                      <a:gd name="connsiteX9" fmla="*/ 280497 w 718410"/>
                      <a:gd name="connsiteY9" fmla="*/ 723224 h 723224"/>
                      <a:gd name="connsiteX10" fmla="*/ 163997 w 718410"/>
                      <a:gd name="connsiteY10" fmla="*/ 709199 h 723224"/>
                      <a:gd name="connsiteX11" fmla="*/ 67477 w 718410"/>
                      <a:gd name="connsiteY11" fmla="*/ 680361 h 723224"/>
                      <a:gd name="connsiteX12" fmla="*/ 10009 w 718410"/>
                      <a:gd name="connsiteY12" fmla="*/ 554426 h 723224"/>
                      <a:gd name="connsiteX13" fmla="*/ 6040 w 718410"/>
                      <a:gd name="connsiteY13" fmla="*/ 179774 h 723224"/>
                      <a:gd name="connsiteX14" fmla="*/ 46838 w 718410"/>
                      <a:gd name="connsiteY14" fmla="*/ 62406 h 723224"/>
                      <a:gd name="connsiteX0" fmla="*/ 46838 w 718410"/>
                      <a:gd name="connsiteY0" fmla="*/ 70140 h 730958"/>
                      <a:gd name="connsiteX1" fmla="*/ 109227 w 718410"/>
                      <a:gd name="connsiteY1" fmla="*/ 26376 h 730958"/>
                      <a:gd name="connsiteX2" fmla="*/ 242396 w 718410"/>
                      <a:gd name="connsiteY2" fmla="*/ 9013 h 730958"/>
                      <a:gd name="connsiteX3" fmla="*/ 391008 w 718410"/>
                      <a:gd name="connsiteY3" fmla="*/ 166080 h 730958"/>
                      <a:gd name="connsiteX4" fmla="*/ 511658 w 718410"/>
                      <a:gd name="connsiteY4" fmla="*/ 192271 h 730958"/>
                      <a:gd name="connsiteX5" fmla="*/ 718147 w 718410"/>
                      <a:gd name="connsiteY5" fmla="*/ 352919 h 730958"/>
                      <a:gd name="connsiteX6" fmla="*/ 556903 w 718410"/>
                      <a:gd name="connsiteY6" fmla="*/ 505005 h 730958"/>
                      <a:gd name="connsiteX7" fmla="*/ 504514 w 718410"/>
                      <a:gd name="connsiteY7" fmla="*/ 625661 h 730958"/>
                      <a:gd name="connsiteX8" fmla="*/ 387831 w 718410"/>
                      <a:gd name="connsiteY8" fmla="*/ 716936 h 730958"/>
                      <a:gd name="connsiteX9" fmla="*/ 280497 w 718410"/>
                      <a:gd name="connsiteY9" fmla="*/ 730958 h 730958"/>
                      <a:gd name="connsiteX10" fmla="*/ 163997 w 718410"/>
                      <a:gd name="connsiteY10" fmla="*/ 716933 h 730958"/>
                      <a:gd name="connsiteX11" fmla="*/ 67477 w 718410"/>
                      <a:gd name="connsiteY11" fmla="*/ 688095 h 730958"/>
                      <a:gd name="connsiteX12" fmla="*/ 10009 w 718410"/>
                      <a:gd name="connsiteY12" fmla="*/ 562160 h 730958"/>
                      <a:gd name="connsiteX13" fmla="*/ 6040 w 718410"/>
                      <a:gd name="connsiteY13" fmla="*/ 187508 h 730958"/>
                      <a:gd name="connsiteX14" fmla="*/ 46838 w 718410"/>
                      <a:gd name="connsiteY14" fmla="*/ 70140 h 730958"/>
                      <a:gd name="connsiteX0" fmla="*/ 46838 w 718410"/>
                      <a:gd name="connsiteY0" fmla="*/ 48389 h 709207"/>
                      <a:gd name="connsiteX1" fmla="*/ 109227 w 718410"/>
                      <a:gd name="connsiteY1" fmla="*/ 4625 h 709207"/>
                      <a:gd name="connsiteX2" fmla="*/ 391008 w 718410"/>
                      <a:gd name="connsiteY2" fmla="*/ 144329 h 709207"/>
                      <a:gd name="connsiteX3" fmla="*/ 511658 w 718410"/>
                      <a:gd name="connsiteY3" fmla="*/ 170520 h 709207"/>
                      <a:gd name="connsiteX4" fmla="*/ 718147 w 718410"/>
                      <a:gd name="connsiteY4" fmla="*/ 331168 h 709207"/>
                      <a:gd name="connsiteX5" fmla="*/ 556903 w 718410"/>
                      <a:gd name="connsiteY5" fmla="*/ 483254 h 709207"/>
                      <a:gd name="connsiteX6" fmla="*/ 504514 w 718410"/>
                      <a:gd name="connsiteY6" fmla="*/ 603910 h 709207"/>
                      <a:gd name="connsiteX7" fmla="*/ 387831 w 718410"/>
                      <a:gd name="connsiteY7" fmla="*/ 695185 h 709207"/>
                      <a:gd name="connsiteX8" fmla="*/ 280497 w 718410"/>
                      <a:gd name="connsiteY8" fmla="*/ 709207 h 709207"/>
                      <a:gd name="connsiteX9" fmla="*/ 163997 w 718410"/>
                      <a:gd name="connsiteY9" fmla="*/ 695182 h 709207"/>
                      <a:gd name="connsiteX10" fmla="*/ 67477 w 718410"/>
                      <a:gd name="connsiteY10" fmla="*/ 666344 h 709207"/>
                      <a:gd name="connsiteX11" fmla="*/ 10009 w 718410"/>
                      <a:gd name="connsiteY11" fmla="*/ 540409 h 709207"/>
                      <a:gd name="connsiteX12" fmla="*/ 6040 w 718410"/>
                      <a:gd name="connsiteY12" fmla="*/ 165757 h 709207"/>
                      <a:gd name="connsiteX13" fmla="*/ 46838 w 718410"/>
                      <a:gd name="connsiteY13" fmla="*/ 48389 h 709207"/>
                      <a:gd name="connsiteX0" fmla="*/ 46838 w 718410"/>
                      <a:gd name="connsiteY0" fmla="*/ 118 h 660936"/>
                      <a:gd name="connsiteX1" fmla="*/ 391008 w 718410"/>
                      <a:gd name="connsiteY1" fmla="*/ 96058 h 660936"/>
                      <a:gd name="connsiteX2" fmla="*/ 511658 w 718410"/>
                      <a:gd name="connsiteY2" fmla="*/ 122249 h 660936"/>
                      <a:gd name="connsiteX3" fmla="*/ 718147 w 718410"/>
                      <a:gd name="connsiteY3" fmla="*/ 282897 h 660936"/>
                      <a:gd name="connsiteX4" fmla="*/ 556903 w 718410"/>
                      <a:gd name="connsiteY4" fmla="*/ 434983 h 660936"/>
                      <a:gd name="connsiteX5" fmla="*/ 504514 w 718410"/>
                      <a:gd name="connsiteY5" fmla="*/ 555639 h 660936"/>
                      <a:gd name="connsiteX6" fmla="*/ 387831 w 718410"/>
                      <a:gd name="connsiteY6" fmla="*/ 646914 h 660936"/>
                      <a:gd name="connsiteX7" fmla="*/ 280497 w 718410"/>
                      <a:gd name="connsiteY7" fmla="*/ 660936 h 660936"/>
                      <a:gd name="connsiteX8" fmla="*/ 163997 w 718410"/>
                      <a:gd name="connsiteY8" fmla="*/ 646911 h 660936"/>
                      <a:gd name="connsiteX9" fmla="*/ 67477 w 718410"/>
                      <a:gd name="connsiteY9" fmla="*/ 618073 h 660936"/>
                      <a:gd name="connsiteX10" fmla="*/ 10009 w 718410"/>
                      <a:gd name="connsiteY10" fmla="*/ 492138 h 660936"/>
                      <a:gd name="connsiteX11" fmla="*/ 6040 w 718410"/>
                      <a:gd name="connsiteY11" fmla="*/ 117486 h 660936"/>
                      <a:gd name="connsiteX12" fmla="*/ 46838 w 718410"/>
                      <a:gd name="connsiteY12" fmla="*/ 118 h 660936"/>
                      <a:gd name="connsiteX0" fmla="*/ 31621 w 743991"/>
                      <a:gd name="connsiteY0" fmla="*/ 36398 h 579848"/>
                      <a:gd name="connsiteX1" fmla="*/ 416589 w 743991"/>
                      <a:gd name="connsiteY1" fmla="*/ 14970 h 579848"/>
                      <a:gd name="connsiteX2" fmla="*/ 537239 w 743991"/>
                      <a:gd name="connsiteY2" fmla="*/ 41161 h 579848"/>
                      <a:gd name="connsiteX3" fmla="*/ 743728 w 743991"/>
                      <a:gd name="connsiteY3" fmla="*/ 201809 h 579848"/>
                      <a:gd name="connsiteX4" fmla="*/ 582484 w 743991"/>
                      <a:gd name="connsiteY4" fmla="*/ 353895 h 579848"/>
                      <a:gd name="connsiteX5" fmla="*/ 530095 w 743991"/>
                      <a:gd name="connsiteY5" fmla="*/ 474551 h 579848"/>
                      <a:gd name="connsiteX6" fmla="*/ 413412 w 743991"/>
                      <a:gd name="connsiteY6" fmla="*/ 565826 h 579848"/>
                      <a:gd name="connsiteX7" fmla="*/ 306078 w 743991"/>
                      <a:gd name="connsiteY7" fmla="*/ 579848 h 579848"/>
                      <a:gd name="connsiteX8" fmla="*/ 189578 w 743991"/>
                      <a:gd name="connsiteY8" fmla="*/ 565823 h 579848"/>
                      <a:gd name="connsiteX9" fmla="*/ 93058 w 743991"/>
                      <a:gd name="connsiteY9" fmla="*/ 536985 h 579848"/>
                      <a:gd name="connsiteX10" fmla="*/ 35590 w 743991"/>
                      <a:gd name="connsiteY10" fmla="*/ 411050 h 579848"/>
                      <a:gd name="connsiteX11" fmla="*/ 31621 w 743991"/>
                      <a:gd name="connsiteY11" fmla="*/ 36398 h 579848"/>
                      <a:gd name="connsiteX0" fmla="*/ 31621 w 743991"/>
                      <a:gd name="connsiteY0" fmla="*/ 36398 h 579848"/>
                      <a:gd name="connsiteX1" fmla="*/ 416589 w 743991"/>
                      <a:gd name="connsiteY1" fmla="*/ 14970 h 579848"/>
                      <a:gd name="connsiteX2" fmla="*/ 537239 w 743991"/>
                      <a:gd name="connsiteY2" fmla="*/ 41161 h 579848"/>
                      <a:gd name="connsiteX3" fmla="*/ 743728 w 743991"/>
                      <a:gd name="connsiteY3" fmla="*/ 201809 h 579848"/>
                      <a:gd name="connsiteX4" fmla="*/ 582484 w 743991"/>
                      <a:gd name="connsiteY4" fmla="*/ 353895 h 579848"/>
                      <a:gd name="connsiteX5" fmla="*/ 530095 w 743991"/>
                      <a:gd name="connsiteY5" fmla="*/ 474551 h 579848"/>
                      <a:gd name="connsiteX6" fmla="*/ 306078 w 743991"/>
                      <a:gd name="connsiteY6" fmla="*/ 579848 h 579848"/>
                      <a:gd name="connsiteX7" fmla="*/ 189578 w 743991"/>
                      <a:gd name="connsiteY7" fmla="*/ 565823 h 579848"/>
                      <a:gd name="connsiteX8" fmla="*/ 93058 w 743991"/>
                      <a:gd name="connsiteY8" fmla="*/ 536985 h 579848"/>
                      <a:gd name="connsiteX9" fmla="*/ 35590 w 743991"/>
                      <a:gd name="connsiteY9" fmla="*/ 411050 h 579848"/>
                      <a:gd name="connsiteX10" fmla="*/ 31621 w 743991"/>
                      <a:gd name="connsiteY10" fmla="*/ 36398 h 579848"/>
                      <a:gd name="connsiteX0" fmla="*/ 31621 w 743991"/>
                      <a:gd name="connsiteY0" fmla="*/ 36398 h 565823"/>
                      <a:gd name="connsiteX1" fmla="*/ 416589 w 743991"/>
                      <a:gd name="connsiteY1" fmla="*/ 14970 h 565823"/>
                      <a:gd name="connsiteX2" fmla="*/ 537239 w 743991"/>
                      <a:gd name="connsiteY2" fmla="*/ 41161 h 565823"/>
                      <a:gd name="connsiteX3" fmla="*/ 743728 w 743991"/>
                      <a:gd name="connsiteY3" fmla="*/ 201809 h 565823"/>
                      <a:gd name="connsiteX4" fmla="*/ 582484 w 743991"/>
                      <a:gd name="connsiteY4" fmla="*/ 353895 h 565823"/>
                      <a:gd name="connsiteX5" fmla="*/ 530095 w 743991"/>
                      <a:gd name="connsiteY5" fmla="*/ 474551 h 565823"/>
                      <a:gd name="connsiteX6" fmla="*/ 189578 w 743991"/>
                      <a:gd name="connsiteY6" fmla="*/ 565823 h 565823"/>
                      <a:gd name="connsiteX7" fmla="*/ 93058 w 743991"/>
                      <a:gd name="connsiteY7" fmla="*/ 536985 h 565823"/>
                      <a:gd name="connsiteX8" fmla="*/ 35590 w 743991"/>
                      <a:gd name="connsiteY8" fmla="*/ 411050 h 565823"/>
                      <a:gd name="connsiteX9" fmla="*/ 31621 w 743991"/>
                      <a:gd name="connsiteY9" fmla="*/ 36398 h 565823"/>
                      <a:gd name="connsiteX0" fmla="*/ 31621 w 743991"/>
                      <a:gd name="connsiteY0" fmla="*/ 36398 h 538638"/>
                      <a:gd name="connsiteX1" fmla="*/ 416589 w 743991"/>
                      <a:gd name="connsiteY1" fmla="*/ 14970 h 538638"/>
                      <a:gd name="connsiteX2" fmla="*/ 537239 w 743991"/>
                      <a:gd name="connsiteY2" fmla="*/ 41161 h 538638"/>
                      <a:gd name="connsiteX3" fmla="*/ 743728 w 743991"/>
                      <a:gd name="connsiteY3" fmla="*/ 201809 h 538638"/>
                      <a:gd name="connsiteX4" fmla="*/ 582484 w 743991"/>
                      <a:gd name="connsiteY4" fmla="*/ 353895 h 538638"/>
                      <a:gd name="connsiteX5" fmla="*/ 530095 w 743991"/>
                      <a:gd name="connsiteY5" fmla="*/ 474551 h 538638"/>
                      <a:gd name="connsiteX6" fmla="*/ 93058 w 743991"/>
                      <a:gd name="connsiteY6" fmla="*/ 536985 h 538638"/>
                      <a:gd name="connsiteX7" fmla="*/ 35590 w 743991"/>
                      <a:gd name="connsiteY7" fmla="*/ 411050 h 538638"/>
                      <a:gd name="connsiteX8" fmla="*/ 31621 w 743991"/>
                      <a:gd name="connsiteY8" fmla="*/ 36398 h 538638"/>
                      <a:gd name="connsiteX0" fmla="*/ 53068 w 765438"/>
                      <a:gd name="connsiteY0" fmla="*/ 36398 h 478935"/>
                      <a:gd name="connsiteX1" fmla="*/ 438036 w 765438"/>
                      <a:gd name="connsiteY1" fmla="*/ 14970 h 478935"/>
                      <a:gd name="connsiteX2" fmla="*/ 558686 w 765438"/>
                      <a:gd name="connsiteY2" fmla="*/ 41161 h 478935"/>
                      <a:gd name="connsiteX3" fmla="*/ 765175 w 765438"/>
                      <a:gd name="connsiteY3" fmla="*/ 201809 h 478935"/>
                      <a:gd name="connsiteX4" fmla="*/ 603931 w 765438"/>
                      <a:gd name="connsiteY4" fmla="*/ 353895 h 478935"/>
                      <a:gd name="connsiteX5" fmla="*/ 551542 w 765438"/>
                      <a:gd name="connsiteY5" fmla="*/ 474551 h 478935"/>
                      <a:gd name="connsiteX6" fmla="*/ 57037 w 765438"/>
                      <a:gd name="connsiteY6" fmla="*/ 411050 h 478935"/>
                      <a:gd name="connsiteX7" fmla="*/ 53068 w 765438"/>
                      <a:gd name="connsiteY7" fmla="*/ 36398 h 478935"/>
                      <a:gd name="connsiteX0" fmla="*/ 53068 w 765182"/>
                      <a:gd name="connsiteY0" fmla="*/ 36398 h 478935"/>
                      <a:gd name="connsiteX1" fmla="*/ 438036 w 765182"/>
                      <a:gd name="connsiteY1" fmla="*/ 14970 h 478935"/>
                      <a:gd name="connsiteX2" fmla="*/ 596786 w 765182"/>
                      <a:gd name="connsiteY2" fmla="*/ 50689 h 478935"/>
                      <a:gd name="connsiteX3" fmla="*/ 765175 w 765182"/>
                      <a:gd name="connsiteY3" fmla="*/ 201809 h 478935"/>
                      <a:gd name="connsiteX4" fmla="*/ 603931 w 765182"/>
                      <a:gd name="connsiteY4" fmla="*/ 353895 h 478935"/>
                      <a:gd name="connsiteX5" fmla="*/ 551542 w 765182"/>
                      <a:gd name="connsiteY5" fmla="*/ 474551 h 478935"/>
                      <a:gd name="connsiteX6" fmla="*/ 57037 w 765182"/>
                      <a:gd name="connsiteY6" fmla="*/ 411050 h 478935"/>
                      <a:gd name="connsiteX7" fmla="*/ 53068 w 765182"/>
                      <a:gd name="connsiteY7" fmla="*/ 36398 h 478935"/>
                      <a:gd name="connsiteX0" fmla="*/ 53068 w 768108"/>
                      <a:gd name="connsiteY0" fmla="*/ 45826 h 488363"/>
                      <a:gd name="connsiteX1" fmla="*/ 438036 w 768108"/>
                      <a:gd name="connsiteY1" fmla="*/ 24398 h 488363"/>
                      <a:gd name="connsiteX2" fmla="*/ 765175 w 768108"/>
                      <a:gd name="connsiteY2" fmla="*/ 211237 h 488363"/>
                      <a:gd name="connsiteX3" fmla="*/ 603931 w 768108"/>
                      <a:gd name="connsiteY3" fmla="*/ 363323 h 488363"/>
                      <a:gd name="connsiteX4" fmla="*/ 551542 w 768108"/>
                      <a:gd name="connsiteY4" fmla="*/ 483979 h 488363"/>
                      <a:gd name="connsiteX5" fmla="*/ 57037 w 768108"/>
                      <a:gd name="connsiteY5" fmla="*/ 420478 h 488363"/>
                      <a:gd name="connsiteX6" fmla="*/ 53068 w 768108"/>
                      <a:gd name="connsiteY6" fmla="*/ 45826 h 488363"/>
                      <a:gd name="connsiteX0" fmla="*/ 56505 w 774582"/>
                      <a:gd name="connsiteY0" fmla="*/ 45826 h 438778"/>
                      <a:gd name="connsiteX1" fmla="*/ 441473 w 774582"/>
                      <a:gd name="connsiteY1" fmla="*/ 24398 h 438778"/>
                      <a:gd name="connsiteX2" fmla="*/ 768612 w 774582"/>
                      <a:gd name="connsiteY2" fmla="*/ 211237 h 438778"/>
                      <a:gd name="connsiteX3" fmla="*/ 607368 w 774582"/>
                      <a:gd name="connsiteY3" fmla="*/ 363323 h 438778"/>
                      <a:gd name="connsiteX4" fmla="*/ 60474 w 774582"/>
                      <a:gd name="connsiteY4" fmla="*/ 420478 h 438778"/>
                      <a:gd name="connsiteX5" fmla="*/ 56505 w 774582"/>
                      <a:gd name="connsiteY5" fmla="*/ 45826 h 438778"/>
                      <a:gd name="connsiteX0" fmla="*/ 56505 w 774582"/>
                      <a:gd name="connsiteY0" fmla="*/ 45826 h 438778"/>
                      <a:gd name="connsiteX1" fmla="*/ 441473 w 774582"/>
                      <a:gd name="connsiteY1" fmla="*/ 24398 h 438778"/>
                      <a:gd name="connsiteX2" fmla="*/ 768612 w 774582"/>
                      <a:gd name="connsiteY2" fmla="*/ 201712 h 438778"/>
                      <a:gd name="connsiteX3" fmla="*/ 607368 w 774582"/>
                      <a:gd name="connsiteY3" fmla="*/ 363323 h 438778"/>
                      <a:gd name="connsiteX4" fmla="*/ 60474 w 774582"/>
                      <a:gd name="connsiteY4" fmla="*/ 420478 h 438778"/>
                      <a:gd name="connsiteX5" fmla="*/ 56505 w 774582"/>
                      <a:gd name="connsiteY5" fmla="*/ 45826 h 438778"/>
                      <a:gd name="connsiteX0" fmla="*/ 56505 w 770747"/>
                      <a:gd name="connsiteY0" fmla="*/ 45826 h 439796"/>
                      <a:gd name="connsiteX1" fmla="*/ 441473 w 770747"/>
                      <a:gd name="connsiteY1" fmla="*/ 24398 h 439796"/>
                      <a:gd name="connsiteX2" fmla="*/ 768612 w 770747"/>
                      <a:gd name="connsiteY2" fmla="*/ 201712 h 439796"/>
                      <a:gd name="connsiteX3" fmla="*/ 556568 w 770747"/>
                      <a:gd name="connsiteY3" fmla="*/ 369673 h 439796"/>
                      <a:gd name="connsiteX4" fmla="*/ 60474 w 770747"/>
                      <a:gd name="connsiteY4" fmla="*/ 420478 h 439796"/>
                      <a:gd name="connsiteX5" fmla="*/ 56505 w 770747"/>
                      <a:gd name="connsiteY5" fmla="*/ 45826 h 439796"/>
                      <a:gd name="connsiteX0" fmla="*/ 56505 w 770564"/>
                      <a:gd name="connsiteY0" fmla="*/ 45826 h 439796"/>
                      <a:gd name="connsiteX1" fmla="*/ 441473 w 770564"/>
                      <a:gd name="connsiteY1" fmla="*/ 24398 h 439796"/>
                      <a:gd name="connsiteX2" fmla="*/ 768612 w 770564"/>
                      <a:gd name="connsiteY2" fmla="*/ 201712 h 439796"/>
                      <a:gd name="connsiteX3" fmla="*/ 556568 w 770564"/>
                      <a:gd name="connsiteY3" fmla="*/ 369673 h 439796"/>
                      <a:gd name="connsiteX4" fmla="*/ 60474 w 770564"/>
                      <a:gd name="connsiteY4" fmla="*/ 420478 h 439796"/>
                      <a:gd name="connsiteX5" fmla="*/ 56505 w 770564"/>
                      <a:gd name="connsiteY5" fmla="*/ 45826 h 439796"/>
                      <a:gd name="connsiteX0" fmla="*/ 67443 w 789029"/>
                      <a:gd name="connsiteY0" fmla="*/ 45826 h 423038"/>
                      <a:gd name="connsiteX1" fmla="*/ 452411 w 789029"/>
                      <a:gd name="connsiteY1" fmla="*/ 24398 h 423038"/>
                      <a:gd name="connsiteX2" fmla="*/ 779550 w 789029"/>
                      <a:gd name="connsiteY2" fmla="*/ 201712 h 423038"/>
                      <a:gd name="connsiteX3" fmla="*/ 71412 w 789029"/>
                      <a:gd name="connsiteY3" fmla="*/ 420478 h 423038"/>
                      <a:gd name="connsiteX4" fmla="*/ 67443 w 789029"/>
                      <a:gd name="connsiteY4" fmla="*/ 45826 h 423038"/>
                      <a:gd name="connsiteX0" fmla="*/ 67443 w 779550"/>
                      <a:gd name="connsiteY0" fmla="*/ 6344 h 383512"/>
                      <a:gd name="connsiteX1" fmla="*/ 779550 w 779550"/>
                      <a:gd name="connsiteY1" fmla="*/ 162230 h 383512"/>
                      <a:gd name="connsiteX2" fmla="*/ 71412 w 779550"/>
                      <a:gd name="connsiteY2" fmla="*/ 380996 h 383512"/>
                      <a:gd name="connsiteX3" fmla="*/ 67443 w 779550"/>
                      <a:gd name="connsiteY3" fmla="*/ 6344 h 383512"/>
                      <a:gd name="connsiteX0" fmla="*/ 67443 w 782725"/>
                      <a:gd name="connsiteY0" fmla="*/ 5475 h 383003"/>
                      <a:gd name="connsiteX1" fmla="*/ 782725 w 782725"/>
                      <a:gd name="connsiteY1" fmla="*/ 186761 h 383003"/>
                      <a:gd name="connsiteX2" fmla="*/ 71412 w 782725"/>
                      <a:gd name="connsiteY2" fmla="*/ 380127 h 383003"/>
                      <a:gd name="connsiteX3" fmla="*/ 67443 w 782725"/>
                      <a:gd name="connsiteY3" fmla="*/ 5475 h 383003"/>
                      <a:gd name="connsiteX0" fmla="*/ 67443 w 782725"/>
                      <a:gd name="connsiteY0" fmla="*/ 5722 h 373700"/>
                      <a:gd name="connsiteX1" fmla="*/ 782725 w 782725"/>
                      <a:gd name="connsiteY1" fmla="*/ 177483 h 373700"/>
                      <a:gd name="connsiteX2" fmla="*/ 71412 w 782725"/>
                      <a:gd name="connsiteY2" fmla="*/ 370849 h 373700"/>
                      <a:gd name="connsiteX3" fmla="*/ 67443 w 782725"/>
                      <a:gd name="connsiteY3" fmla="*/ 5722 h 373700"/>
                      <a:gd name="connsiteX0" fmla="*/ 58520 w 773816"/>
                      <a:gd name="connsiteY0" fmla="*/ 5673 h 364262"/>
                      <a:gd name="connsiteX1" fmla="*/ 773802 w 773816"/>
                      <a:gd name="connsiteY1" fmla="*/ 177434 h 364262"/>
                      <a:gd name="connsiteX2" fmla="*/ 78364 w 773816"/>
                      <a:gd name="connsiteY2" fmla="*/ 361278 h 364262"/>
                      <a:gd name="connsiteX3" fmla="*/ 58520 w 773816"/>
                      <a:gd name="connsiteY3" fmla="*/ 5673 h 364262"/>
                      <a:gd name="connsiteX0" fmla="*/ 52098 w 767418"/>
                      <a:gd name="connsiteY0" fmla="*/ 5593 h 348558"/>
                      <a:gd name="connsiteX1" fmla="*/ 767380 w 767418"/>
                      <a:gd name="connsiteY1" fmla="*/ 177354 h 348558"/>
                      <a:gd name="connsiteX2" fmla="*/ 84642 w 767418"/>
                      <a:gd name="connsiteY2" fmla="*/ 345323 h 348558"/>
                      <a:gd name="connsiteX3" fmla="*/ 52098 w 767418"/>
                      <a:gd name="connsiteY3" fmla="*/ 5593 h 348558"/>
                      <a:gd name="connsiteX0" fmla="*/ 69341 w 752873"/>
                      <a:gd name="connsiteY0" fmla="*/ 5763 h 342357"/>
                      <a:gd name="connsiteX1" fmla="*/ 752873 w 752873"/>
                      <a:gd name="connsiteY1" fmla="*/ 171174 h 342357"/>
                      <a:gd name="connsiteX2" fmla="*/ 70135 w 752873"/>
                      <a:gd name="connsiteY2" fmla="*/ 339143 h 342357"/>
                      <a:gd name="connsiteX3" fmla="*/ 69341 w 752873"/>
                      <a:gd name="connsiteY3" fmla="*/ 5763 h 342357"/>
                      <a:gd name="connsiteX0" fmla="*/ 54826 w 764577"/>
                      <a:gd name="connsiteY0" fmla="*/ 5634 h 347007"/>
                      <a:gd name="connsiteX1" fmla="*/ 764551 w 764577"/>
                      <a:gd name="connsiteY1" fmla="*/ 175808 h 347007"/>
                      <a:gd name="connsiteX2" fmla="*/ 81813 w 764577"/>
                      <a:gd name="connsiteY2" fmla="*/ 343777 h 347007"/>
                      <a:gd name="connsiteX3" fmla="*/ 54826 w 764577"/>
                      <a:gd name="connsiteY3" fmla="*/ 5634 h 347007"/>
                      <a:gd name="connsiteX0" fmla="*/ 69342 w 752873"/>
                      <a:gd name="connsiteY0" fmla="*/ 5967 h 335395"/>
                      <a:gd name="connsiteX1" fmla="*/ 752873 w 752873"/>
                      <a:gd name="connsiteY1" fmla="*/ 164235 h 335395"/>
                      <a:gd name="connsiteX2" fmla="*/ 70135 w 752873"/>
                      <a:gd name="connsiteY2" fmla="*/ 332204 h 335395"/>
                      <a:gd name="connsiteX3" fmla="*/ 69342 w 752873"/>
                      <a:gd name="connsiteY3" fmla="*/ 5967 h 335395"/>
                      <a:gd name="connsiteX0" fmla="*/ 62417 w 745954"/>
                      <a:gd name="connsiteY0" fmla="*/ 5862 h 316592"/>
                      <a:gd name="connsiteX1" fmla="*/ 745948 w 745954"/>
                      <a:gd name="connsiteY1" fmla="*/ 164130 h 316592"/>
                      <a:gd name="connsiteX2" fmla="*/ 75116 w 745954"/>
                      <a:gd name="connsiteY2" fmla="*/ 313049 h 316592"/>
                      <a:gd name="connsiteX3" fmla="*/ 62417 w 745954"/>
                      <a:gd name="connsiteY3" fmla="*/ 5862 h 316592"/>
                      <a:gd name="connsiteX0" fmla="*/ 58520 w 742065"/>
                      <a:gd name="connsiteY0" fmla="*/ 5979 h 337749"/>
                      <a:gd name="connsiteX1" fmla="*/ 742051 w 742065"/>
                      <a:gd name="connsiteY1" fmla="*/ 164247 h 337749"/>
                      <a:gd name="connsiteX2" fmla="*/ 78363 w 742065"/>
                      <a:gd name="connsiteY2" fmla="*/ 334597 h 337749"/>
                      <a:gd name="connsiteX3" fmla="*/ 58520 w 742065"/>
                      <a:gd name="connsiteY3" fmla="*/ 5979 h 337749"/>
                      <a:gd name="connsiteX0" fmla="*/ 57265 w 743195"/>
                      <a:gd name="connsiteY0" fmla="*/ 5909 h 340067"/>
                      <a:gd name="connsiteX1" fmla="*/ 743177 w 743195"/>
                      <a:gd name="connsiteY1" fmla="*/ 166558 h 340067"/>
                      <a:gd name="connsiteX2" fmla="*/ 79489 w 743195"/>
                      <a:gd name="connsiteY2" fmla="*/ 336908 h 340067"/>
                      <a:gd name="connsiteX3" fmla="*/ 57265 w 743195"/>
                      <a:gd name="connsiteY3" fmla="*/ 5909 h 340067"/>
                      <a:gd name="connsiteX0" fmla="*/ 68064 w 753994"/>
                      <a:gd name="connsiteY0" fmla="*/ 5909 h 340067"/>
                      <a:gd name="connsiteX1" fmla="*/ 753976 w 753994"/>
                      <a:gd name="connsiteY1" fmla="*/ 166558 h 340067"/>
                      <a:gd name="connsiteX2" fmla="*/ 90288 w 753994"/>
                      <a:gd name="connsiteY2" fmla="*/ 336908 h 340067"/>
                      <a:gd name="connsiteX3" fmla="*/ 68064 w 753994"/>
                      <a:gd name="connsiteY3" fmla="*/ 5909 h 340067"/>
                      <a:gd name="connsiteX0" fmla="*/ 68064 w 753994"/>
                      <a:gd name="connsiteY0" fmla="*/ 2099 h 336257"/>
                      <a:gd name="connsiteX1" fmla="*/ 753976 w 753994"/>
                      <a:gd name="connsiteY1" fmla="*/ 162748 h 336257"/>
                      <a:gd name="connsiteX2" fmla="*/ 90288 w 753994"/>
                      <a:gd name="connsiteY2" fmla="*/ 333098 h 336257"/>
                      <a:gd name="connsiteX3" fmla="*/ 68064 w 753994"/>
                      <a:gd name="connsiteY3" fmla="*/ 2099 h 336257"/>
                      <a:gd name="connsiteX0" fmla="*/ 68064 w 753994"/>
                      <a:gd name="connsiteY0" fmla="*/ 2099 h 333224"/>
                      <a:gd name="connsiteX1" fmla="*/ 753976 w 753994"/>
                      <a:gd name="connsiteY1" fmla="*/ 162748 h 333224"/>
                      <a:gd name="connsiteX2" fmla="*/ 90288 w 753994"/>
                      <a:gd name="connsiteY2" fmla="*/ 333098 h 333224"/>
                      <a:gd name="connsiteX3" fmla="*/ 68064 w 753994"/>
                      <a:gd name="connsiteY3" fmla="*/ 2099 h 333224"/>
                      <a:gd name="connsiteX0" fmla="*/ 68064 w 753994"/>
                      <a:gd name="connsiteY0" fmla="*/ 2099 h 338452"/>
                      <a:gd name="connsiteX1" fmla="*/ 753976 w 753994"/>
                      <a:gd name="connsiteY1" fmla="*/ 162748 h 338452"/>
                      <a:gd name="connsiteX2" fmla="*/ 90288 w 753994"/>
                      <a:gd name="connsiteY2" fmla="*/ 333098 h 338452"/>
                      <a:gd name="connsiteX3" fmla="*/ 68064 w 753994"/>
                      <a:gd name="connsiteY3" fmla="*/ 2099 h 338452"/>
                      <a:gd name="connsiteX0" fmla="*/ 68064 w 753994"/>
                      <a:gd name="connsiteY0" fmla="*/ 8569 h 344922"/>
                      <a:gd name="connsiteX1" fmla="*/ 753976 w 753994"/>
                      <a:gd name="connsiteY1" fmla="*/ 169218 h 344922"/>
                      <a:gd name="connsiteX2" fmla="*/ 90288 w 753994"/>
                      <a:gd name="connsiteY2" fmla="*/ 339568 h 344922"/>
                      <a:gd name="connsiteX3" fmla="*/ 68064 w 753994"/>
                      <a:gd name="connsiteY3" fmla="*/ 8569 h 344922"/>
                      <a:gd name="connsiteX0" fmla="*/ 68064 w 753994"/>
                      <a:gd name="connsiteY0" fmla="*/ 9270 h 345227"/>
                      <a:gd name="connsiteX1" fmla="*/ 753976 w 753994"/>
                      <a:gd name="connsiteY1" fmla="*/ 155631 h 345227"/>
                      <a:gd name="connsiteX2" fmla="*/ 90288 w 753994"/>
                      <a:gd name="connsiteY2" fmla="*/ 340269 h 345227"/>
                      <a:gd name="connsiteX3" fmla="*/ 68064 w 753994"/>
                      <a:gd name="connsiteY3" fmla="*/ 9270 h 345227"/>
                      <a:gd name="connsiteX0" fmla="*/ 68064 w 756375"/>
                      <a:gd name="connsiteY0" fmla="*/ 8792 h 345006"/>
                      <a:gd name="connsiteX1" fmla="*/ 756357 w 756375"/>
                      <a:gd name="connsiteY1" fmla="*/ 164681 h 345006"/>
                      <a:gd name="connsiteX2" fmla="*/ 90288 w 756375"/>
                      <a:gd name="connsiteY2" fmla="*/ 339791 h 345006"/>
                      <a:gd name="connsiteX3" fmla="*/ 68064 w 756375"/>
                      <a:gd name="connsiteY3" fmla="*/ 8792 h 345006"/>
                      <a:gd name="connsiteX0" fmla="*/ 68064 w 757163"/>
                      <a:gd name="connsiteY0" fmla="*/ 8685 h 344835"/>
                      <a:gd name="connsiteX1" fmla="*/ 756357 w 757163"/>
                      <a:gd name="connsiteY1" fmla="*/ 164574 h 344835"/>
                      <a:gd name="connsiteX2" fmla="*/ 90288 w 757163"/>
                      <a:gd name="connsiteY2" fmla="*/ 339684 h 344835"/>
                      <a:gd name="connsiteX3" fmla="*/ 68064 w 757163"/>
                      <a:gd name="connsiteY3" fmla="*/ 8685 h 344835"/>
                      <a:gd name="connsiteX0" fmla="*/ 68064 w 756358"/>
                      <a:gd name="connsiteY0" fmla="*/ 8685 h 344835"/>
                      <a:gd name="connsiteX1" fmla="*/ 756357 w 756358"/>
                      <a:gd name="connsiteY1" fmla="*/ 164574 h 344835"/>
                      <a:gd name="connsiteX2" fmla="*/ 90288 w 756358"/>
                      <a:gd name="connsiteY2" fmla="*/ 339684 h 344835"/>
                      <a:gd name="connsiteX3" fmla="*/ 68064 w 756358"/>
                      <a:gd name="connsiteY3" fmla="*/ 8685 h 344835"/>
                      <a:gd name="connsiteX0" fmla="*/ 70335 w 753877"/>
                      <a:gd name="connsiteY0" fmla="*/ 7554 h 379653"/>
                      <a:gd name="connsiteX1" fmla="*/ 753866 w 753877"/>
                      <a:gd name="connsiteY1" fmla="*/ 199160 h 379653"/>
                      <a:gd name="connsiteX2" fmla="*/ 87797 w 753877"/>
                      <a:gd name="connsiteY2" fmla="*/ 374270 h 379653"/>
                      <a:gd name="connsiteX3" fmla="*/ 70335 w 753877"/>
                      <a:gd name="connsiteY3" fmla="*/ 7554 h 379653"/>
                      <a:gd name="connsiteX0" fmla="*/ 71500 w 755039"/>
                      <a:gd name="connsiteY0" fmla="*/ 7595 h 386663"/>
                      <a:gd name="connsiteX1" fmla="*/ 755031 w 755039"/>
                      <a:gd name="connsiteY1" fmla="*/ 199201 h 386663"/>
                      <a:gd name="connsiteX2" fmla="*/ 86580 w 755039"/>
                      <a:gd name="connsiteY2" fmla="*/ 381455 h 386663"/>
                      <a:gd name="connsiteX3" fmla="*/ 71500 w 755039"/>
                      <a:gd name="connsiteY3" fmla="*/ 7595 h 386663"/>
                      <a:gd name="connsiteX0" fmla="*/ 71500 w 755039"/>
                      <a:gd name="connsiteY0" fmla="*/ 7595 h 394809"/>
                      <a:gd name="connsiteX1" fmla="*/ 755031 w 755039"/>
                      <a:gd name="connsiteY1" fmla="*/ 199201 h 394809"/>
                      <a:gd name="connsiteX2" fmla="*/ 86580 w 755039"/>
                      <a:gd name="connsiteY2" fmla="*/ 381455 h 394809"/>
                      <a:gd name="connsiteX3" fmla="*/ 71500 w 755039"/>
                      <a:gd name="connsiteY3" fmla="*/ 7595 h 394809"/>
                      <a:gd name="connsiteX0" fmla="*/ 71500 w 755039"/>
                      <a:gd name="connsiteY0" fmla="*/ 15403 h 402617"/>
                      <a:gd name="connsiteX1" fmla="*/ 755031 w 755039"/>
                      <a:gd name="connsiteY1" fmla="*/ 207009 h 402617"/>
                      <a:gd name="connsiteX2" fmla="*/ 86580 w 755039"/>
                      <a:gd name="connsiteY2" fmla="*/ 389263 h 402617"/>
                      <a:gd name="connsiteX3" fmla="*/ 71500 w 755039"/>
                      <a:gd name="connsiteY3" fmla="*/ 15403 h 402617"/>
                      <a:gd name="connsiteX0" fmla="*/ 71500 w 755039"/>
                      <a:gd name="connsiteY0" fmla="*/ 22643 h 409857"/>
                      <a:gd name="connsiteX1" fmla="*/ 755031 w 755039"/>
                      <a:gd name="connsiteY1" fmla="*/ 214249 h 409857"/>
                      <a:gd name="connsiteX2" fmla="*/ 86580 w 755039"/>
                      <a:gd name="connsiteY2" fmla="*/ 396503 h 409857"/>
                      <a:gd name="connsiteX3" fmla="*/ 71500 w 755039"/>
                      <a:gd name="connsiteY3" fmla="*/ 22643 h 409857"/>
                      <a:gd name="connsiteX0" fmla="*/ 71500 w 755039"/>
                      <a:gd name="connsiteY0" fmla="*/ 29498 h 416712"/>
                      <a:gd name="connsiteX1" fmla="*/ 755031 w 755039"/>
                      <a:gd name="connsiteY1" fmla="*/ 221104 h 416712"/>
                      <a:gd name="connsiteX2" fmla="*/ 86580 w 755039"/>
                      <a:gd name="connsiteY2" fmla="*/ 403358 h 416712"/>
                      <a:gd name="connsiteX3" fmla="*/ 71500 w 755039"/>
                      <a:gd name="connsiteY3" fmla="*/ 29498 h 416712"/>
                      <a:gd name="connsiteX0" fmla="*/ 78847 w 762386"/>
                      <a:gd name="connsiteY0" fmla="*/ 29498 h 416712"/>
                      <a:gd name="connsiteX1" fmla="*/ 762378 w 762386"/>
                      <a:gd name="connsiteY1" fmla="*/ 221104 h 416712"/>
                      <a:gd name="connsiteX2" fmla="*/ 93927 w 762386"/>
                      <a:gd name="connsiteY2" fmla="*/ 403358 h 416712"/>
                      <a:gd name="connsiteX3" fmla="*/ 78847 w 762386"/>
                      <a:gd name="connsiteY3" fmla="*/ 29498 h 416712"/>
                      <a:gd name="connsiteX0" fmla="*/ 79696 w 763235"/>
                      <a:gd name="connsiteY0" fmla="*/ 29498 h 416712"/>
                      <a:gd name="connsiteX1" fmla="*/ 763227 w 763235"/>
                      <a:gd name="connsiteY1" fmla="*/ 221104 h 416712"/>
                      <a:gd name="connsiteX2" fmla="*/ 94776 w 763235"/>
                      <a:gd name="connsiteY2" fmla="*/ 403358 h 416712"/>
                      <a:gd name="connsiteX3" fmla="*/ 79696 w 763235"/>
                      <a:gd name="connsiteY3" fmla="*/ 29498 h 41671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763235" h="416712">
                        <a:moveTo>
                          <a:pt x="79696" y="29498"/>
                        </a:moveTo>
                        <a:cubicBezTo>
                          <a:pt x="181050" y="-83161"/>
                          <a:pt x="760714" y="158794"/>
                          <a:pt x="763227" y="221104"/>
                        </a:cubicBezTo>
                        <a:cubicBezTo>
                          <a:pt x="765740" y="283414"/>
                          <a:pt x="213460" y="467442"/>
                          <a:pt x="94776" y="403358"/>
                        </a:cubicBezTo>
                        <a:cubicBezTo>
                          <a:pt x="-26289" y="413095"/>
                          <a:pt x="-31430" y="35980"/>
                          <a:pt x="79696" y="29498"/>
                        </a:cubicBezTo>
                        <a:close/>
                      </a:path>
                    </a:pathLst>
                  </a:custGeom>
                  <a:blipFill dpi="0" rotWithShape="1">
                    <a:blip r:embed="rId6">
                      <a:alphaModFix amt="90000"/>
                    </a:blip>
                    <a:srcRect/>
                    <a:tile tx="0" ty="0" sx="100000" sy="100000" flip="none" algn="tl"/>
                  </a:blipFill>
                  <a:ln w="9525">
                    <a:noFill/>
                  </a:ln>
                  <a:scene3d>
                    <a:camera prst="orthographicFront"/>
                    <a:lightRig rig="threePt" dir="t"/>
                  </a:scene3d>
                  <a:sp3d>
                    <a:bevelT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70" name="타원 69">
                    <a:extLst>
                      <a:ext uri="{FF2B5EF4-FFF2-40B4-BE49-F238E27FC236}">
                        <a16:creationId xmlns:a16="http://schemas.microsoft.com/office/drawing/2014/main" id="{2CB715D2-EA28-2E22-FCB2-A5A534EDB785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368517" y="5605333"/>
                    <a:ext cx="128960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71" name="타원 70">
                    <a:extLst>
                      <a:ext uri="{FF2B5EF4-FFF2-40B4-BE49-F238E27FC236}">
                        <a16:creationId xmlns:a16="http://schemas.microsoft.com/office/drawing/2014/main" id="{70003836-5738-063E-BFC9-91117428CFA3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477074" y="5631049"/>
                    <a:ext cx="128960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72" name="타원 71">
                    <a:extLst>
                      <a:ext uri="{FF2B5EF4-FFF2-40B4-BE49-F238E27FC236}">
                        <a16:creationId xmlns:a16="http://schemas.microsoft.com/office/drawing/2014/main" id="{DE70E580-9163-120D-22B0-0F2EE93436F0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454643" y="5523127"/>
                    <a:ext cx="128960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73" name="타원 72">
                    <a:extLst>
                      <a:ext uri="{FF2B5EF4-FFF2-40B4-BE49-F238E27FC236}">
                        <a16:creationId xmlns:a16="http://schemas.microsoft.com/office/drawing/2014/main" id="{DA8B30C2-17E9-C3C6-FCD4-4C6578694425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399169" y="5449393"/>
                    <a:ext cx="128960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74" name="타원 73">
                    <a:extLst>
                      <a:ext uri="{FF2B5EF4-FFF2-40B4-BE49-F238E27FC236}">
                        <a16:creationId xmlns:a16="http://schemas.microsoft.com/office/drawing/2014/main" id="{9BAF915F-610E-13C6-8F23-383C805A7DC0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434232" y="5581161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75" name="타원 74">
                    <a:extLst>
                      <a:ext uri="{FF2B5EF4-FFF2-40B4-BE49-F238E27FC236}">
                        <a16:creationId xmlns:a16="http://schemas.microsoft.com/office/drawing/2014/main" id="{C35C03F1-0A5B-8F71-3B31-01E522E520B0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513380" y="5616816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76" name="타원 75">
                    <a:extLst>
                      <a:ext uri="{FF2B5EF4-FFF2-40B4-BE49-F238E27FC236}">
                        <a16:creationId xmlns:a16="http://schemas.microsoft.com/office/drawing/2014/main" id="{515320DE-519D-29A9-1640-980475068DBC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423986" y="5656826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77" name="타원 76">
                    <a:extLst>
                      <a:ext uri="{FF2B5EF4-FFF2-40B4-BE49-F238E27FC236}">
                        <a16:creationId xmlns:a16="http://schemas.microsoft.com/office/drawing/2014/main" id="{149E2B5B-21F6-DE58-055D-7F9ECB501481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452303" y="5727923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78" name="타원 77">
                    <a:extLst>
                      <a:ext uri="{FF2B5EF4-FFF2-40B4-BE49-F238E27FC236}">
                        <a16:creationId xmlns:a16="http://schemas.microsoft.com/office/drawing/2014/main" id="{BC3AABB3-2029-9D76-657F-248A8E580BC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503204" y="5687912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79" name="타원 78">
                    <a:extLst>
                      <a:ext uri="{FF2B5EF4-FFF2-40B4-BE49-F238E27FC236}">
                        <a16:creationId xmlns:a16="http://schemas.microsoft.com/office/drawing/2014/main" id="{BDAF8EAC-1CD2-FE74-8C88-7964A2842D08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457491" y="5496944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80" name="타원 79">
                    <a:extLst>
                      <a:ext uri="{FF2B5EF4-FFF2-40B4-BE49-F238E27FC236}">
                        <a16:creationId xmlns:a16="http://schemas.microsoft.com/office/drawing/2014/main" id="{16FF899C-F4D9-5877-30A1-DF4856F8C9E0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492811" y="5525835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81" name="타원 80">
                    <a:extLst>
                      <a:ext uri="{FF2B5EF4-FFF2-40B4-BE49-F238E27FC236}">
                        <a16:creationId xmlns:a16="http://schemas.microsoft.com/office/drawing/2014/main" id="{2FD719B6-AE18-C196-6DD8-DF2E4F77F0B0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390402" y="5697084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82" name="타원 81">
                    <a:extLst>
                      <a:ext uri="{FF2B5EF4-FFF2-40B4-BE49-F238E27FC236}">
                        <a16:creationId xmlns:a16="http://schemas.microsoft.com/office/drawing/2014/main" id="{CFF67F57-3431-9902-E83C-877F35DA8255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400857" y="5755692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83" name="타원 82">
                    <a:extLst>
                      <a:ext uri="{FF2B5EF4-FFF2-40B4-BE49-F238E27FC236}">
                        <a16:creationId xmlns:a16="http://schemas.microsoft.com/office/drawing/2014/main" id="{757102C7-E9C9-EA7B-7D99-EF6919905892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537885" y="5779016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84" name="순서도: 지연 770">
                    <a:extLst>
                      <a:ext uri="{FF2B5EF4-FFF2-40B4-BE49-F238E27FC236}">
                        <a16:creationId xmlns:a16="http://schemas.microsoft.com/office/drawing/2014/main" id="{5F950C06-2F5D-D941-0C9D-B2DAEFD6C03B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5012410" y="4414422"/>
                    <a:ext cx="960531" cy="327899"/>
                  </a:xfrm>
                  <a:custGeom>
                    <a:avLst/>
                    <a:gdLst>
                      <a:gd name="connsiteX0" fmla="*/ 0 w 524463"/>
                      <a:gd name="connsiteY0" fmla="*/ 0 h 821164"/>
                      <a:gd name="connsiteX1" fmla="*/ 262232 w 524463"/>
                      <a:gd name="connsiteY1" fmla="*/ 0 h 821164"/>
                      <a:gd name="connsiteX2" fmla="*/ 524464 w 524463"/>
                      <a:gd name="connsiteY2" fmla="*/ 410582 h 821164"/>
                      <a:gd name="connsiteX3" fmla="*/ 262232 w 524463"/>
                      <a:gd name="connsiteY3" fmla="*/ 821164 h 821164"/>
                      <a:gd name="connsiteX4" fmla="*/ 0 w 524463"/>
                      <a:gd name="connsiteY4" fmla="*/ 821164 h 821164"/>
                      <a:gd name="connsiteX5" fmla="*/ 0 w 524463"/>
                      <a:gd name="connsiteY5" fmla="*/ 0 h 821164"/>
                      <a:gd name="connsiteX0" fmla="*/ 19050 w 524464"/>
                      <a:gd name="connsiteY0" fmla="*/ 50803 h 821164"/>
                      <a:gd name="connsiteX1" fmla="*/ 262232 w 524464"/>
                      <a:gd name="connsiteY1" fmla="*/ 0 h 821164"/>
                      <a:gd name="connsiteX2" fmla="*/ 524464 w 524464"/>
                      <a:gd name="connsiteY2" fmla="*/ 410582 h 821164"/>
                      <a:gd name="connsiteX3" fmla="*/ 262232 w 524464"/>
                      <a:gd name="connsiteY3" fmla="*/ 821164 h 821164"/>
                      <a:gd name="connsiteX4" fmla="*/ 0 w 524464"/>
                      <a:gd name="connsiteY4" fmla="*/ 821164 h 821164"/>
                      <a:gd name="connsiteX5" fmla="*/ 19050 w 524464"/>
                      <a:gd name="connsiteY5" fmla="*/ 50803 h 821164"/>
                      <a:gd name="connsiteX0" fmla="*/ 0 w 505414"/>
                      <a:gd name="connsiteY0" fmla="*/ 50803 h 821164"/>
                      <a:gd name="connsiteX1" fmla="*/ 243182 w 505414"/>
                      <a:gd name="connsiteY1" fmla="*/ 0 h 821164"/>
                      <a:gd name="connsiteX2" fmla="*/ 505414 w 505414"/>
                      <a:gd name="connsiteY2" fmla="*/ 410582 h 821164"/>
                      <a:gd name="connsiteX3" fmla="*/ 243182 w 505414"/>
                      <a:gd name="connsiteY3" fmla="*/ 821164 h 821164"/>
                      <a:gd name="connsiteX4" fmla="*/ 6350 w 505414"/>
                      <a:gd name="connsiteY4" fmla="*/ 789414 h 821164"/>
                      <a:gd name="connsiteX5" fmla="*/ 0 w 505414"/>
                      <a:gd name="connsiteY5" fmla="*/ 50803 h 821164"/>
                      <a:gd name="connsiteX0" fmla="*/ 0 w 505414"/>
                      <a:gd name="connsiteY0" fmla="*/ 75333 h 845694"/>
                      <a:gd name="connsiteX1" fmla="*/ 243182 w 505414"/>
                      <a:gd name="connsiteY1" fmla="*/ 24530 h 845694"/>
                      <a:gd name="connsiteX2" fmla="*/ 505414 w 505414"/>
                      <a:gd name="connsiteY2" fmla="*/ 435112 h 845694"/>
                      <a:gd name="connsiteX3" fmla="*/ 243182 w 505414"/>
                      <a:gd name="connsiteY3" fmla="*/ 845694 h 845694"/>
                      <a:gd name="connsiteX4" fmla="*/ 6350 w 505414"/>
                      <a:gd name="connsiteY4" fmla="*/ 813944 h 845694"/>
                      <a:gd name="connsiteX5" fmla="*/ 0 w 505414"/>
                      <a:gd name="connsiteY5" fmla="*/ 75333 h 845694"/>
                      <a:gd name="connsiteX0" fmla="*/ 0 w 505414"/>
                      <a:gd name="connsiteY0" fmla="*/ 62182 h 832543"/>
                      <a:gd name="connsiteX1" fmla="*/ 243182 w 505414"/>
                      <a:gd name="connsiteY1" fmla="*/ 11379 h 832543"/>
                      <a:gd name="connsiteX2" fmla="*/ 505414 w 505414"/>
                      <a:gd name="connsiteY2" fmla="*/ 421961 h 832543"/>
                      <a:gd name="connsiteX3" fmla="*/ 243182 w 505414"/>
                      <a:gd name="connsiteY3" fmla="*/ 832543 h 832543"/>
                      <a:gd name="connsiteX4" fmla="*/ 6350 w 505414"/>
                      <a:gd name="connsiteY4" fmla="*/ 800793 h 832543"/>
                      <a:gd name="connsiteX5" fmla="*/ 0 w 505414"/>
                      <a:gd name="connsiteY5" fmla="*/ 62182 h 832543"/>
                      <a:gd name="connsiteX0" fmla="*/ 0 w 518115"/>
                      <a:gd name="connsiteY0" fmla="*/ 176337 h 832395"/>
                      <a:gd name="connsiteX1" fmla="*/ 255883 w 518115"/>
                      <a:gd name="connsiteY1" fmla="*/ 11231 h 832395"/>
                      <a:gd name="connsiteX2" fmla="*/ 518115 w 518115"/>
                      <a:gd name="connsiteY2" fmla="*/ 421813 h 832395"/>
                      <a:gd name="connsiteX3" fmla="*/ 255883 w 518115"/>
                      <a:gd name="connsiteY3" fmla="*/ 832395 h 832395"/>
                      <a:gd name="connsiteX4" fmla="*/ 19051 w 518115"/>
                      <a:gd name="connsiteY4" fmla="*/ 800645 h 832395"/>
                      <a:gd name="connsiteX5" fmla="*/ 0 w 518115"/>
                      <a:gd name="connsiteY5" fmla="*/ 176337 h 832395"/>
                      <a:gd name="connsiteX0" fmla="*/ 0 w 519401"/>
                      <a:gd name="connsiteY0" fmla="*/ 184794 h 840852"/>
                      <a:gd name="connsiteX1" fmla="*/ 255883 w 519401"/>
                      <a:gd name="connsiteY1" fmla="*/ 19688 h 840852"/>
                      <a:gd name="connsiteX2" fmla="*/ 352107 w 519401"/>
                      <a:gd name="connsiteY2" fmla="*/ 48956 h 840852"/>
                      <a:gd name="connsiteX3" fmla="*/ 518115 w 519401"/>
                      <a:gd name="connsiteY3" fmla="*/ 430270 h 840852"/>
                      <a:gd name="connsiteX4" fmla="*/ 255883 w 519401"/>
                      <a:gd name="connsiteY4" fmla="*/ 840852 h 840852"/>
                      <a:gd name="connsiteX5" fmla="*/ 19051 w 519401"/>
                      <a:gd name="connsiteY5" fmla="*/ 809102 h 840852"/>
                      <a:gd name="connsiteX6" fmla="*/ 0 w 519401"/>
                      <a:gd name="connsiteY6" fmla="*/ 184794 h 840852"/>
                      <a:gd name="connsiteX0" fmla="*/ 0 w 522056"/>
                      <a:gd name="connsiteY0" fmla="*/ 168859 h 824917"/>
                      <a:gd name="connsiteX1" fmla="*/ 255883 w 522056"/>
                      <a:gd name="connsiteY1" fmla="*/ 3753 h 824917"/>
                      <a:gd name="connsiteX2" fmla="*/ 402907 w 522056"/>
                      <a:gd name="connsiteY2" fmla="*/ 83824 h 824917"/>
                      <a:gd name="connsiteX3" fmla="*/ 518115 w 522056"/>
                      <a:gd name="connsiteY3" fmla="*/ 414335 h 824917"/>
                      <a:gd name="connsiteX4" fmla="*/ 255883 w 522056"/>
                      <a:gd name="connsiteY4" fmla="*/ 824917 h 824917"/>
                      <a:gd name="connsiteX5" fmla="*/ 19051 w 522056"/>
                      <a:gd name="connsiteY5" fmla="*/ 793167 h 824917"/>
                      <a:gd name="connsiteX6" fmla="*/ 0 w 522056"/>
                      <a:gd name="connsiteY6" fmla="*/ 168859 h 824917"/>
                      <a:gd name="connsiteX0" fmla="*/ 0 w 521019"/>
                      <a:gd name="connsiteY0" fmla="*/ 168859 h 824917"/>
                      <a:gd name="connsiteX1" fmla="*/ 255883 w 521019"/>
                      <a:gd name="connsiteY1" fmla="*/ 3753 h 824917"/>
                      <a:gd name="connsiteX2" fmla="*/ 402907 w 521019"/>
                      <a:gd name="connsiteY2" fmla="*/ 83824 h 824917"/>
                      <a:gd name="connsiteX3" fmla="*/ 518115 w 521019"/>
                      <a:gd name="connsiteY3" fmla="*/ 414335 h 824917"/>
                      <a:gd name="connsiteX4" fmla="*/ 466407 w 521019"/>
                      <a:gd name="connsiteY4" fmla="*/ 687074 h 824917"/>
                      <a:gd name="connsiteX5" fmla="*/ 255883 w 521019"/>
                      <a:gd name="connsiteY5" fmla="*/ 824917 h 824917"/>
                      <a:gd name="connsiteX6" fmla="*/ 19051 w 521019"/>
                      <a:gd name="connsiteY6" fmla="*/ 793167 h 824917"/>
                      <a:gd name="connsiteX7" fmla="*/ 0 w 521019"/>
                      <a:gd name="connsiteY7" fmla="*/ 168859 h 824917"/>
                      <a:gd name="connsiteX0" fmla="*/ 0 w 518998"/>
                      <a:gd name="connsiteY0" fmla="*/ 167272 h 823330"/>
                      <a:gd name="connsiteX1" fmla="*/ 255883 w 518998"/>
                      <a:gd name="connsiteY1" fmla="*/ 2166 h 823330"/>
                      <a:gd name="connsiteX2" fmla="*/ 402907 w 518998"/>
                      <a:gd name="connsiteY2" fmla="*/ 82237 h 823330"/>
                      <a:gd name="connsiteX3" fmla="*/ 491807 w 518998"/>
                      <a:gd name="connsiteY3" fmla="*/ 209234 h 823330"/>
                      <a:gd name="connsiteX4" fmla="*/ 518115 w 518998"/>
                      <a:gd name="connsiteY4" fmla="*/ 412748 h 823330"/>
                      <a:gd name="connsiteX5" fmla="*/ 466407 w 518998"/>
                      <a:gd name="connsiteY5" fmla="*/ 685487 h 823330"/>
                      <a:gd name="connsiteX6" fmla="*/ 255883 w 518998"/>
                      <a:gd name="connsiteY6" fmla="*/ 823330 h 823330"/>
                      <a:gd name="connsiteX7" fmla="*/ 19051 w 518998"/>
                      <a:gd name="connsiteY7" fmla="*/ 791580 h 823330"/>
                      <a:gd name="connsiteX8" fmla="*/ 0 w 518998"/>
                      <a:gd name="connsiteY8" fmla="*/ 167272 h 823330"/>
                      <a:gd name="connsiteX0" fmla="*/ 21253 w 540251"/>
                      <a:gd name="connsiteY0" fmla="*/ 167272 h 823330"/>
                      <a:gd name="connsiteX1" fmla="*/ 277136 w 540251"/>
                      <a:gd name="connsiteY1" fmla="*/ 2166 h 823330"/>
                      <a:gd name="connsiteX2" fmla="*/ 424160 w 540251"/>
                      <a:gd name="connsiteY2" fmla="*/ 82237 h 823330"/>
                      <a:gd name="connsiteX3" fmla="*/ 513060 w 540251"/>
                      <a:gd name="connsiteY3" fmla="*/ 209234 h 823330"/>
                      <a:gd name="connsiteX4" fmla="*/ 539368 w 540251"/>
                      <a:gd name="connsiteY4" fmla="*/ 412748 h 823330"/>
                      <a:gd name="connsiteX5" fmla="*/ 487660 w 540251"/>
                      <a:gd name="connsiteY5" fmla="*/ 685487 h 823330"/>
                      <a:gd name="connsiteX6" fmla="*/ 277136 w 540251"/>
                      <a:gd name="connsiteY6" fmla="*/ 823330 h 823330"/>
                      <a:gd name="connsiteX7" fmla="*/ 40304 w 540251"/>
                      <a:gd name="connsiteY7" fmla="*/ 791580 h 823330"/>
                      <a:gd name="connsiteX8" fmla="*/ 11411 w 540251"/>
                      <a:gd name="connsiteY8" fmla="*/ 615633 h 823330"/>
                      <a:gd name="connsiteX9" fmla="*/ 21253 w 540251"/>
                      <a:gd name="connsiteY9" fmla="*/ 167272 h 823330"/>
                      <a:gd name="connsiteX0" fmla="*/ 54342 w 573340"/>
                      <a:gd name="connsiteY0" fmla="*/ 167272 h 823330"/>
                      <a:gd name="connsiteX1" fmla="*/ 310225 w 573340"/>
                      <a:gd name="connsiteY1" fmla="*/ 2166 h 823330"/>
                      <a:gd name="connsiteX2" fmla="*/ 457249 w 573340"/>
                      <a:gd name="connsiteY2" fmla="*/ 82237 h 823330"/>
                      <a:gd name="connsiteX3" fmla="*/ 546149 w 573340"/>
                      <a:gd name="connsiteY3" fmla="*/ 209234 h 823330"/>
                      <a:gd name="connsiteX4" fmla="*/ 572457 w 573340"/>
                      <a:gd name="connsiteY4" fmla="*/ 412748 h 823330"/>
                      <a:gd name="connsiteX5" fmla="*/ 520749 w 573340"/>
                      <a:gd name="connsiteY5" fmla="*/ 685487 h 823330"/>
                      <a:gd name="connsiteX6" fmla="*/ 310225 w 573340"/>
                      <a:gd name="connsiteY6" fmla="*/ 823330 h 823330"/>
                      <a:gd name="connsiteX7" fmla="*/ 73393 w 573340"/>
                      <a:gd name="connsiteY7" fmla="*/ 791580 h 823330"/>
                      <a:gd name="connsiteX8" fmla="*/ 44500 w 573340"/>
                      <a:gd name="connsiteY8" fmla="*/ 615633 h 823330"/>
                      <a:gd name="connsiteX9" fmla="*/ 50 w 573340"/>
                      <a:gd name="connsiteY9" fmla="*/ 240987 h 823330"/>
                      <a:gd name="connsiteX10" fmla="*/ 54342 w 573340"/>
                      <a:gd name="connsiteY10" fmla="*/ 167272 h 823330"/>
                      <a:gd name="connsiteX0" fmla="*/ 54342 w 573340"/>
                      <a:gd name="connsiteY0" fmla="*/ 155040 h 811098"/>
                      <a:gd name="connsiteX1" fmla="*/ 253075 w 573340"/>
                      <a:gd name="connsiteY1" fmla="*/ 2634 h 811098"/>
                      <a:gd name="connsiteX2" fmla="*/ 457249 w 573340"/>
                      <a:gd name="connsiteY2" fmla="*/ 70005 h 811098"/>
                      <a:gd name="connsiteX3" fmla="*/ 546149 w 573340"/>
                      <a:gd name="connsiteY3" fmla="*/ 197002 h 811098"/>
                      <a:gd name="connsiteX4" fmla="*/ 572457 w 573340"/>
                      <a:gd name="connsiteY4" fmla="*/ 400516 h 811098"/>
                      <a:gd name="connsiteX5" fmla="*/ 520749 w 573340"/>
                      <a:gd name="connsiteY5" fmla="*/ 673255 h 811098"/>
                      <a:gd name="connsiteX6" fmla="*/ 310225 w 573340"/>
                      <a:gd name="connsiteY6" fmla="*/ 811098 h 811098"/>
                      <a:gd name="connsiteX7" fmla="*/ 73393 w 573340"/>
                      <a:gd name="connsiteY7" fmla="*/ 779348 h 811098"/>
                      <a:gd name="connsiteX8" fmla="*/ 44500 w 573340"/>
                      <a:gd name="connsiteY8" fmla="*/ 603401 h 811098"/>
                      <a:gd name="connsiteX9" fmla="*/ 50 w 573340"/>
                      <a:gd name="connsiteY9" fmla="*/ 228755 h 811098"/>
                      <a:gd name="connsiteX10" fmla="*/ 54342 w 573340"/>
                      <a:gd name="connsiteY10" fmla="*/ 155040 h 811098"/>
                      <a:gd name="connsiteX0" fmla="*/ 54342 w 573340"/>
                      <a:gd name="connsiteY0" fmla="*/ 155040 h 798398"/>
                      <a:gd name="connsiteX1" fmla="*/ 253075 w 573340"/>
                      <a:gd name="connsiteY1" fmla="*/ 2634 h 798398"/>
                      <a:gd name="connsiteX2" fmla="*/ 457249 w 573340"/>
                      <a:gd name="connsiteY2" fmla="*/ 70005 h 798398"/>
                      <a:gd name="connsiteX3" fmla="*/ 546149 w 573340"/>
                      <a:gd name="connsiteY3" fmla="*/ 197002 h 798398"/>
                      <a:gd name="connsiteX4" fmla="*/ 572457 w 573340"/>
                      <a:gd name="connsiteY4" fmla="*/ 400516 h 798398"/>
                      <a:gd name="connsiteX5" fmla="*/ 520749 w 573340"/>
                      <a:gd name="connsiteY5" fmla="*/ 673255 h 798398"/>
                      <a:gd name="connsiteX6" fmla="*/ 272125 w 573340"/>
                      <a:gd name="connsiteY6" fmla="*/ 798398 h 798398"/>
                      <a:gd name="connsiteX7" fmla="*/ 73393 w 573340"/>
                      <a:gd name="connsiteY7" fmla="*/ 779348 h 798398"/>
                      <a:gd name="connsiteX8" fmla="*/ 44500 w 573340"/>
                      <a:gd name="connsiteY8" fmla="*/ 603401 h 798398"/>
                      <a:gd name="connsiteX9" fmla="*/ 50 w 573340"/>
                      <a:gd name="connsiteY9" fmla="*/ 228755 h 798398"/>
                      <a:gd name="connsiteX10" fmla="*/ 54342 w 573340"/>
                      <a:gd name="connsiteY10" fmla="*/ 155040 h 798398"/>
                      <a:gd name="connsiteX0" fmla="*/ 54342 w 575221"/>
                      <a:gd name="connsiteY0" fmla="*/ 155040 h 798398"/>
                      <a:gd name="connsiteX1" fmla="*/ 253075 w 575221"/>
                      <a:gd name="connsiteY1" fmla="*/ 2634 h 798398"/>
                      <a:gd name="connsiteX2" fmla="*/ 457249 w 575221"/>
                      <a:gd name="connsiteY2" fmla="*/ 70005 h 798398"/>
                      <a:gd name="connsiteX3" fmla="*/ 546149 w 575221"/>
                      <a:gd name="connsiteY3" fmla="*/ 197002 h 798398"/>
                      <a:gd name="connsiteX4" fmla="*/ 572457 w 575221"/>
                      <a:gd name="connsiteY4" fmla="*/ 400516 h 798398"/>
                      <a:gd name="connsiteX5" fmla="*/ 488999 w 575221"/>
                      <a:gd name="connsiteY5" fmla="*/ 666905 h 798398"/>
                      <a:gd name="connsiteX6" fmla="*/ 272125 w 575221"/>
                      <a:gd name="connsiteY6" fmla="*/ 798398 h 798398"/>
                      <a:gd name="connsiteX7" fmla="*/ 73393 w 575221"/>
                      <a:gd name="connsiteY7" fmla="*/ 779348 h 798398"/>
                      <a:gd name="connsiteX8" fmla="*/ 44500 w 575221"/>
                      <a:gd name="connsiteY8" fmla="*/ 603401 h 798398"/>
                      <a:gd name="connsiteX9" fmla="*/ 50 w 575221"/>
                      <a:gd name="connsiteY9" fmla="*/ 228755 h 798398"/>
                      <a:gd name="connsiteX10" fmla="*/ 54342 w 575221"/>
                      <a:gd name="connsiteY10" fmla="*/ 155040 h 798398"/>
                      <a:gd name="connsiteX0" fmla="*/ 54342 w 575221"/>
                      <a:gd name="connsiteY0" fmla="*/ 155040 h 798398"/>
                      <a:gd name="connsiteX1" fmla="*/ 253075 w 575221"/>
                      <a:gd name="connsiteY1" fmla="*/ 2634 h 798398"/>
                      <a:gd name="connsiteX2" fmla="*/ 457249 w 575221"/>
                      <a:gd name="connsiteY2" fmla="*/ 70005 h 798398"/>
                      <a:gd name="connsiteX3" fmla="*/ 546149 w 575221"/>
                      <a:gd name="connsiteY3" fmla="*/ 197002 h 798398"/>
                      <a:gd name="connsiteX4" fmla="*/ 572457 w 575221"/>
                      <a:gd name="connsiteY4" fmla="*/ 400516 h 798398"/>
                      <a:gd name="connsiteX5" fmla="*/ 488999 w 575221"/>
                      <a:gd name="connsiteY5" fmla="*/ 666905 h 798398"/>
                      <a:gd name="connsiteX6" fmla="*/ 272125 w 575221"/>
                      <a:gd name="connsiteY6" fmla="*/ 798398 h 798398"/>
                      <a:gd name="connsiteX7" fmla="*/ 73393 w 575221"/>
                      <a:gd name="connsiteY7" fmla="*/ 779348 h 798398"/>
                      <a:gd name="connsiteX8" fmla="*/ 44500 w 575221"/>
                      <a:gd name="connsiteY8" fmla="*/ 603401 h 798398"/>
                      <a:gd name="connsiteX9" fmla="*/ 50 w 575221"/>
                      <a:gd name="connsiteY9" fmla="*/ 228755 h 798398"/>
                      <a:gd name="connsiteX10" fmla="*/ 54342 w 575221"/>
                      <a:gd name="connsiteY10" fmla="*/ 155040 h 798398"/>
                      <a:gd name="connsiteX0" fmla="*/ 54342 w 575221"/>
                      <a:gd name="connsiteY0" fmla="*/ 155040 h 798398"/>
                      <a:gd name="connsiteX1" fmla="*/ 253075 w 575221"/>
                      <a:gd name="connsiteY1" fmla="*/ 2634 h 798398"/>
                      <a:gd name="connsiteX2" fmla="*/ 457249 w 575221"/>
                      <a:gd name="connsiteY2" fmla="*/ 70005 h 798398"/>
                      <a:gd name="connsiteX3" fmla="*/ 546149 w 575221"/>
                      <a:gd name="connsiteY3" fmla="*/ 197002 h 798398"/>
                      <a:gd name="connsiteX4" fmla="*/ 572457 w 575221"/>
                      <a:gd name="connsiteY4" fmla="*/ 400516 h 798398"/>
                      <a:gd name="connsiteX5" fmla="*/ 488999 w 575221"/>
                      <a:gd name="connsiteY5" fmla="*/ 666905 h 798398"/>
                      <a:gd name="connsiteX6" fmla="*/ 272125 w 575221"/>
                      <a:gd name="connsiteY6" fmla="*/ 798398 h 798398"/>
                      <a:gd name="connsiteX7" fmla="*/ 73393 w 575221"/>
                      <a:gd name="connsiteY7" fmla="*/ 779348 h 798398"/>
                      <a:gd name="connsiteX8" fmla="*/ 44500 w 575221"/>
                      <a:gd name="connsiteY8" fmla="*/ 603401 h 798398"/>
                      <a:gd name="connsiteX9" fmla="*/ 50 w 575221"/>
                      <a:gd name="connsiteY9" fmla="*/ 228755 h 798398"/>
                      <a:gd name="connsiteX10" fmla="*/ 54342 w 575221"/>
                      <a:gd name="connsiteY10" fmla="*/ 155040 h 798398"/>
                      <a:gd name="connsiteX0" fmla="*/ 54342 w 575221"/>
                      <a:gd name="connsiteY0" fmla="*/ 155040 h 798398"/>
                      <a:gd name="connsiteX1" fmla="*/ 253075 w 575221"/>
                      <a:gd name="connsiteY1" fmla="*/ 2634 h 798398"/>
                      <a:gd name="connsiteX2" fmla="*/ 457249 w 575221"/>
                      <a:gd name="connsiteY2" fmla="*/ 70005 h 798398"/>
                      <a:gd name="connsiteX3" fmla="*/ 546149 w 575221"/>
                      <a:gd name="connsiteY3" fmla="*/ 197002 h 798398"/>
                      <a:gd name="connsiteX4" fmla="*/ 572457 w 575221"/>
                      <a:gd name="connsiteY4" fmla="*/ 400516 h 798398"/>
                      <a:gd name="connsiteX5" fmla="*/ 488999 w 575221"/>
                      <a:gd name="connsiteY5" fmla="*/ 666905 h 798398"/>
                      <a:gd name="connsiteX6" fmla="*/ 272125 w 575221"/>
                      <a:gd name="connsiteY6" fmla="*/ 798398 h 798398"/>
                      <a:gd name="connsiteX7" fmla="*/ 73393 w 575221"/>
                      <a:gd name="connsiteY7" fmla="*/ 779348 h 798398"/>
                      <a:gd name="connsiteX8" fmla="*/ 44500 w 575221"/>
                      <a:gd name="connsiteY8" fmla="*/ 603401 h 798398"/>
                      <a:gd name="connsiteX9" fmla="*/ 50 w 575221"/>
                      <a:gd name="connsiteY9" fmla="*/ 228755 h 798398"/>
                      <a:gd name="connsiteX10" fmla="*/ 54342 w 575221"/>
                      <a:gd name="connsiteY10" fmla="*/ 155040 h 798398"/>
                      <a:gd name="connsiteX0" fmla="*/ 47992 w 575221"/>
                      <a:gd name="connsiteY0" fmla="*/ 121896 h 797001"/>
                      <a:gd name="connsiteX1" fmla="*/ 253075 w 575221"/>
                      <a:gd name="connsiteY1" fmla="*/ 1237 h 797001"/>
                      <a:gd name="connsiteX2" fmla="*/ 457249 w 575221"/>
                      <a:gd name="connsiteY2" fmla="*/ 68608 h 797001"/>
                      <a:gd name="connsiteX3" fmla="*/ 546149 w 575221"/>
                      <a:gd name="connsiteY3" fmla="*/ 195605 h 797001"/>
                      <a:gd name="connsiteX4" fmla="*/ 572457 w 575221"/>
                      <a:gd name="connsiteY4" fmla="*/ 399119 h 797001"/>
                      <a:gd name="connsiteX5" fmla="*/ 488999 w 575221"/>
                      <a:gd name="connsiteY5" fmla="*/ 665508 h 797001"/>
                      <a:gd name="connsiteX6" fmla="*/ 272125 w 575221"/>
                      <a:gd name="connsiteY6" fmla="*/ 797001 h 797001"/>
                      <a:gd name="connsiteX7" fmla="*/ 73393 w 575221"/>
                      <a:gd name="connsiteY7" fmla="*/ 777951 h 797001"/>
                      <a:gd name="connsiteX8" fmla="*/ 44500 w 575221"/>
                      <a:gd name="connsiteY8" fmla="*/ 602004 h 797001"/>
                      <a:gd name="connsiteX9" fmla="*/ 50 w 575221"/>
                      <a:gd name="connsiteY9" fmla="*/ 227358 h 797001"/>
                      <a:gd name="connsiteX10" fmla="*/ 47992 w 575221"/>
                      <a:gd name="connsiteY10" fmla="*/ 121896 h 797001"/>
                      <a:gd name="connsiteX0" fmla="*/ 51978 w 579207"/>
                      <a:gd name="connsiteY0" fmla="*/ 121896 h 797001"/>
                      <a:gd name="connsiteX1" fmla="*/ 257061 w 579207"/>
                      <a:gd name="connsiteY1" fmla="*/ 1237 h 797001"/>
                      <a:gd name="connsiteX2" fmla="*/ 461235 w 579207"/>
                      <a:gd name="connsiteY2" fmla="*/ 68608 h 797001"/>
                      <a:gd name="connsiteX3" fmla="*/ 550135 w 579207"/>
                      <a:gd name="connsiteY3" fmla="*/ 195605 h 797001"/>
                      <a:gd name="connsiteX4" fmla="*/ 576443 w 579207"/>
                      <a:gd name="connsiteY4" fmla="*/ 399119 h 797001"/>
                      <a:gd name="connsiteX5" fmla="*/ 492985 w 579207"/>
                      <a:gd name="connsiteY5" fmla="*/ 665508 h 797001"/>
                      <a:gd name="connsiteX6" fmla="*/ 276111 w 579207"/>
                      <a:gd name="connsiteY6" fmla="*/ 797001 h 797001"/>
                      <a:gd name="connsiteX7" fmla="*/ 77379 w 579207"/>
                      <a:gd name="connsiteY7" fmla="*/ 777951 h 797001"/>
                      <a:gd name="connsiteX8" fmla="*/ 3243 w 579207"/>
                      <a:gd name="connsiteY8" fmla="*/ 609148 h 797001"/>
                      <a:gd name="connsiteX9" fmla="*/ 4036 w 579207"/>
                      <a:gd name="connsiteY9" fmla="*/ 227358 h 797001"/>
                      <a:gd name="connsiteX10" fmla="*/ 51978 w 579207"/>
                      <a:gd name="connsiteY10" fmla="*/ 121896 h 797001"/>
                      <a:gd name="connsiteX0" fmla="*/ 44834 w 579207"/>
                      <a:gd name="connsiteY0" fmla="*/ 109558 h 796569"/>
                      <a:gd name="connsiteX1" fmla="*/ 257061 w 579207"/>
                      <a:gd name="connsiteY1" fmla="*/ 805 h 796569"/>
                      <a:gd name="connsiteX2" fmla="*/ 461235 w 579207"/>
                      <a:gd name="connsiteY2" fmla="*/ 68176 h 796569"/>
                      <a:gd name="connsiteX3" fmla="*/ 550135 w 579207"/>
                      <a:gd name="connsiteY3" fmla="*/ 195173 h 796569"/>
                      <a:gd name="connsiteX4" fmla="*/ 576443 w 579207"/>
                      <a:gd name="connsiteY4" fmla="*/ 398687 h 796569"/>
                      <a:gd name="connsiteX5" fmla="*/ 492985 w 579207"/>
                      <a:gd name="connsiteY5" fmla="*/ 665076 h 796569"/>
                      <a:gd name="connsiteX6" fmla="*/ 276111 w 579207"/>
                      <a:gd name="connsiteY6" fmla="*/ 796569 h 796569"/>
                      <a:gd name="connsiteX7" fmla="*/ 77379 w 579207"/>
                      <a:gd name="connsiteY7" fmla="*/ 777519 h 796569"/>
                      <a:gd name="connsiteX8" fmla="*/ 3243 w 579207"/>
                      <a:gd name="connsiteY8" fmla="*/ 608716 h 796569"/>
                      <a:gd name="connsiteX9" fmla="*/ 4036 w 579207"/>
                      <a:gd name="connsiteY9" fmla="*/ 226926 h 796569"/>
                      <a:gd name="connsiteX10" fmla="*/ 44834 w 579207"/>
                      <a:gd name="connsiteY10" fmla="*/ 109558 h 796569"/>
                      <a:gd name="connsiteX0" fmla="*/ 44834 w 579207"/>
                      <a:gd name="connsiteY0" fmla="*/ 109558 h 796569"/>
                      <a:gd name="connsiteX1" fmla="*/ 257061 w 579207"/>
                      <a:gd name="connsiteY1" fmla="*/ 805 h 796569"/>
                      <a:gd name="connsiteX2" fmla="*/ 461235 w 579207"/>
                      <a:gd name="connsiteY2" fmla="*/ 68176 h 796569"/>
                      <a:gd name="connsiteX3" fmla="*/ 550135 w 579207"/>
                      <a:gd name="connsiteY3" fmla="*/ 195173 h 796569"/>
                      <a:gd name="connsiteX4" fmla="*/ 576443 w 579207"/>
                      <a:gd name="connsiteY4" fmla="*/ 398687 h 796569"/>
                      <a:gd name="connsiteX5" fmla="*/ 492985 w 579207"/>
                      <a:gd name="connsiteY5" fmla="*/ 665076 h 796569"/>
                      <a:gd name="connsiteX6" fmla="*/ 276111 w 579207"/>
                      <a:gd name="connsiteY6" fmla="*/ 796569 h 796569"/>
                      <a:gd name="connsiteX7" fmla="*/ 77379 w 579207"/>
                      <a:gd name="connsiteY7" fmla="*/ 777519 h 796569"/>
                      <a:gd name="connsiteX8" fmla="*/ 3243 w 579207"/>
                      <a:gd name="connsiteY8" fmla="*/ 608716 h 796569"/>
                      <a:gd name="connsiteX9" fmla="*/ 4036 w 579207"/>
                      <a:gd name="connsiteY9" fmla="*/ 226926 h 796569"/>
                      <a:gd name="connsiteX10" fmla="*/ 44834 w 579207"/>
                      <a:gd name="connsiteY10" fmla="*/ 109558 h 796569"/>
                      <a:gd name="connsiteX0" fmla="*/ 44834 w 579207"/>
                      <a:gd name="connsiteY0" fmla="*/ 109558 h 796569"/>
                      <a:gd name="connsiteX1" fmla="*/ 257061 w 579207"/>
                      <a:gd name="connsiteY1" fmla="*/ 805 h 796569"/>
                      <a:gd name="connsiteX2" fmla="*/ 461235 w 579207"/>
                      <a:gd name="connsiteY2" fmla="*/ 68176 h 796569"/>
                      <a:gd name="connsiteX3" fmla="*/ 550135 w 579207"/>
                      <a:gd name="connsiteY3" fmla="*/ 195173 h 796569"/>
                      <a:gd name="connsiteX4" fmla="*/ 576443 w 579207"/>
                      <a:gd name="connsiteY4" fmla="*/ 398687 h 796569"/>
                      <a:gd name="connsiteX5" fmla="*/ 492985 w 579207"/>
                      <a:gd name="connsiteY5" fmla="*/ 665076 h 796569"/>
                      <a:gd name="connsiteX6" fmla="*/ 276111 w 579207"/>
                      <a:gd name="connsiteY6" fmla="*/ 796569 h 796569"/>
                      <a:gd name="connsiteX7" fmla="*/ 77379 w 579207"/>
                      <a:gd name="connsiteY7" fmla="*/ 777519 h 796569"/>
                      <a:gd name="connsiteX8" fmla="*/ 3243 w 579207"/>
                      <a:gd name="connsiteY8" fmla="*/ 608716 h 796569"/>
                      <a:gd name="connsiteX9" fmla="*/ 4036 w 579207"/>
                      <a:gd name="connsiteY9" fmla="*/ 226926 h 796569"/>
                      <a:gd name="connsiteX10" fmla="*/ 44834 w 579207"/>
                      <a:gd name="connsiteY10" fmla="*/ 109558 h 796569"/>
                      <a:gd name="connsiteX0" fmla="*/ 44834 w 579207"/>
                      <a:gd name="connsiteY0" fmla="*/ 109558 h 796569"/>
                      <a:gd name="connsiteX1" fmla="*/ 257061 w 579207"/>
                      <a:gd name="connsiteY1" fmla="*/ 805 h 796569"/>
                      <a:gd name="connsiteX2" fmla="*/ 461235 w 579207"/>
                      <a:gd name="connsiteY2" fmla="*/ 68176 h 796569"/>
                      <a:gd name="connsiteX3" fmla="*/ 550135 w 579207"/>
                      <a:gd name="connsiteY3" fmla="*/ 195173 h 796569"/>
                      <a:gd name="connsiteX4" fmla="*/ 576443 w 579207"/>
                      <a:gd name="connsiteY4" fmla="*/ 398687 h 796569"/>
                      <a:gd name="connsiteX5" fmla="*/ 492985 w 579207"/>
                      <a:gd name="connsiteY5" fmla="*/ 665076 h 796569"/>
                      <a:gd name="connsiteX6" fmla="*/ 276111 w 579207"/>
                      <a:gd name="connsiteY6" fmla="*/ 796569 h 796569"/>
                      <a:gd name="connsiteX7" fmla="*/ 77379 w 579207"/>
                      <a:gd name="connsiteY7" fmla="*/ 777519 h 796569"/>
                      <a:gd name="connsiteX8" fmla="*/ 3243 w 579207"/>
                      <a:gd name="connsiteY8" fmla="*/ 608716 h 796569"/>
                      <a:gd name="connsiteX9" fmla="*/ 4036 w 579207"/>
                      <a:gd name="connsiteY9" fmla="*/ 226926 h 796569"/>
                      <a:gd name="connsiteX10" fmla="*/ 44834 w 579207"/>
                      <a:gd name="connsiteY10" fmla="*/ 109558 h 796569"/>
                      <a:gd name="connsiteX0" fmla="*/ 44834 w 579207"/>
                      <a:gd name="connsiteY0" fmla="*/ 93345 h 780356"/>
                      <a:gd name="connsiteX1" fmla="*/ 247536 w 579207"/>
                      <a:gd name="connsiteY1" fmla="*/ 1261 h 780356"/>
                      <a:gd name="connsiteX2" fmla="*/ 461235 w 579207"/>
                      <a:gd name="connsiteY2" fmla="*/ 51963 h 780356"/>
                      <a:gd name="connsiteX3" fmla="*/ 550135 w 579207"/>
                      <a:gd name="connsiteY3" fmla="*/ 178960 h 780356"/>
                      <a:gd name="connsiteX4" fmla="*/ 576443 w 579207"/>
                      <a:gd name="connsiteY4" fmla="*/ 382474 h 780356"/>
                      <a:gd name="connsiteX5" fmla="*/ 492985 w 579207"/>
                      <a:gd name="connsiteY5" fmla="*/ 648863 h 780356"/>
                      <a:gd name="connsiteX6" fmla="*/ 276111 w 579207"/>
                      <a:gd name="connsiteY6" fmla="*/ 780356 h 780356"/>
                      <a:gd name="connsiteX7" fmla="*/ 77379 w 579207"/>
                      <a:gd name="connsiteY7" fmla="*/ 761306 h 780356"/>
                      <a:gd name="connsiteX8" fmla="*/ 3243 w 579207"/>
                      <a:gd name="connsiteY8" fmla="*/ 592503 h 780356"/>
                      <a:gd name="connsiteX9" fmla="*/ 4036 w 579207"/>
                      <a:gd name="connsiteY9" fmla="*/ 210713 h 780356"/>
                      <a:gd name="connsiteX10" fmla="*/ 44834 w 579207"/>
                      <a:gd name="connsiteY10" fmla="*/ 93345 h 780356"/>
                      <a:gd name="connsiteX0" fmla="*/ 44834 w 579207"/>
                      <a:gd name="connsiteY0" fmla="*/ 92586 h 779597"/>
                      <a:gd name="connsiteX1" fmla="*/ 247536 w 579207"/>
                      <a:gd name="connsiteY1" fmla="*/ 502 h 779597"/>
                      <a:gd name="connsiteX2" fmla="*/ 439804 w 579207"/>
                      <a:gd name="connsiteY2" fmla="*/ 63113 h 779597"/>
                      <a:gd name="connsiteX3" fmla="*/ 550135 w 579207"/>
                      <a:gd name="connsiteY3" fmla="*/ 178201 h 779597"/>
                      <a:gd name="connsiteX4" fmla="*/ 576443 w 579207"/>
                      <a:gd name="connsiteY4" fmla="*/ 381715 h 779597"/>
                      <a:gd name="connsiteX5" fmla="*/ 492985 w 579207"/>
                      <a:gd name="connsiteY5" fmla="*/ 648104 h 779597"/>
                      <a:gd name="connsiteX6" fmla="*/ 276111 w 579207"/>
                      <a:gd name="connsiteY6" fmla="*/ 779597 h 779597"/>
                      <a:gd name="connsiteX7" fmla="*/ 77379 w 579207"/>
                      <a:gd name="connsiteY7" fmla="*/ 760547 h 779597"/>
                      <a:gd name="connsiteX8" fmla="*/ 3243 w 579207"/>
                      <a:gd name="connsiteY8" fmla="*/ 591744 h 779597"/>
                      <a:gd name="connsiteX9" fmla="*/ 4036 w 579207"/>
                      <a:gd name="connsiteY9" fmla="*/ 209954 h 779597"/>
                      <a:gd name="connsiteX10" fmla="*/ 44834 w 579207"/>
                      <a:gd name="connsiteY10" fmla="*/ 92586 h 779597"/>
                      <a:gd name="connsiteX0" fmla="*/ 44834 w 579207"/>
                      <a:gd name="connsiteY0" fmla="*/ 82080 h 769091"/>
                      <a:gd name="connsiteX1" fmla="*/ 247536 w 579207"/>
                      <a:gd name="connsiteY1" fmla="*/ 4284 h 769091"/>
                      <a:gd name="connsiteX2" fmla="*/ 439804 w 579207"/>
                      <a:gd name="connsiteY2" fmla="*/ 52607 h 769091"/>
                      <a:gd name="connsiteX3" fmla="*/ 550135 w 579207"/>
                      <a:gd name="connsiteY3" fmla="*/ 167695 h 769091"/>
                      <a:gd name="connsiteX4" fmla="*/ 576443 w 579207"/>
                      <a:gd name="connsiteY4" fmla="*/ 371209 h 769091"/>
                      <a:gd name="connsiteX5" fmla="*/ 492985 w 579207"/>
                      <a:gd name="connsiteY5" fmla="*/ 637598 h 769091"/>
                      <a:gd name="connsiteX6" fmla="*/ 276111 w 579207"/>
                      <a:gd name="connsiteY6" fmla="*/ 769091 h 769091"/>
                      <a:gd name="connsiteX7" fmla="*/ 77379 w 579207"/>
                      <a:gd name="connsiteY7" fmla="*/ 750041 h 769091"/>
                      <a:gd name="connsiteX8" fmla="*/ 3243 w 579207"/>
                      <a:gd name="connsiteY8" fmla="*/ 581238 h 769091"/>
                      <a:gd name="connsiteX9" fmla="*/ 4036 w 579207"/>
                      <a:gd name="connsiteY9" fmla="*/ 199448 h 769091"/>
                      <a:gd name="connsiteX10" fmla="*/ 44834 w 579207"/>
                      <a:gd name="connsiteY10" fmla="*/ 82080 h 769091"/>
                      <a:gd name="connsiteX0" fmla="*/ 44834 w 579207"/>
                      <a:gd name="connsiteY0" fmla="*/ 78633 h 765644"/>
                      <a:gd name="connsiteX1" fmla="*/ 104842 w 579207"/>
                      <a:gd name="connsiteY1" fmla="*/ 22959 h 765644"/>
                      <a:gd name="connsiteX2" fmla="*/ 247536 w 579207"/>
                      <a:gd name="connsiteY2" fmla="*/ 837 h 765644"/>
                      <a:gd name="connsiteX3" fmla="*/ 439804 w 579207"/>
                      <a:gd name="connsiteY3" fmla="*/ 49160 h 765644"/>
                      <a:gd name="connsiteX4" fmla="*/ 550135 w 579207"/>
                      <a:gd name="connsiteY4" fmla="*/ 164248 h 765644"/>
                      <a:gd name="connsiteX5" fmla="*/ 576443 w 579207"/>
                      <a:gd name="connsiteY5" fmla="*/ 367762 h 765644"/>
                      <a:gd name="connsiteX6" fmla="*/ 492985 w 579207"/>
                      <a:gd name="connsiteY6" fmla="*/ 634151 h 765644"/>
                      <a:gd name="connsiteX7" fmla="*/ 276111 w 579207"/>
                      <a:gd name="connsiteY7" fmla="*/ 765644 h 765644"/>
                      <a:gd name="connsiteX8" fmla="*/ 77379 w 579207"/>
                      <a:gd name="connsiteY8" fmla="*/ 746594 h 765644"/>
                      <a:gd name="connsiteX9" fmla="*/ 3243 w 579207"/>
                      <a:gd name="connsiteY9" fmla="*/ 577791 h 765644"/>
                      <a:gd name="connsiteX10" fmla="*/ 4036 w 579207"/>
                      <a:gd name="connsiteY10" fmla="*/ 196001 h 765644"/>
                      <a:gd name="connsiteX11" fmla="*/ 44834 w 579207"/>
                      <a:gd name="connsiteY11" fmla="*/ 78633 h 765644"/>
                      <a:gd name="connsiteX0" fmla="*/ 44834 w 577756"/>
                      <a:gd name="connsiteY0" fmla="*/ 78633 h 765644"/>
                      <a:gd name="connsiteX1" fmla="*/ 104842 w 577756"/>
                      <a:gd name="connsiteY1" fmla="*/ 22959 h 765644"/>
                      <a:gd name="connsiteX2" fmla="*/ 247536 w 577756"/>
                      <a:gd name="connsiteY2" fmla="*/ 837 h 765644"/>
                      <a:gd name="connsiteX3" fmla="*/ 439804 w 577756"/>
                      <a:gd name="connsiteY3" fmla="*/ 49160 h 765644"/>
                      <a:gd name="connsiteX4" fmla="*/ 538229 w 577756"/>
                      <a:gd name="connsiteY4" fmla="*/ 178539 h 765644"/>
                      <a:gd name="connsiteX5" fmla="*/ 576443 w 577756"/>
                      <a:gd name="connsiteY5" fmla="*/ 367762 h 765644"/>
                      <a:gd name="connsiteX6" fmla="*/ 492985 w 577756"/>
                      <a:gd name="connsiteY6" fmla="*/ 634151 h 765644"/>
                      <a:gd name="connsiteX7" fmla="*/ 276111 w 577756"/>
                      <a:gd name="connsiteY7" fmla="*/ 765644 h 765644"/>
                      <a:gd name="connsiteX8" fmla="*/ 77379 w 577756"/>
                      <a:gd name="connsiteY8" fmla="*/ 746594 h 765644"/>
                      <a:gd name="connsiteX9" fmla="*/ 3243 w 577756"/>
                      <a:gd name="connsiteY9" fmla="*/ 577791 h 765644"/>
                      <a:gd name="connsiteX10" fmla="*/ 4036 w 577756"/>
                      <a:gd name="connsiteY10" fmla="*/ 196001 h 765644"/>
                      <a:gd name="connsiteX11" fmla="*/ 44834 w 577756"/>
                      <a:gd name="connsiteY11" fmla="*/ 78633 h 765644"/>
                      <a:gd name="connsiteX0" fmla="*/ 44834 w 577756"/>
                      <a:gd name="connsiteY0" fmla="*/ 79401 h 766412"/>
                      <a:gd name="connsiteX1" fmla="*/ 104842 w 577756"/>
                      <a:gd name="connsiteY1" fmla="*/ 23727 h 766412"/>
                      <a:gd name="connsiteX2" fmla="*/ 247536 w 577756"/>
                      <a:gd name="connsiteY2" fmla="*/ 1605 h 766412"/>
                      <a:gd name="connsiteX3" fmla="*/ 430279 w 577756"/>
                      <a:gd name="connsiteY3" fmla="*/ 64216 h 766412"/>
                      <a:gd name="connsiteX4" fmla="*/ 538229 w 577756"/>
                      <a:gd name="connsiteY4" fmla="*/ 179307 h 766412"/>
                      <a:gd name="connsiteX5" fmla="*/ 576443 w 577756"/>
                      <a:gd name="connsiteY5" fmla="*/ 368530 h 766412"/>
                      <a:gd name="connsiteX6" fmla="*/ 492985 w 577756"/>
                      <a:gd name="connsiteY6" fmla="*/ 634919 h 766412"/>
                      <a:gd name="connsiteX7" fmla="*/ 276111 w 577756"/>
                      <a:gd name="connsiteY7" fmla="*/ 766412 h 766412"/>
                      <a:gd name="connsiteX8" fmla="*/ 77379 w 577756"/>
                      <a:gd name="connsiteY8" fmla="*/ 747362 h 766412"/>
                      <a:gd name="connsiteX9" fmla="*/ 3243 w 577756"/>
                      <a:gd name="connsiteY9" fmla="*/ 578559 h 766412"/>
                      <a:gd name="connsiteX10" fmla="*/ 4036 w 577756"/>
                      <a:gd name="connsiteY10" fmla="*/ 196769 h 766412"/>
                      <a:gd name="connsiteX11" fmla="*/ 44834 w 577756"/>
                      <a:gd name="connsiteY11" fmla="*/ 79401 h 766412"/>
                      <a:gd name="connsiteX0" fmla="*/ 44834 w 577756"/>
                      <a:gd name="connsiteY0" fmla="*/ 65900 h 752911"/>
                      <a:gd name="connsiteX1" fmla="*/ 104842 w 577756"/>
                      <a:gd name="connsiteY1" fmla="*/ 10226 h 752911"/>
                      <a:gd name="connsiteX2" fmla="*/ 240392 w 577756"/>
                      <a:gd name="connsiteY2" fmla="*/ 4773 h 752911"/>
                      <a:gd name="connsiteX3" fmla="*/ 430279 w 577756"/>
                      <a:gd name="connsiteY3" fmla="*/ 50715 h 752911"/>
                      <a:gd name="connsiteX4" fmla="*/ 538229 w 577756"/>
                      <a:gd name="connsiteY4" fmla="*/ 165806 h 752911"/>
                      <a:gd name="connsiteX5" fmla="*/ 576443 w 577756"/>
                      <a:gd name="connsiteY5" fmla="*/ 355029 h 752911"/>
                      <a:gd name="connsiteX6" fmla="*/ 492985 w 577756"/>
                      <a:gd name="connsiteY6" fmla="*/ 621418 h 752911"/>
                      <a:gd name="connsiteX7" fmla="*/ 276111 w 577756"/>
                      <a:gd name="connsiteY7" fmla="*/ 752911 h 752911"/>
                      <a:gd name="connsiteX8" fmla="*/ 77379 w 577756"/>
                      <a:gd name="connsiteY8" fmla="*/ 733861 h 752911"/>
                      <a:gd name="connsiteX9" fmla="*/ 3243 w 577756"/>
                      <a:gd name="connsiteY9" fmla="*/ 565058 h 752911"/>
                      <a:gd name="connsiteX10" fmla="*/ 4036 w 577756"/>
                      <a:gd name="connsiteY10" fmla="*/ 183268 h 752911"/>
                      <a:gd name="connsiteX11" fmla="*/ 44834 w 577756"/>
                      <a:gd name="connsiteY11" fmla="*/ 65900 h 752911"/>
                      <a:gd name="connsiteX0" fmla="*/ 44834 w 577756"/>
                      <a:gd name="connsiteY0" fmla="*/ 62406 h 749417"/>
                      <a:gd name="connsiteX1" fmla="*/ 107223 w 577756"/>
                      <a:gd name="connsiteY1" fmla="*/ 18642 h 749417"/>
                      <a:gd name="connsiteX2" fmla="*/ 240392 w 577756"/>
                      <a:gd name="connsiteY2" fmla="*/ 1279 h 749417"/>
                      <a:gd name="connsiteX3" fmla="*/ 430279 w 577756"/>
                      <a:gd name="connsiteY3" fmla="*/ 47221 h 749417"/>
                      <a:gd name="connsiteX4" fmla="*/ 538229 w 577756"/>
                      <a:gd name="connsiteY4" fmla="*/ 162312 h 749417"/>
                      <a:gd name="connsiteX5" fmla="*/ 576443 w 577756"/>
                      <a:gd name="connsiteY5" fmla="*/ 351535 h 749417"/>
                      <a:gd name="connsiteX6" fmla="*/ 492985 w 577756"/>
                      <a:gd name="connsiteY6" fmla="*/ 617924 h 749417"/>
                      <a:gd name="connsiteX7" fmla="*/ 276111 w 577756"/>
                      <a:gd name="connsiteY7" fmla="*/ 749417 h 749417"/>
                      <a:gd name="connsiteX8" fmla="*/ 77379 w 577756"/>
                      <a:gd name="connsiteY8" fmla="*/ 730367 h 749417"/>
                      <a:gd name="connsiteX9" fmla="*/ 3243 w 577756"/>
                      <a:gd name="connsiteY9" fmla="*/ 561564 h 749417"/>
                      <a:gd name="connsiteX10" fmla="*/ 4036 w 577756"/>
                      <a:gd name="connsiteY10" fmla="*/ 179774 h 749417"/>
                      <a:gd name="connsiteX11" fmla="*/ 44834 w 577756"/>
                      <a:gd name="connsiteY11" fmla="*/ 62406 h 749417"/>
                      <a:gd name="connsiteX0" fmla="*/ 44834 w 577338"/>
                      <a:gd name="connsiteY0" fmla="*/ 62406 h 749417"/>
                      <a:gd name="connsiteX1" fmla="*/ 107223 w 577338"/>
                      <a:gd name="connsiteY1" fmla="*/ 18642 h 749417"/>
                      <a:gd name="connsiteX2" fmla="*/ 240392 w 577338"/>
                      <a:gd name="connsiteY2" fmla="*/ 1279 h 749417"/>
                      <a:gd name="connsiteX3" fmla="*/ 430279 w 577338"/>
                      <a:gd name="connsiteY3" fmla="*/ 47221 h 749417"/>
                      <a:gd name="connsiteX4" fmla="*/ 538229 w 577338"/>
                      <a:gd name="connsiteY4" fmla="*/ 162312 h 749417"/>
                      <a:gd name="connsiteX5" fmla="*/ 576443 w 577338"/>
                      <a:gd name="connsiteY5" fmla="*/ 351535 h 749417"/>
                      <a:gd name="connsiteX6" fmla="*/ 502510 w 577338"/>
                      <a:gd name="connsiteY6" fmla="*/ 617927 h 749417"/>
                      <a:gd name="connsiteX7" fmla="*/ 276111 w 577338"/>
                      <a:gd name="connsiteY7" fmla="*/ 749417 h 749417"/>
                      <a:gd name="connsiteX8" fmla="*/ 77379 w 577338"/>
                      <a:gd name="connsiteY8" fmla="*/ 730367 h 749417"/>
                      <a:gd name="connsiteX9" fmla="*/ 3243 w 577338"/>
                      <a:gd name="connsiteY9" fmla="*/ 561564 h 749417"/>
                      <a:gd name="connsiteX10" fmla="*/ 4036 w 577338"/>
                      <a:gd name="connsiteY10" fmla="*/ 179774 h 749417"/>
                      <a:gd name="connsiteX11" fmla="*/ 44834 w 577338"/>
                      <a:gd name="connsiteY11" fmla="*/ 62406 h 749417"/>
                      <a:gd name="connsiteX0" fmla="*/ 44834 w 577338"/>
                      <a:gd name="connsiteY0" fmla="*/ 62406 h 749417"/>
                      <a:gd name="connsiteX1" fmla="*/ 107223 w 577338"/>
                      <a:gd name="connsiteY1" fmla="*/ 18642 h 749417"/>
                      <a:gd name="connsiteX2" fmla="*/ 240392 w 577338"/>
                      <a:gd name="connsiteY2" fmla="*/ 1279 h 749417"/>
                      <a:gd name="connsiteX3" fmla="*/ 430279 w 577338"/>
                      <a:gd name="connsiteY3" fmla="*/ 47221 h 749417"/>
                      <a:gd name="connsiteX4" fmla="*/ 538229 w 577338"/>
                      <a:gd name="connsiteY4" fmla="*/ 162312 h 749417"/>
                      <a:gd name="connsiteX5" fmla="*/ 576443 w 577338"/>
                      <a:gd name="connsiteY5" fmla="*/ 351535 h 749417"/>
                      <a:gd name="connsiteX6" fmla="*/ 502510 w 577338"/>
                      <a:gd name="connsiteY6" fmla="*/ 617927 h 749417"/>
                      <a:gd name="connsiteX7" fmla="*/ 385827 w 577338"/>
                      <a:gd name="connsiteY7" fmla="*/ 709202 h 749417"/>
                      <a:gd name="connsiteX8" fmla="*/ 276111 w 577338"/>
                      <a:gd name="connsiteY8" fmla="*/ 749417 h 749417"/>
                      <a:gd name="connsiteX9" fmla="*/ 77379 w 577338"/>
                      <a:gd name="connsiteY9" fmla="*/ 730367 h 749417"/>
                      <a:gd name="connsiteX10" fmla="*/ 3243 w 577338"/>
                      <a:gd name="connsiteY10" fmla="*/ 561564 h 749417"/>
                      <a:gd name="connsiteX11" fmla="*/ 4036 w 577338"/>
                      <a:gd name="connsiteY11" fmla="*/ 179774 h 749417"/>
                      <a:gd name="connsiteX12" fmla="*/ 44834 w 577338"/>
                      <a:gd name="connsiteY12" fmla="*/ 62406 h 749417"/>
                      <a:gd name="connsiteX0" fmla="*/ 44834 w 576847"/>
                      <a:gd name="connsiteY0" fmla="*/ 62406 h 749417"/>
                      <a:gd name="connsiteX1" fmla="*/ 107223 w 576847"/>
                      <a:gd name="connsiteY1" fmla="*/ 18642 h 749417"/>
                      <a:gd name="connsiteX2" fmla="*/ 240392 w 576847"/>
                      <a:gd name="connsiteY2" fmla="*/ 1279 h 749417"/>
                      <a:gd name="connsiteX3" fmla="*/ 430279 w 576847"/>
                      <a:gd name="connsiteY3" fmla="*/ 47221 h 749417"/>
                      <a:gd name="connsiteX4" fmla="*/ 538229 w 576847"/>
                      <a:gd name="connsiteY4" fmla="*/ 162312 h 749417"/>
                      <a:gd name="connsiteX5" fmla="*/ 576443 w 576847"/>
                      <a:gd name="connsiteY5" fmla="*/ 351535 h 749417"/>
                      <a:gd name="connsiteX6" fmla="*/ 554899 w 576847"/>
                      <a:gd name="connsiteY6" fmla="*/ 497271 h 749417"/>
                      <a:gd name="connsiteX7" fmla="*/ 502510 w 576847"/>
                      <a:gd name="connsiteY7" fmla="*/ 617927 h 749417"/>
                      <a:gd name="connsiteX8" fmla="*/ 385827 w 576847"/>
                      <a:gd name="connsiteY8" fmla="*/ 709202 h 749417"/>
                      <a:gd name="connsiteX9" fmla="*/ 276111 w 576847"/>
                      <a:gd name="connsiteY9" fmla="*/ 749417 h 749417"/>
                      <a:gd name="connsiteX10" fmla="*/ 77379 w 576847"/>
                      <a:gd name="connsiteY10" fmla="*/ 730367 h 749417"/>
                      <a:gd name="connsiteX11" fmla="*/ 3243 w 576847"/>
                      <a:gd name="connsiteY11" fmla="*/ 561564 h 749417"/>
                      <a:gd name="connsiteX12" fmla="*/ 4036 w 576847"/>
                      <a:gd name="connsiteY12" fmla="*/ 179774 h 749417"/>
                      <a:gd name="connsiteX13" fmla="*/ 44834 w 576847"/>
                      <a:gd name="connsiteY13" fmla="*/ 62406 h 749417"/>
                      <a:gd name="connsiteX0" fmla="*/ 44834 w 576847"/>
                      <a:gd name="connsiteY0" fmla="*/ 62406 h 749417"/>
                      <a:gd name="connsiteX1" fmla="*/ 107223 w 576847"/>
                      <a:gd name="connsiteY1" fmla="*/ 18642 h 749417"/>
                      <a:gd name="connsiteX2" fmla="*/ 240392 w 576847"/>
                      <a:gd name="connsiteY2" fmla="*/ 1279 h 749417"/>
                      <a:gd name="connsiteX3" fmla="*/ 430279 w 576847"/>
                      <a:gd name="connsiteY3" fmla="*/ 47221 h 749417"/>
                      <a:gd name="connsiteX4" fmla="*/ 538229 w 576847"/>
                      <a:gd name="connsiteY4" fmla="*/ 162312 h 749417"/>
                      <a:gd name="connsiteX5" fmla="*/ 576443 w 576847"/>
                      <a:gd name="connsiteY5" fmla="*/ 351535 h 749417"/>
                      <a:gd name="connsiteX6" fmla="*/ 554899 w 576847"/>
                      <a:gd name="connsiteY6" fmla="*/ 497271 h 749417"/>
                      <a:gd name="connsiteX7" fmla="*/ 502510 w 576847"/>
                      <a:gd name="connsiteY7" fmla="*/ 617927 h 749417"/>
                      <a:gd name="connsiteX8" fmla="*/ 385827 w 576847"/>
                      <a:gd name="connsiteY8" fmla="*/ 709202 h 749417"/>
                      <a:gd name="connsiteX9" fmla="*/ 276111 w 576847"/>
                      <a:gd name="connsiteY9" fmla="*/ 749417 h 749417"/>
                      <a:gd name="connsiteX10" fmla="*/ 161993 w 576847"/>
                      <a:gd name="connsiteY10" fmla="*/ 709199 h 749417"/>
                      <a:gd name="connsiteX11" fmla="*/ 77379 w 576847"/>
                      <a:gd name="connsiteY11" fmla="*/ 730367 h 749417"/>
                      <a:gd name="connsiteX12" fmla="*/ 3243 w 576847"/>
                      <a:gd name="connsiteY12" fmla="*/ 561564 h 749417"/>
                      <a:gd name="connsiteX13" fmla="*/ 4036 w 576847"/>
                      <a:gd name="connsiteY13" fmla="*/ 179774 h 749417"/>
                      <a:gd name="connsiteX14" fmla="*/ 44834 w 576847"/>
                      <a:gd name="connsiteY14" fmla="*/ 62406 h 749417"/>
                      <a:gd name="connsiteX0" fmla="*/ 44834 w 576847"/>
                      <a:gd name="connsiteY0" fmla="*/ 62406 h 730367"/>
                      <a:gd name="connsiteX1" fmla="*/ 107223 w 576847"/>
                      <a:gd name="connsiteY1" fmla="*/ 18642 h 730367"/>
                      <a:gd name="connsiteX2" fmla="*/ 240392 w 576847"/>
                      <a:gd name="connsiteY2" fmla="*/ 1279 h 730367"/>
                      <a:gd name="connsiteX3" fmla="*/ 430279 w 576847"/>
                      <a:gd name="connsiteY3" fmla="*/ 47221 h 730367"/>
                      <a:gd name="connsiteX4" fmla="*/ 538229 w 576847"/>
                      <a:gd name="connsiteY4" fmla="*/ 162312 h 730367"/>
                      <a:gd name="connsiteX5" fmla="*/ 576443 w 576847"/>
                      <a:gd name="connsiteY5" fmla="*/ 351535 h 730367"/>
                      <a:gd name="connsiteX6" fmla="*/ 554899 w 576847"/>
                      <a:gd name="connsiteY6" fmla="*/ 497271 h 730367"/>
                      <a:gd name="connsiteX7" fmla="*/ 502510 w 576847"/>
                      <a:gd name="connsiteY7" fmla="*/ 617927 h 730367"/>
                      <a:gd name="connsiteX8" fmla="*/ 385827 w 576847"/>
                      <a:gd name="connsiteY8" fmla="*/ 709202 h 730367"/>
                      <a:gd name="connsiteX9" fmla="*/ 278493 w 576847"/>
                      <a:gd name="connsiteY9" fmla="*/ 723224 h 730367"/>
                      <a:gd name="connsiteX10" fmla="*/ 161993 w 576847"/>
                      <a:gd name="connsiteY10" fmla="*/ 709199 h 730367"/>
                      <a:gd name="connsiteX11" fmla="*/ 77379 w 576847"/>
                      <a:gd name="connsiteY11" fmla="*/ 730367 h 730367"/>
                      <a:gd name="connsiteX12" fmla="*/ 3243 w 576847"/>
                      <a:gd name="connsiteY12" fmla="*/ 561564 h 730367"/>
                      <a:gd name="connsiteX13" fmla="*/ 4036 w 576847"/>
                      <a:gd name="connsiteY13" fmla="*/ 179774 h 730367"/>
                      <a:gd name="connsiteX14" fmla="*/ 44834 w 576847"/>
                      <a:gd name="connsiteY14" fmla="*/ 62406 h 730367"/>
                      <a:gd name="connsiteX0" fmla="*/ 44834 w 576847"/>
                      <a:gd name="connsiteY0" fmla="*/ 62406 h 723224"/>
                      <a:gd name="connsiteX1" fmla="*/ 107223 w 576847"/>
                      <a:gd name="connsiteY1" fmla="*/ 18642 h 723224"/>
                      <a:gd name="connsiteX2" fmla="*/ 240392 w 576847"/>
                      <a:gd name="connsiteY2" fmla="*/ 1279 h 723224"/>
                      <a:gd name="connsiteX3" fmla="*/ 430279 w 576847"/>
                      <a:gd name="connsiteY3" fmla="*/ 47221 h 723224"/>
                      <a:gd name="connsiteX4" fmla="*/ 538229 w 576847"/>
                      <a:gd name="connsiteY4" fmla="*/ 162312 h 723224"/>
                      <a:gd name="connsiteX5" fmla="*/ 576443 w 576847"/>
                      <a:gd name="connsiteY5" fmla="*/ 351535 h 723224"/>
                      <a:gd name="connsiteX6" fmla="*/ 554899 w 576847"/>
                      <a:gd name="connsiteY6" fmla="*/ 497271 h 723224"/>
                      <a:gd name="connsiteX7" fmla="*/ 502510 w 576847"/>
                      <a:gd name="connsiteY7" fmla="*/ 617927 h 723224"/>
                      <a:gd name="connsiteX8" fmla="*/ 385827 w 576847"/>
                      <a:gd name="connsiteY8" fmla="*/ 709202 h 723224"/>
                      <a:gd name="connsiteX9" fmla="*/ 278493 w 576847"/>
                      <a:gd name="connsiteY9" fmla="*/ 723224 h 723224"/>
                      <a:gd name="connsiteX10" fmla="*/ 161993 w 576847"/>
                      <a:gd name="connsiteY10" fmla="*/ 709199 h 723224"/>
                      <a:gd name="connsiteX11" fmla="*/ 65473 w 576847"/>
                      <a:gd name="connsiteY11" fmla="*/ 680361 h 723224"/>
                      <a:gd name="connsiteX12" fmla="*/ 3243 w 576847"/>
                      <a:gd name="connsiteY12" fmla="*/ 561564 h 723224"/>
                      <a:gd name="connsiteX13" fmla="*/ 4036 w 576847"/>
                      <a:gd name="connsiteY13" fmla="*/ 179774 h 723224"/>
                      <a:gd name="connsiteX14" fmla="*/ 44834 w 576847"/>
                      <a:gd name="connsiteY14" fmla="*/ 62406 h 723224"/>
                      <a:gd name="connsiteX0" fmla="*/ 41078 w 573091"/>
                      <a:gd name="connsiteY0" fmla="*/ 62406 h 723224"/>
                      <a:gd name="connsiteX1" fmla="*/ 103467 w 573091"/>
                      <a:gd name="connsiteY1" fmla="*/ 18642 h 723224"/>
                      <a:gd name="connsiteX2" fmla="*/ 236636 w 573091"/>
                      <a:gd name="connsiteY2" fmla="*/ 1279 h 723224"/>
                      <a:gd name="connsiteX3" fmla="*/ 426523 w 573091"/>
                      <a:gd name="connsiteY3" fmla="*/ 47221 h 723224"/>
                      <a:gd name="connsiteX4" fmla="*/ 534473 w 573091"/>
                      <a:gd name="connsiteY4" fmla="*/ 162312 h 723224"/>
                      <a:gd name="connsiteX5" fmla="*/ 572687 w 573091"/>
                      <a:gd name="connsiteY5" fmla="*/ 351535 h 723224"/>
                      <a:gd name="connsiteX6" fmla="*/ 551143 w 573091"/>
                      <a:gd name="connsiteY6" fmla="*/ 497271 h 723224"/>
                      <a:gd name="connsiteX7" fmla="*/ 498754 w 573091"/>
                      <a:gd name="connsiteY7" fmla="*/ 617927 h 723224"/>
                      <a:gd name="connsiteX8" fmla="*/ 382071 w 573091"/>
                      <a:gd name="connsiteY8" fmla="*/ 709202 h 723224"/>
                      <a:gd name="connsiteX9" fmla="*/ 274737 w 573091"/>
                      <a:gd name="connsiteY9" fmla="*/ 723224 h 723224"/>
                      <a:gd name="connsiteX10" fmla="*/ 158237 w 573091"/>
                      <a:gd name="connsiteY10" fmla="*/ 709199 h 723224"/>
                      <a:gd name="connsiteX11" fmla="*/ 61717 w 573091"/>
                      <a:gd name="connsiteY11" fmla="*/ 680361 h 723224"/>
                      <a:gd name="connsiteX12" fmla="*/ 11393 w 573091"/>
                      <a:gd name="connsiteY12" fmla="*/ 554423 h 723224"/>
                      <a:gd name="connsiteX13" fmla="*/ 280 w 573091"/>
                      <a:gd name="connsiteY13" fmla="*/ 179774 h 723224"/>
                      <a:gd name="connsiteX14" fmla="*/ 41078 w 573091"/>
                      <a:gd name="connsiteY14" fmla="*/ 62406 h 723224"/>
                      <a:gd name="connsiteX0" fmla="*/ 43044 w 575057"/>
                      <a:gd name="connsiteY0" fmla="*/ 62406 h 723224"/>
                      <a:gd name="connsiteX1" fmla="*/ 105433 w 575057"/>
                      <a:gd name="connsiteY1" fmla="*/ 18642 h 723224"/>
                      <a:gd name="connsiteX2" fmla="*/ 238602 w 575057"/>
                      <a:gd name="connsiteY2" fmla="*/ 1279 h 723224"/>
                      <a:gd name="connsiteX3" fmla="*/ 428489 w 575057"/>
                      <a:gd name="connsiteY3" fmla="*/ 47221 h 723224"/>
                      <a:gd name="connsiteX4" fmla="*/ 536439 w 575057"/>
                      <a:gd name="connsiteY4" fmla="*/ 162312 h 723224"/>
                      <a:gd name="connsiteX5" fmla="*/ 574653 w 575057"/>
                      <a:gd name="connsiteY5" fmla="*/ 351535 h 723224"/>
                      <a:gd name="connsiteX6" fmla="*/ 553109 w 575057"/>
                      <a:gd name="connsiteY6" fmla="*/ 497271 h 723224"/>
                      <a:gd name="connsiteX7" fmla="*/ 500720 w 575057"/>
                      <a:gd name="connsiteY7" fmla="*/ 617927 h 723224"/>
                      <a:gd name="connsiteX8" fmla="*/ 384037 w 575057"/>
                      <a:gd name="connsiteY8" fmla="*/ 709202 h 723224"/>
                      <a:gd name="connsiteX9" fmla="*/ 276703 w 575057"/>
                      <a:gd name="connsiteY9" fmla="*/ 723224 h 723224"/>
                      <a:gd name="connsiteX10" fmla="*/ 160203 w 575057"/>
                      <a:gd name="connsiteY10" fmla="*/ 709199 h 723224"/>
                      <a:gd name="connsiteX11" fmla="*/ 63683 w 575057"/>
                      <a:gd name="connsiteY11" fmla="*/ 680361 h 723224"/>
                      <a:gd name="connsiteX12" fmla="*/ 13359 w 575057"/>
                      <a:gd name="connsiteY12" fmla="*/ 554423 h 723224"/>
                      <a:gd name="connsiteX13" fmla="*/ 2246 w 575057"/>
                      <a:gd name="connsiteY13" fmla="*/ 179774 h 723224"/>
                      <a:gd name="connsiteX14" fmla="*/ 43044 w 575057"/>
                      <a:gd name="connsiteY14" fmla="*/ 62406 h 723224"/>
                      <a:gd name="connsiteX0" fmla="*/ 46838 w 578851"/>
                      <a:gd name="connsiteY0" fmla="*/ 62406 h 723224"/>
                      <a:gd name="connsiteX1" fmla="*/ 109227 w 578851"/>
                      <a:gd name="connsiteY1" fmla="*/ 18642 h 723224"/>
                      <a:gd name="connsiteX2" fmla="*/ 242396 w 578851"/>
                      <a:gd name="connsiteY2" fmla="*/ 1279 h 723224"/>
                      <a:gd name="connsiteX3" fmla="*/ 432283 w 578851"/>
                      <a:gd name="connsiteY3" fmla="*/ 47221 h 723224"/>
                      <a:gd name="connsiteX4" fmla="*/ 540233 w 578851"/>
                      <a:gd name="connsiteY4" fmla="*/ 162312 h 723224"/>
                      <a:gd name="connsiteX5" fmla="*/ 578447 w 578851"/>
                      <a:gd name="connsiteY5" fmla="*/ 351535 h 723224"/>
                      <a:gd name="connsiteX6" fmla="*/ 556903 w 578851"/>
                      <a:gd name="connsiteY6" fmla="*/ 497271 h 723224"/>
                      <a:gd name="connsiteX7" fmla="*/ 504514 w 578851"/>
                      <a:gd name="connsiteY7" fmla="*/ 617927 h 723224"/>
                      <a:gd name="connsiteX8" fmla="*/ 387831 w 578851"/>
                      <a:gd name="connsiteY8" fmla="*/ 709202 h 723224"/>
                      <a:gd name="connsiteX9" fmla="*/ 280497 w 578851"/>
                      <a:gd name="connsiteY9" fmla="*/ 723224 h 723224"/>
                      <a:gd name="connsiteX10" fmla="*/ 163997 w 578851"/>
                      <a:gd name="connsiteY10" fmla="*/ 709199 h 723224"/>
                      <a:gd name="connsiteX11" fmla="*/ 67477 w 578851"/>
                      <a:gd name="connsiteY11" fmla="*/ 680361 h 723224"/>
                      <a:gd name="connsiteX12" fmla="*/ 10009 w 578851"/>
                      <a:gd name="connsiteY12" fmla="*/ 554426 h 723224"/>
                      <a:gd name="connsiteX13" fmla="*/ 6040 w 578851"/>
                      <a:gd name="connsiteY13" fmla="*/ 179774 h 723224"/>
                      <a:gd name="connsiteX14" fmla="*/ 46838 w 578851"/>
                      <a:gd name="connsiteY14" fmla="*/ 62406 h 723224"/>
                      <a:gd name="connsiteX0" fmla="*/ 46838 w 813420"/>
                      <a:gd name="connsiteY0" fmla="*/ 62406 h 723224"/>
                      <a:gd name="connsiteX1" fmla="*/ 109227 w 813420"/>
                      <a:gd name="connsiteY1" fmla="*/ 18642 h 723224"/>
                      <a:gd name="connsiteX2" fmla="*/ 242396 w 813420"/>
                      <a:gd name="connsiteY2" fmla="*/ 1279 h 723224"/>
                      <a:gd name="connsiteX3" fmla="*/ 432283 w 813420"/>
                      <a:gd name="connsiteY3" fmla="*/ 47221 h 723224"/>
                      <a:gd name="connsiteX4" fmla="*/ 540233 w 813420"/>
                      <a:gd name="connsiteY4" fmla="*/ 162312 h 723224"/>
                      <a:gd name="connsiteX5" fmla="*/ 813397 w 813420"/>
                      <a:gd name="connsiteY5" fmla="*/ 380110 h 723224"/>
                      <a:gd name="connsiteX6" fmla="*/ 556903 w 813420"/>
                      <a:gd name="connsiteY6" fmla="*/ 497271 h 723224"/>
                      <a:gd name="connsiteX7" fmla="*/ 504514 w 813420"/>
                      <a:gd name="connsiteY7" fmla="*/ 617927 h 723224"/>
                      <a:gd name="connsiteX8" fmla="*/ 387831 w 813420"/>
                      <a:gd name="connsiteY8" fmla="*/ 709202 h 723224"/>
                      <a:gd name="connsiteX9" fmla="*/ 280497 w 813420"/>
                      <a:gd name="connsiteY9" fmla="*/ 723224 h 723224"/>
                      <a:gd name="connsiteX10" fmla="*/ 163997 w 813420"/>
                      <a:gd name="connsiteY10" fmla="*/ 709199 h 723224"/>
                      <a:gd name="connsiteX11" fmla="*/ 67477 w 813420"/>
                      <a:gd name="connsiteY11" fmla="*/ 680361 h 723224"/>
                      <a:gd name="connsiteX12" fmla="*/ 10009 w 813420"/>
                      <a:gd name="connsiteY12" fmla="*/ 554426 h 723224"/>
                      <a:gd name="connsiteX13" fmla="*/ 6040 w 813420"/>
                      <a:gd name="connsiteY13" fmla="*/ 179774 h 723224"/>
                      <a:gd name="connsiteX14" fmla="*/ 46838 w 813420"/>
                      <a:gd name="connsiteY14" fmla="*/ 62406 h 723224"/>
                      <a:gd name="connsiteX0" fmla="*/ 46838 w 794372"/>
                      <a:gd name="connsiteY0" fmla="*/ 62406 h 723224"/>
                      <a:gd name="connsiteX1" fmla="*/ 109227 w 794372"/>
                      <a:gd name="connsiteY1" fmla="*/ 18642 h 723224"/>
                      <a:gd name="connsiteX2" fmla="*/ 242396 w 794372"/>
                      <a:gd name="connsiteY2" fmla="*/ 1279 h 723224"/>
                      <a:gd name="connsiteX3" fmla="*/ 432283 w 794372"/>
                      <a:gd name="connsiteY3" fmla="*/ 47221 h 723224"/>
                      <a:gd name="connsiteX4" fmla="*/ 540233 w 794372"/>
                      <a:gd name="connsiteY4" fmla="*/ 162312 h 723224"/>
                      <a:gd name="connsiteX5" fmla="*/ 794347 w 794372"/>
                      <a:gd name="connsiteY5" fmla="*/ 237235 h 723224"/>
                      <a:gd name="connsiteX6" fmla="*/ 556903 w 794372"/>
                      <a:gd name="connsiteY6" fmla="*/ 497271 h 723224"/>
                      <a:gd name="connsiteX7" fmla="*/ 504514 w 794372"/>
                      <a:gd name="connsiteY7" fmla="*/ 617927 h 723224"/>
                      <a:gd name="connsiteX8" fmla="*/ 387831 w 794372"/>
                      <a:gd name="connsiteY8" fmla="*/ 709202 h 723224"/>
                      <a:gd name="connsiteX9" fmla="*/ 280497 w 794372"/>
                      <a:gd name="connsiteY9" fmla="*/ 723224 h 723224"/>
                      <a:gd name="connsiteX10" fmla="*/ 163997 w 794372"/>
                      <a:gd name="connsiteY10" fmla="*/ 709199 h 723224"/>
                      <a:gd name="connsiteX11" fmla="*/ 67477 w 794372"/>
                      <a:gd name="connsiteY11" fmla="*/ 680361 h 723224"/>
                      <a:gd name="connsiteX12" fmla="*/ 10009 w 794372"/>
                      <a:gd name="connsiteY12" fmla="*/ 554426 h 723224"/>
                      <a:gd name="connsiteX13" fmla="*/ 6040 w 794372"/>
                      <a:gd name="connsiteY13" fmla="*/ 179774 h 723224"/>
                      <a:gd name="connsiteX14" fmla="*/ 46838 w 794372"/>
                      <a:gd name="connsiteY14" fmla="*/ 62406 h 723224"/>
                      <a:gd name="connsiteX0" fmla="*/ 46838 w 718184"/>
                      <a:gd name="connsiteY0" fmla="*/ 62406 h 723224"/>
                      <a:gd name="connsiteX1" fmla="*/ 109227 w 718184"/>
                      <a:gd name="connsiteY1" fmla="*/ 18642 h 723224"/>
                      <a:gd name="connsiteX2" fmla="*/ 242396 w 718184"/>
                      <a:gd name="connsiteY2" fmla="*/ 1279 h 723224"/>
                      <a:gd name="connsiteX3" fmla="*/ 432283 w 718184"/>
                      <a:gd name="connsiteY3" fmla="*/ 47221 h 723224"/>
                      <a:gd name="connsiteX4" fmla="*/ 540233 w 718184"/>
                      <a:gd name="connsiteY4" fmla="*/ 162312 h 723224"/>
                      <a:gd name="connsiteX5" fmla="*/ 718147 w 718184"/>
                      <a:gd name="connsiteY5" fmla="*/ 345185 h 723224"/>
                      <a:gd name="connsiteX6" fmla="*/ 556903 w 718184"/>
                      <a:gd name="connsiteY6" fmla="*/ 497271 h 723224"/>
                      <a:gd name="connsiteX7" fmla="*/ 504514 w 718184"/>
                      <a:gd name="connsiteY7" fmla="*/ 617927 h 723224"/>
                      <a:gd name="connsiteX8" fmla="*/ 387831 w 718184"/>
                      <a:gd name="connsiteY8" fmla="*/ 709202 h 723224"/>
                      <a:gd name="connsiteX9" fmla="*/ 280497 w 718184"/>
                      <a:gd name="connsiteY9" fmla="*/ 723224 h 723224"/>
                      <a:gd name="connsiteX10" fmla="*/ 163997 w 718184"/>
                      <a:gd name="connsiteY10" fmla="*/ 709199 h 723224"/>
                      <a:gd name="connsiteX11" fmla="*/ 67477 w 718184"/>
                      <a:gd name="connsiteY11" fmla="*/ 680361 h 723224"/>
                      <a:gd name="connsiteX12" fmla="*/ 10009 w 718184"/>
                      <a:gd name="connsiteY12" fmla="*/ 554426 h 723224"/>
                      <a:gd name="connsiteX13" fmla="*/ 6040 w 718184"/>
                      <a:gd name="connsiteY13" fmla="*/ 179774 h 723224"/>
                      <a:gd name="connsiteX14" fmla="*/ 46838 w 718184"/>
                      <a:gd name="connsiteY14" fmla="*/ 62406 h 723224"/>
                      <a:gd name="connsiteX0" fmla="*/ 46838 w 718410"/>
                      <a:gd name="connsiteY0" fmla="*/ 62406 h 723224"/>
                      <a:gd name="connsiteX1" fmla="*/ 109227 w 718410"/>
                      <a:gd name="connsiteY1" fmla="*/ 18642 h 723224"/>
                      <a:gd name="connsiteX2" fmla="*/ 242396 w 718410"/>
                      <a:gd name="connsiteY2" fmla="*/ 1279 h 723224"/>
                      <a:gd name="connsiteX3" fmla="*/ 432283 w 718410"/>
                      <a:gd name="connsiteY3" fmla="*/ 47221 h 723224"/>
                      <a:gd name="connsiteX4" fmla="*/ 511658 w 718410"/>
                      <a:gd name="connsiteY4" fmla="*/ 184537 h 723224"/>
                      <a:gd name="connsiteX5" fmla="*/ 718147 w 718410"/>
                      <a:gd name="connsiteY5" fmla="*/ 345185 h 723224"/>
                      <a:gd name="connsiteX6" fmla="*/ 556903 w 718410"/>
                      <a:gd name="connsiteY6" fmla="*/ 497271 h 723224"/>
                      <a:gd name="connsiteX7" fmla="*/ 504514 w 718410"/>
                      <a:gd name="connsiteY7" fmla="*/ 617927 h 723224"/>
                      <a:gd name="connsiteX8" fmla="*/ 387831 w 718410"/>
                      <a:gd name="connsiteY8" fmla="*/ 709202 h 723224"/>
                      <a:gd name="connsiteX9" fmla="*/ 280497 w 718410"/>
                      <a:gd name="connsiteY9" fmla="*/ 723224 h 723224"/>
                      <a:gd name="connsiteX10" fmla="*/ 163997 w 718410"/>
                      <a:gd name="connsiteY10" fmla="*/ 709199 h 723224"/>
                      <a:gd name="connsiteX11" fmla="*/ 67477 w 718410"/>
                      <a:gd name="connsiteY11" fmla="*/ 680361 h 723224"/>
                      <a:gd name="connsiteX12" fmla="*/ 10009 w 718410"/>
                      <a:gd name="connsiteY12" fmla="*/ 554426 h 723224"/>
                      <a:gd name="connsiteX13" fmla="*/ 6040 w 718410"/>
                      <a:gd name="connsiteY13" fmla="*/ 179774 h 723224"/>
                      <a:gd name="connsiteX14" fmla="*/ 46838 w 718410"/>
                      <a:gd name="connsiteY14" fmla="*/ 62406 h 723224"/>
                      <a:gd name="connsiteX0" fmla="*/ 46838 w 718410"/>
                      <a:gd name="connsiteY0" fmla="*/ 70140 h 730958"/>
                      <a:gd name="connsiteX1" fmla="*/ 109227 w 718410"/>
                      <a:gd name="connsiteY1" fmla="*/ 26376 h 730958"/>
                      <a:gd name="connsiteX2" fmla="*/ 242396 w 718410"/>
                      <a:gd name="connsiteY2" fmla="*/ 9013 h 730958"/>
                      <a:gd name="connsiteX3" fmla="*/ 391008 w 718410"/>
                      <a:gd name="connsiteY3" fmla="*/ 166080 h 730958"/>
                      <a:gd name="connsiteX4" fmla="*/ 511658 w 718410"/>
                      <a:gd name="connsiteY4" fmla="*/ 192271 h 730958"/>
                      <a:gd name="connsiteX5" fmla="*/ 718147 w 718410"/>
                      <a:gd name="connsiteY5" fmla="*/ 352919 h 730958"/>
                      <a:gd name="connsiteX6" fmla="*/ 556903 w 718410"/>
                      <a:gd name="connsiteY6" fmla="*/ 505005 h 730958"/>
                      <a:gd name="connsiteX7" fmla="*/ 504514 w 718410"/>
                      <a:gd name="connsiteY7" fmla="*/ 625661 h 730958"/>
                      <a:gd name="connsiteX8" fmla="*/ 387831 w 718410"/>
                      <a:gd name="connsiteY8" fmla="*/ 716936 h 730958"/>
                      <a:gd name="connsiteX9" fmla="*/ 280497 w 718410"/>
                      <a:gd name="connsiteY9" fmla="*/ 730958 h 730958"/>
                      <a:gd name="connsiteX10" fmla="*/ 163997 w 718410"/>
                      <a:gd name="connsiteY10" fmla="*/ 716933 h 730958"/>
                      <a:gd name="connsiteX11" fmla="*/ 67477 w 718410"/>
                      <a:gd name="connsiteY11" fmla="*/ 688095 h 730958"/>
                      <a:gd name="connsiteX12" fmla="*/ 10009 w 718410"/>
                      <a:gd name="connsiteY12" fmla="*/ 562160 h 730958"/>
                      <a:gd name="connsiteX13" fmla="*/ 6040 w 718410"/>
                      <a:gd name="connsiteY13" fmla="*/ 187508 h 730958"/>
                      <a:gd name="connsiteX14" fmla="*/ 46838 w 718410"/>
                      <a:gd name="connsiteY14" fmla="*/ 70140 h 730958"/>
                      <a:gd name="connsiteX0" fmla="*/ 46838 w 718410"/>
                      <a:gd name="connsiteY0" fmla="*/ 48389 h 709207"/>
                      <a:gd name="connsiteX1" fmla="*/ 109227 w 718410"/>
                      <a:gd name="connsiteY1" fmla="*/ 4625 h 709207"/>
                      <a:gd name="connsiteX2" fmla="*/ 391008 w 718410"/>
                      <a:gd name="connsiteY2" fmla="*/ 144329 h 709207"/>
                      <a:gd name="connsiteX3" fmla="*/ 511658 w 718410"/>
                      <a:gd name="connsiteY3" fmla="*/ 170520 h 709207"/>
                      <a:gd name="connsiteX4" fmla="*/ 718147 w 718410"/>
                      <a:gd name="connsiteY4" fmla="*/ 331168 h 709207"/>
                      <a:gd name="connsiteX5" fmla="*/ 556903 w 718410"/>
                      <a:gd name="connsiteY5" fmla="*/ 483254 h 709207"/>
                      <a:gd name="connsiteX6" fmla="*/ 504514 w 718410"/>
                      <a:gd name="connsiteY6" fmla="*/ 603910 h 709207"/>
                      <a:gd name="connsiteX7" fmla="*/ 387831 w 718410"/>
                      <a:gd name="connsiteY7" fmla="*/ 695185 h 709207"/>
                      <a:gd name="connsiteX8" fmla="*/ 280497 w 718410"/>
                      <a:gd name="connsiteY8" fmla="*/ 709207 h 709207"/>
                      <a:gd name="connsiteX9" fmla="*/ 163997 w 718410"/>
                      <a:gd name="connsiteY9" fmla="*/ 695182 h 709207"/>
                      <a:gd name="connsiteX10" fmla="*/ 67477 w 718410"/>
                      <a:gd name="connsiteY10" fmla="*/ 666344 h 709207"/>
                      <a:gd name="connsiteX11" fmla="*/ 10009 w 718410"/>
                      <a:gd name="connsiteY11" fmla="*/ 540409 h 709207"/>
                      <a:gd name="connsiteX12" fmla="*/ 6040 w 718410"/>
                      <a:gd name="connsiteY12" fmla="*/ 165757 h 709207"/>
                      <a:gd name="connsiteX13" fmla="*/ 46838 w 718410"/>
                      <a:gd name="connsiteY13" fmla="*/ 48389 h 709207"/>
                      <a:gd name="connsiteX0" fmla="*/ 46838 w 718410"/>
                      <a:gd name="connsiteY0" fmla="*/ 118 h 660936"/>
                      <a:gd name="connsiteX1" fmla="*/ 391008 w 718410"/>
                      <a:gd name="connsiteY1" fmla="*/ 96058 h 660936"/>
                      <a:gd name="connsiteX2" fmla="*/ 511658 w 718410"/>
                      <a:gd name="connsiteY2" fmla="*/ 122249 h 660936"/>
                      <a:gd name="connsiteX3" fmla="*/ 718147 w 718410"/>
                      <a:gd name="connsiteY3" fmla="*/ 282897 h 660936"/>
                      <a:gd name="connsiteX4" fmla="*/ 556903 w 718410"/>
                      <a:gd name="connsiteY4" fmla="*/ 434983 h 660936"/>
                      <a:gd name="connsiteX5" fmla="*/ 504514 w 718410"/>
                      <a:gd name="connsiteY5" fmla="*/ 555639 h 660936"/>
                      <a:gd name="connsiteX6" fmla="*/ 387831 w 718410"/>
                      <a:gd name="connsiteY6" fmla="*/ 646914 h 660936"/>
                      <a:gd name="connsiteX7" fmla="*/ 280497 w 718410"/>
                      <a:gd name="connsiteY7" fmla="*/ 660936 h 660936"/>
                      <a:gd name="connsiteX8" fmla="*/ 163997 w 718410"/>
                      <a:gd name="connsiteY8" fmla="*/ 646911 h 660936"/>
                      <a:gd name="connsiteX9" fmla="*/ 67477 w 718410"/>
                      <a:gd name="connsiteY9" fmla="*/ 618073 h 660936"/>
                      <a:gd name="connsiteX10" fmla="*/ 10009 w 718410"/>
                      <a:gd name="connsiteY10" fmla="*/ 492138 h 660936"/>
                      <a:gd name="connsiteX11" fmla="*/ 6040 w 718410"/>
                      <a:gd name="connsiteY11" fmla="*/ 117486 h 660936"/>
                      <a:gd name="connsiteX12" fmla="*/ 46838 w 718410"/>
                      <a:gd name="connsiteY12" fmla="*/ 118 h 660936"/>
                      <a:gd name="connsiteX0" fmla="*/ 31621 w 743991"/>
                      <a:gd name="connsiteY0" fmla="*/ 36398 h 579848"/>
                      <a:gd name="connsiteX1" fmla="*/ 416589 w 743991"/>
                      <a:gd name="connsiteY1" fmla="*/ 14970 h 579848"/>
                      <a:gd name="connsiteX2" fmla="*/ 537239 w 743991"/>
                      <a:gd name="connsiteY2" fmla="*/ 41161 h 579848"/>
                      <a:gd name="connsiteX3" fmla="*/ 743728 w 743991"/>
                      <a:gd name="connsiteY3" fmla="*/ 201809 h 579848"/>
                      <a:gd name="connsiteX4" fmla="*/ 582484 w 743991"/>
                      <a:gd name="connsiteY4" fmla="*/ 353895 h 579848"/>
                      <a:gd name="connsiteX5" fmla="*/ 530095 w 743991"/>
                      <a:gd name="connsiteY5" fmla="*/ 474551 h 579848"/>
                      <a:gd name="connsiteX6" fmla="*/ 413412 w 743991"/>
                      <a:gd name="connsiteY6" fmla="*/ 565826 h 579848"/>
                      <a:gd name="connsiteX7" fmla="*/ 306078 w 743991"/>
                      <a:gd name="connsiteY7" fmla="*/ 579848 h 579848"/>
                      <a:gd name="connsiteX8" fmla="*/ 189578 w 743991"/>
                      <a:gd name="connsiteY8" fmla="*/ 565823 h 579848"/>
                      <a:gd name="connsiteX9" fmla="*/ 93058 w 743991"/>
                      <a:gd name="connsiteY9" fmla="*/ 536985 h 579848"/>
                      <a:gd name="connsiteX10" fmla="*/ 35590 w 743991"/>
                      <a:gd name="connsiteY10" fmla="*/ 411050 h 579848"/>
                      <a:gd name="connsiteX11" fmla="*/ 31621 w 743991"/>
                      <a:gd name="connsiteY11" fmla="*/ 36398 h 579848"/>
                      <a:gd name="connsiteX0" fmla="*/ 31621 w 743991"/>
                      <a:gd name="connsiteY0" fmla="*/ 36398 h 579848"/>
                      <a:gd name="connsiteX1" fmla="*/ 416589 w 743991"/>
                      <a:gd name="connsiteY1" fmla="*/ 14970 h 579848"/>
                      <a:gd name="connsiteX2" fmla="*/ 537239 w 743991"/>
                      <a:gd name="connsiteY2" fmla="*/ 41161 h 579848"/>
                      <a:gd name="connsiteX3" fmla="*/ 743728 w 743991"/>
                      <a:gd name="connsiteY3" fmla="*/ 201809 h 579848"/>
                      <a:gd name="connsiteX4" fmla="*/ 582484 w 743991"/>
                      <a:gd name="connsiteY4" fmla="*/ 353895 h 579848"/>
                      <a:gd name="connsiteX5" fmla="*/ 530095 w 743991"/>
                      <a:gd name="connsiteY5" fmla="*/ 474551 h 579848"/>
                      <a:gd name="connsiteX6" fmla="*/ 306078 w 743991"/>
                      <a:gd name="connsiteY6" fmla="*/ 579848 h 579848"/>
                      <a:gd name="connsiteX7" fmla="*/ 189578 w 743991"/>
                      <a:gd name="connsiteY7" fmla="*/ 565823 h 579848"/>
                      <a:gd name="connsiteX8" fmla="*/ 93058 w 743991"/>
                      <a:gd name="connsiteY8" fmla="*/ 536985 h 579848"/>
                      <a:gd name="connsiteX9" fmla="*/ 35590 w 743991"/>
                      <a:gd name="connsiteY9" fmla="*/ 411050 h 579848"/>
                      <a:gd name="connsiteX10" fmla="*/ 31621 w 743991"/>
                      <a:gd name="connsiteY10" fmla="*/ 36398 h 579848"/>
                      <a:gd name="connsiteX0" fmla="*/ 31621 w 743991"/>
                      <a:gd name="connsiteY0" fmla="*/ 36398 h 565823"/>
                      <a:gd name="connsiteX1" fmla="*/ 416589 w 743991"/>
                      <a:gd name="connsiteY1" fmla="*/ 14970 h 565823"/>
                      <a:gd name="connsiteX2" fmla="*/ 537239 w 743991"/>
                      <a:gd name="connsiteY2" fmla="*/ 41161 h 565823"/>
                      <a:gd name="connsiteX3" fmla="*/ 743728 w 743991"/>
                      <a:gd name="connsiteY3" fmla="*/ 201809 h 565823"/>
                      <a:gd name="connsiteX4" fmla="*/ 582484 w 743991"/>
                      <a:gd name="connsiteY4" fmla="*/ 353895 h 565823"/>
                      <a:gd name="connsiteX5" fmla="*/ 530095 w 743991"/>
                      <a:gd name="connsiteY5" fmla="*/ 474551 h 565823"/>
                      <a:gd name="connsiteX6" fmla="*/ 189578 w 743991"/>
                      <a:gd name="connsiteY6" fmla="*/ 565823 h 565823"/>
                      <a:gd name="connsiteX7" fmla="*/ 93058 w 743991"/>
                      <a:gd name="connsiteY7" fmla="*/ 536985 h 565823"/>
                      <a:gd name="connsiteX8" fmla="*/ 35590 w 743991"/>
                      <a:gd name="connsiteY8" fmla="*/ 411050 h 565823"/>
                      <a:gd name="connsiteX9" fmla="*/ 31621 w 743991"/>
                      <a:gd name="connsiteY9" fmla="*/ 36398 h 565823"/>
                      <a:gd name="connsiteX0" fmla="*/ 31621 w 743991"/>
                      <a:gd name="connsiteY0" fmla="*/ 36398 h 538638"/>
                      <a:gd name="connsiteX1" fmla="*/ 416589 w 743991"/>
                      <a:gd name="connsiteY1" fmla="*/ 14970 h 538638"/>
                      <a:gd name="connsiteX2" fmla="*/ 537239 w 743991"/>
                      <a:gd name="connsiteY2" fmla="*/ 41161 h 538638"/>
                      <a:gd name="connsiteX3" fmla="*/ 743728 w 743991"/>
                      <a:gd name="connsiteY3" fmla="*/ 201809 h 538638"/>
                      <a:gd name="connsiteX4" fmla="*/ 582484 w 743991"/>
                      <a:gd name="connsiteY4" fmla="*/ 353895 h 538638"/>
                      <a:gd name="connsiteX5" fmla="*/ 530095 w 743991"/>
                      <a:gd name="connsiteY5" fmla="*/ 474551 h 538638"/>
                      <a:gd name="connsiteX6" fmla="*/ 93058 w 743991"/>
                      <a:gd name="connsiteY6" fmla="*/ 536985 h 538638"/>
                      <a:gd name="connsiteX7" fmla="*/ 35590 w 743991"/>
                      <a:gd name="connsiteY7" fmla="*/ 411050 h 538638"/>
                      <a:gd name="connsiteX8" fmla="*/ 31621 w 743991"/>
                      <a:gd name="connsiteY8" fmla="*/ 36398 h 538638"/>
                      <a:gd name="connsiteX0" fmla="*/ 53068 w 765438"/>
                      <a:gd name="connsiteY0" fmla="*/ 36398 h 478935"/>
                      <a:gd name="connsiteX1" fmla="*/ 438036 w 765438"/>
                      <a:gd name="connsiteY1" fmla="*/ 14970 h 478935"/>
                      <a:gd name="connsiteX2" fmla="*/ 558686 w 765438"/>
                      <a:gd name="connsiteY2" fmla="*/ 41161 h 478935"/>
                      <a:gd name="connsiteX3" fmla="*/ 765175 w 765438"/>
                      <a:gd name="connsiteY3" fmla="*/ 201809 h 478935"/>
                      <a:gd name="connsiteX4" fmla="*/ 603931 w 765438"/>
                      <a:gd name="connsiteY4" fmla="*/ 353895 h 478935"/>
                      <a:gd name="connsiteX5" fmla="*/ 551542 w 765438"/>
                      <a:gd name="connsiteY5" fmla="*/ 474551 h 478935"/>
                      <a:gd name="connsiteX6" fmla="*/ 57037 w 765438"/>
                      <a:gd name="connsiteY6" fmla="*/ 411050 h 478935"/>
                      <a:gd name="connsiteX7" fmla="*/ 53068 w 765438"/>
                      <a:gd name="connsiteY7" fmla="*/ 36398 h 478935"/>
                      <a:gd name="connsiteX0" fmla="*/ 53068 w 765182"/>
                      <a:gd name="connsiteY0" fmla="*/ 36398 h 478935"/>
                      <a:gd name="connsiteX1" fmla="*/ 438036 w 765182"/>
                      <a:gd name="connsiteY1" fmla="*/ 14970 h 478935"/>
                      <a:gd name="connsiteX2" fmla="*/ 596786 w 765182"/>
                      <a:gd name="connsiteY2" fmla="*/ 50689 h 478935"/>
                      <a:gd name="connsiteX3" fmla="*/ 765175 w 765182"/>
                      <a:gd name="connsiteY3" fmla="*/ 201809 h 478935"/>
                      <a:gd name="connsiteX4" fmla="*/ 603931 w 765182"/>
                      <a:gd name="connsiteY4" fmla="*/ 353895 h 478935"/>
                      <a:gd name="connsiteX5" fmla="*/ 551542 w 765182"/>
                      <a:gd name="connsiteY5" fmla="*/ 474551 h 478935"/>
                      <a:gd name="connsiteX6" fmla="*/ 57037 w 765182"/>
                      <a:gd name="connsiteY6" fmla="*/ 411050 h 478935"/>
                      <a:gd name="connsiteX7" fmla="*/ 53068 w 765182"/>
                      <a:gd name="connsiteY7" fmla="*/ 36398 h 478935"/>
                      <a:gd name="connsiteX0" fmla="*/ 53068 w 768108"/>
                      <a:gd name="connsiteY0" fmla="*/ 45826 h 488363"/>
                      <a:gd name="connsiteX1" fmla="*/ 438036 w 768108"/>
                      <a:gd name="connsiteY1" fmla="*/ 24398 h 488363"/>
                      <a:gd name="connsiteX2" fmla="*/ 765175 w 768108"/>
                      <a:gd name="connsiteY2" fmla="*/ 211237 h 488363"/>
                      <a:gd name="connsiteX3" fmla="*/ 603931 w 768108"/>
                      <a:gd name="connsiteY3" fmla="*/ 363323 h 488363"/>
                      <a:gd name="connsiteX4" fmla="*/ 551542 w 768108"/>
                      <a:gd name="connsiteY4" fmla="*/ 483979 h 488363"/>
                      <a:gd name="connsiteX5" fmla="*/ 57037 w 768108"/>
                      <a:gd name="connsiteY5" fmla="*/ 420478 h 488363"/>
                      <a:gd name="connsiteX6" fmla="*/ 53068 w 768108"/>
                      <a:gd name="connsiteY6" fmla="*/ 45826 h 488363"/>
                      <a:gd name="connsiteX0" fmla="*/ 56505 w 774582"/>
                      <a:gd name="connsiteY0" fmla="*/ 45826 h 438778"/>
                      <a:gd name="connsiteX1" fmla="*/ 441473 w 774582"/>
                      <a:gd name="connsiteY1" fmla="*/ 24398 h 438778"/>
                      <a:gd name="connsiteX2" fmla="*/ 768612 w 774582"/>
                      <a:gd name="connsiteY2" fmla="*/ 211237 h 438778"/>
                      <a:gd name="connsiteX3" fmla="*/ 607368 w 774582"/>
                      <a:gd name="connsiteY3" fmla="*/ 363323 h 438778"/>
                      <a:gd name="connsiteX4" fmla="*/ 60474 w 774582"/>
                      <a:gd name="connsiteY4" fmla="*/ 420478 h 438778"/>
                      <a:gd name="connsiteX5" fmla="*/ 56505 w 774582"/>
                      <a:gd name="connsiteY5" fmla="*/ 45826 h 438778"/>
                      <a:gd name="connsiteX0" fmla="*/ 56505 w 774582"/>
                      <a:gd name="connsiteY0" fmla="*/ 45826 h 438778"/>
                      <a:gd name="connsiteX1" fmla="*/ 441473 w 774582"/>
                      <a:gd name="connsiteY1" fmla="*/ 24398 h 438778"/>
                      <a:gd name="connsiteX2" fmla="*/ 768612 w 774582"/>
                      <a:gd name="connsiteY2" fmla="*/ 201712 h 438778"/>
                      <a:gd name="connsiteX3" fmla="*/ 607368 w 774582"/>
                      <a:gd name="connsiteY3" fmla="*/ 363323 h 438778"/>
                      <a:gd name="connsiteX4" fmla="*/ 60474 w 774582"/>
                      <a:gd name="connsiteY4" fmla="*/ 420478 h 438778"/>
                      <a:gd name="connsiteX5" fmla="*/ 56505 w 774582"/>
                      <a:gd name="connsiteY5" fmla="*/ 45826 h 438778"/>
                      <a:gd name="connsiteX0" fmla="*/ 56505 w 770747"/>
                      <a:gd name="connsiteY0" fmla="*/ 45826 h 439796"/>
                      <a:gd name="connsiteX1" fmla="*/ 441473 w 770747"/>
                      <a:gd name="connsiteY1" fmla="*/ 24398 h 439796"/>
                      <a:gd name="connsiteX2" fmla="*/ 768612 w 770747"/>
                      <a:gd name="connsiteY2" fmla="*/ 201712 h 439796"/>
                      <a:gd name="connsiteX3" fmla="*/ 556568 w 770747"/>
                      <a:gd name="connsiteY3" fmla="*/ 369673 h 439796"/>
                      <a:gd name="connsiteX4" fmla="*/ 60474 w 770747"/>
                      <a:gd name="connsiteY4" fmla="*/ 420478 h 439796"/>
                      <a:gd name="connsiteX5" fmla="*/ 56505 w 770747"/>
                      <a:gd name="connsiteY5" fmla="*/ 45826 h 439796"/>
                      <a:gd name="connsiteX0" fmla="*/ 56505 w 770564"/>
                      <a:gd name="connsiteY0" fmla="*/ 45826 h 439796"/>
                      <a:gd name="connsiteX1" fmla="*/ 441473 w 770564"/>
                      <a:gd name="connsiteY1" fmla="*/ 24398 h 439796"/>
                      <a:gd name="connsiteX2" fmla="*/ 768612 w 770564"/>
                      <a:gd name="connsiteY2" fmla="*/ 201712 h 439796"/>
                      <a:gd name="connsiteX3" fmla="*/ 556568 w 770564"/>
                      <a:gd name="connsiteY3" fmla="*/ 369673 h 439796"/>
                      <a:gd name="connsiteX4" fmla="*/ 60474 w 770564"/>
                      <a:gd name="connsiteY4" fmla="*/ 420478 h 439796"/>
                      <a:gd name="connsiteX5" fmla="*/ 56505 w 770564"/>
                      <a:gd name="connsiteY5" fmla="*/ 45826 h 439796"/>
                      <a:gd name="connsiteX0" fmla="*/ 67443 w 789029"/>
                      <a:gd name="connsiteY0" fmla="*/ 45826 h 423038"/>
                      <a:gd name="connsiteX1" fmla="*/ 452411 w 789029"/>
                      <a:gd name="connsiteY1" fmla="*/ 24398 h 423038"/>
                      <a:gd name="connsiteX2" fmla="*/ 779550 w 789029"/>
                      <a:gd name="connsiteY2" fmla="*/ 201712 h 423038"/>
                      <a:gd name="connsiteX3" fmla="*/ 71412 w 789029"/>
                      <a:gd name="connsiteY3" fmla="*/ 420478 h 423038"/>
                      <a:gd name="connsiteX4" fmla="*/ 67443 w 789029"/>
                      <a:gd name="connsiteY4" fmla="*/ 45826 h 423038"/>
                      <a:gd name="connsiteX0" fmla="*/ 67443 w 779550"/>
                      <a:gd name="connsiteY0" fmla="*/ 6344 h 383512"/>
                      <a:gd name="connsiteX1" fmla="*/ 779550 w 779550"/>
                      <a:gd name="connsiteY1" fmla="*/ 162230 h 383512"/>
                      <a:gd name="connsiteX2" fmla="*/ 71412 w 779550"/>
                      <a:gd name="connsiteY2" fmla="*/ 380996 h 383512"/>
                      <a:gd name="connsiteX3" fmla="*/ 67443 w 779550"/>
                      <a:gd name="connsiteY3" fmla="*/ 6344 h 383512"/>
                      <a:gd name="connsiteX0" fmla="*/ 67443 w 782725"/>
                      <a:gd name="connsiteY0" fmla="*/ 5475 h 383003"/>
                      <a:gd name="connsiteX1" fmla="*/ 782725 w 782725"/>
                      <a:gd name="connsiteY1" fmla="*/ 186761 h 383003"/>
                      <a:gd name="connsiteX2" fmla="*/ 71412 w 782725"/>
                      <a:gd name="connsiteY2" fmla="*/ 380127 h 383003"/>
                      <a:gd name="connsiteX3" fmla="*/ 67443 w 782725"/>
                      <a:gd name="connsiteY3" fmla="*/ 5475 h 383003"/>
                      <a:gd name="connsiteX0" fmla="*/ 67443 w 782725"/>
                      <a:gd name="connsiteY0" fmla="*/ 5722 h 373700"/>
                      <a:gd name="connsiteX1" fmla="*/ 782725 w 782725"/>
                      <a:gd name="connsiteY1" fmla="*/ 177483 h 373700"/>
                      <a:gd name="connsiteX2" fmla="*/ 71412 w 782725"/>
                      <a:gd name="connsiteY2" fmla="*/ 370849 h 373700"/>
                      <a:gd name="connsiteX3" fmla="*/ 67443 w 782725"/>
                      <a:gd name="connsiteY3" fmla="*/ 5722 h 373700"/>
                      <a:gd name="connsiteX0" fmla="*/ 58520 w 773816"/>
                      <a:gd name="connsiteY0" fmla="*/ 5673 h 364262"/>
                      <a:gd name="connsiteX1" fmla="*/ 773802 w 773816"/>
                      <a:gd name="connsiteY1" fmla="*/ 177434 h 364262"/>
                      <a:gd name="connsiteX2" fmla="*/ 78364 w 773816"/>
                      <a:gd name="connsiteY2" fmla="*/ 361278 h 364262"/>
                      <a:gd name="connsiteX3" fmla="*/ 58520 w 773816"/>
                      <a:gd name="connsiteY3" fmla="*/ 5673 h 364262"/>
                      <a:gd name="connsiteX0" fmla="*/ 52098 w 767418"/>
                      <a:gd name="connsiteY0" fmla="*/ 5593 h 348558"/>
                      <a:gd name="connsiteX1" fmla="*/ 767380 w 767418"/>
                      <a:gd name="connsiteY1" fmla="*/ 177354 h 348558"/>
                      <a:gd name="connsiteX2" fmla="*/ 84642 w 767418"/>
                      <a:gd name="connsiteY2" fmla="*/ 345323 h 348558"/>
                      <a:gd name="connsiteX3" fmla="*/ 52098 w 767418"/>
                      <a:gd name="connsiteY3" fmla="*/ 5593 h 348558"/>
                      <a:gd name="connsiteX0" fmla="*/ 69341 w 752873"/>
                      <a:gd name="connsiteY0" fmla="*/ 5763 h 342357"/>
                      <a:gd name="connsiteX1" fmla="*/ 752873 w 752873"/>
                      <a:gd name="connsiteY1" fmla="*/ 171174 h 342357"/>
                      <a:gd name="connsiteX2" fmla="*/ 70135 w 752873"/>
                      <a:gd name="connsiteY2" fmla="*/ 339143 h 342357"/>
                      <a:gd name="connsiteX3" fmla="*/ 69341 w 752873"/>
                      <a:gd name="connsiteY3" fmla="*/ 5763 h 342357"/>
                      <a:gd name="connsiteX0" fmla="*/ 54826 w 764577"/>
                      <a:gd name="connsiteY0" fmla="*/ 5634 h 347007"/>
                      <a:gd name="connsiteX1" fmla="*/ 764551 w 764577"/>
                      <a:gd name="connsiteY1" fmla="*/ 175808 h 347007"/>
                      <a:gd name="connsiteX2" fmla="*/ 81813 w 764577"/>
                      <a:gd name="connsiteY2" fmla="*/ 343777 h 347007"/>
                      <a:gd name="connsiteX3" fmla="*/ 54826 w 764577"/>
                      <a:gd name="connsiteY3" fmla="*/ 5634 h 347007"/>
                      <a:gd name="connsiteX0" fmla="*/ 69342 w 752873"/>
                      <a:gd name="connsiteY0" fmla="*/ 5967 h 335395"/>
                      <a:gd name="connsiteX1" fmla="*/ 752873 w 752873"/>
                      <a:gd name="connsiteY1" fmla="*/ 164235 h 335395"/>
                      <a:gd name="connsiteX2" fmla="*/ 70135 w 752873"/>
                      <a:gd name="connsiteY2" fmla="*/ 332204 h 335395"/>
                      <a:gd name="connsiteX3" fmla="*/ 69342 w 752873"/>
                      <a:gd name="connsiteY3" fmla="*/ 5967 h 335395"/>
                      <a:gd name="connsiteX0" fmla="*/ 62417 w 745954"/>
                      <a:gd name="connsiteY0" fmla="*/ 5862 h 316592"/>
                      <a:gd name="connsiteX1" fmla="*/ 745948 w 745954"/>
                      <a:gd name="connsiteY1" fmla="*/ 164130 h 316592"/>
                      <a:gd name="connsiteX2" fmla="*/ 75116 w 745954"/>
                      <a:gd name="connsiteY2" fmla="*/ 313049 h 316592"/>
                      <a:gd name="connsiteX3" fmla="*/ 62417 w 745954"/>
                      <a:gd name="connsiteY3" fmla="*/ 5862 h 316592"/>
                      <a:gd name="connsiteX0" fmla="*/ 58520 w 742065"/>
                      <a:gd name="connsiteY0" fmla="*/ 5979 h 337749"/>
                      <a:gd name="connsiteX1" fmla="*/ 742051 w 742065"/>
                      <a:gd name="connsiteY1" fmla="*/ 164247 h 337749"/>
                      <a:gd name="connsiteX2" fmla="*/ 78363 w 742065"/>
                      <a:gd name="connsiteY2" fmla="*/ 334597 h 337749"/>
                      <a:gd name="connsiteX3" fmla="*/ 58520 w 742065"/>
                      <a:gd name="connsiteY3" fmla="*/ 5979 h 337749"/>
                      <a:gd name="connsiteX0" fmla="*/ 57265 w 743195"/>
                      <a:gd name="connsiteY0" fmla="*/ 5909 h 340067"/>
                      <a:gd name="connsiteX1" fmla="*/ 743177 w 743195"/>
                      <a:gd name="connsiteY1" fmla="*/ 166558 h 340067"/>
                      <a:gd name="connsiteX2" fmla="*/ 79489 w 743195"/>
                      <a:gd name="connsiteY2" fmla="*/ 336908 h 340067"/>
                      <a:gd name="connsiteX3" fmla="*/ 57265 w 743195"/>
                      <a:gd name="connsiteY3" fmla="*/ 5909 h 340067"/>
                      <a:gd name="connsiteX0" fmla="*/ 68064 w 753994"/>
                      <a:gd name="connsiteY0" fmla="*/ 5909 h 340067"/>
                      <a:gd name="connsiteX1" fmla="*/ 753976 w 753994"/>
                      <a:gd name="connsiteY1" fmla="*/ 166558 h 340067"/>
                      <a:gd name="connsiteX2" fmla="*/ 90288 w 753994"/>
                      <a:gd name="connsiteY2" fmla="*/ 336908 h 340067"/>
                      <a:gd name="connsiteX3" fmla="*/ 68064 w 753994"/>
                      <a:gd name="connsiteY3" fmla="*/ 5909 h 340067"/>
                      <a:gd name="connsiteX0" fmla="*/ 68064 w 753994"/>
                      <a:gd name="connsiteY0" fmla="*/ 2099 h 336257"/>
                      <a:gd name="connsiteX1" fmla="*/ 753976 w 753994"/>
                      <a:gd name="connsiteY1" fmla="*/ 162748 h 336257"/>
                      <a:gd name="connsiteX2" fmla="*/ 90288 w 753994"/>
                      <a:gd name="connsiteY2" fmla="*/ 333098 h 336257"/>
                      <a:gd name="connsiteX3" fmla="*/ 68064 w 753994"/>
                      <a:gd name="connsiteY3" fmla="*/ 2099 h 336257"/>
                      <a:gd name="connsiteX0" fmla="*/ 68064 w 753994"/>
                      <a:gd name="connsiteY0" fmla="*/ 2099 h 333224"/>
                      <a:gd name="connsiteX1" fmla="*/ 753976 w 753994"/>
                      <a:gd name="connsiteY1" fmla="*/ 162748 h 333224"/>
                      <a:gd name="connsiteX2" fmla="*/ 90288 w 753994"/>
                      <a:gd name="connsiteY2" fmla="*/ 333098 h 333224"/>
                      <a:gd name="connsiteX3" fmla="*/ 68064 w 753994"/>
                      <a:gd name="connsiteY3" fmla="*/ 2099 h 333224"/>
                      <a:gd name="connsiteX0" fmla="*/ 68064 w 753994"/>
                      <a:gd name="connsiteY0" fmla="*/ 2099 h 338452"/>
                      <a:gd name="connsiteX1" fmla="*/ 753976 w 753994"/>
                      <a:gd name="connsiteY1" fmla="*/ 162748 h 338452"/>
                      <a:gd name="connsiteX2" fmla="*/ 90288 w 753994"/>
                      <a:gd name="connsiteY2" fmla="*/ 333098 h 338452"/>
                      <a:gd name="connsiteX3" fmla="*/ 68064 w 753994"/>
                      <a:gd name="connsiteY3" fmla="*/ 2099 h 338452"/>
                      <a:gd name="connsiteX0" fmla="*/ 68064 w 753994"/>
                      <a:gd name="connsiteY0" fmla="*/ 8569 h 344922"/>
                      <a:gd name="connsiteX1" fmla="*/ 753976 w 753994"/>
                      <a:gd name="connsiteY1" fmla="*/ 169218 h 344922"/>
                      <a:gd name="connsiteX2" fmla="*/ 90288 w 753994"/>
                      <a:gd name="connsiteY2" fmla="*/ 339568 h 344922"/>
                      <a:gd name="connsiteX3" fmla="*/ 68064 w 753994"/>
                      <a:gd name="connsiteY3" fmla="*/ 8569 h 344922"/>
                      <a:gd name="connsiteX0" fmla="*/ 68064 w 753994"/>
                      <a:gd name="connsiteY0" fmla="*/ 9270 h 345227"/>
                      <a:gd name="connsiteX1" fmla="*/ 753976 w 753994"/>
                      <a:gd name="connsiteY1" fmla="*/ 155631 h 345227"/>
                      <a:gd name="connsiteX2" fmla="*/ 90288 w 753994"/>
                      <a:gd name="connsiteY2" fmla="*/ 340269 h 345227"/>
                      <a:gd name="connsiteX3" fmla="*/ 68064 w 753994"/>
                      <a:gd name="connsiteY3" fmla="*/ 9270 h 345227"/>
                      <a:gd name="connsiteX0" fmla="*/ 68064 w 756375"/>
                      <a:gd name="connsiteY0" fmla="*/ 8792 h 345006"/>
                      <a:gd name="connsiteX1" fmla="*/ 756357 w 756375"/>
                      <a:gd name="connsiteY1" fmla="*/ 164681 h 345006"/>
                      <a:gd name="connsiteX2" fmla="*/ 90288 w 756375"/>
                      <a:gd name="connsiteY2" fmla="*/ 339791 h 345006"/>
                      <a:gd name="connsiteX3" fmla="*/ 68064 w 756375"/>
                      <a:gd name="connsiteY3" fmla="*/ 8792 h 345006"/>
                      <a:gd name="connsiteX0" fmla="*/ 68064 w 757163"/>
                      <a:gd name="connsiteY0" fmla="*/ 8685 h 344835"/>
                      <a:gd name="connsiteX1" fmla="*/ 756357 w 757163"/>
                      <a:gd name="connsiteY1" fmla="*/ 164574 h 344835"/>
                      <a:gd name="connsiteX2" fmla="*/ 90288 w 757163"/>
                      <a:gd name="connsiteY2" fmla="*/ 339684 h 344835"/>
                      <a:gd name="connsiteX3" fmla="*/ 68064 w 757163"/>
                      <a:gd name="connsiteY3" fmla="*/ 8685 h 344835"/>
                      <a:gd name="connsiteX0" fmla="*/ 68064 w 756358"/>
                      <a:gd name="connsiteY0" fmla="*/ 8685 h 344835"/>
                      <a:gd name="connsiteX1" fmla="*/ 756357 w 756358"/>
                      <a:gd name="connsiteY1" fmla="*/ 164574 h 344835"/>
                      <a:gd name="connsiteX2" fmla="*/ 90288 w 756358"/>
                      <a:gd name="connsiteY2" fmla="*/ 339684 h 344835"/>
                      <a:gd name="connsiteX3" fmla="*/ 68064 w 756358"/>
                      <a:gd name="connsiteY3" fmla="*/ 8685 h 344835"/>
                      <a:gd name="connsiteX0" fmla="*/ 68064 w 808850"/>
                      <a:gd name="connsiteY0" fmla="*/ 8740 h 362007"/>
                      <a:gd name="connsiteX1" fmla="*/ 756357 w 808850"/>
                      <a:gd name="connsiteY1" fmla="*/ 164629 h 362007"/>
                      <a:gd name="connsiteX2" fmla="*/ 686262 w 808850"/>
                      <a:gd name="connsiteY2" fmla="*/ 333079 h 362007"/>
                      <a:gd name="connsiteX3" fmla="*/ 90288 w 808850"/>
                      <a:gd name="connsiteY3" fmla="*/ 339739 h 362007"/>
                      <a:gd name="connsiteX4" fmla="*/ 68064 w 808850"/>
                      <a:gd name="connsiteY4" fmla="*/ 8740 h 362007"/>
                      <a:gd name="connsiteX0" fmla="*/ 68064 w 765906"/>
                      <a:gd name="connsiteY0" fmla="*/ 25068 h 378335"/>
                      <a:gd name="connsiteX1" fmla="*/ 684919 w 765906"/>
                      <a:gd name="connsiteY1" fmla="*/ 54754 h 378335"/>
                      <a:gd name="connsiteX2" fmla="*/ 686262 w 765906"/>
                      <a:gd name="connsiteY2" fmla="*/ 349407 h 378335"/>
                      <a:gd name="connsiteX3" fmla="*/ 90288 w 765906"/>
                      <a:gd name="connsiteY3" fmla="*/ 356067 h 378335"/>
                      <a:gd name="connsiteX4" fmla="*/ 68064 w 765906"/>
                      <a:gd name="connsiteY4" fmla="*/ 25068 h 378335"/>
                      <a:gd name="connsiteX0" fmla="*/ 68064 w 767294"/>
                      <a:gd name="connsiteY0" fmla="*/ 26037 h 390026"/>
                      <a:gd name="connsiteX1" fmla="*/ 684919 w 767294"/>
                      <a:gd name="connsiteY1" fmla="*/ 55723 h 390026"/>
                      <a:gd name="connsiteX2" fmla="*/ 688643 w 767294"/>
                      <a:gd name="connsiteY2" fmla="*/ 371810 h 390026"/>
                      <a:gd name="connsiteX3" fmla="*/ 90288 w 767294"/>
                      <a:gd name="connsiteY3" fmla="*/ 357036 h 390026"/>
                      <a:gd name="connsiteX4" fmla="*/ 68064 w 767294"/>
                      <a:gd name="connsiteY4" fmla="*/ 26037 h 390026"/>
                      <a:gd name="connsiteX0" fmla="*/ 15677 w 1079745"/>
                      <a:gd name="connsiteY0" fmla="*/ 95073 h 344762"/>
                      <a:gd name="connsiteX1" fmla="*/ 975432 w 1079745"/>
                      <a:gd name="connsiteY1" fmla="*/ 10459 h 344762"/>
                      <a:gd name="connsiteX2" fmla="*/ 979156 w 1079745"/>
                      <a:gd name="connsiteY2" fmla="*/ 326546 h 344762"/>
                      <a:gd name="connsiteX3" fmla="*/ 380801 w 1079745"/>
                      <a:gd name="connsiteY3" fmla="*/ 311772 h 344762"/>
                      <a:gd name="connsiteX4" fmla="*/ 15677 w 1079745"/>
                      <a:gd name="connsiteY4" fmla="*/ 95073 h 344762"/>
                      <a:gd name="connsiteX0" fmla="*/ 35489 w 1099557"/>
                      <a:gd name="connsiteY0" fmla="*/ 95073 h 337766"/>
                      <a:gd name="connsiteX1" fmla="*/ 995244 w 1099557"/>
                      <a:gd name="connsiteY1" fmla="*/ 10459 h 337766"/>
                      <a:gd name="connsiteX2" fmla="*/ 998968 w 1099557"/>
                      <a:gd name="connsiteY2" fmla="*/ 326546 h 337766"/>
                      <a:gd name="connsiteX3" fmla="*/ 164869 w 1099557"/>
                      <a:gd name="connsiteY3" fmla="*/ 285581 h 337766"/>
                      <a:gd name="connsiteX4" fmla="*/ 35489 w 1099557"/>
                      <a:gd name="connsiteY4" fmla="*/ 95073 h 337766"/>
                      <a:gd name="connsiteX0" fmla="*/ 35489 w 1044653"/>
                      <a:gd name="connsiteY0" fmla="*/ 99402 h 342095"/>
                      <a:gd name="connsiteX1" fmla="*/ 842844 w 1044653"/>
                      <a:gd name="connsiteY1" fmla="*/ 10028 h 342095"/>
                      <a:gd name="connsiteX2" fmla="*/ 998968 w 1044653"/>
                      <a:gd name="connsiteY2" fmla="*/ 330875 h 342095"/>
                      <a:gd name="connsiteX3" fmla="*/ 164869 w 1044653"/>
                      <a:gd name="connsiteY3" fmla="*/ 289910 h 342095"/>
                      <a:gd name="connsiteX4" fmla="*/ 35489 w 1044653"/>
                      <a:gd name="connsiteY4" fmla="*/ 99402 h 342095"/>
                      <a:gd name="connsiteX0" fmla="*/ 35489 w 947868"/>
                      <a:gd name="connsiteY0" fmla="*/ 99402 h 342095"/>
                      <a:gd name="connsiteX1" fmla="*/ 842844 w 947868"/>
                      <a:gd name="connsiteY1" fmla="*/ 10028 h 342095"/>
                      <a:gd name="connsiteX2" fmla="*/ 865618 w 947868"/>
                      <a:gd name="connsiteY2" fmla="*/ 330875 h 342095"/>
                      <a:gd name="connsiteX3" fmla="*/ 164869 w 947868"/>
                      <a:gd name="connsiteY3" fmla="*/ 289910 h 342095"/>
                      <a:gd name="connsiteX4" fmla="*/ 35489 w 947868"/>
                      <a:gd name="connsiteY4" fmla="*/ 99402 h 342095"/>
                      <a:gd name="connsiteX0" fmla="*/ 31641 w 969271"/>
                      <a:gd name="connsiteY0" fmla="*/ 109695 h 340479"/>
                      <a:gd name="connsiteX1" fmla="*/ 862809 w 969271"/>
                      <a:gd name="connsiteY1" fmla="*/ 8412 h 340479"/>
                      <a:gd name="connsiteX2" fmla="*/ 885583 w 969271"/>
                      <a:gd name="connsiteY2" fmla="*/ 329259 h 340479"/>
                      <a:gd name="connsiteX3" fmla="*/ 184834 w 969271"/>
                      <a:gd name="connsiteY3" fmla="*/ 288294 h 340479"/>
                      <a:gd name="connsiteX4" fmla="*/ 31641 w 969271"/>
                      <a:gd name="connsiteY4" fmla="*/ 109695 h 340479"/>
                      <a:gd name="connsiteX0" fmla="*/ 47517 w 985147"/>
                      <a:gd name="connsiteY0" fmla="*/ 109695 h 337328"/>
                      <a:gd name="connsiteX1" fmla="*/ 878685 w 985147"/>
                      <a:gd name="connsiteY1" fmla="*/ 8412 h 337328"/>
                      <a:gd name="connsiteX2" fmla="*/ 901459 w 985147"/>
                      <a:gd name="connsiteY2" fmla="*/ 329259 h 337328"/>
                      <a:gd name="connsiteX3" fmla="*/ 124510 w 985147"/>
                      <a:gd name="connsiteY3" fmla="*/ 264482 h 337328"/>
                      <a:gd name="connsiteX4" fmla="*/ 47517 w 985147"/>
                      <a:gd name="connsiteY4" fmla="*/ 109695 h 337328"/>
                      <a:gd name="connsiteX0" fmla="*/ 47517 w 985147"/>
                      <a:gd name="connsiteY0" fmla="*/ 109695 h 337818"/>
                      <a:gd name="connsiteX1" fmla="*/ 878685 w 985147"/>
                      <a:gd name="connsiteY1" fmla="*/ 8412 h 337818"/>
                      <a:gd name="connsiteX2" fmla="*/ 901459 w 985147"/>
                      <a:gd name="connsiteY2" fmla="*/ 329259 h 337818"/>
                      <a:gd name="connsiteX3" fmla="*/ 124510 w 985147"/>
                      <a:gd name="connsiteY3" fmla="*/ 269248 h 337818"/>
                      <a:gd name="connsiteX4" fmla="*/ 47517 w 985147"/>
                      <a:gd name="connsiteY4" fmla="*/ 109695 h 337818"/>
                      <a:gd name="connsiteX0" fmla="*/ 47517 w 976225"/>
                      <a:gd name="connsiteY0" fmla="*/ 109874 h 340842"/>
                      <a:gd name="connsiteX1" fmla="*/ 878685 w 976225"/>
                      <a:gd name="connsiteY1" fmla="*/ 8591 h 340842"/>
                      <a:gd name="connsiteX2" fmla="*/ 885584 w 976225"/>
                      <a:gd name="connsiteY2" fmla="*/ 332616 h 340842"/>
                      <a:gd name="connsiteX3" fmla="*/ 124510 w 976225"/>
                      <a:gd name="connsiteY3" fmla="*/ 269427 h 340842"/>
                      <a:gd name="connsiteX4" fmla="*/ 47517 w 976225"/>
                      <a:gd name="connsiteY4" fmla="*/ 109874 h 340842"/>
                      <a:gd name="connsiteX0" fmla="*/ 73892 w 931681"/>
                      <a:gd name="connsiteY0" fmla="*/ 90934 h 344124"/>
                      <a:gd name="connsiteX1" fmla="*/ 838385 w 931681"/>
                      <a:gd name="connsiteY1" fmla="*/ 11873 h 344124"/>
                      <a:gd name="connsiteX2" fmla="*/ 845284 w 931681"/>
                      <a:gd name="connsiteY2" fmla="*/ 335898 h 344124"/>
                      <a:gd name="connsiteX3" fmla="*/ 84210 w 931681"/>
                      <a:gd name="connsiteY3" fmla="*/ 272709 h 344124"/>
                      <a:gd name="connsiteX4" fmla="*/ 73892 w 931681"/>
                      <a:gd name="connsiteY4" fmla="*/ 90934 h 344124"/>
                      <a:gd name="connsiteX0" fmla="*/ 62070 w 946865"/>
                      <a:gd name="connsiteY0" fmla="*/ 90937 h 344124"/>
                      <a:gd name="connsiteX1" fmla="*/ 851963 w 946865"/>
                      <a:gd name="connsiteY1" fmla="*/ 11873 h 344124"/>
                      <a:gd name="connsiteX2" fmla="*/ 858862 w 946865"/>
                      <a:gd name="connsiteY2" fmla="*/ 335898 h 344124"/>
                      <a:gd name="connsiteX3" fmla="*/ 97788 w 946865"/>
                      <a:gd name="connsiteY3" fmla="*/ 272709 h 344124"/>
                      <a:gd name="connsiteX4" fmla="*/ 62070 w 946865"/>
                      <a:gd name="connsiteY4" fmla="*/ 90937 h 344124"/>
                      <a:gd name="connsiteX0" fmla="*/ 73891 w 958686"/>
                      <a:gd name="connsiteY0" fmla="*/ 90937 h 344124"/>
                      <a:gd name="connsiteX1" fmla="*/ 863784 w 958686"/>
                      <a:gd name="connsiteY1" fmla="*/ 11873 h 344124"/>
                      <a:gd name="connsiteX2" fmla="*/ 870683 w 958686"/>
                      <a:gd name="connsiteY2" fmla="*/ 335898 h 344124"/>
                      <a:gd name="connsiteX3" fmla="*/ 84209 w 958686"/>
                      <a:gd name="connsiteY3" fmla="*/ 272712 h 344124"/>
                      <a:gd name="connsiteX4" fmla="*/ 73891 w 958686"/>
                      <a:gd name="connsiteY4" fmla="*/ 90937 h 344124"/>
                      <a:gd name="connsiteX0" fmla="*/ 78914 w 963709"/>
                      <a:gd name="connsiteY0" fmla="*/ 90937 h 344124"/>
                      <a:gd name="connsiteX1" fmla="*/ 868807 w 963709"/>
                      <a:gd name="connsiteY1" fmla="*/ 11873 h 344124"/>
                      <a:gd name="connsiteX2" fmla="*/ 875706 w 963709"/>
                      <a:gd name="connsiteY2" fmla="*/ 335898 h 344124"/>
                      <a:gd name="connsiteX3" fmla="*/ 79707 w 963709"/>
                      <a:gd name="connsiteY3" fmla="*/ 272712 h 344124"/>
                      <a:gd name="connsiteX4" fmla="*/ 78914 w 963709"/>
                      <a:gd name="connsiteY4" fmla="*/ 90937 h 344124"/>
                      <a:gd name="connsiteX0" fmla="*/ 86098 w 957388"/>
                      <a:gd name="connsiteY0" fmla="*/ 90940 h 344124"/>
                      <a:gd name="connsiteX1" fmla="*/ 863291 w 957388"/>
                      <a:gd name="connsiteY1" fmla="*/ 11873 h 344124"/>
                      <a:gd name="connsiteX2" fmla="*/ 870190 w 957388"/>
                      <a:gd name="connsiteY2" fmla="*/ 335898 h 344124"/>
                      <a:gd name="connsiteX3" fmla="*/ 74191 w 957388"/>
                      <a:gd name="connsiteY3" fmla="*/ 272712 h 344124"/>
                      <a:gd name="connsiteX4" fmla="*/ 86098 w 957388"/>
                      <a:gd name="connsiteY4" fmla="*/ 90940 h 344124"/>
                      <a:gd name="connsiteX0" fmla="*/ 78914 w 963709"/>
                      <a:gd name="connsiteY0" fmla="*/ 96245 h 343079"/>
                      <a:gd name="connsiteX1" fmla="*/ 868807 w 963709"/>
                      <a:gd name="connsiteY1" fmla="*/ 10828 h 343079"/>
                      <a:gd name="connsiteX2" fmla="*/ 875706 w 963709"/>
                      <a:gd name="connsiteY2" fmla="*/ 334853 h 343079"/>
                      <a:gd name="connsiteX3" fmla="*/ 79707 w 963709"/>
                      <a:gd name="connsiteY3" fmla="*/ 271667 h 343079"/>
                      <a:gd name="connsiteX4" fmla="*/ 78914 w 963709"/>
                      <a:gd name="connsiteY4" fmla="*/ 96245 h 343079"/>
                      <a:gd name="connsiteX0" fmla="*/ 82438 w 967233"/>
                      <a:gd name="connsiteY0" fmla="*/ 96245 h 341508"/>
                      <a:gd name="connsiteX1" fmla="*/ 872331 w 967233"/>
                      <a:gd name="connsiteY1" fmla="*/ 10828 h 341508"/>
                      <a:gd name="connsiteX2" fmla="*/ 879230 w 967233"/>
                      <a:gd name="connsiteY2" fmla="*/ 334853 h 341508"/>
                      <a:gd name="connsiteX3" fmla="*/ 76881 w 967233"/>
                      <a:gd name="connsiteY3" fmla="*/ 252617 h 341508"/>
                      <a:gd name="connsiteX4" fmla="*/ 82438 w 967233"/>
                      <a:gd name="connsiteY4" fmla="*/ 96245 h 341508"/>
                      <a:gd name="connsiteX0" fmla="*/ 82438 w 967233"/>
                      <a:gd name="connsiteY0" fmla="*/ 96245 h 342214"/>
                      <a:gd name="connsiteX1" fmla="*/ 872331 w 967233"/>
                      <a:gd name="connsiteY1" fmla="*/ 10828 h 342214"/>
                      <a:gd name="connsiteX2" fmla="*/ 879230 w 967233"/>
                      <a:gd name="connsiteY2" fmla="*/ 334853 h 342214"/>
                      <a:gd name="connsiteX3" fmla="*/ 76881 w 967233"/>
                      <a:gd name="connsiteY3" fmla="*/ 262145 h 342214"/>
                      <a:gd name="connsiteX4" fmla="*/ 82438 w 967233"/>
                      <a:gd name="connsiteY4" fmla="*/ 96245 h 342214"/>
                      <a:gd name="connsiteX0" fmla="*/ 77346 w 962141"/>
                      <a:gd name="connsiteY0" fmla="*/ 96245 h 342214"/>
                      <a:gd name="connsiteX1" fmla="*/ 867239 w 962141"/>
                      <a:gd name="connsiteY1" fmla="*/ 10828 h 342214"/>
                      <a:gd name="connsiteX2" fmla="*/ 874138 w 962141"/>
                      <a:gd name="connsiteY2" fmla="*/ 334853 h 342214"/>
                      <a:gd name="connsiteX3" fmla="*/ 71789 w 962141"/>
                      <a:gd name="connsiteY3" fmla="*/ 262145 h 342214"/>
                      <a:gd name="connsiteX4" fmla="*/ 77346 w 962141"/>
                      <a:gd name="connsiteY4" fmla="*/ 96245 h 342214"/>
                      <a:gd name="connsiteX0" fmla="*/ 77346 w 962141"/>
                      <a:gd name="connsiteY0" fmla="*/ 96245 h 341546"/>
                      <a:gd name="connsiteX1" fmla="*/ 867239 w 962141"/>
                      <a:gd name="connsiteY1" fmla="*/ 10828 h 341546"/>
                      <a:gd name="connsiteX2" fmla="*/ 874138 w 962141"/>
                      <a:gd name="connsiteY2" fmla="*/ 334853 h 341546"/>
                      <a:gd name="connsiteX3" fmla="*/ 71789 w 962141"/>
                      <a:gd name="connsiteY3" fmla="*/ 262145 h 341546"/>
                      <a:gd name="connsiteX4" fmla="*/ 77346 w 962141"/>
                      <a:gd name="connsiteY4" fmla="*/ 96245 h 341546"/>
                      <a:gd name="connsiteX0" fmla="*/ 77346 w 962141"/>
                      <a:gd name="connsiteY0" fmla="*/ 96245 h 342464"/>
                      <a:gd name="connsiteX1" fmla="*/ 867239 w 962141"/>
                      <a:gd name="connsiteY1" fmla="*/ 10828 h 342464"/>
                      <a:gd name="connsiteX2" fmla="*/ 874138 w 962141"/>
                      <a:gd name="connsiteY2" fmla="*/ 334853 h 342464"/>
                      <a:gd name="connsiteX3" fmla="*/ 71789 w 962141"/>
                      <a:gd name="connsiteY3" fmla="*/ 262145 h 342464"/>
                      <a:gd name="connsiteX4" fmla="*/ 77346 w 962141"/>
                      <a:gd name="connsiteY4" fmla="*/ 96245 h 342464"/>
                      <a:gd name="connsiteX0" fmla="*/ 77346 w 962141"/>
                      <a:gd name="connsiteY0" fmla="*/ 87786 h 334005"/>
                      <a:gd name="connsiteX1" fmla="*/ 867239 w 962141"/>
                      <a:gd name="connsiteY1" fmla="*/ 2369 h 334005"/>
                      <a:gd name="connsiteX2" fmla="*/ 874138 w 962141"/>
                      <a:gd name="connsiteY2" fmla="*/ 326394 h 334005"/>
                      <a:gd name="connsiteX3" fmla="*/ 71789 w 962141"/>
                      <a:gd name="connsiteY3" fmla="*/ 253686 h 334005"/>
                      <a:gd name="connsiteX4" fmla="*/ 77346 w 962141"/>
                      <a:gd name="connsiteY4" fmla="*/ 87786 h 334005"/>
                      <a:gd name="connsiteX0" fmla="*/ 77346 w 960530"/>
                      <a:gd name="connsiteY0" fmla="*/ 81681 h 327900"/>
                      <a:gd name="connsiteX1" fmla="*/ 864064 w 960530"/>
                      <a:gd name="connsiteY1" fmla="*/ 2614 h 327900"/>
                      <a:gd name="connsiteX2" fmla="*/ 874138 w 960530"/>
                      <a:gd name="connsiteY2" fmla="*/ 320289 h 327900"/>
                      <a:gd name="connsiteX3" fmla="*/ 71789 w 960530"/>
                      <a:gd name="connsiteY3" fmla="*/ 247581 h 327900"/>
                      <a:gd name="connsiteX4" fmla="*/ 77346 w 960530"/>
                      <a:gd name="connsiteY4" fmla="*/ 81681 h 32790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</a:cxnLst>
                    <a:rect l="l" t="t" r="r" b="b"/>
                    <a:pathLst>
                      <a:path w="960530" h="327900">
                        <a:moveTo>
                          <a:pt x="77346" y="81681"/>
                        </a:moveTo>
                        <a:cubicBezTo>
                          <a:pt x="200132" y="35697"/>
                          <a:pt x="731265" y="-11751"/>
                          <a:pt x="864064" y="2614"/>
                        </a:cubicBezTo>
                        <a:cubicBezTo>
                          <a:pt x="996863" y="16979"/>
                          <a:pt x="985149" y="291104"/>
                          <a:pt x="874138" y="320289"/>
                        </a:cubicBezTo>
                        <a:cubicBezTo>
                          <a:pt x="763127" y="349474"/>
                          <a:pt x="187125" y="288149"/>
                          <a:pt x="71789" y="247581"/>
                        </a:cubicBezTo>
                        <a:cubicBezTo>
                          <a:pt x="-34196" y="193028"/>
                          <a:pt x="-14729" y="119119"/>
                          <a:pt x="77346" y="81681"/>
                        </a:cubicBezTo>
                        <a:close/>
                      </a:path>
                    </a:pathLst>
                  </a:custGeom>
                  <a:blipFill dpi="0" rotWithShape="1">
                    <a:blip r:embed="rId6">
                      <a:alphaModFix amt="90000"/>
                    </a:blip>
                    <a:srcRect/>
                    <a:tile tx="0" ty="0" sx="100000" sy="100000" flip="none" algn="tl"/>
                  </a:blipFill>
                  <a:ln w="9525">
                    <a:noFill/>
                  </a:ln>
                  <a:scene3d>
                    <a:camera prst="orthographicFront"/>
                    <a:lightRig rig="threePt" dir="t"/>
                  </a:scene3d>
                  <a:sp3d>
                    <a:bevelT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85" name="타원 84">
                    <a:extLst>
                      <a:ext uri="{FF2B5EF4-FFF2-40B4-BE49-F238E27FC236}">
                        <a16:creationId xmlns:a16="http://schemas.microsoft.com/office/drawing/2014/main" id="{558D7125-98A9-14AB-7125-7322B5370D8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373781" y="4505426"/>
                    <a:ext cx="128960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86" name="타원 85">
                    <a:extLst>
                      <a:ext uri="{FF2B5EF4-FFF2-40B4-BE49-F238E27FC236}">
                        <a16:creationId xmlns:a16="http://schemas.microsoft.com/office/drawing/2014/main" id="{B9481D65-954E-F38B-7A99-ACC8E306D08E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482338" y="4531143"/>
                    <a:ext cx="128960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87" name="타원 86">
                    <a:extLst>
                      <a:ext uri="{FF2B5EF4-FFF2-40B4-BE49-F238E27FC236}">
                        <a16:creationId xmlns:a16="http://schemas.microsoft.com/office/drawing/2014/main" id="{B238003F-7083-F04D-3621-2DFD717452E8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459907" y="4423220"/>
                    <a:ext cx="128960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88" name="타원 87">
                    <a:extLst>
                      <a:ext uri="{FF2B5EF4-FFF2-40B4-BE49-F238E27FC236}">
                        <a16:creationId xmlns:a16="http://schemas.microsoft.com/office/drawing/2014/main" id="{2F348842-C9E9-6D0F-32D9-9528CEEB4293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404433" y="4349487"/>
                    <a:ext cx="128960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89" name="타원 88">
                    <a:extLst>
                      <a:ext uri="{FF2B5EF4-FFF2-40B4-BE49-F238E27FC236}">
                        <a16:creationId xmlns:a16="http://schemas.microsoft.com/office/drawing/2014/main" id="{9F4AE43A-7961-0933-9E56-862D37954B19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439497" y="4481254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90" name="타원 89">
                    <a:extLst>
                      <a:ext uri="{FF2B5EF4-FFF2-40B4-BE49-F238E27FC236}">
                        <a16:creationId xmlns:a16="http://schemas.microsoft.com/office/drawing/2014/main" id="{C19A4544-BE67-557D-97CF-4B0483205759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518643" y="4516910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91" name="타원 90">
                    <a:extLst>
                      <a:ext uri="{FF2B5EF4-FFF2-40B4-BE49-F238E27FC236}">
                        <a16:creationId xmlns:a16="http://schemas.microsoft.com/office/drawing/2014/main" id="{27925DC4-2B11-1DAE-E601-8F3315A5E2A0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429250" y="4556922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92" name="타원 91">
                    <a:extLst>
                      <a:ext uri="{FF2B5EF4-FFF2-40B4-BE49-F238E27FC236}">
                        <a16:creationId xmlns:a16="http://schemas.microsoft.com/office/drawing/2014/main" id="{C8BA4E44-9DAB-837A-6147-5B27BE8B429C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457566" y="4628018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93" name="타원 92">
                    <a:extLst>
                      <a:ext uri="{FF2B5EF4-FFF2-40B4-BE49-F238E27FC236}">
                        <a16:creationId xmlns:a16="http://schemas.microsoft.com/office/drawing/2014/main" id="{8E71DCFD-0A7C-E21A-610C-B306440DB4F4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508469" y="4588006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94" name="타원 93">
                    <a:extLst>
                      <a:ext uri="{FF2B5EF4-FFF2-40B4-BE49-F238E27FC236}">
                        <a16:creationId xmlns:a16="http://schemas.microsoft.com/office/drawing/2014/main" id="{0052BC6D-19B6-7689-0ED1-C5CB43A8883B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462754" y="4397038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95" name="타원 94">
                    <a:extLst>
                      <a:ext uri="{FF2B5EF4-FFF2-40B4-BE49-F238E27FC236}">
                        <a16:creationId xmlns:a16="http://schemas.microsoft.com/office/drawing/2014/main" id="{F7C68D25-8506-4D72-AD68-93E81BA7B5F4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498074" y="4425930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96" name="타원 95">
                    <a:extLst>
                      <a:ext uri="{FF2B5EF4-FFF2-40B4-BE49-F238E27FC236}">
                        <a16:creationId xmlns:a16="http://schemas.microsoft.com/office/drawing/2014/main" id="{16CA93B0-B831-B913-6382-D4B69EF89BDB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395665" y="4597180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97" name="타원 96">
                    <a:extLst>
                      <a:ext uri="{FF2B5EF4-FFF2-40B4-BE49-F238E27FC236}">
                        <a16:creationId xmlns:a16="http://schemas.microsoft.com/office/drawing/2014/main" id="{E0AF0736-2A0B-9236-5CCD-7F7C9F1A0C88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406122" y="4655787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98" name="타원 97">
                    <a:extLst>
                      <a:ext uri="{FF2B5EF4-FFF2-40B4-BE49-F238E27FC236}">
                        <a16:creationId xmlns:a16="http://schemas.microsoft.com/office/drawing/2014/main" id="{D03CADD2-BA4D-F75B-BF69-73D6A591E6CE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543148" y="4679110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99" name="타원 98">
                    <a:extLst>
                      <a:ext uri="{FF2B5EF4-FFF2-40B4-BE49-F238E27FC236}">
                        <a16:creationId xmlns:a16="http://schemas.microsoft.com/office/drawing/2014/main" id="{DAF2471F-DD68-7D2F-6C3A-8A16DAF8D826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482338" y="4639688"/>
                    <a:ext cx="128960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00" name="타원 99">
                    <a:extLst>
                      <a:ext uri="{FF2B5EF4-FFF2-40B4-BE49-F238E27FC236}">
                        <a16:creationId xmlns:a16="http://schemas.microsoft.com/office/drawing/2014/main" id="{B82023B5-3010-3613-AA62-25B7EEF5B10D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429250" y="4665467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01" name="타원 100">
                    <a:extLst>
                      <a:ext uri="{FF2B5EF4-FFF2-40B4-BE49-F238E27FC236}">
                        <a16:creationId xmlns:a16="http://schemas.microsoft.com/office/drawing/2014/main" id="{68EB830D-0E93-BB4F-67D5-932DB271EE0A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457566" y="4736563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02" name="타원 101">
                    <a:extLst>
                      <a:ext uri="{FF2B5EF4-FFF2-40B4-BE49-F238E27FC236}">
                        <a16:creationId xmlns:a16="http://schemas.microsoft.com/office/drawing/2014/main" id="{7DD7A503-38CB-7ADD-E4A2-DF139041D816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508469" y="4696552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03" name="타원 102">
                    <a:extLst>
                      <a:ext uri="{FF2B5EF4-FFF2-40B4-BE49-F238E27FC236}">
                        <a16:creationId xmlns:a16="http://schemas.microsoft.com/office/drawing/2014/main" id="{72E54767-18B4-FE2D-AD38-77CA33CBCCB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395665" y="4705725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04" name="타원 103">
                    <a:extLst>
                      <a:ext uri="{FF2B5EF4-FFF2-40B4-BE49-F238E27FC236}">
                        <a16:creationId xmlns:a16="http://schemas.microsoft.com/office/drawing/2014/main" id="{BCF2B012-876B-9F73-AF45-4523769EC06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406122" y="4764332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05" name="타원 104">
                    <a:extLst>
                      <a:ext uri="{FF2B5EF4-FFF2-40B4-BE49-F238E27FC236}">
                        <a16:creationId xmlns:a16="http://schemas.microsoft.com/office/drawing/2014/main" id="{E9260437-86A5-CA0E-11F4-35738E241430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525794" y="4807181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06" name="타원 105">
                    <a:extLst>
                      <a:ext uri="{FF2B5EF4-FFF2-40B4-BE49-F238E27FC236}">
                        <a16:creationId xmlns:a16="http://schemas.microsoft.com/office/drawing/2014/main" id="{8E91F360-E43B-A322-AD5C-8997AF37B470}"/>
                      </a:ext>
                    </a:extLst>
                  </p:cNvPr>
                  <p:cNvSpPr/>
                  <p:nvPr/>
                </p:nvSpPr>
                <p:spPr>
                  <a:xfrm rot="18511974">
                    <a:off x="5459582" y="4288004"/>
                    <a:ext cx="128962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07" name="타원 106">
                    <a:extLst>
                      <a:ext uri="{FF2B5EF4-FFF2-40B4-BE49-F238E27FC236}">
                        <a16:creationId xmlns:a16="http://schemas.microsoft.com/office/drawing/2014/main" id="{BDBE988E-9FEF-198B-DEAF-05C7FF7FA755}"/>
                      </a:ext>
                    </a:extLst>
                  </p:cNvPr>
                  <p:cNvSpPr/>
                  <p:nvPr/>
                </p:nvSpPr>
                <p:spPr>
                  <a:xfrm rot="18511974">
                    <a:off x="5406493" y="4313784"/>
                    <a:ext cx="58823" cy="62651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08" name="타원 107">
                    <a:extLst>
                      <a:ext uri="{FF2B5EF4-FFF2-40B4-BE49-F238E27FC236}">
                        <a16:creationId xmlns:a16="http://schemas.microsoft.com/office/drawing/2014/main" id="{12297072-CEC1-24D1-46BC-5CF5C6AF9C61}"/>
                      </a:ext>
                    </a:extLst>
                  </p:cNvPr>
                  <p:cNvSpPr/>
                  <p:nvPr/>
                </p:nvSpPr>
                <p:spPr>
                  <a:xfrm rot="18511974">
                    <a:off x="5434811" y="4384879"/>
                    <a:ext cx="58823" cy="62651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09" name="타원 108">
                    <a:extLst>
                      <a:ext uri="{FF2B5EF4-FFF2-40B4-BE49-F238E27FC236}">
                        <a16:creationId xmlns:a16="http://schemas.microsoft.com/office/drawing/2014/main" id="{82A9D11C-BB33-E8D5-7191-B7D96B5361D9}"/>
                      </a:ext>
                    </a:extLst>
                  </p:cNvPr>
                  <p:cNvSpPr/>
                  <p:nvPr/>
                </p:nvSpPr>
                <p:spPr>
                  <a:xfrm rot="18511974">
                    <a:off x="5485712" y="4344867"/>
                    <a:ext cx="58823" cy="62651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10" name="타원 109">
                    <a:extLst>
                      <a:ext uri="{FF2B5EF4-FFF2-40B4-BE49-F238E27FC236}">
                        <a16:creationId xmlns:a16="http://schemas.microsoft.com/office/drawing/2014/main" id="{9B3EEF7E-8FAC-1613-1983-587FC2DE0CB2}"/>
                      </a:ext>
                    </a:extLst>
                  </p:cNvPr>
                  <p:cNvSpPr/>
                  <p:nvPr/>
                </p:nvSpPr>
                <p:spPr>
                  <a:xfrm rot="18511974">
                    <a:off x="5372909" y="4354040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11" name="타원 110">
                    <a:extLst>
                      <a:ext uri="{FF2B5EF4-FFF2-40B4-BE49-F238E27FC236}">
                        <a16:creationId xmlns:a16="http://schemas.microsoft.com/office/drawing/2014/main" id="{334C7179-3354-D2B0-D65E-3FFDDDFA00C8}"/>
                      </a:ext>
                    </a:extLst>
                  </p:cNvPr>
                  <p:cNvSpPr/>
                  <p:nvPr/>
                </p:nvSpPr>
                <p:spPr>
                  <a:xfrm rot="18511974">
                    <a:off x="5383366" y="4412647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12" name="타원 111">
                    <a:extLst>
                      <a:ext uri="{FF2B5EF4-FFF2-40B4-BE49-F238E27FC236}">
                        <a16:creationId xmlns:a16="http://schemas.microsoft.com/office/drawing/2014/main" id="{D3E87531-55B9-BBB2-3E37-AED663546AC8}"/>
                      </a:ext>
                    </a:extLst>
                  </p:cNvPr>
                  <p:cNvSpPr/>
                  <p:nvPr/>
                </p:nvSpPr>
                <p:spPr>
                  <a:xfrm rot="18511974">
                    <a:off x="5520392" y="4435971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13" name="TextBox 112">
                    <a:extLst>
                      <a:ext uri="{FF2B5EF4-FFF2-40B4-BE49-F238E27FC236}">
                        <a16:creationId xmlns:a16="http://schemas.microsoft.com/office/drawing/2014/main" id="{0035404B-5C14-5E6C-1EFF-1336C009F9C7}"/>
                      </a:ext>
                    </a:extLst>
                  </p:cNvPr>
                  <p:cNvSpPr txBox="1"/>
                  <p:nvPr/>
                </p:nvSpPr>
                <p:spPr>
                  <a:xfrm>
                    <a:off x="3732276" y="6853405"/>
                    <a:ext cx="2178763" cy="49446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500" b="1" dirty="0">
                        <a:latin typeface="+mn-ea"/>
                      </a:rPr>
                      <a:t>384-Pillar Plate</a:t>
                    </a:r>
                    <a:endParaRPr lang="ko-KR" altLang="en-US" sz="500" b="1" dirty="0">
                      <a:latin typeface="+mn-ea"/>
                    </a:endParaRPr>
                  </a:p>
                </p:txBody>
              </p:sp>
              <p:sp>
                <p:nvSpPr>
                  <p:cNvPr id="114" name="타원 113">
                    <a:extLst>
                      <a:ext uri="{FF2B5EF4-FFF2-40B4-BE49-F238E27FC236}">
                        <a16:creationId xmlns:a16="http://schemas.microsoft.com/office/drawing/2014/main" id="{D0A1B827-E412-9FAD-E65E-5623115DCCCE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61629" y="5836876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15" name="타원 114">
                    <a:extLst>
                      <a:ext uri="{FF2B5EF4-FFF2-40B4-BE49-F238E27FC236}">
                        <a16:creationId xmlns:a16="http://schemas.microsoft.com/office/drawing/2014/main" id="{3F23AE12-D090-3622-7040-4FC06E540EAB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85711" y="5818213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16" name="타원 115">
                    <a:extLst>
                      <a:ext uri="{FF2B5EF4-FFF2-40B4-BE49-F238E27FC236}">
                        <a16:creationId xmlns:a16="http://schemas.microsoft.com/office/drawing/2014/main" id="{D3FAC0CB-04AA-00D3-27EB-7C090FD957EC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31752" y="5862940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17" name="타원 116">
                    <a:extLst>
                      <a:ext uri="{FF2B5EF4-FFF2-40B4-BE49-F238E27FC236}">
                        <a16:creationId xmlns:a16="http://schemas.microsoft.com/office/drawing/2014/main" id="{3F222989-B41D-019E-3AFC-A5DC542D46B8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43184" y="5800855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19" name="타원 118">
                    <a:extLst>
                      <a:ext uri="{FF2B5EF4-FFF2-40B4-BE49-F238E27FC236}">
                        <a16:creationId xmlns:a16="http://schemas.microsoft.com/office/drawing/2014/main" id="{D65AFDEC-7C8C-0158-75B6-9489DF80F3FB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56407" y="5961711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20" name="타원 119">
                    <a:extLst>
                      <a:ext uri="{FF2B5EF4-FFF2-40B4-BE49-F238E27FC236}">
                        <a16:creationId xmlns:a16="http://schemas.microsoft.com/office/drawing/2014/main" id="{7C3C6EC1-59BA-1AF7-A5D0-6D20A1FC462E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60821" y="5880441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21" name="타원 120">
                    <a:extLst>
                      <a:ext uri="{FF2B5EF4-FFF2-40B4-BE49-F238E27FC236}">
                        <a16:creationId xmlns:a16="http://schemas.microsoft.com/office/drawing/2014/main" id="{F040B686-DF7C-3347-197A-49F3BC7A94F9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82589" y="5804887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22" name="타원 121">
                    <a:extLst>
                      <a:ext uri="{FF2B5EF4-FFF2-40B4-BE49-F238E27FC236}">
                        <a16:creationId xmlns:a16="http://schemas.microsoft.com/office/drawing/2014/main" id="{D1047463-5110-0169-6D6F-0CA8ADDF389E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62893" y="5907812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23" name="타원 122">
                    <a:extLst>
                      <a:ext uri="{FF2B5EF4-FFF2-40B4-BE49-F238E27FC236}">
                        <a16:creationId xmlns:a16="http://schemas.microsoft.com/office/drawing/2014/main" id="{7A04B975-C247-BBBB-FA6B-A996B1D19025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88789" y="5849759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24" name="원호 123">
                    <a:extLst>
                      <a:ext uri="{FF2B5EF4-FFF2-40B4-BE49-F238E27FC236}">
                        <a16:creationId xmlns:a16="http://schemas.microsoft.com/office/drawing/2014/main" id="{0B160848-9F46-37EF-90AB-4603FCBE7E0C}"/>
                      </a:ext>
                    </a:extLst>
                  </p:cNvPr>
                  <p:cNvSpPr/>
                  <p:nvPr/>
                </p:nvSpPr>
                <p:spPr>
                  <a:xfrm rot="13759440">
                    <a:off x="4230924" y="5838745"/>
                    <a:ext cx="183351" cy="255281"/>
                  </a:xfrm>
                  <a:prstGeom prst="arc">
                    <a:avLst/>
                  </a:prstGeom>
                  <a:ln>
                    <a:solidFill>
                      <a:srgbClr val="92D05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27" name="타원 126">
                    <a:extLst>
                      <a:ext uri="{FF2B5EF4-FFF2-40B4-BE49-F238E27FC236}">
                        <a16:creationId xmlns:a16="http://schemas.microsoft.com/office/drawing/2014/main" id="{7209EA8B-B5E0-2908-EA28-9B771AA487D6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87985" y="5899702"/>
                    <a:ext cx="128960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28" name="타원 127">
                    <a:extLst>
                      <a:ext uri="{FF2B5EF4-FFF2-40B4-BE49-F238E27FC236}">
                        <a16:creationId xmlns:a16="http://schemas.microsoft.com/office/drawing/2014/main" id="{917488F9-37AC-CBE0-B01B-51A6A87A38D8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96542" y="5925420"/>
                    <a:ext cx="128960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29" name="타원 128">
                    <a:extLst>
                      <a:ext uri="{FF2B5EF4-FFF2-40B4-BE49-F238E27FC236}">
                        <a16:creationId xmlns:a16="http://schemas.microsoft.com/office/drawing/2014/main" id="{6A1A71A8-D4DD-049A-D7B4-8E3A4E08DAD7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74112" y="5817496"/>
                    <a:ext cx="128960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30" name="타원 129">
                    <a:extLst>
                      <a:ext uri="{FF2B5EF4-FFF2-40B4-BE49-F238E27FC236}">
                        <a16:creationId xmlns:a16="http://schemas.microsoft.com/office/drawing/2014/main" id="{C91DC429-D9BC-D6BC-A337-8785EFB91620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56770" y="5776462"/>
                    <a:ext cx="128960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31" name="타원 130">
                    <a:extLst>
                      <a:ext uri="{FF2B5EF4-FFF2-40B4-BE49-F238E27FC236}">
                        <a16:creationId xmlns:a16="http://schemas.microsoft.com/office/drawing/2014/main" id="{26E53350-FDA6-7C07-ED23-5E77EF2887D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53701" y="5875531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32" name="타원 131">
                    <a:extLst>
                      <a:ext uri="{FF2B5EF4-FFF2-40B4-BE49-F238E27FC236}">
                        <a16:creationId xmlns:a16="http://schemas.microsoft.com/office/drawing/2014/main" id="{AFCCCC67-230C-7CC5-C9A1-6983E462B9FC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32847" y="5911187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33" name="타원 132">
                    <a:extLst>
                      <a:ext uri="{FF2B5EF4-FFF2-40B4-BE49-F238E27FC236}">
                        <a16:creationId xmlns:a16="http://schemas.microsoft.com/office/drawing/2014/main" id="{7AEAEA73-50F7-8150-83A2-5B1C8C30E8C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43454" y="5951197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34" name="타원 133">
                    <a:extLst>
                      <a:ext uri="{FF2B5EF4-FFF2-40B4-BE49-F238E27FC236}">
                        <a16:creationId xmlns:a16="http://schemas.microsoft.com/office/drawing/2014/main" id="{5DB91098-EBB7-3268-73F6-069BC86EABCB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71770" y="6022293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35" name="타원 134">
                    <a:extLst>
                      <a:ext uri="{FF2B5EF4-FFF2-40B4-BE49-F238E27FC236}">
                        <a16:creationId xmlns:a16="http://schemas.microsoft.com/office/drawing/2014/main" id="{6066BB53-83FE-C963-9615-DB7774D7618B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22673" y="5982283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36" name="타원 135">
                    <a:extLst>
                      <a:ext uri="{FF2B5EF4-FFF2-40B4-BE49-F238E27FC236}">
                        <a16:creationId xmlns:a16="http://schemas.microsoft.com/office/drawing/2014/main" id="{2EB61D2F-C68C-6838-0F87-8414E482B62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76960" y="5791315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37" name="타원 136">
                    <a:extLst>
                      <a:ext uri="{FF2B5EF4-FFF2-40B4-BE49-F238E27FC236}">
                        <a16:creationId xmlns:a16="http://schemas.microsoft.com/office/drawing/2014/main" id="{A0A708F7-949C-10E1-0FAA-BB31FF15E730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12280" y="5820207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38" name="타원 137">
                    <a:extLst>
                      <a:ext uri="{FF2B5EF4-FFF2-40B4-BE49-F238E27FC236}">
                        <a16:creationId xmlns:a16="http://schemas.microsoft.com/office/drawing/2014/main" id="{BE889DC2-15BC-64C9-3B6E-9C6E71A16C22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09869" y="5991455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39" name="타원 138">
                    <a:extLst>
                      <a:ext uri="{FF2B5EF4-FFF2-40B4-BE49-F238E27FC236}">
                        <a16:creationId xmlns:a16="http://schemas.microsoft.com/office/drawing/2014/main" id="{D3A760C1-0B7B-6093-0BEF-EACE070F4EFE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20326" y="6050062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40" name="타원 139">
                    <a:extLst>
                      <a:ext uri="{FF2B5EF4-FFF2-40B4-BE49-F238E27FC236}">
                        <a16:creationId xmlns:a16="http://schemas.microsoft.com/office/drawing/2014/main" id="{BC2C8196-3DA3-6A5F-F5A5-22AC90299EB9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57354" y="6073386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41" name="타원 140">
                    <a:extLst>
                      <a:ext uri="{FF2B5EF4-FFF2-40B4-BE49-F238E27FC236}">
                        <a16:creationId xmlns:a16="http://schemas.microsoft.com/office/drawing/2014/main" id="{4264C399-8928-8746-1F5F-117B94934584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87986" y="5789516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42" name="타원 141">
                    <a:extLst>
                      <a:ext uri="{FF2B5EF4-FFF2-40B4-BE49-F238E27FC236}">
                        <a16:creationId xmlns:a16="http://schemas.microsoft.com/office/drawing/2014/main" id="{5219F797-5230-7EA1-AF27-03E6BA0E66DB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53597" y="5865926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43" name="타원 142">
                    <a:extLst>
                      <a:ext uri="{FF2B5EF4-FFF2-40B4-BE49-F238E27FC236}">
                        <a16:creationId xmlns:a16="http://schemas.microsoft.com/office/drawing/2014/main" id="{9E4AE105-AE20-0396-5412-EF35F0AF2392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37994" y="5964862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44" name="타원 143">
                    <a:extLst>
                      <a:ext uri="{FF2B5EF4-FFF2-40B4-BE49-F238E27FC236}">
                        <a16:creationId xmlns:a16="http://schemas.microsoft.com/office/drawing/2014/main" id="{0F70CB99-738C-FB85-F4D0-C4F9877B326B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986949" y="5939453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45" name="타원 144">
                    <a:extLst>
                      <a:ext uri="{FF2B5EF4-FFF2-40B4-BE49-F238E27FC236}">
                        <a16:creationId xmlns:a16="http://schemas.microsoft.com/office/drawing/2014/main" id="{050C5FFD-D7A8-38FE-5398-75E19BF26184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37851" y="5899441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46" name="타원 145">
                    <a:extLst>
                      <a:ext uri="{FF2B5EF4-FFF2-40B4-BE49-F238E27FC236}">
                        <a16:creationId xmlns:a16="http://schemas.microsoft.com/office/drawing/2014/main" id="{E6DAF654-C32F-E8A0-FF17-1B2BB5500F2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72531" y="5990545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47" name="타원 146">
                    <a:extLst>
                      <a:ext uri="{FF2B5EF4-FFF2-40B4-BE49-F238E27FC236}">
                        <a16:creationId xmlns:a16="http://schemas.microsoft.com/office/drawing/2014/main" id="{1AB060F1-3FD5-F746-9A70-599115327662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53172" y="5882022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48" name="타원 147">
                    <a:extLst>
                      <a:ext uri="{FF2B5EF4-FFF2-40B4-BE49-F238E27FC236}">
                        <a16:creationId xmlns:a16="http://schemas.microsoft.com/office/drawing/2014/main" id="{C6689371-3B01-29E1-4AF0-70F6A88AEABC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89298" y="5836520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49" name="타원 148">
                    <a:extLst>
                      <a:ext uri="{FF2B5EF4-FFF2-40B4-BE49-F238E27FC236}">
                        <a16:creationId xmlns:a16="http://schemas.microsoft.com/office/drawing/2014/main" id="{23531CFE-4D25-E9B1-1548-75C49D4FE3F1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990562" y="5907457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50" name="타원 149">
                    <a:extLst>
                      <a:ext uri="{FF2B5EF4-FFF2-40B4-BE49-F238E27FC236}">
                        <a16:creationId xmlns:a16="http://schemas.microsoft.com/office/drawing/2014/main" id="{A5CA2E6E-D2DB-AA92-B9BB-7291FBD02AED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16458" y="5849404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51" name="타원 150">
                    <a:extLst>
                      <a:ext uri="{FF2B5EF4-FFF2-40B4-BE49-F238E27FC236}">
                        <a16:creationId xmlns:a16="http://schemas.microsoft.com/office/drawing/2014/main" id="{982BEF27-A5CD-B840-0F63-0E7427E6238B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24211" y="5925064"/>
                    <a:ext cx="128960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52" name="타원 151">
                    <a:extLst>
                      <a:ext uri="{FF2B5EF4-FFF2-40B4-BE49-F238E27FC236}">
                        <a16:creationId xmlns:a16="http://schemas.microsoft.com/office/drawing/2014/main" id="{72CEA722-D492-A14D-A089-7F51FC4A9F6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981368" y="5875176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53" name="타원 152">
                    <a:extLst>
                      <a:ext uri="{FF2B5EF4-FFF2-40B4-BE49-F238E27FC236}">
                        <a16:creationId xmlns:a16="http://schemas.microsoft.com/office/drawing/2014/main" id="{9909D3D2-0B6F-935D-B840-4C55AE6EFBD0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60515" y="5910831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54" name="타원 153">
                    <a:extLst>
                      <a:ext uri="{FF2B5EF4-FFF2-40B4-BE49-F238E27FC236}">
                        <a16:creationId xmlns:a16="http://schemas.microsoft.com/office/drawing/2014/main" id="{9E3007F6-1EB3-CD4D-F10D-D4EB1CD5920B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999438" y="6021938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55" name="타원 154">
                    <a:extLst>
                      <a:ext uri="{FF2B5EF4-FFF2-40B4-BE49-F238E27FC236}">
                        <a16:creationId xmlns:a16="http://schemas.microsoft.com/office/drawing/2014/main" id="{4B8581BA-1408-8C20-E1FC-23BB5641426E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50340" y="5981928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56" name="타원 155">
                    <a:extLst>
                      <a:ext uri="{FF2B5EF4-FFF2-40B4-BE49-F238E27FC236}">
                        <a16:creationId xmlns:a16="http://schemas.microsoft.com/office/drawing/2014/main" id="{029C2E51-1743-EFC1-0E0C-FAD902BAAC83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85020" y="6073031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57" name="타원 156">
                    <a:extLst>
                      <a:ext uri="{FF2B5EF4-FFF2-40B4-BE49-F238E27FC236}">
                        <a16:creationId xmlns:a16="http://schemas.microsoft.com/office/drawing/2014/main" id="{ECF8821D-609C-BDDB-6DB9-2928B63312D7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65661" y="5964507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pic>
                <p:nvPicPr>
                  <p:cNvPr id="158" name="그림 157">
                    <a:extLst>
                      <a:ext uri="{FF2B5EF4-FFF2-40B4-BE49-F238E27FC236}">
                        <a16:creationId xmlns:a16="http://schemas.microsoft.com/office/drawing/2014/main" id="{77720749-DE0D-BA23-A592-90E617B7F3E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7">
                    <a:extLst>
                      <a:ext uri="{BEBA8EAE-BF5A-486C-A8C5-ECC9F3942E4B}">
                        <a14:imgProps xmlns:a14="http://schemas.microsoft.com/office/drawing/2010/main">
                          <a14:imgLayer r:embed="rId8">
                            <a14:imgEffect>
                              <a14:sharpenSoften amount="25000"/>
                            </a14:imgEffect>
                          </a14:imgLayer>
                        </a14:imgProps>
                      </a:ext>
                    </a:extLst>
                  </a:blip>
                  <a:srcRect l="46605" t="24341" r="2101" b="48447"/>
                  <a:stretch/>
                </p:blipFill>
                <p:spPr>
                  <a:xfrm>
                    <a:off x="521020" y="3229605"/>
                    <a:ext cx="2948685" cy="1986441"/>
                  </a:xfrm>
                  <a:prstGeom prst="rect">
                    <a:avLst/>
                  </a:prstGeom>
                </p:spPr>
              </p:pic>
              <p:sp>
                <p:nvSpPr>
                  <p:cNvPr id="159" name="TextBox 158">
                    <a:extLst>
                      <a:ext uri="{FF2B5EF4-FFF2-40B4-BE49-F238E27FC236}">
                        <a16:creationId xmlns:a16="http://schemas.microsoft.com/office/drawing/2014/main" id="{A0291F43-F0A1-2FB4-314C-AC7054E85C48}"/>
                      </a:ext>
                    </a:extLst>
                  </p:cNvPr>
                  <p:cNvSpPr txBox="1"/>
                  <p:nvPr/>
                </p:nvSpPr>
                <p:spPr>
                  <a:xfrm>
                    <a:off x="351736" y="5254312"/>
                    <a:ext cx="3058427" cy="49446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500" b="1" dirty="0">
                        <a:latin typeface="+mn-ea"/>
                      </a:rPr>
                      <a:t>Sample Dispensing Unit</a:t>
                    </a:r>
                    <a:endParaRPr lang="ko-KR" altLang="en-US" sz="500" b="1" dirty="0">
                      <a:latin typeface="+mn-ea"/>
                    </a:endParaRPr>
                  </a:p>
                </p:txBody>
              </p:sp>
              <p:sp>
                <p:nvSpPr>
                  <p:cNvPr id="160" name="타원 159">
                    <a:extLst>
                      <a:ext uri="{FF2B5EF4-FFF2-40B4-BE49-F238E27FC236}">
                        <a16:creationId xmlns:a16="http://schemas.microsoft.com/office/drawing/2014/main" id="{207F3474-D552-BB3C-DED8-8A4A96DA1D7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369093" y="5903302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61" name="타원 160">
                    <a:extLst>
                      <a:ext uri="{FF2B5EF4-FFF2-40B4-BE49-F238E27FC236}">
                        <a16:creationId xmlns:a16="http://schemas.microsoft.com/office/drawing/2014/main" id="{6575CEA2-7BFE-05D2-6323-D3C9339F820E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393173" y="5884641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62" name="타원 161">
                    <a:extLst>
                      <a:ext uri="{FF2B5EF4-FFF2-40B4-BE49-F238E27FC236}">
                        <a16:creationId xmlns:a16="http://schemas.microsoft.com/office/drawing/2014/main" id="{BD85B5DC-3B25-D7B5-4717-BF660B82C046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39216" y="5929368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63" name="타원 162">
                    <a:extLst>
                      <a:ext uri="{FF2B5EF4-FFF2-40B4-BE49-F238E27FC236}">
                        <a16:creationId xmlns:a16="http://schemas.microsoft.com/office/drawing/2014/main" id="{CE796DAB-7E92-C0C6-4ED6-6F7509505F89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50648" y="5867282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64" name="타원 163">
                    <a:extLst>
                      <a:ext uri="{FF2B5EF4-FFF2-40B4-BE49-F238E27FC236}">
                        <a16:creationId xmlns:a16="http://schemas.microsoft.com/office/drawing/2014/main" id="{873259AF-6ECF-21BF-2820-37F24F0852E7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70357" y="5974239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65" name="타원 164">
                    <a:extLst>
                      <a:ext uri="{FF2B5EF4-FFF2-40B4-BE49-F238E27FC236}">
                        <a16:creationId xmlns:a16="http://schemas.microsoft.com/office/drawing/2014/main" id="{814CA99F-7A43-7D09-4F0F-8AEE689C2915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96253" y="5916187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66" name="타원 165">
                    <a:extLst>
                      <a:ext uri="{FF2B5EF4-FFF2-40B4-BE49-F238E27FC236}">
                        <a16:creationId xmlns:a16="http://schemas.microsoft.com/office/drawing/2014/main" id="{3DFFEEC5-77BC-6A7C-B599-05674D69148C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81574" y="5883923"/>
                    <a:ext cx="128960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67" name="타원 166">
                    <a:extLst>
                      <a:ext uri="{FF2B5EF4-FFF2-40B4-BE49-F238E27FC236}">
                        <a16:creationId xmlns:a16="http://schemas.microsoft.com/office/drawing/2014/main" id="{C0433CB5-1065-9DEE-1980-61FF49DFDB9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61163" y="5941958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68" name="타원 167">
                    <a:extLst>
                      <a:ext uri="{FF2B5EF4-FFF2-40B4-BE49-F238E27FC236}">
                        <a16:creationId xmlns:a16="http://schemas.microsoft.com/office/drawing/2014/main" id="{70F34987-D71A-28AA-4D68-982969FF7C80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84422" y="5857742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69" name="타원 168">
                    <a:extLst>
                      <a:ext uri="{FF2B5EF4-FFF2-40B4-BE49-F238E27FC236}">
                        <a16:creationId xmlns:a16="http://schemas.microsoft.com/office/drawing/2014/main" id="{B575E145-9D32-3D7F-39FA-75A063745A0B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319742" y="5886633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70" name="타원 169">
                    <a:extLst>
                      <a:ext uri="{FF2B5EF4-FFF2-40B4-BE49-F238E27FC236}">
                        <a16:creationId xmlns:a16="http://schemas.microsoft.com/office/drawing/2014/main" id="{A2AE0EE6-C6B4-AF43-2525-8149F4B8ADE7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370886" y="6015410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71" name="타원 170">
                    <a:extLst>
                      <a:ext uri="{FF2B5EF4-FFF2-40B4-BE49-F238E27FC236}">
                        <a16:creationId xmlns:a16="http://schemas.microsoft.com/office/drawing/2014/main" id="{73FE8356-1A42-546D-B75D-7BA6E22C86A8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394968" y="5996748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72" name="타원 171">
                    <a:extLst>
                      <a:ext uri="{FF2B5EF4-FFF2-40B4-BE49-F238E27FC236}">
                        <a16:creationId xmlns:a16="http://schemas.microsoft.com/office/drawing/2014/main" id="{C552BB11-6D7F-CA8D-7BF4-B16E585C5EC4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41009" y="6041475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73" name="타원 172">
                    <a:extLst>
                      <a:ext uri="{FF2B5EF4-FFF2-40B4-BE49-F238E27FC236}">
                        <a16:creationId xmlns:a16="http://schemas.microsoft.com/office/drawing/2014/main" id="{AEAC778E-1755-F37E-F7EE-10799FF036C5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52441" y="5979391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74" name="타원 173">
                    <a:extLst>
                      <a:ext uri="{FF2B5EF4-FFF2-40B4-BE49-F238E27FC236}">
                        <a16:creationId xmlns:a16="http://schemas.microsoft.com/office/drawing/2014/main" id="{AC5A4807-3BBC-EC5F-3B2E-ECBAC422DFB8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72150" y="6086348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75" name="타원 174">
                    <a:extLst>
                      <a:ext uri="{FF2B5EF4-FFF2-40B4-BE49-F238E27FC236}">
                        <a16:creationId xmlns:a16="http://schemas.microsoft.com/office/drawing/2014/main" id="{A36E3CC6-7AD0-3FA1-06FB-66AD13348A2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98046" y="6028294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76" name="타원 175">
                    <a:extLst>
                      <a:ext uri="{FF2B5EF4-FFF2-40B4-BE49-F238E27FC236}">
                        <a16:creationId xmlns:a16="http://schemas.microsoft.com/office/drawing/2014/main" id="{26A4A6A9-C3DD-97DB-A104-35520938A134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83369" y="5996032"/>
                    <a:ext cx="128960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77" name="타원 176">
                    <a:extLst>
                      <a:ext uri="{FF2B5EF4-FFF2-40B4-BE49-F238E27FC236}">
                        <a16:creationId xmlns:a16="http://schemas.microsoft.com/office/drawing/2014/main" id="{9D297E14-325C-4B50-7DF6-6F5B29C0F959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62958" y="6054066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78" name="타원 177">
                    <a:extLst>
                      <a:ext uri="{FF2B5EF4-FFF2-40B4-BE49-F238E27FC236}">
                        <a16:creationId xmlns:a16="http://schemas.microsoft.com/office/drawing/2014/main" id="{C2456DCE-15A8-CAA2-699F-3D825D0D3ED5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86217" y="5969851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79" name="타원 178">
                    <a:extLst>
                      <a:ext uri="{FF2B5EF4-FFF2-40B4-BE49-F238E27FC236}">
                        <a16:creationId xmlns:a16="http://schemas.microsoft.com/office/drawing/2014/main" id="{3447CA14-6081-5A9F-5794-183A4A641CE4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321537" y="5998741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80" name="타원 179">
                    <a:extLst>
                      <a:ext uri="{FF2B5EF4-FFF2-40B4-BE49-F238E27FC236}">
                        <a16:creationId xmlns:a16="http://schemas.microsoft.com/office/drawing/2014/main" id="{2FD4683B-110A-D2BF-42AD-29A580FAE856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67853" y="5765706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81" name="타원 180">
                    <a:extLst>
                      <a:ext uri="{FF2B5EF4-FFF2-40B4-BE49-F238E27FC236}">
                        <a16:creationId xmlns:a16="http://schemas.microsoft.com/office/drawing/2014/main" id="{A3C629C6-9C8A-284E-36EA-D05ADEC9F0C4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91933" y="5747044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82" name="타원 181">
                    <a:extLst>
                      <a:ext uri="{FF2B5EF4-FFF2-40B4-BE49-F238E27FC236}">
                        <a16:creationId xmlns:a16="http://schemas.microsoft.com/office/drawing/2014/main" id="{C904F675-C34E-A75D-F1BF-B4095CE12E39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37976" y="5791771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83" name="타원 182">
                    <a:extLst>
                      <a:ext uri="{FF2B5EF4-FFF2-40B4-BE49-F238E27FC236}">
                        <a16:creationId xmlns:a16="http://schemas.microsoft.com/office/drawing/2014/main" id="{D86FFE2F-D5B3-E845-5708-29B2F56392AB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49408" y="5729687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84" name="타원 183">
                    <a:extLst>
                      <a:ext uri="{FF2B5EF4-FFF2-40B4-BE49-F238E27FC236}">
                        <a16:creationId xmlns:a16="http://schemas.microsoft.com/office/drawing/2014/main" id="{A1D4E207-968C-3F87-73A2-652F940A2E3B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69117" y="5836644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85" name="타원 184">
                    <a:extLst>
                      <a:ext uri="{FF2B5EF4-FFF2-40B4-BE49-F238E27FC236}">
                        <a16:creationId xmlns:a16="http://schemas.microsoft.com/office/drawing/2014/main" id="{1FBE51E3-769B-E5AB-D6E6-861696A3DB3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95013" y="5778590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86" name="타원 185">
                    <a:extLst>
                      <a:ext uri="{FF2B5EF4-FFF2-40B4-BE49-F238E27FC236}">
                        <a16:creationId xmlns:a16="http://schemas.microsoft.com/office/drawing/2014/main" id="{48D177F5-DA81-A3BF-58F0-BF08D4A100C5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80335" y="5746327"/>
                    <a:ext cx="128960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87" name="타원 186">
                    <a:extLst>
                      <a:ext uri="{FF2B5EF4-FFF2-40B4-BE49-F238E27FC236}">
                        <a16:creationId xmlns:a16="http://schemas.microsoft.com/office/drawing/2014/main" id="{F7C02F84-A9E7-3ABA-2C03-421D128A958D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59923" y="5804363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88" name="타원 187">
                    <a:extLst>
                      <a:ext uri="{FF2B5EF4-FFF2-40B4-BE49-F238E27FC236}">
                        <a16:creationId xmlns:a16="http://schemas.microsoft.com/office/drawing/2014/main" id="{E285F057-8E55-8D3A-B2F1-466B39398851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83182" y="5720147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89" name="타원 188">
                    <a:extLst>
                      <a:ext uri="{FF2B5EF4-FFF2-40B4-BE49-F238E27FC236}">
                        <a16:creationId xmlns:a16="http://schemas.microsoft.com/office/drawing/2014/main" id="{5EDE60DB-CDDF-2CA8-5741-1DEEAF3D1D94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18502" y="5749037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90" name="타원 189">
                    <a:extLst>
                      <a:ext uri="{FF2B5EF4-FFF2-40B4-BE49-F238E27FC236}">
                        <a16:creationId xmlns:a16="http://schemas.microsoft.com/office/drawing/2014/main" id="{7C57F569-A43C-1124-9F0B-61EB3B1EB88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372981" y="5816897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91" name="타원 190">
                    <a:extLst>
                      <a:ext uri="{FF2B5EF4-FFF2-40B4-BE49-F238E27FC236}">
                        <a16:creationId xmlns:a16="http://schemas.microsoft.com/office/drawing/2014/main" id="{FE6AC9CC-1E3B-D419-A87D-169F7E83807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397061" y="5798235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92" name="타원 191">
                    <a:extLst>
                      <a:ext uri="{FF2B5EF4-FFF2-40B4-BE49-F238E27FC236}">
                        <a16:creationId xmlns:a16="http://schemas.microsoft.com/office/drawing/2014/main" id="{9676DC1B-BF99-4441-3CFC-ADADC867C984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43104" y="5842962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93" name="타원 192">
                    <a:extLst>
                      <a:ext uri="{FF2B5EF4-FFF2-40B4-BE49-F238E27FC236}">
                        <a16:creationId xmlns:a16="http://schemas.microsoft.com/office/drawing/2014/main" id="{75B5AFC1-D749-EA83-AC83-53CB6792485A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54536" y="5780876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94" name="타원 193">
                    <a:extLst>
                      <a:ext uri="{FF2B5EF4-FFF2-40B4-BE49-F238E27FC236}">
                        <a16:creationId xmlns:a16="http://schemas.microsoft.com/office/drawing/2014/main" id="{24855721-E54F-9C5D-E5B0-02BA3D560B6E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74245" y="5887833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95" name="타원 194">
                    <a:extLst>
                      <a:ext uri="{FF2B5EF4-FFF2-40B4-BE49-F238E27FC236}">
                        <a16:creationId xmlns:a16="http://schemas.microsoft.com/office/drawing/2014/main" id="{D5E6EBB5-0D88-82EC-6F95-57C93AAB9C7C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300141" y="5829781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96" name="타원 195">
                    <a:extLst>
                      <a:ext uri="{FF2B5EF4-FFF2-40B4-BE49-F238E27FC236}">
                        <a16:creationId xmlns:a16="http://schemas.microsoft.com/office/drawing/2014/main" id="{29B1FCCB-0158-7855-6169-65E9DF939CF5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85462" y="5797517"/>
                    <a:ext cx="128960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97" name="타원 196">
                    <a:extLst>
                      <a:ext uri="{FF2B5EF4-FFF2-40B4-BE49-F238E27FC236}">
                        <a16:creationId xmlns:a16="http://schemas.microsoft.com/office/drawing/2014/main" id="{A7149A07-2114-9B5A-0353-3208CEB23DC0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65051" y="5855552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98" name="타원 197">
                    <a:extLst>
                      <a:ext uri="{FF2B5EF4-FFF2-40B4-BE49-F238E27FC236}">
                        <a16:creationId xmlns:a16="http://schemas.microsoft.com/office/drawing/2014/main" id="{02C95278-266F-44E6-5A1F-01611E0F223E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88311" y="5771336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199" name="타원 198">
                    <a:extLst>
                      <a:ext uri="{FF2B5EF4-FFF2-40B4-BE49-F238E27FC236}">
                        <a16:creationId xmlns:a16="http://schemas.microsoft.com/office/drawing/2014/main" id="{1B490DC0-0ACB-3956-6D8B-0F7A8738E0B1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323630" y="5800228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00" name="타원 199">
                    <a:extLst>
                      <a:ext uri="{FF2B5EF4-FFF2-40B4-BE49-F238E27FC236}">
                        <a16:creationId xmlns:a16="http://schemas.microsoft.com/office/drawing/2014/main" id="{FD2114DA-EED8-C698-0EF2-E3319D5FD2A3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32446" y="6039843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01" name="타원 200">
                    <a:extLst>
                      <a:ext uri="{FF2B5EF4-FFF2-40B4-BE49-F238E27FC236}">
                        <a16:creationId xmlns:a16="http://schemas.microsoft.com/office/drawing/2014/main" id="{84B188F4-3D5E-56FE-0FA2-2207EC4065C2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56528" y="6021180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02" name="타원 201">
                    <a:extLst>
                      <a:ext uri="{FF2B5EF4-FFF2-40B4-BE49-F238E27FC236}">
                        <a16:creationId xmlns:a16="http://schemas.microsoft.com/office/drawing/2014/main" id="{D504ED8D-8E61-0DC9-6890-E65460946FF9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02570" y="6065907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03" name="타원 202">
                    <a:extLst>
                      <a:ext uri="{FF2B5EF4-FFF2-40B4-BE49-F238E27FC236}">
                        <a16:creationId xmlns:a16="http://schemas.microsoft.com/office/drawing/2014/main" id="{8B7E4FCC-1770-EA29-E721-BA54A2707430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14001" y="6003822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04" name="타원 203">
                    <a:extLst>
                      <a:ext uri="{FF2B5EF4-FFF2-40B4-BE49-F238E27FC236}">
                        <a16:creationId xmlns:a16="http://schemas.microsoft.com/office/drawing/2014/main" id="{7BBDDAA8-58FC-9002-FAC3-B9E2A41A8777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33710" y="6110779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05" name="타원 204">
                    <a:extLst>
                      <a:ext uri="{FF2B5EF4-FFF2-40B4-BE49-F238E27FC236}">
                        <a16:creationId xmlns:a16="http://schemas.microsoft.com/office/drawing/2014/main" id="{0CC94C83-3E33-AA0F-137C-C39237020AE1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59607" y="6052726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06" name="타원 205">
                    <a:extLst>
                      <a:ext uri="{FF2B5EF4-FFF2-40B4-BE49-F238E27FC236}">
                        <a16:creationId xmlns:a16="http://schemas.microsoft.com/office/drawing/2014/main" id="{ECD564A4-4750-36B0-D067-FC4A2DB71698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50485" y="6017621"/>
                    <a:ext cx="128960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07" name="타원 206">
                    <a:extLst>
                      <a:ext uri="{FF2B5EF4-FFF2-40B4-BE49-F238E27FC236}">
                        <a16:creationId xmlns:a16="http://schemas.microsoft.com/office/drawing/2014/main" id="{766A3169-E7CA-58A6-2ACA-D76166E2FC14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24518" y="6078500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08" name="타원 207">
                    <a:extLst>
                      <a:ext uri="{FF2B5EF4-FFF2-40B4-BE49-F238E27FC236}">
                        <a16:creationId xmlns:a16="http://schemas.microsoft.com/office/drawing/2014/main" id="{CAEB4276-1ED1-DFF9-F81C-EDC75A2D4ED1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47777" y="5994284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09" name="타원 208">
                    <a:extLst>
                      <a:ext uri="{FF2B5EF4-FFF2-40B4-BE49-F238E27FC236}">
                        <a16:creationId xmlns:a16="http://schemas.microsoft.com/office/drawing/2014/main" id="{2805298F-5B1F-BC8C-85E3-FE135DD54206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83097" y="6023175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10" name="타원 209">
                    <a:extLst>
                      <a:ext uri="{FF2B5EF4-FFF2-40B4-BE49-F238E27FC236}">
                        <a16:creationId xmlns:a16="http://schemas.microsoft.com/office/drawing/2014/main" id="{ABFA214D-C114-64A2-2D14-A18704FF0116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69975" y="6016712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11" name="타원 210">
                    <a:extLst>
                      <a:ext uri="{FF2B5EF4-FFF2-40B4-BE49-F238E27FC236}">
                        <a16:creationId xmlns:a16="http://schemas.microsoft.com/office/drawing/2014/main" id="{CBCA4F05-F846-0A17-D95E-7546EB966C32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94056" y="5998049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12" name="타원 211">
                    <a:extLst>
                      <a:ext uri="{FF2B5EF4-FFF2-40B4-BE49-F238E27FC236}">
                        <a16:creationId xmlns:a16="http://schemas.microsoft.com/office/drawing/2014/main" id="{34BF042F-D7EB-4F49-1694-9D84356E6DC9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940098" y="6042776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13" name="타원 212">
                    <a:extLst>
                      <a:ext uri="{FF2B5EF4-FFF2-40B4-BE49-F238E27FC236}">
                        <a16:creationId xmlns:a16="http://schemas.microsoft.com/office/drawing/2014/main" id="{2940BC93-888F-6FEC-ECBA-797EC07925BE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951530" y="5980691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14" name="타원 213">
                    <a:extLst>
                      <a:ext uri="{FF2B5EF4-FFF2-40B4-BE49-F238E27FC236}">
                        <a16:creationId xmlns:a16="http://schemas.microsoft.com/office/drawing/2014/main" id="{FC95E2F9-1B08-7AD5-FDC1-8E0C71261D02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971239" y="6087648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15" name="타원 214">
                    <a:extLst>
                      <a:ext uri="{FF2B5EF4-FFF2-40B4-BE49-F238E27FC236}">
                        <a16:creationId xmlns:a16="http://schemas.microsoft.com/office/drawing/2014/main" id="{FA077E4A-DA7C-C8AF-A6D7-E98B81240257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997135" y="6029595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16" name="타원 215">
                    <a:extLst>
                      <a:ext uri="{FF2B5EF4-FFF2-40B4-BE49-F238E27FC236}">
                        <a16:creationId xmlns:a16="http://schemas.microsoft.com/office/drawing/2014/main" id="{7CFE2FE1-5680-E825-BFF0-65B1431DD4F1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982458" y="5997334"/>
                    <a:ext cx="128960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17" name="타원 216">
                    <a:extLst>
                      <a:ext uri="{FF2B5EF4-FFF2-40B4-BE49-F238E27FC236}">
                        <a16:creationId xmlns:a16="http://schemas.microsoft.com/office/drawing/2014/main" id="{E76562B8-8770-7C06-1FA0-BEBBB0AE1921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962046" y="6055369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18" name="타원 217">
                    <a:extLst>
                      <a:ext uri="{FF2B5EF4-FFF2-40B4-BE49-F238E27FC236}">
                        <a16:creationId xmlns:a16="http://schemas.microsoft.com/office/drawing/2014/main" id="{94528318-07FF-6C44-66E3-447335C64873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985305" y="5971153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19" name="타원 218">
                    <a:extLst>
                      <a:ext uri="{FF2B5EF4-FFF2-40B4-BE49-F238E27FC236}">
                        <a16:creationId xmlns:a16="http://schemas.microsoft.com/office/drawing/2014/main" id="{42EB60A9-1BC6-8D8B-6668-72EB3DFD8A45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20625" y="6000045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20" name="타원 219">
                    <a:extLst>
                      <a:ext uri="{FF2B5EF4-FFF2-40B4-BE49-F238E27FC236}">
                        <a16:creationId xmlns:a16="http://schemas.microsoft.com/office/drawing/2014/main" id="{EF9B14D7-B8EC-9482-C6AB-7C482161331E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91602" y="5806993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21" name="타원 220">
                    <a:extLst>
                      <a:ext uri="{FF2B5EF4-FFF2-40B4-BE49-F238E27FC236}">
                        <a16:creationId xmlns:a16="http://schemas.microsoft.com/office/drawing/2014/main" id="{0CAC463D-EA39-CBE5-CD84-DEBA79C19BDD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15684" y="5788330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22" name="타원 221">
                    <a:extLst>
                      <a:ext uri="{FF2B5EF4-FFF2-40B4-BE49-F238E27FC236}">
                        <a16:creationId xmlns:a16="http://schemas.microsoft.com/office/drawing/2014/main" id="{C2229101-5ECC-4474-788A-E00DE896F540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961727" y="5833057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23" name="타원 222">
                    <a:extLst>
                      <a:ext uri="{FF2B5EF4-FFF2-40B4-BE49-F238E27FC236}">
                        <a16:creationId xmlns:a16="http://schemas.microsoft.com/office/drawing/2014/main" id="{348C524B-28BD-B4A2-9F99-FF132C3B917E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991835" y="5797729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24" name="타원 223">
                    <a:extLst>
                      <a:ext uri="{FF2B5EF4-FFF2-40B4-BE49-F238E27FC236}">
                        <a16:creationId xmlns:a16="http://schemas.microsoft.com/office/drawing/2014/main" id="{A8456191-332F-1756-2E89-E9AC73CEFC83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992866" y="5877929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25" name="타원 224">
                    <a:extLst>
                      <a:ext uri="{FF2B5EF4-FFF2-40B4-BE49-F238E27FC236}">
                        <a16:creationId xmlns:a16="http://schemas.microsoft.com/office/drawing/2014/main" id="{970326B7-821C-E098-7DB9-1243771DE519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18762" y="5819876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26" name="타원 225">
                    <a:extLst>
                      <a:ext uri="{FF2B5EF4-FFF2-40B4-BE49-F238E27FC236}">
                        <a16:creationId xmlns:a16="http://schemas.microsoft.com/office/drawing/2014/main" id="{0119C25B-8149-9423-1E0A-5544904049BD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944217" y="5842403"/>
                    <a:ext cx="128960" cy="147466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27" name="타원 226">
                    <a:extLst>
                      <a:ext uri="{FF2B5EF4-FFF2-40B4-BE49-F238E27FC236}">
                        <a16:creationId xmlns:a16="http://schemas.microsoft.com/office/drawing/2014/main" id="{372B4F42-F3A5-B2AE-57B3-445FA3864EEC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926007" y="5974405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28" name="타원 227">
                    <a:extLst>
                      <a:ext uri="{FF2B5EF4-FFF2-40B4-BE49-F238E27FC236}">
                        <a16:creationId xmlns:a16="http://schemas.microsoft.com/office/drawing/2014/main" id="{31935110-0D92-195B-6BA3-1CFD7F0F9F99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06933" y="5761432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29" name="타원 228">
                    <a:extLst>
                      <a:ext uri="{FF2B5EF4-FFF2-40B4-BE49-F238E27FC236}">
                        <a16:creationId xmlns:a16="http://schemas.microsoft.com/office/drawing/2014/main" id="{CD92F184-EA22-923C-1C13-7CD8356BF950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42253" y="5790323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30" name="타원 229">
                    <a:extLst>
                      <a:ext uri="{FF2B5EF4-FFF2-40B4-BE49-F238E27FC236}">
                        <a16:creationId xmlns:a16="http://schemas.microsoft.com/office/drawing/2014/main" id="{85D14F38-95BC-75B8-BFA3-18A06661F264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13302" y="6025932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31" name="타원 230">
                    <a:extLst>
                      <a:ext uri="{FF2B5EF4-FFF2-40B4-BE49-F238E27FC236}">
                        <a16:creationId xmlns:a16="http://schemas.microsoft.com/office/drawing/2014/main" id="{71563D4D-9D79-689C-08C5-477FFD047DC8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07564" y="5865787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32" name="타원 231">
                    <a:extLst>
                      <a:ext uri="{FF2B5EF4-FFF2-40B4-BE49-F238E27FC236}">
                        <a16:creationId xmlns:a16="http://schemas.microsoft.com/office/drawing/2014/main" id="{22237BFE-9586-48BD-74B3-212ABC970FCB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95416" y="6055707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33" name="타원 232">
                    <a:extLst>
                      <a:ext uri="{FF2B5EF4-FFF2-40B4-BE49-F238E27FC236}">
                        <a16:creationId xmlns:a16="http://schemas.microsoft.com/office/drawing/2014/main" id="{1B13E81E-6AF7-BDBF-ACC2-116C8587D7B8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80432" y="6097465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34" name="타원 233">
                    <a:extLst>
                      <a:ext uri="{FF2B5EF4-FFF2-40B4-BE49-F238E27FC236}">
                        <a16:creationId xmlns:a16="http://schemas.microsoft.com/office/drawing/2014/main" id="{DDAC7072-42BB-CF14-05A7-5480AA01721C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931315" y="5907070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35" name="타원 234">
                    <a:extLst>
                      <a:ext uri="{FF2B5EF4-FFF2-40B4-BE49-F238E27FC236}">
                        <a16:creationId xmlns:a16="http://schemas.microsoft.com/office/drawing/2014/main" id="{94DDD2C2-8010-E62D-512B-68487FD8A50D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949721" y="5874540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36" name="타원 235">
                    <a:extLst>
                      <a:ext uri="{FF2B5EF4-FFF2-40B4-BE49-F238E27FC236}">
                        <a16:creationId xmlns:a16="http://schemas.microsoft.com/office/drawing/2014/main" id="{1BF74095-106F-52FC-07DB-A7C9C029BC57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42010" y="5971568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37" name="타원 236">
                    <a:extLst>
                      <a:ext uri="{FF2B5EF4-FFF2-40B4-BE49-F238E27FC236}">
                        <a16:creationId xmlns:a16="http://schemas.microsoft.com/office/drawing/2014/main" id="{2EB5D50F-831B-CAA4-488D-B312F8696EB6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36273" y="5811424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38" name="타원 237">
                    <a:extLst>
                      <a:ext uri="{FF2B5EF4-FFF2-40B4-BE49-F238E27FC236}">
                        <a16:creationId xmlns:a16="http://schemas.microsoft.com/office/drawing/2014/main" id="{AB6F2A26-317C-3AF3-6E85-E207C388453B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24127" y="6001343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39" name="타원 238">
                    <a:extLst>
                      <a:ext uri="{FF2B5EF4-FFF2-40B4-BE49-F238E27FC236}">
                        <a16:creationId xmlns:a16="http://schemas.microsoft.com/office/drawing/2014/main" id="{FD949666-AE22-BAC0-1D19-0FA975D2B6C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259447" y="6030235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40" name="타원 239">
                    <a:extLst>
                      <a:ext uri="{FF2B5EF4-FFF2-40B4-BE49-F238E27FC236}">
                        <a16:creationId xmlns:a16="http://schemas.microsoft.com/office/drawing/2014/main" id="{59BC3547-2894-C898-B1D5-995776B78329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60024" y="5852705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41" name="타원 240">
                    <a:extLst>
                      <a:ext uri="{FF2B5EF4-FFF2-40B4-BE49-F238E27FC236}">
                        <a16:creationId xmlns:a16="http://schemas.microsoft.com/office/drawing/2014/main" id="{06F55A36-E1FF-40D7-C839-D027D80B0E16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18603" y="5797378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42" name="타원 241">
                    <a:extLst>
                      <a:ext uri="{FF2B5EF4-FFF2-40B4-BE49-F238E27FC236}">
                        <a16:creationId xmlns:a16="http://schemas.microsoft.com/office/drawing/2014/main" id="{200E9445-6DB1-1310-DC39-6D0575A84183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71645" y="5748741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43" name="타원 242">
                    <a:extLst>
                      <a:ext uri="{FF2B5EF4-FFF2-40B4-BE49-F238E27FC236}">
                        <a16:creationId xmlns:a16="http://schemas.microsoft.com/office/drawing/2014/main" id="{AE761D69-51CB-E7E0-6578-E7C48689AF4D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131318" y="5753042"/>
                    <a:ext cx="58822" cy="62652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44" name="타원 243">
                    <a:extLst>
                      <a:ext uri="{FF2B5EF4-FFF2-40B4-BE49-F238E27FC236}">
                        <a16:creationId xmlns:a16="http://schemas.microsoft.com/office/drawing/2014/main" id="{A6B81A99-D09E-163E-D83A-2D0CC31E736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4056863" y="5759527"/>
                    <a:ext cx="45719" cy="45719"/>
                  </a:xfrm>
                  <a:prstGeom prst="ellipse">
                    <a:avLst/>
                  </a:prstGeom>
                  <a:solidFill>
                    <a:srgbClr val="C00000"/>
                  </a:solidFill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sp>
                <p:nvSpPr>
                  <p:cNvPr id="245" name="TextBox 244">
                    <a:extLst>
                      <a:ext uri="{FF2B5EF4-FFF2-40B4-BE49-F238E27FC236}">
                        <a16:creationId xmlns:a16="http://schemas.microsoft.com/office/drawing/2014/main" id="{3381D95E-3D47-39B5-C20F-636AF918BB8B}"/>
                      </a:ext>
                    </a:extLst>
                  </p:cNvPr>
                  <p:cNvSpPr txBox="1"/>
                  <p:nvPr/>
                </p:nvSpPr>
                <p:spPr>
                  <a:xfrm>
                    <a:off x="1868575" y="4142138"/>
                    <a:ext cx="1808664" cy="57275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>
                      <a:lnSpc>
                        <a:spcPts val="400"/>
                      </a:lnSpc>
                    </a:pPr>
                    <a:r>
                      <a:rPr lang="en-US" altLang="ko-KR" sz="500" b="1">
                        <a:solidFill>
                          <a:schemeClr val="bg1"/>
                        </a:solidFill>
                        <a:latin typeface="+mn-ea"/>
                      </a:rPr>
                      <a:t>Dispensing </a:t>
                    </a:r>
                  </a:p>
                  <a:p>
                    <a:pPr algn="ctr">
                      <a:lnSpc>
                        <a:spcPts val="400"/>
                      </a:lnSpc>
                    </a:pPr>
                    <a:r>
                      <a:rPr lang="en-US" altLang="ko-KR" sz="500" b="1">
                        <a:solidFill>
                          <a:schemeClr val="bg1"/>
                        </a:solidFill>
                        <a:latin typeface="+mn-ea"/>
                      </a:rPr>
                      <a:t>Head</a:t>
                    </a:r>
                    <a:endParaRPr lang="ko-KR" altLang="en-US" sz="500" b="1" dirty="0">
                      <a:solidFill>
                        <a:schemeClr val="bg1"/>
                      </a:solidFill>
                      <a:latin typeface="+mn-ea"/>
                    </a:endParaRPr>
                  </a:p>
                </p:txBody>
              </p:sp>
              <p:sp>
                <p:nvSpPr>
                  <p:cNvPr id="246" name="TextBox 245">
                    <a:extLst>
                      <a:ext uri="{FF2B5EF4-FFF2-40B4-BE49-F238E27FC236}">
                        <a16:creationId xmlns:a16="http://schemas.microsoft.com/office/drawing/2014/main" id="{7F550949-3805-C4A1-7711-3DEA610F81F3}"/>
                      </a:ext>
                    </a:extLst>
                  </p:cNvPr>
                  <p:cNvSpPr txBox="1"/>
                  <p:nvPr/>
                </p:nvSpPr>
                <p:spPr>
                  <a:xfrm>
                    <a:off x="1766804" y="4643208"/>
                    <a:ext cx="1803297" cy="57275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>
                      <a:lnSpc>
                        <a:spcPts val="400"/>
                      </a:lnSpc>
                    </a:pPr>
                    <a:r>
                      <a:rPr lang="en-US" altLang="ko-KR" sz="500" b="1">
                        <a:solidFill>
                          <a:schemeClr val="bg1"/>
                        </a:solidFill>
                        <a:latin typeface="+mn-ea"/>
                      </a:rPr>
                      <a:t>Disposable </a:t>
                    </a:r>
                  </a:p>
                  <a:p>
                    <a:pPr algn="ctr">
                      <a:lnSpc>
                        <a:spcPts val="400"/>
                      </a:lnSpc>
                    </a:pPr>
                    <a:r>
                      <a:rPr lang="en-US" altLang="ko-KR" sz="500" b="1">
                        <a:solidFill>
                          <a:schemeClr val="bg1"/>
                        </a:solidFill>
                        <a:latin typeface="+mn-ea"/>
                      </a:rPr>
                      <a:t>Nozzle</a:t>
                    </a:r>
                    <a:endParaRPr lang="ko-KR" altLang="en-US" sz="500" b="1" dirty="0">
                      <a:solidFill>
                        <a:schemeClr val="bg1"/>
                      </a:solidFill>
                      <a:latin typeface="+mn-ea"/>
                    </a:endParaRPr>
                  </a:p>
                </p:txBody>
              </p:sp>
              <p:sp>
                <p:nvSpPr>
                  <p:cNvPr id="249" name="순서도: 지연 248">
                    <a:extLst>
                      <a:ext uri="{FF2B5EF4-FFF2-40B4-BE49-F238E27FC236}">
                        <a16:creationId xmlns:a16="http://schemas.microsoft.com/office/drawing/2014/main" id="{5592D9A8-C192-991F-5814-09427D8A4D4D}"/>
                      </a:ext>
                    </a:extLst>
                  </p:cNvPr>
                  <p:cNvSpPr/>
                  <p:nvPr/>
                </p:nvSpPr>
                <p:spPr>
                  <a:xfrm rot="6872222">
                    <a:off x="5761481" y="4194824"/>
                    <a:ext cx="728057" cy="220698"/>
                  </a:xfrm>
                  <a:prstGeom prst="flowChartDelay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28575">
                    <a:solidFill>
                      <a:schemeClr val="tx1"/>
                    </a:solidFill>
                  </a:ln>
                  <a:scene3d>
                    <a:camera prst="orthographicFront"/>
                    <a:lightRig rig="threePt" dir="t"/>
                  </a:scene3d>
                  <a:sp3d>
                    <a:bevelT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00" b="1">
                      <a:latin typeface="+mn-ea"/>
                    </a:endParaRPr>
                  </a:p>
                </p:txBody>
              </p:sp>
              <p:pic>
                <p:nvPicPr>
                  <p:cNvPr id="250" name="그래픽 249" descr="시계 방향으로 굽은 줄 화살표">
                    <a:extLst>
                      <a:ext uri="{FF2B5EF4-FFF2-40B4-BE49-F238E27FC236}">
                        <a16:creationId xmlns:a16="http://schemas.microsoft.com/office/drawing/2014/main" id="{C62987E0-2EED-C84A-BACC-E63A4623BD5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9">
                    <a:extLst>
                      <a:ext uri="{28A0092B-C50C-407E-A947-70E740481C1C}">
                        <a14:useLocalDpi xmlns:a14="http://schemas.microsoft.com/office/drawing/2010/main" val="0"/>
                      </a:ext>
                      <a:ext uri="{96DAC541-7B7A-43D3-8B79-37D633B846F1}">
                        <asvg:svgBlip xmlns:asvg="http://schemas.microsoft.com/office/drawing/2016/SVG/main" xmlns="" r:embed="rId11"/>
                      </a:ext>
                    </a:extLst>
                  </a:blip>
                  <a:stretch>
                    <a:fillRect/>
                  </a:stretch>
                </p:blipFill>
                <p:spPr>
                  <a:xfrm rot="5400000">
                    <a:off x="5718473" y="3731037"/>
                    <a:ext cx="426575" cy="426574"/>
                  </a:xfrm>
                  <a:prstGeom prst="rect">
                    <a:avLst/>
                  </a:prstGeom>
                </p:spPr>
              </p:pic>
            </p:grpSp>
            <p:pic>
              <p:nvPicPr>
                <p:cNvPr id="4" name="그림 3">
                  <a:extLst>
                    <a:ext uri="{FF2B5EF4-FFF2-40B4-BE49-F238E27FC236}">
                      <a16:creationId xmlns:a16="http://schemas.microsoft.com/office/drawing/2014/main" id="{8A33626A-8699-B28E-6762-B5724937E66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/>
                <a:srcRect t="20322"/>
                <a:stretch/>
              </p:blipFill>
              <p:spPr>
                <a:xfrm>
                  <a:off x="2786100" y="4466603"/>
                  <a:ext cx="1834920" cy="1122776"/>
                </a:xfrm>
                <a:prstGeom prst="rect">
                  <a:avLst/>
                </a:prstGeom>
              </p:spPr>
            </p:pic>
          </p:grpSp>
          <p:pic>
            <p:nvPicPr>
              <p:cNvPr id="247" name="그림 246">
                <a:extLst>
                  <a:ext uri="{FF2B5EF4-FFF2-40B4-BE49-F238E27FC236}">
                    <a16:creationId xmlns:a16="http://schemas.microsoft.com/office/drawing/2014/main" id="{36D418F1-DF49-80D2-CEC9-86053CA5775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1266485" y="8516194"/>
                <a:ext cx="122400" cy="129600"/>
              </a:xfrm>
              <a:prstGeom prst="rect">
                <a:avLst/>
              </a:prstGeom>
              <a:ln w="19050">
                <a:noFill/>
              </a:ln>
            </p:spPr>
          </p:pic>
          <p:pic>
            <p:nvPicPr>
              <p:cNvPr id="255" name="그림 254">
                <a:extLst>
                  <a:ext uri="{FF2B5EF4-FFF2-40B4-BE49-F238E27FC236}">
                    <a16:creationId xmlns:a16="http://schemas.microsoft.com/office/drawing/2014/main" id="{76615647-A3E6-E2C6-A6E3-B48DD760AF4C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 rot="18398590">
                <a:off x="967194" y="8798747"/>
                <a:ext cx="122400" cy="129600"/>
              </a:xfrm>
              <a:prstGeom prst="rect">
                <a:avLst/>
              </a:prstGeom>
              <a:ln w="19050">
                <a:noFill/>
              </a:ln>
            </p:spPr>
          </p:pic>
        </p:grpSp>
      </p:grpSp>
    </p:spTree>
    <p:extLst>
      <p:ext uri="{BB962C8B-B14F-4D97-AF65-F5344CB8AC3E}">
        <p14:creationId xmlns:p14="http://schemas.microsoft.com/office/powerpoint/2010/main" val="3045558045"/>
      </p:ext>
    </p:extLst>
  </p:cSld>
  <p:clrMapOvr>
    <a:masterClrMapping/>
  </p:clrMapOvr>
  <p:extLst mod="1">
    <p:ext uri="{6950BFC3-D8DA-4A85-94F7-54DA5524770B}">
      <p188:commentRel xmlns:p188="http://schemas.microsoft.com/office/powerpoint/2018/8/main" xmlns="" r:id="rId14"/>
    </p:ext>
  </p:extLs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1" y="28528"/>
            <a:ext cx="6858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/>
              <a:t>Supple Fig. S2. (a) </a:t>
            </a:r>
            <a:r>
              <a:rPr lang="en-US" altLang="ko-KR" sz="1400" dirty="0"/>
              <a:t>Pie chart of the number of drug response data/sample. We  obtained an average of 6.3 anticancer drug response data/sample from 103 patients. (</a:t>
            </a:r>
            <a:r>
              <a:rPr lang="en-US" altLang="ko-KR" sz="1400" dirty="0" smtClean="0"/>
              <a:t>b) </a:t>
            </a:r>
            <a:r>
              <a:rPr lang="en-US" altLang="ko-KR" sz="1400" dirty="0"/>
              <a:t>Pearson correlation analysis of tissue weight, number of live cells, tumor purity, and obtained drug data.</a:t>
            </a:r>
            <a:endParaRPr lang="ko-KR" altLang="en-US" sz="1400" dirty="0"/>
          </a:p>
        </p:txBody>
      </p:sp>
      <p:grpSp>
        <p:nvGrpSpPr>
          <p:cNvPr id="4" name="그룹 3"/>
          <p:cNvGrpSpPr/>
          <p:nvPr/>
        </p:nvGrpSpPr>
        <p:grpSpPr>
          <a:xfrm>
            <a:off x="432580" y="1515355"/>
            <a:ext cx="6230652" cy="3499407"/>
            <a:chOff x="432580" y="1515355"/>
            <a:chExt cx="6230652" cy="3499407"/>
          </a:xfrm>
        </p:grpSpPr>
        <p:pic>
          <p:nvPicPr>
            <p:cNvPr id="9" name="그림 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2580" y="1515355"/>
              <a:ext cx="6230652" cy="3499407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4243561" y="4403558"/>
              <a:ext cx="537445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.4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F9305815-914B-4144-9E5D-72948E0A8CE9}"/>
              </a:ext>
            </a:extLst>
          </p:cNvPr>
          <p:cNvSpPr txBox="1"/>
          <p:nvPr/>
        </p:nvSpPr>
        <p:spPr>
          <a:xfrm>
            <a:off x="119805" y="1256706"/>
            <a:ext cx="3403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9305815-914B-4144-9E5D-72948E0A8CE9}"/>
              </a:ext>
            </a:extLst>
          </p:cNvPr>
          <p:cNvSpPr txBox="1"/>
          <p:nvPr/>
        </p:nvSpPr>
        <p:spPr>
          <a:xfrm>
            <a:off x="250714" y="5824480"/>
            <a:ext cx="3637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2580" y="5698378"/>
            <a:ext cx="4249280" cy="33530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69071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7771247-6059-EA9B-1FDD-5F9928AEC7D2}"/>
              </a:ext>
            </a:extLst>
          </p:cNvPr>
          <p:cNvSpPr txBox="1"/>
          <p:nvPr/>
        </p:nvSpPr>
        <p:spPr>
          <a:xfrm>
            <a:off x="1" y="28528"/>
            <a:ext cx="6858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Supple Fig. </a:t>
            </a:r>
            <a:r>
              <a:rPr lang="en-US" altLang="ko-KR" sz="1400" b="1" dirty="0" smtClean="0"/>
              <a:t>S3. </a:t>
            </a:r>
            <a:r>
              <a:rPr lang="en-US" altLang="ko-KR" sz="1400" dirty="0"/>
              <a:t>Correlation plot showing genotype similarity between each whole-exome sequencing (DNA) / mRNA sequencing (RNA) sample. </a:t>
            </a:r>
            <a:endParaRPr lang="ko-KR" altLang="en-US" sz="1400" dirty="0"/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C8D1CF02-FD7C-394F-E307-8CA4E0A313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4734" y="721733"/>
            <a:ext cx="4928532" cy="53099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88487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7771247-6059-EA9B-1FDD-5F9928AEC7D2}"/>
              </a:ext>
            </a:extLst>
          </p:cNvPr>
          <p:cNvSpPr txBox="1"/>
          <p:nvPr/>
        </p:nvSpPr>
        <p:spPr>
          <a:xfrm>
            <a:off x="1" y="28528"/>
            <a:ext cx="6858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Supple Fig. </a:t>
            </a:r>
            <a:r>
              <a:rPr lang="en-US" altLang="ko-KR" sz="1400" b="1" dirty="0" smtClean="0"/>
              <a:t>S4. </a:t>
            </a:r>
            <a:r>
              <a:rPr lang="en-US" altLang="ko-KR" sz="1400" dirty="0"/>
              <a:t>Correlation plot showing similarity between each whole-exome sequencing sample. Similarity are measured by percentage of overlap, Jaccard index, and Pearson correlation coefficient for</a:t>
            </a:r>
            <a:r>
              <a:rPr lang="ko-KR" altLang="en-US" sz="1400" dirty="0"/>
              <a:t> </a:t>
            </a:r>
            <a:r>
              <a:rPr lang="en-US" altLang="ko-KR" sz="1400" dirty="0"/>
              <a:t>(a) mutation signatures, (b) somatic mutations, and (c) copy number alternation (CNA), respectively.</a:t>
            </a:r>
            <a:endParaRPr lang="ko-KR" altLang="en-US" sz="1400" dirty="0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587" y="1339265"/>
            <a:ext cx="6620828" cy="21169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21547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C257126-43BA-182E-8270-85F1E06429C6}"/>
              </a:ext>
            </a:extLst>
          </p:cNvPr>
          <p:cNvSpPr txBox="1"/>
          <p:nvPr/>
        </p:nvSpPr>
        <p:spPr>
          <a:xfrm>
            <a:off x="1" y="28528"/>
            <a:ext cx="6858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Supple Fig. </a:t>
            </a:r>
            <a:r>
              <a:rPr lang="en-US" altLang="ko-KR" sz="1400" b="1" dirty="0" smtClean="0"/>
              <a:t>S5. </a:t>
            </a:r>
            <a:r>
              <a:rPr lang="en-US" altLang="ko-KR" sz="1400" dirty="0"/>
              <a:t>Autosomal copy number alternation profiles of </a:t>
            </a:r>
            <a:r>
              <a:rPr lang="en-US" altLang="ko-KR" sz="1400" dirty="0" err="1"/>
              <a:t>tumoroids</a:t>
            </a:r>
            <a:r>
              <a:rPr lang="en-US" altLang="ko-KR" sz="1400" dirty="0"/>
              <a:t> and their parental primary tumors.</a:t>
            </a:r>
            <a:endParaRPr lang="ko-KR" altLang="en-US" sz="1400" dirty="0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2CA0965D-0609-5A26-AFC0-6E4DF86B92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6714" y="619002"/>
            <a:ext cx="5964572" cy="38907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916978"/>
      </p:ext>
    </p:extLst>
  </p:cSld>
  <p:clrMapOvr>
    <a:masterClrMapping/>
  </p:clrMapOvr>
  <p:extLst mod="1">
    <p:ext uri="{6950BFC3-D8DA-4A85-94F7-54DA5524770B}">
      <p188:commentRel xmlns:p188="http://schemas.microsoft.com/office/powerpoint/2018/8/main" xmlns="" r:id="rId3"/>
    </p:ext>
  </p:extLst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08283" y="863638"/>
            <a:ext cx="3248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a</a:t>
            </a:r>
            <a:endParaRPr lang="ko-KR" alt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3026326" y="863638"/>
            <a:ext cx="32485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b="1" dirty="0"/>
              <a:t>b</a:t>
            </a:r>
            <a:endParaRPr lang="ko-KR" altLang="en-US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41E2875-D73B-75AF-11D1-638E36390929}"/>
              </a:ext>
            </a:extLst>
          </p:cNvPr>
          <p:cNvSpPr txBox="1"/>
          <p:nvPr/>
        </p:nvSpPr>
        <p:spPr>
          <a:xfrm>
            <a:off x="1" y="28528"/>
            <a:ext cx="6858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Supple Fig. </a:t>
            </a:r>
            <a:r>
              <a:rPr lang="en-US" altLang="ko-KR" sz="1400" b="1" dirty="0" smtClean="0"/>
              <a:t>S6. </a:t>
            </a:r>
            <a:r>
              <a:rPr lang="en-US" altLang="ko-KR" sz="1400" dirty="0"/>
              <a:t>Scatter plot showing similarity between </a:t>
            </a:r>
            <a:r>
              <a:rPr lang="en-US" altLang="ko-KR" sz="1400" dirty="0" err="1"/>
              <a:t>tumoroid</a:t>
            </a:r>
            <a:r>
              <a:rPr lang="en-US" altLang="ko-KR" sz="1400" dirty="0"/>
              <a:t> and parental primary tumor according to (a) a purity of primary tumor and (b) the passage number of </a:t>
            </a:r>
            <a:r>
              <a:rPr lang="en-US" altLang="ko-KR" sz="1400" dirty="0" err="1"/>
              <a:t>tumoroid</a:t>
            </a:r>
            <a:r>
              <a:rPr lang="en-US" altLang="ko-KR" sz="1400" dirty="0"/>
              <a:t>. CNA;</a:t>
            </a:r>
            <a:r>
              <a:rPr lang="ko-KR" altLang="en-US" sz="1400" dirty="0"/>
              <a:t> </a:t>
            </a:r>
            <a:r>
              <a:rPr lang="en-US" altLang="ko-KR" sz="1400" dirty="0"/>
              <a:t>copy</a:t>
            </a:r>
            <a:r>
              <a:rPr lang="ko-KR" altLang="en-US" sz="1400" dirty="0"/>
              <a:t> </a:t>
            </a:r>
            <a:r>
              <a:rPr lang="en-US" altLang="ko-KR" sz="1400" dirty="0"/>
              <a:t>number</a:t>
            </a:r>
            <a:r>
              <a:rPr lang="ko-KR" altLang="en-US" sz="1400" dirty="0"/>
              <a:t> </a:t>
            </a:r>
            <a:r>
              <a:rPr lang="en-US" altLang="ko-KR" sz="1400" dirty="0"/>
              <a:t>alternation</a:t>
            </a:r>
            <a:endParaRPr lang="ko-KR" altLang="en-US" sz="1400" dirty="0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/>
          <a:srcRect r="1579"/>
          <a:stretch/>
        </p:blipFill>
        <p:spPr>
          <a:xfrm>
            <a:off x="270710" y="1329416"/>
            <a:ext cx="5624764" cy="25831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4988131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6CFBA36-5F25-2C61-A47E-28E736E07FE1}"/>
              </a:ext>
            </a:extLst>
          </p:cNvPr>
          <p:cNvSpPr txBox="1"/>
          <p:nvPr/>
        </p:nvSpPr>
        <p:spPr>
          <a:xfrm>
            <a:off x="1" y="28528"/>
            <a:ext cx="6858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Supple Fig. </a:t>
            </a:r>
            <a:r>
              <a:rPr lang="en-US" altLang="ko-KR" sz="1400" b="1" dirty="0" smtClean="0"/>
              <a:t>S7. </a:t>
            </a:r>
            <a:r>
              <a:rPr lang="en-US" altLang="ko-KR" sz="1400" dirty="0"/>
              <a:t>Heatmap showing the expression patterns of the 20 most highly differently expressed genes for each patient.</a:t>
            </a:r>
            <a:endParaRPr lang="ko-KR" altLang="en-US" sz="1400" dirty="0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BDF9F37D-B646-0CE6-E3BA-9411FD2C37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661" y="665691"/>
            <a:ext cx="5478011" cy="3477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885440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56">
            <a:extLst>
              <a:ext uri="{FF2B5EF4-FFF2-40B4-BE49-F238E27FC236}">
                <a16:creationId xmlns:a16="http://schemas.microsoft.com/office/drawing/2014/main" id="{B684143B-870C-48B9-87D7-9CD34573AE83}"/>
              </a:ext>
            </a:extLst>
          </p:cNvPr>
          <p:cNvSpPr/>
          <p:nvPr/>
        </p:nvSpPr>
        <p:spPr>
          <a:xfrm>
            <a:off x="0" y="84443"/>
            <a:ext cx="685800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400" b="1" dirty="0"/>
              <a:t>Supple Fig. S8. </a:t>
            </a:r>
            <a:r>
              <a:rPr lang="en-US" altLang="ko-KR" sz="1400" dirty="0"/>
              <a:t>The </a:t>
            </a:r>
            <a:r>
              <a:rPr lang="en-US" altLang="ko-KR" sz="1400" dirty="0" err="1" smtClean="0"/>
              <a:t>clinicopathological</a:t>
            </a:r>
            <a:r>
              <a:rPr lang="en-US" altLang="ko-KR" sz="1400" dirty="0" smtClean="0"/>
              <a:t> </a:t>
            </a:r>
            <a:r>
              <a:rPr lang="en-US" altLang="ko-KR" sz="1400" dirty="0"/>
              <a:t>description, recurrence status and 4 drug responsiveness of 89 GC patients by cure-GA. The </a:t>
            </a:r>
            <a:r>
              <a:rPr lang="en-US" altLang="ko-KR" sz="1400" dirty="0" err="1"/>
              <a:t>heatmap</a:t>
            </a:r>
            <a:r>
              <a:rPr lang="en-US" altLang="ko-KR" sz="1400" dirty="0"/>
              <a:t> shows 5-Fu, </a:t>
            </a:r>
            <a:r>
              <a:rPr lang="en-US" altLang="ko-KR" sz="1400" dirty="0" err="1"/>
              <a:t>Irinotecan</a:t>
            </a:r>
            <a:r>
              <a:rPr lang="en-US" altLang="ko-KR" sz="1400" dirty="0"/>
              <a:t>, </a:t>
            </a:r>
            <a:r>
              <a:rPr lang="en-US" altLang="ko-KR" sz="1400" dirty="0" smtClean="0"/>
              <a:t>Paclitaxel </a:t>
            </a:r>
            <a:r>
              <a:rPr lang="en-US" altLang="ko-KR" sz="1400" dirty="0"/>
              <a:t>and </a:t>
            </a:r>
            <a:r>
              <a:rPr lang="en-US" altLang="ko-KR" sz="1400" dirty="0" err="1"/>
              <a:t>Oxaliplatin</a:t>
            </a:r>
            <a:r>
              <a:rPr lang="en-US" altLang="ko-KR" sz="1400" dirty="0"/>
              <a:t> </a:t>
            </a:r>
            <a:r>
              <a:rPr lang="en-US" altLang="ko-KR" sz="1400" dirty="0" smtClean="0"/>
              <a:t>sensitive </a:t>
            </a:r>
            <a:r>
              <a:rPr lang="en-US" altLang="ko-KR" sz="1400" dirty="0"/>
              <a:t>(red) or </a:t>
            </a:r>
            <a:r>
              <a:rPr lang="en-US" altLang="ko-KR" sz="1400" dirty="0" err="1" smtClean="0"/>
              <a:t>nonsensitive</a:t>
            </a:r>
            <a:r>
              <a:rPr lang="en-US" altLang="ko-KR" sz="1400" dirty="0" smtClean="0"/>
              <a:t> </a:t>
            </a:r>
            <a:r>
              <a:rPr lang="en-US" altLang="ko-KR" sz="1400" dirty="0"/>
              <a:t>(blue) in each GC patients by Cure-GA. 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2"/>
          <a:srcRect t="846"/>
          <a:stretch/>
        </p:blipFill>
        <p:spPr>
          <a:xfrm>
            <a:off x="149832" y="1279900"/>
            <a:ext cx="6544818" cy="35990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80307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083</TotalTime>
  <Words>367</Words>
  <Application>Microsoft Office PowerPoint</Application>
  <PresentationFormat>A4 용지(210x297mm)</PresentationFormat>
  <Paragraphs>46</Paragraphs>
  <Slides>10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0</vt:i4>
      </vt:variant>
    </vt:vector>
  </HeadingPairs>
  <TitlesOfParts>
    <vt:vector size="17" baseType="lpstr">
      <vt:lpstr>맑은 고딕</vt:lpstr>
      <vt:lpstr>Arial</vt:lpstr>
      <vt:lpstr>Calibri</vt:lpstr>
      <vt:lpstr>Calibri Light</vt:lpstr>
      <vt:lpstr>Times New Roman</vt:lpstr>
      <vt:lpstr>Office Theme</vt:lpstr>
      <vt:lpstr>Prism 9</vt:lpstr>
      <vt:lpstr>Supplementary Figures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n yukyung</dc:creator>
  <cp:lastModifiedBy>vdiadmin</cp:lastModifiedBy>
  <cp:revision>2204</cp:revision>
  <cp:lastPrinted>2024-02-16T07:54:22Z</cp:lastPrinted>
  <dcterms:created xsi:type="dcterms:W3CDTF">2019-09-20T17:59:28Z</dcterms:created>
  <dcterms:modified xsi:type="dcterms:W3CDTF">2024-12-17T02:37:30Z</dcterms:modified>
</cp:coreProperties>
</file>